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3" r:id="rId2"/>
    <p:sldId id="259" r:id="rId3"/>
    <p:sldId id="258" r:id="rId4"/>
    <p:sldId id="261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99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ersonnel\Th&#232;se\D&#233;oloration%20RB5\spectre%20RB5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SUS\Downloads\spectre%20RB5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0507726269315678E-2"/>
          <c:y val="7.2916666666666671E-2"/>
          <c:w val="0.86534216335540837"/>
          <c:h val="0.7777777777777777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Feuil1!$B$2</c:f>
              <c:strCache>
                <c:ptCount val="1"/>
                <c:pt idx="0">
                  <c:v>RB5 (25 mg/L)</c:v>
                </c:pt>
              </c:strCache>
            </c:strRef>
          </c:tx>
          <c:spPr>
            <a:ln w="12700">
              <a:solidFill>
                <a:srgbClr val="666699"/>
              </a:solidFill>
              <a:prstDash val="solid"/>
            </a:ln>
          </c:spPr>
          <c:marker>
            <c:symbol val="none"/>
          </c:marker>
          <c:xVal>
            <c:numRef>
              <c:f>Feuil1!$A$3:$A$303</c:f>
              <c:numCache>
                <c:formatCode>General</c:formatCode>
                <c:ptCount val="301"/>
                <c:pt idx="0">
                  <c:v>800</c:v>
                </c:pt>
                <c:pt idx="1">
                  <c:v>798</c:v>
                </c:pt>
                <c:pt idx="2">
                  <c:v>796</c:v>
                </c:pt>
                <c:pt idx="3">
                  <c:v>794</c:v>
                </c:pt>
                <c:pt idx="4">
                  <c:v>792</c:v>
                </c:pt>
                <c:pt idx="5">
                  <c:v>790</c:v>
                </c:pt>
                <c:pt idx="6">
                  <c:v>788</c:v>
                </c:pt>
                <c:pt idx="7">
                  <c:v>786</c:v>
                </c:pt>
                <c:pt idx="8">
                  <c:v>784</c:v>
                </c:pt>
                <c:pt idx="9">
                  <c:v>782</c:v>
                </c:pt>
                <c:pt idx="10">
                  <c:v>780</c:v>
                </c:pt>
                <c:pt idx="11">
                  <c:v>778</c:v>
                </c:pt>
                <c:pt idx="12">
                  <c:v>776</c:v>
                </c:pt>
                <c:pt idx="13">
                  <c:v>774</c:v>
                </c:pt>
                <c:pt idx="14">
                  <c:v>772</c:v>
                </c:pt>
                <c:pt idx="15">
                  <c:v>770</c:v>
                </c:pt>
                <c:pt idx="16">
                  <c:v>768</c:v>
                </c:pt>
                <c:pt idx="17">
                  <c:v>766</c:v>
                </c:pt>
                <c:pt idx="18">
                  <c:v>764</c:v>
                </c:pt>
                <c:pt idx="19">
                  <c:v>762</c:v>
                </c:pt>
                <c:pt idx="20">
                  <c:v>760</c:v>
                </c:pt>
                <c:pt idx="21">
                  <c:v>758</c:v>
                </c:pt>
                <c:pt idx="22">
                  <c:v>756</c:v>
                </c:pt>
                <c:pt idx="23">
                  <c:v>754</c:v>
                </c:pt>
                <c:pt idx="24">
                  <c:v>752</c:v>
                </c:pt>
                <c:pt idx="25">
                  <c:v>750</c:v>
                </c:pt>
                <c:pt idx="26">
                  <c:v>748</c:v>
                </c:pt>
                <c:pt idx="27">
                  <c:v>746</c:v>
                </c:pt>
                <c:pt idx="28">
                  <c:v>744</c:v>
                </c:pt>
                <c:pt idx="29">
                  <c:v>742</c:v>
                </c:pt>
                <c:pt idx="30">
                  <c:v>740</c:v>
                </c:pt>
                <c:pt idx="31">
                  <c:v>738</c:v>
                </c:pt>
                <c:pt idx="32">
                  <c:v>736</c:v>
                </c:pt>
                <c:pt idx="33">
                  <c:v>734</c:v>
                </c:pt>
                <c:pt idx="34">
                  <c:v>732</c:v>
                </c:pt>
                <c:pt idx="35">
                  <c:v>730</c:v>
                </c:pt>
                <c:pt idx="36">
                  <c:v>728</c:v>
                </c:pt>
                <c:pt idx="37">
                  <c:v>726</c:v>
                </c:pt>
                <c:pt idx="38">
                  <c:v>724</c:v>
                </c:pt>
                <c:pt idx="39">
                  <c:v>722</c:v>
                </c:pt>
                <c:pt idx="40">
                  <c:v>720</c:v>
                </c:pt>
                <c:pt idx="41">
                  <c:v>718</c:v>
                </c:pt>
                <c:pt idx="42">
                  <c:v>716</c:v>
                </c:pt>
                <c:pt idx="43">
                  <c:v>714</c:v>
                </c:pt>
                <c:pt idx="44">
                  <c:v>712</c:v>
                </c:pt>
                <c:pt idx="45">
                  <c:v>710</c:v>
                </c:pt>
                <c:pt idx="46">
                  <c:v>708</c:v>
                </c:pt>
                <c:pt idx="47">
                  <c:v>706</c:v>
                </c:pt>
                <c:pt idx="48">
                  <c:v>704</c:v>
                </c:pt>
                <c:pt idx="49">
                  <c:v>702</c:v>
                </c:pt>
                <c:pt idx="50">
                  <c:v>700</c:v>
                </c:pt>
                <c:pt idx="51">
                  <c:v>698</c:v>
                </c:pt>
                <c:pt idx="52">
                  <c:v>696</c:v>
                </c:pt>
                <c:pt idx="53">
                  <c:v>694</c:v>
                </c:pt>
                <c:pt idx="54">
                  <c:v>692</c:v>
                </c:pt>
                <c:pt idx="55">
                  <c:v>690</c:v>
                </c:pt>
                <c:pt idx="56">
                  <c:v>688</c:v>
                </c:pt>
                <c:pt idx="57">
                  <c:v>686</c:v>
                </c:pt>
                <c:pt idx="58">
                  <c:v>684</c:v>
                </c:pt>
                <c:pt idx="59">
                  <c:v>682</c:v>
                </c:pt>
                <c:pt idx="60">
                  <c:v>680</c:v>
                </c:pt>
                <c:pt idx="61">
                  <c:v>678</c:v>
                </c:pt>
                <c:pt idx="62">
                  <c:v>676</c:v>
                </c:pt>
                <c:pt idx="63">
                  <c:v>674</c:v>
                </c:pt>
                <c:pt idx="64">
                  <c:v>672</c:v>
                </c:pt>
                <c:pt idx="65">
                  <c:v>670</c:v>
                </c:pt>
                <c:pt idx="66">
                  <c:v>668</c:v>
                </c:pt>
                <c:pt idx="67">
                  <c:v>666</c:v>
                </c:pt>
                <c:pt idx="68">
                  <c:v>664</c:v>
                </c:pt>
                <c:pt idx="69">
                  <c:v>662</c:v>
                </c:pt>
                <c:pt idx="70">
                  <c:v>660</c:v>
                </c:pt>
                <c:pt idx="71">
                  <c:v>658</c:v>
                </c:pt>
                <c:pt idx="72">
                  <c:v>656</c:v>
                </c:pt>
                <c:pt idx="73">
                  <c:v>654</c:v>
                </c:pt>
                <c:pt idx="74">
                  <c:v>652</c:v>
                </c:pt>
                <c:pt idx="75">
                  <c:v>650</c:v>
                </c:pt>
                <c:pt idx="76">
                  <c:v>648</c:v>
                </c:pt>
                <c:pt idx="77">
                  <c:v>646</c:v>
                </c:pt>
                <c:pt idx="78">
                  <c:v>644</c:v>
                </c:pt>
                <c:pt idx="79">
                  <c:v>642</c:v>
                </c:pt>
                <c:pt idx="80">
                  <c:v>640</c:v>
                </c:pt>
                <c:pt idx="81">
                  <c:v>638</c:v>
                </c:pt>
                <c:pt idx="82">
                  <c:v>636</c:v>
                </c:pt>
                <c:pt idx="83">
                  <c:v>634</c:v>
                </c:pt>
                <c:pt idx="84">
                  <c:v>632</c:v>
                </c:pt>
                <c:pt idx="85">
                  <c:v>630</c:v>
                </c:pt>
                <c:pt idx="86">
                  <c:v>628</c:v>
                </c:pt>
                <c:pt idx="87">
                  <c:v>626</c:v>
                </c:pt>
                <c:pt idx="88">
                  <c:v>624</c:v>
                </c:pt>
                <c:pt idx="89">
                  <c:v>622</c:v>
                </c:pt>
                <c:pt idx="90">
                  <c:v>620</c:v>
                </c:pt>
                <c:pt idx="91">
                  <c:v>618</c:v>
                </c:pt>
                <c:pt idx="92">
                  <c:v>616</c:v>
                </c:pt>
                <c:pt idx="93">
                  <c:v>614</c:v>
                </c:pt>
                <c:pt idx="94">
                  <c:v>612</c:v>
                </c:pt>
                <c:pt idx="95">
                  <c:v>610</c:v>
                </c:pt>
                <c:pt idx="96">
                  <c:v>608</c:v>
                </c:pt>
                <c:pt idx="97">
                  <c:v>606</c:v>
                </c:pt>
                <c:pt idx="98">
                  <c:v>604</c:v>
                </c:pt>
                <c:pt idx="99">
                  <c:v>602</c:v>
                </c:pt>
                <c:pt idx="100">
                  <c:v>600</c:v>
                </c:pt>
                <c:pt idx="101">
                  <c:v>598</c:v>
                </c:pt>
                <c:pt idx="102">
                  <c:v>596</c:v>
                </c:pt>
                <c:pt idx="103">
                  <c:v>594</c:v>
                </c:pt>
                <c:pt idx="104">
                  <c:v>592</c:v>
                </c:pt>
                <c:pt idx="105">
                  <c:v>590</c:v>
                </c:pt>
                <c:pt idx="106">
                  <c:v>588</c:v>
                </c:pt>
                <c:pt idx="107">
                  <c:v>586</c:v>
                </c:pt>
                <c:pt idx="108">
                  <c:v>584</c:v>
                </c:pt>
                <c:pt idx="109">
                  <c:v>582</c:v>
                </c:pt>
                <c:pt idx="110">
                  <c:v>580</c:v>
                </c:pt>
                <c:pt idx="111">
                  <c:v>578</c:v>
                </c:pt>
                <c:pt idx="112">
                  <c:v>576</c:v>
                </c:pt>
                <c:pt idx="113">
                  <c:v>574</c:v>
                </c:pt>
                <c:pt idx="114">
                  <c:v>572</c:v>
                </c:pt>
                <c:pt idx="115">
                  <c:v>570</c:v>
                </c:pt>
                <c:pt idx="116">
                  <c:v>568</c:v>
                </c:pt>
                <c:pt idx="117">
                  <c:v>566</c:v>
                </c:pt>
                <c:pt idx="118">
                  <c:v>564</c:v>
                </c:pt>
                <c:pt idx="119">
                  <c:v>562</c:v>
                </c:pt>
                <c:pt idx="120">
                  <c:v>560</c:v>
                </c:pt>
                <c:pt idx="121">
                  <c:v>558</c:v>
                </c:pt>
                <c:pt idx="122">
                  <c:v>556</c:v>
                </c:pt>
                <c:pt idx="123">
                  <c:v>554</c:v>
                </c:pt>
                <c:pt idx="124">
                  <c:v>552</c:v>
                </c:pt>
                <c:pt idx="125">
                  <c:v>550</c:v>
                </c:pt>
                <c:pt idx="126">
                  <c:v>548</c:v>
                </c:pt>
                <c:pt idx="127">
                  <c:v>546</c:v>
                </c:pt>
                <c:pt idx="128">
                  <c:v>544</c:v>
                </c:pt>
                <c:pt idx="129">
                  <c:v>542</c:v>
                </c:pt>
                <c:pt idx="130">
                  <c:v>540</c:v>
                </c:pt>
                <c:pt idx="131">
                  <c:v>538</c:v>
                </c:pt>
                <c:pt idx="132">
                  <c:v>536</c:v>
                </c:pt>
                <c:pt idx="133">
                  <c:v>534</c:v>
                </c:pt>
                <c:pt idx="134">
                  <c:v>532</c:v>
                </c:pt>
                <c:pt idx="135">
                  <c:v>530</c:v>
                </c:pt>
                <c:pt idx="136">
                  <c:v>528</c:v>
                </c:pt>
                <c:pt idx="137">
                  <c:v>526</c:v>
                </c:pt>
                <c:pt idx="138">
                  <c:v>524</c:v>
                </c:pt>
                <c:pt idx="139">
                  <c:v>522</c:v>
                </c:pt>
                <c:pt idx="140">
                  <c:v>520</c:v>
                </c:pt>
                <c:pt idx="141">
                  <c:v>518</c:v>
                </c:pt>
                <c:pt idx="142">
                  <c:v>516</c:v>
                </c:pt>
                <c:pt idx="143">
                  <c:v>514</c:v>
                </c:pt>
                <c:pt idx="144">
                  <c:v>512</c:v>
                </c:pt>
                <c:pt idx="145">
                  <c:v>510</c:v>
                </c:pt>
                <c:pt idx="146">
                  <c:v>508</c:v>
                </c:pt>
                <c:pt idx="147">
                  <c:v>506</c:v>
                </c:pt>
                <c:pt idx="148">
                  <c:v>504</c:v>
                </c:pt>
                <c:pt idx="149">
                  <c:v>502</c:v>
                </c:pt>
                <c:pt idx="150">
                  <c:v>500</c:v>
                </c:pt>
                <c:pt idx="151">
                  <c:v>498</c:v>
                </c:pt>
                <c:pt idx="152">
                  <c:v>496</c:v>
                </c:pt>
                <c:pt idx="153">
                  <c:v>494</c:v>
                </c:pt>
                <c:pt idx="154">
                  <c:v>492</c:v>
                </c:pt>
                <c:pt idx="155">
                  <c:v>490</c:v>
                </c:pt>
                <c:pt idx="156">
                  <c:v>488</c:v>
                </c:pt>
                <c:pt idx="157">
                  <c:v>486</c:v>
                </c:pt>
                <c:pt idx="158">
                  <c:v>484</c:v>
                </c:pt>
                <c:pt idx="159">
                  <c:v>482</c:v>
                </c:pt>
                <c:pt idx="160">
                  <c:v>480</c:v>
                </c:pt>
                <c:pt idx="161">
                  <c:v>478</c:v>
                </c:pt>
                <c:pt idx="162">
                  <c:v>476</c:v>
                </c:pt>
                <c:pt idx="163">
                  <c:v>474</c:v>
                </c:pt>
                <c:pt idx="164">
                  <c:v>472</c:v>
                </c:pt>
                <c:pt idx="165">
                  <c:v>470</c:v>
                </c:pt>
                <c:pt idx="166">
                  <c:v>468</c:v>
                </c:pt>
                <c:pt idx="167">
                  <c:v>466</c:v>
                </c:pt>
                <c:pt idx="168">
                  <c:v>464</c:v>
                </c:pt>
                <c:pt idx="169">
                  <c:v>462</c:v>
                </c:pt>
                <c:pt idx="170">
                  <c:v>460</c:v>
                </c:pt>
                <c:pt idx="171">
                  <c:v>458</c:v>
                </c:pt>
                <c:pt idx="172">
                  <c:v>456</c:v>
                </c:pt>
                <c:pt idx="173">
                  <c:v>454</c:v>
                </c:pt>
                <c:pt idx="174">
                  <c:v>452</c:v>
                </c:pt>
                <c:pt idx="175">
                  <c:v>450</c:v>
                </c:pt>
                <c:pt idx="176">
                  <c:v>448</c:v>
                </c:pt>
                <c:pt idx="177">
                  <c:v>446</c:v>
                </c:pt>
                <c:pt idx="178">
                  <c:v>444</c:v>
                </c:pt>
                <c:pt idx="179">
                  <c:v>442</c:v>
                </c:pt>
                <c:pt idx="180">
                  <c:v>440</c:v>
                </c:pt>
                <c:pt idx="181">
                  <c:v>438</c:v>
                </c:pt>
                <c:pt idx="182">
                  <c:v>436</c:v>
                </c:pt>
                <c:pt idx="183">
                  <c:v>434</c:v>
                </c:pt>
                <c:pt idx="184">
                  <c:v>432</c:v>
                </c:pt>
                <c:pt idx="185">
                  <c:v>430</c:v>
                </c:pt>
                <c:pt idx="186">
                  <c:v>428</c:v>
                </c:pt>
                <c:pt idx="187">
                  <c:v>426</c:v>
                </c:pt>
                <c:pt idx="188">
                  <c:v>424</c:v>
                </c:pt>
                <c:pt idx="189">
                  <c:v>422</c:v>
                </c:pt>
                <c:pt idx="190">
                  <c:v>420</c:v>
                </c:pt>
                <c:pt idx="191">
                  <c:v>418</c:v>
                </c:pt>
                <c:pt idx="192">
                  <c:v>416</c:v>
                </c:pt>
                <c:pt idx="193">
                  <c:v>414</c:v>
                </c:pt>
                <c:pt idx="194">
                  <c:v>412</c:v>
                </c:pt>
                <c:pt idx="195">
                  <c:v>410</c:v>
                </c:pt>
                <c:pt idx="196">
                  <c:v>408</c:v>
                </c:pt>
                <c:pt idx="197">
                  <c:v>406</c:v>
                </c:pt>
                <c:pt idx="198">
                  <c:v>404</c:v>
                </c:pt>
                <c:pt idx="199">
                  <c:v>402</c:v>
                </c:pt>
                <c:pt idx="200">
                  <c:v>400</c:v>
                </c:pt>
                <c:pt idx="201">
                  <c:v>398</c:v>
                </c:pt>
                <c:pt idx="202">
                  <c:v>396</c:v>
                </c:pt>
                <c:pt idx="203">
                  <c:v>394</c:v>
                </c:pt>
                <c:pt idx="204">
                  <c:v>392</c:v>
                </c:pt>
                <c:pt idx="205">
                  <c:v>390</c:v>
                </c:pt>
                <c:pt idx="206">
                  <c:v>388</c:v>
                </c:pt>
                <c:pt idx="207">
                  <c:v>386</c:v>
                </c:pt>
                <c:pt idx="208">
                  <c:v>384</c:v>
                </c:pt>
                <c:pt idx="209">
                  <c:v>382</c:v>
                </c:pt>
                <c:pt idx="210">
                  <c:v>380</c:v>
                </c:pt>
                <c:pt idx="211">
                  <c:v>378</c:v>
                </c:pt>
                <c:pt idx="212">
                  <c:v>376</c:v>
                </c:pt>
                <c:pt idx="213">
                  <c:v>374</c:v>
                </c:pt>
                <c:pt idx="214">
                  <c:v>372</c:v>
                </c:pt>
                <c:pt idx="215">
                  <c:v>370</c:v>
                </c:pt>
                <c:pt idx="216">
                  <c:v>368</c:v>
                </c:pt>
                <c:pt idx="217">
                  <c:v>366</c:v>
                </c:pt>
                <c:pt idx="218">
                  <c:v>364</c:v>
                </c:pt>
                <c:pt idx="219">
                  <c:v>362</c:v>
                </c:pt>
                <c:pt idx="220">
                  <c:v>360</c:v>
                </c:pt>
                <c:pt idx="221">
                  <c:v>358</c:v>
                </c:pt>
                <c:pt idx="222">
                  <c:v>356</c:v>
                </c:pt>
                <c:pt idx="223">
                  <c:v>354</c:v>
                </c:pt>
                <c:pt idx="224">
                  <c:v>352</c:v>
                </c:pt>
                <c:pt idx="225">
                  <c:v>350</c:v>
                </c:pt>
                <c:pt idx="226">
                  <c:v>348</c:v>
                </c:pt>
                <c:pt idx="227">
                  <c:v>346</c:v>
                </c:pt>
                <c:pt idx="228">
                  <c:v>344</c:v>
                </c:pt>
                <c:pt idx="229">
                  <c:v>342</c:v>
                </c:pt>
                <c:pt idx="230">
                  <c:v>340</c:v>
                </c:pt>
                <c:pt idx="231">
                  <c:v>338</c:v>
                </c:pt>
                <c:pt idx="232">
                  <c:v>336</c:v>
                </c:pt>
                <c:pt idx="233">
                  <c:v>334</c:v>
                </c:pt>
                <c:pt idx="234">
                  <c:v>332</c:v>
                </c:pt>
                <c:pt idx="235">
                  <c:v>330</c:v>
                </c:pt>
                <c:pt idx="236">
                  <c:v>328</c:v>
                </c:pt>
                <c:pt idx="237">
                  <c:v>326</c:v>
                </c:pt>
                <c:pt idx="238">
                  <c:v>324</c:v>
                </c:pt>
                <c:pt idx="239">
                  <c:v>322</c:v>
                </c:pt>
                <c:pt idx="240">
                  <c:v>320</c:v>
                </c:pt>
                <c:pt idx="241">
                  <c:v>318</c:v>
                </c:pt>
                <c:pt idx="242">
                  <c:v>316</c:v>
                </c:pt>
                <c:pt idx="243">
                  <c:v>314</c:v>
                </c:pt>
                <c:pt idx="244">
                  <c:v>312</c:v>
                </c:pt>
                <c:pt idx="245">
                  <c:v>310</c:v>
                </c:pt>
                <c:pt idx="246">
                  <c:v>308</c:v>
                </c:pt>
                <c:pt idx="247">
                  <c:v>306</c:v>
                </c:pt>
                <c:pt idx="248">
                  <c:v>304</c:v>
                </c:pt>
                <c:pt idx="249">
                  <c:v>302</c:v>
                </c:pt>
                <c:pt idx="250">
                  <c:v>300</c:v>
                </c:pt>
                <c:pt idx="251">
                  <c:v>298</c:v>
                </c:pt>
                <c:pt idx="252">
                  <c:v>296</c:v>
                </c:pt>
                <c:pt idx="253">
                  <c:v>294</c:v>
                </c:pt>
                <c:pt idx="254">
                  <c:v>292</c:v>
                </c:pt>
                <c:pt idx="255">
                  <c:v>290</c:v>
                </c:pt>
                <c:pt idx="256">
                  <c:v>288</c:v>
                </c:pt>
                <c:pt idx="257">
                  <c:v>286</c:v>
                </c:pt>
                <c:pt idx="258">
                  <c:v>284</c:v>
                </c:pt>
                <c:pt idx="259">
                  <c:v>282</c:v>
                </c:pt>
                <c:pt idx="260">
                  <c:v>280</c:v>
                </c:pt>
                <c:pt idx="261">
                  <c:v>278</c:v>
                </c:pt>
                <c:pt idx="262">
                  <c:v>276</c:v>
                </c:pt>
                <c:pt idx="263">
                  <c:v>274</c:v>
                </c:pt>
                <c:pt idx="264">
                  <c:v>272</c:v>
                </c:pt>
                <c:pt idx="265">
                  <c:v>270</c:v>
                </c:pt>
                <c:pt idx="266">
                  <c:v>268</c:v>
                </c:pt>
                <c:pt idx="267">
                  <c:v>266</c:v>
                </c:pt>
                <c:pt idx="268">
                  <c:v>264</c:v>
                </c:pt>
                <c:pt idx="269">
                  <c:v>262</c:v>
                </c:pt>
                <c:pt idx="270">
                  <c:v>260</c:v>
                </c:pt>
                <c:pt idx="271">
                  <c:v>258</c:v>
                </c:pt>
                <c:pt idx="272">
                  <c:v>256</c:v>
                </c:pt>
                <c:pt idx="273">
                  <c:v>254</c:v>
                </c:pt>
                <c:pt idx="274">
                  <c:v>252</c:v>
                </c:pt>
                <c:pt idx="275">
                  <c:v>250</c:v>
                </c:pt>
                <c:pt idx="276">
                  <c:v>248</c:v>
                </c:pt>
                <c:pt idx="277">
                  <c:v>246</c:v>
                </c:pt>
                <c:pt idx="278">
                  <c:v>244</c:v>
                </c:pt>
                <c:pt idx="279">
                  <c:v>242</c:v>
                </c:pt>
                <c:pt idx="280">
                  <c:v>240</c:v>
                </c:pt>
                <c:pt idx="281">
                  <c:v>238</c:v>
                </c:pt>
                <c:pt idx="282">
                  <c:v>236</c:v>
                </c:pt>
                <c:pt idx="283">
                  <c:v>234</c:v>
                </c:pt>
                <c:pt idx="284">
                  <c:v>232</c:v>
                </c:pt>
                <c:pt idx="285">
                  <c:v>230</c:v>
                </c:pt>
                <c:pt idx="286">
                  <c:v>228</c:v>
                </c:pt>
                <c:pt idx="287">
                  <c:v>226</c:v>
                </c:pt>
                <c:pt idx="288">
                  <c:v>224</c:v>
                </c:pt>
                <c:pt idx="289">
                  <c:v>222</c:v>
                </c:pt>
                <c:pt idx="290">
                  <c:v>220</c:v>
                </c:pt>
                <c:pt idx="291">
                  <c:v>218</c:v>
                </c:pt>
                <c:pt idx="292">
                  <c:v>216</c:v>
                </c:pt>
                <c:pt idx="293">
                  <c:v>214</c:v>
                </c:pt>
                <c:pt idx="294">
                  <c:v>212</c:v>
                </c:pt>
                <c:pt idx="295">
                  <c:v>210</c:v>
                </c:pt>
                <c:pt idx="296">
                  <c:v>208</c:v>
                </c:pt>
                <c:pt idx="297">
                  <c:v>206</c:v>
                </c:pt>
                <c:pt idx="298">
                  <c:v>204</c:v>
                </c:pt>
                <c:pt idx="299">
                  <c:v>202</c:v>
                </c:pt>
                <c:pt idx="300">
                  <c:v>200</c:v>
                </c:pt>
              </c:numCache>
            </c:numRef>
          </c:xVal>
          <c:yVal>
            <c:numRef>
              <c:f>Feuil1!$B$3:$B$303</c:f>
              <c:numCache>
                <c:formatCode>General</c:formatCode>
                <c:ptCount val="301"/>
                <c:pt idx="0">
                  <c:v>7.8499999999999993E-3</c:v>
                </c:pt>
                <c:pt idx="1">
                  <c:v>-3.5999999999999999E-3</c:v>
                </c:pt>
                <c:pt idx="2">
                  <c:v>3.64E-3</c:v>
                </c:pt>
                <c:pt idx="3">
                  <c:v>2.5200000000000001E-3</c:v>
                </c:pt>
                <c:pt idx="4">
                  <c:v>3.64E-3</c:v>
                </c:pt>
                <c:pt idx="5">
                  <c:v>3.8600000000000001E-3</c:v>
                </c:pt>
                <c:pt idx="6">
                  <c:v>-3.5400000000000002E-3</c:v>
                </c:pt>
                <c:pt idx="7">
                  <c:v>-4.7999999999999996E-3</c:v>
                </c:pt>
                <c:pt idx="8">
                  <c:v>3.9100000000000003E-3</c:v>
                </c:pt>
                <c:pt idx="9">
                  <c:v>6.8799999999999998E-3</c:v>
                </c:pt>
                <c:pt idx="10">
                  <c:v>2.7399999999999998E-3</c:v>
                </c:pt>
                <c:pt idx="11">
                  <c:v>4.3099999999999996E-3</c:v>
                </c:pt>
                <c:pt idx="12">
                  <c:v>-1.07E-3</c:v>
                </c:pt>
                <c:pt idx="13">
                  <c:v>8.4999999999999995E-4</c:v>
                </c:pt>
                <c:pt idx="14">
                  <c:v>-2.49E-3</c:v>
                </c:pt>
                <c:pt idx="15">
                  <c:v>-5.4000000000000001E-4</c:v>
                </c:pt>
                <c:pt idx="16">
                  <c:v>1.7099999999999999E-3</c:v>
                </c:pt>
                <c:pt idx="17">
                  <c:v>7.5799999999999999E-3</c:v>
                </c:pt>
                <c:pt idx="18">
                  <c:v>-1.1E-4</c:v>
                </c:pt>
                <c:pt idx="19">
                  <c:v>8.7500000000000008E-3</c:v>
                </c:pt>
                <c:pt idx="20">
                  <c:v>-1.15E-3</c:v>
                </c:pt>
                <c:pt idx="21">
                  <c:v>2.48E-3</c:v>
                </c:pt>
                <c:pt idx="22">
                  <c:v>-2.48E-3</c:v>
                </c:pt>
                <c:pt idx="23">
                  <c:v>2.5400000000000002E-3</c:v>
                </c:pt>
                <c:pt idx="24">
                  <c:v>4.9500000000000004E-3</c:v>
                </c:pt>
                <c:pt idx="25">
                  <c:v>1.32E-3</c:v>
                </c:pt>
                <c:pt idx="26">
                  <c:v>6.2399999999999999E-3</c:v>
                </c:pt>
                <c:pt idx="27">
                  <c:v>-3.8500000000000001E-3</c:v>
                </c:pt>
                <c:pt idx="28">
                  <c:v>6.2500000000000003E-3</c:v>
                </c:pt>
                <c:pt idx="29">
                  <c:v>1.7099999999999999E-3</c:v>
                </c:pt>
                <c:pt idx="30">
                  <c:v>5.7299999999999999E-3</c:v>
                </c:pt>
                <c:pt idx="31">
                  <c:v>7.9799999999999992E-3</c:v>
                </c:pt>
                <c:pt idx="32">
                  <c:v>3.5E-4</c:v>
                </c:pt>
                <c:pt idx="33">
                  <c:v>4.8799999999999998E-3</c:v>
                </c:pt>
                <c:pt idx="34">
                  <c:v>1.81E-3</c:v>
                </c:pt>
                <c:pt idx="35">
                  <c:v>-4.0000000000000002E-4</c:v>
                </c:pt>
                <c:pt idx="36">
                  <c:v>2.9199999999999999E-3</c:v>
                </c:pt>
                <c:pt idx="37">
                  <c:v>5.1500000000000001E-3</c:v>
                </c:pt>
                <c:pt idx="38">
                  <c:v>-2.3000000000000001E-4</c:v>
                </c:pt>
                <c:pt idx="39">
                  <c:v>6.1599999999999997E-3</c:v>
                </c:pt>
                <c:pt idx="40">
                  <c:v>3.2699999999999999E-3</c:v>
                </c:pt>
                <c:pt idx="41">
                  <c:v>7.2300000000000003E-3</c:v>
                </c:pt>
                <c:pt idx="42">
                  <c:v>5.0400000000000002E-3</c:v>
                </c:pt>
                <c:pt idx="43">
                  <c:v>4.2100000000000002E-3</c:v>
                </c:pt>
                <c:pt idx="44">
                  <c:v>-5.5000000000000003E-4</c:v>
                </c:pt>
                <c:pt idx="45">
                  <c:v>9.11E-3</c:v>
                </c:pt>
                <c:pt idx="46">
                  <c:v>9.7999999999999997E-3</c:v>
                </c:pt>
                <c:pt idx="47">
                  <c:v>7.3899999999999999E-3</c:v>
                </c:pt>
                <c:pt idx="48">
                  <c:v>1.001E-2</c:v>
                </c:pt>
                <c:pt idx="49">
                  <c:v>1.3780000000000001E-2</c:v>
                </c:pt>
                <c:pt idx="50">
                  <c:v>1.3820000000000001E-2</c:v>
                </c:pt>
                <c:pt idx="51">
                  <c:v>1.472E-2</c:v>
                </c:pt>
                <c:pt idx="52">
                  <c:v>1.7649999999999999E-2</c:v>
                </c:pt>
                <c:pt idx="53">
                  <c:v>1.383E-2</c:v>
                </c:pt>
                <c:pt idx="54">
                  <c:v>2.3789999999999999E-2</c:v>
                </c:pt>
                <c:pt idx="55">
                  <c:v>1.9400000000000001E-2</c:v>
                </c:pt>
                <c:pt idx="56">
                  <c:v>2.6259999999999999E-2</c:v>
                </c:pt>
                <c:pt idx="57">
                  <c:v>2.8910000000000002E-2</c:v>
                </c:pt>
                <c:pt idx="58">
                  <c:v>3.5950000000000003E-2</c:v>
                </c:pt>
                <c:pt idx="59">
                  <c:v>3.5900000000000001E-2</c:v>
                </c:pt>
                <c:pt idx="60">
                  <c:v>4.2419999999999999E-2</c:v>
                </c:pt>
                <c:pt idx="61">
                  <c:v>4.8189999999999997E-2</c:v>
                </c:pt>
                <c:pt idx="62">
                  <c:v>5.237E-2</c:v>
                </c:pt>
                <c:pt idx="63">
                  <c:v>6.1330000000000003E-2</c:v>
                </c:pt>
                <c:pt idx="64">
                  <c:v>6.9889999999999994E-2</c:v>
                </c:pt>
                <c:pt idx="65">
                  <c:v>8.0829999999999999E-2</c:v>
                </c:pt>
                <c:pt idx="66">
                  <c:v>9.1910000000000006E-2</c:v>
                </c:pt>
                <c:pt idx="67">
                  <c:v>0.10353</c:v>
                </c:pt>
                <c:pt idx="68">
                  <c:v>0.11687</c:v>
                </c:pt>
                <c:pt idx="69">
                  <c:v>0.12716</c:v>
                </c:pt>
                <c:pt idx="70">
                  <c:v>0.14133000000000001</c:v>
                </c:pt>
                <c:pt idx="71">
                  <c:v>0.15912999999999999</c:v>
                </c:pt>
                <c:pt idx="72">
                  <c:v>0.17438999999999999</c:v>
                </c:pt>
                <c:pt idx="73">
                  <c:v>0.19303000000000001</c:v>
                </c:pt>
                <c:pt idx="74">
                  <c:v>0.21390999999999999</c:v>
                </c:pt>
                <c:pt idx="75">
                  <c:v>0.23175999999999999</c:v>
                </c:pt>
                <c:pt idx="76">
                  <c:v>0.25424000000000002</c:v>
                </c:pt>
                <c:pt idx="77">
                  <c:v>0.27884999999999999</c:v>
                </c:pt>
                <c:pt idx="78">
                  <c:v>0.30208000000000002</c:v>
                </c:pt>
                <c:pt idx="79">
                  <c:v>0.33099000000000001</c:v>
                </c:pt>
                <c:pt idx="80">
                  <c:v>0.35254999999999997</c:v>
                </c:pt>
                <c:pt idx="81">
                  <c:v>0.37162000000000001</c:v>
                </c:pt>
                <c:pt idx="82">
                  <c:v>0.40140999999999999</c:v>
                </c:pt>
                <c:pt idx="83">
                  <c:v>0.42212</c:v>
                </c:pt>
                <c:pt idx="84">
                  <c:v>0.44784000000000002</c:v>
                </c:pt>
                <c:pt idx="85">
                  <c:v>0.47072000000000003</c:v>
                </c:pt>
                <c:pt idx="86">
                  <c:v>0.49347000000000002</c:v>
                </c:pt>
                <c:pt idx="87">
                  <c:v>0.51473999999999998</c:v>
                </c:pt>
                <c:pt idx="88">
                  <c:v>0.53261000000000003</c:v>
                </c:pt>
                <c:pt idx="89">
                  <c:v>0.54803999999999997</c:v>
                </c:pt>
                <c:pt idx="90">
                  <c:v>0.56105000000000005</c:v>
                </c:pt>
                <c:pt idx="91">
                  <c:v>0.57023999999999997</c:v>
                </c:pt>
                <c:pt idx="92">
                  <c:v>0.58445999999999998</c:v>
                </c:pt>
                <c:pt idx="93">
                  <c:v>0.59379000000000004</c:v>
                </c:pt>
                <c:pt idx="94">
                  <c:v>0.60167999999999999</c:v>
                </c:pt>
                <c:pt idx="95">
                  <c:v>0.60857000000000006</c:v>
                </c:pt>
                <c:pt idx="96">
                  <c:v>0.61570000000000003</c:v>
                </c:pt>
                <c:pt idx="97">
                  <c:v>0.61670000000000003</c:v>
                </c:pt>
                <c:pt idx="98">
                  <c:v>0.61985999999999997</c:v>
                </c:pt>
                <c:pt idx="99">
                  <c:v>0.62500999999999995</c:v>
                </c:pt>
                <c:pt idx="100">
                  <c:v>0.62238000000000004</c:v>
                </c:pt>
                <c:pt idx="101">
                  <c:v>0.62421000000000004</c:v>
                </c:pt>
                <c:pt idx="102">
                  <c:v>0.62402000000000002</c:v>
                </c:pt>
                <c:pt idx="103">
                  <c:v>0.61911000000000005</c:v>
                </c:pt>
                <c:pt idx="104">
                  <c:v>0.61563999999999997</c:v>
                </c:pt>
                <c:pt idx="105">
                  <c:v>0.61246</c:v>
                </c:pt>
                <c:pt idx="106">
                  <c:v>0.61158000000000001</c:v>
                </c:pt>
                <c:pt idx="107">
                  <c:v>0.60731000000000002</c:v>
                </c:pt>
                <c:pt idx="108">
                  <c:v>0.59935000000000005</c:v>
                </c:pt>
                <c:pt idx="109">
                  <c:v>0.59225000000000005</c:v>
                </c:pt>
                <c:pt idx="110">
                  <c:v>0.58628000000000002</c:v>
                </c:pt>
                <c:pt idx="111">
                  <c:v>0.57882</c:v>
                </c:pt>
                <c:pt idx="112">
                  <c:v>0.57030999999999998</c:v>
                </c:pt>
                <c:pt idx="113">
                  <c:v>0.55939000000000005</c:v>
                </c:pt>
                <c:pt idx="114">
                  <c:v>0.55071000000000003</c:v>
                </c:pt>
                <c:pt idx="115">
                  <c:v>0.53964999999999996</c:v>
                </c:pt>
                <c:pt idx="116">
                  <c:v>0.52866999999999997</c:v>
                </c:pt>
                <c:pt idx="117">
                  <c:v>0.51459999999999995</c:v>
                </c:pt>
                <c:pt idx="118">
                  <c:v>0.50271999999999994</c:v>
                </c:pt>
                <c:pt idx="119">
                  <c:v>0.49129</c:v>
                </c:pt>
                <c:pt idx="120">
                  <c:v>0.47847000000000001</c:v>
                </c:pt>
                <c:pt idx="121">
                  <c:v>0.46587000000000001</c:v>
                </c:pt>
                <c:pt idx="122">
                  <c:v>0.45521</c:v>
                </c:pt>
                <c:pt idx="123">
                  <c:v>0.44296000000000002</c:v>
                </c:pt>
                <c:pt idx="124">
                  <c:v>0.43028</c:v>
                </c:pt>
                <c:pt idx="125">
                  <c:v>0.41882000000000003</c:v>
                </c:pt>
                <c:pt idx="126">
                  <c:v>0.40786</c:v>
                </c:pt>
                <c:pt idx="127">
                  <c:v>0.39528999999999997</c:v>
                </c:pt>
                <c:pt idx="128">
                  <c:v>0.38424000000000003</c:v>
                </c:pt>
                <c:pt idx="129">
                  <c:v>0.37297000000000002</c:v>
                </c:pt>
                <c:pt idx="130">
                  <c:v>0.36194999999999999</c:v>
                </c:pt>
                <c:pt idx="131">
                  <c:v>0.35137000000000002</c:v>
                </c:pt>
                <c:pt idx="132">
                  <c:v>0.34065000000000001</c:v>
                </c:pt>
                <c:pt idx="133">
                  <c:v>0.33056000000000002</c:v>
                </c:pt>
                <c:pt idx="134">
                  <c:v>0.32133</c:v>
                </c:pt>
                <c:pt idx="135">
                  <c:v>0.30947000000000002</c:v>
                </c:pt>
                <c:pt idx="136">
                  <c:v>0.30074000000000001</c:v>
                </c:pt>
                <c:pt idx="137">
                  <c:v>0.29110000000000003</c:v>
                </c:pt>
                <c:pt idx="138">
                  <c:v>0.28170000000000001</c:v>
                </c:pt>
                <c:pt idx="139">
                  <c:v>0.27365</c:v>
                </c:pt>
                <c:pt idx="140">
                  <c:v>0.26529999999999998</c:v>
                </c:pt>
                <c:pt idx="141">
                  <c:v>0.25661</c:v>
                </c:pt>
                <c:pt idx="142">
                  <c:v>0.24793999999999999</c:v>
                </c:pt>
                <c:pt idx="143">
                  <c:v>0.24048</c:v>
                </c:pt>
                <c:pt idx="144">
                  <c:v>0.23219000000000001</c:v>
                </c:pt>
                <c:pt idx="145">
                  <c:v>0.22617999999999999</c:v>
                </c:pt>
                <c:pt idx="146">
                  <c:v>0.22017999999999999</c:v>
                </c:pt>
                <c:pt idx="147">
                  <c:v>0.21529999999999999</c:v>
                </c:pt>
                <c:pt idx="148">
                  <c:v>0.21251999999999999</c:v>
                </c:pt>
                <c:pt idx="149">
                  <c:v>0.20802000000000001</c:v>
                </c:pt>
                <c:pt idx="150">
                  <c:v>0.20407</c:v>
                </c:pt>
                <c:pt idx="151">
                  <c:v>0.20277000000000001</c:v>
                </c:pt>
                <c:pt idx="152">
                  <c:v>0.20250000000000001</c:v>
                </c:pt>
                <c:pt idx="153">
                  <c:v>0.20133000000000001</c:v>
                </c:pt>
                <c:pt idx="154">
                  <c:v>0.20199</c:v>
                </c:pt>
                <c:pt idx="155">
                  <c:v>0.20207</c:v>
                </c:pt>
                <c:pt idx="156">
                  <c:v>0.20252000000000001</c:v>
                </c:pt>
                <c:pt idx="157">
                  <c:v>0.2026</c:v>
                </c:pt>
                <c:pt idx="158">
                  <c:v>0.20211999999999999</c:v>
                </c:pt>
                <c:pt idx="159">
                  <c:v>0.20102</c:v>
                </c:pt>
                <c:pt idx="160">
                  <c:v>0.19939999999999999</c:v>
                </c:pt>
                <c:pt idx="161">
                  <c:v>0.19708999999999999</c:v>
                </c:pt>
                <c:pt idx="162">
                  <c:v>0.19361</c:v>
                </c:pt>
                <c:pt idx="163">
                  <c:v>0.19086</c:v>
                </c:pt>
                <c:pt idx="164">
                  <c:v>0.18773999999999999</c:v>
                </c:pt>
                <c:pt idx="165">
                  <c:v>0.1847</c:v>
                </c:pt>
                <c:pt idx="166">
                  <c:v>0.18243000000000001</c:v>
                </c:pt>
                <c:pt idx="167">
                  <c:v>0.17946999999999999</c:v>
                </c:pt>
                <c:pt idx="168">
                  <c:v>0.17788000000000001</c:v>
                </c:pt>
                <c:pt idx="169">
                  <c:v>0.17610999999999999</c:v>
                </c:pt>
                <c:pt idx="170">
                  <c:v>0.17496</c:v>
                </c:pt>
                <c:pt idx="171">
                  <c:v>0.17401</c:v>
                </c:pt>
                <c:pt idx="172">
                  <c:v>0.17330999999999999</c:v>
                </c:pt>
                <c:pt idx="173">
                  <c:v>0.17266000000000001</c:v>
                </c:pt>
                <c:pt idx="174">
                  <c:v>0.17169000000000001</c:v>
                </c:pt>
                <c:pt idx="175">
                  <c:v>0.17041000000000001</c:v>
                </c:pt>
                <c:pt idx="176">
                  <c:v>0.16933000000000001</c:v>
                </c:pt>
                <c:pt idx="177">
                  <c:v>0.16819000000000001</c:v>
                </c:pt>
                <c:pt idx="178">
                  <c:v>0.16664000000000001</c:v>
                </c:pt>
                <c:pt idx="179">
                  <c:v>0.16592000000000001</c:v>
                </c:pt>
                <c:pt idx="180">
                  <c:v>0.16489000000000001</c:v>
                </c:pt>
                <c:pt idx="181">
                  <c:v>0.16388</c:v>
                </c:pt>
                <c:pt idx="182">
                  <c:v>0.16306000000000001</c:v>
                </c:pt>
                <c:pt idx="183">
                  <c:v>0.16233</c:v>
                </c:pt>
                <c:pt idx="184">
                  <c:v>0.16142000000000001</c:v>
                </c:pt>
                <c:pt idx="185">
                  <c:v>0.16089999999999999</c:v>
                </c:pt>
                <c:pt idx="186">
                  <c:v>0.16028000000000001</c:v>
                </c:pt>
                <c:pt idx="187">
                  <c:v>0.15998000000000001</c:v>
                </c:pt>
                <c:pt idx="188">
                  <c:v>0.15984999999999999</c:v>
                </c:pt>
                <c:pt idx="189">
                  <c:v>0.15981999999999999</c:v>
                </c:pt>
                <c:pt idx="190">
                  <c:v>0.16005</c:v>
                </c:pt>
                <c:pt idx="191">
                  <c:v>0.16002</c:v>
                </c:pt>
                <c:pt idx="192">
                  <c:v>0.16012999999999999</c:v>
                </c:pt>
                <c:pt idx="193">
                  <c:v>0.16087000000000001</c:v>
                </c:pt>
                <c:pt idx="194">
                  <c:v>0.16088</c:v>
                </c:pt>
                <c:pt idx="195">
                  <c:v>0.16192000000000001</c:v>
                </c:pt>
                <c:pt idx="196">
                  <c:v>0.16347999999999999</c:v>
                </c:pt>
                <c:pt idx="197">
                  <c:v>0.16614000000000001</c:v>
                </c:pt>
                <c:pt idx="198">
                  <c:v>0.16997999999999999</c:v>
                </c:pt>
                <c:pt idx="199">
                  <c:v>0.17549000000000001</c:v>
                </c:pt>
                <c:pt idx="200">
                  <c:v>0.18165999999999999</c:v>
                </c:pt>
                <c:pt idx="201">
                  <c:v>0.18820999999999999</c:v>
                </c:pt>
                <c:pt idx="202">
                  <c:v>0.19475000000000001</c:v>
                </c:pt>
                <c:pt idx="203">
                  <c:v>0.19894000000000001</c:v>
                </c:pt>
                <c:pt idx="204">
                  <c:v>0.20089000000000001</c:v>
                </c:pt>
                <c:pt idx="205">
                  <c:v>0.20093</c:v>
                </c:pt>
                <c:pt idx="206">
                  <c:v>0.19872999999999999</c:v>
                </c:pt>
                <c:pt idx="207">
                  <c:v>0.19517999999999999</c:v>
                </c:pt>
                <c:pt idx="208">
                  <c:v>0.19045000000000001</c:v>
                </c:pt>
                <c:pt idx="209">
                  <c:v>0.18551000000000001</c:v>
                </c:pt>
                <c:pt idx="210">
                  <c:v>0.1802</c:v>
                </c:pt>
                <c:pt idx="211">
                  <c:v>0.17488000000000001</c:v>
                </c:pt>
                <c:pt idx="212">
                  <c:v>0.17</c:v>
                </c:pt>
                <c:pt idx="213">
                  <c:v>0.16467000000000001</c:v>
                </c:pt>
                <c:pt idx="214">
                  <c:v>0.15853</c:v>
                </c:pt>
                <c:pt idx="215">
                  <c:v>0.15282000000000001</c:v>
                </c:pt>
                <c:pt idx="216">
                  <c:v>0.14674999999999999</c:v>
                </c:pt>
                <c:pt idx="217">
                  <c:v>0.14158000000000001</c:v>
                </c:pt>
                <c:pt idx="218">
                  <c:v>0.13621</c:v>
                </c:pt>
                <c:pt idx="219">
                  <c:v>0.13272</c:v>
                </c:pt>
                <c:pt idx="220">
                  <c:v>0.13091</c:v>
                </c:pt>
                <c:pt idx="221">
                  <c:v>0.13069</c:v>
                </c:pt>
                <c:pt idx="222">
                  <c:v>0.13295000000000001</c:v>
                </c:pt>
                <c:pt idx="223">
                  <c:v>0.13674</c:v>
                </c:pt>
                <c:pt idx="224">
                  <c:v>0.14282</c:v>
                </c:pt>
                <c:pt idx="225">
                  <c:v>0.14960999999999999</c:v>
                </c:pt>
                <c:pt idx="226">
                  <c:v>0.15733</c:v>
                </c:pt>
                <c:pt idx="227">
                  <c:v>0.16528999999999999</c:v>
                </c:pt>
                <c:pt idx="228">
                  <c:v>0.17288999999999999</c:v>
                </c:pt>
                <c:pt idx="229">
                  <c:v>0.18279999999999999</c:v>
                </c:pt>
                <c:pt idx="230">
                  <c:v>0.19631999999999999</c:v>
                </c:pt>
                <c:pt idx="231">
                  <c:v>0.21079999999999999</c:v>
                </c:pt>
                <c:pt idx="232">
                  <c:v>0.22983000000000001</c:v>
                </c:pt>
                <c:pt idx="233">
                  <c:v>0.25256000000000001</c:v>
                </c:pt>
                <c:pt idx="234">
                  <c:v>0.27553</c:v>
                </c:pt>
                <c:pt idx="235">
                  <c:v>0.30125999999999997</c:v>
                </c:pt>
                <c:pt idx="236">
                  <c:v>0.32750000000000001</c:v>
                </c:pt>
                <c:pt idx="237">
                  <c:v>0.35010999999999998</c:v>
                </c:pt>
                <c:pt idx="238">
                  <c:v>0.37076999999999999</c:v>
                </c:pt>
                <c:pt idx="239">
                  <c:v>0.38911000000000001</c:v>
                </c:pt>
                <c:pt idx="240">
                  <c:v>0.40375</c:v>
                </c:pt>
                <c:pt idx="241">
                  <c:v>0.41395999999999999</c:v>
                </c:pt>
                <c:pt idx="242">
                  <c:v>0.42318</c:v>
                </c:pt>
                <c:pt idx="243">
                  <c:v>0.42910999999999999</c:v>
                </c:pt>
                <c:pt idx="244">
                  <c:v>0.43425999999999998</c:v>
                </c:pt>
                <c:pt idx="245">
                  <c:v>0.43643999999999999</c:v>
                </c:pt>
                <c:pt idx="246">
                  <c:v>0.43642999999999998</c:v>
                </c:pt>
                <c:pt idx="247">
                  <c:v>0.43458999999999998</c:v>
                </c:pt>
                <c:pt idx="248">
                  <c:v>0.43060999999999999</c:v>
                </c:pt>
                <c:pt idx="249">
                  <c:v>0.42659000000000002</c:v>
                </c:pt>
                <c:pt idx="250">
                  <c:v>0.41970000000000002</c:v>
                </c:pt>
                <c:pt idx="251">
                  <c:v>0.41266000000000003</c:v>
                </c:pt>
                <c:pt idx="252">
                  <c:v>0.40448000000000001</c:v>
                </c:pt>
                <c:pt idx="253">
                  <c:v>0.39459</c:v>
                </c:pt>
                <c:pt idx="254">
                  <c:v>0.38371</c:v>
                </c:pt>
                <c:pt idx="255">
                  <c:v>0.37329000000000001</c:v>
                </c:pt>
                <c:pt idx="256">
                  <c:v>0.35926000000000002</c:v>
                </c:pt>
                <c:pt idx="257">
                  <c:v>0.34842000000000001</c:v>
                </c:pt>
                <c:pt idx="258">
                  <c:v>0.33560000000000001</c:v>
                </c:pt>
                <c:pt idx="259">
                  <c:v>0.32361000000000001</c:v>
                </c:pt>
                <c:pt idx="260">
                  <c:v>0.31418000000000001</c:v>
                </c:pt>
                <c:pt idx="261">
                  <c:v>0.30441000000000001</c:v>
                </c:pt>
                <c:pt idx="262">
                  <c:v>0.29616999999999999</c:v>
                </c:pt>
                <c:pt idx="263">
                  <c:v>0.29552</c:v>
                </c:pt>
                <c:pt idx="264">
                  <c:v>0.28782999999999997</c:v>
                </c:pt>
                <c:pt idx="265">
                  <c:v>0.28833999999999999</c:v>
                </c:pt>
                <c:pt idx="266">
                  <c:v>0.26112999999999997</c:v>
                </c:pt>
                <c:pt idx="267">
                  <c:v>0.24501000000000001</c:v>
                </c:pt>
                <c:pt idx="268">
                  <c:v>0.23133000000000001</c:v>
                </c:pt>
                <c:pt idx="269">
                  <c:v>0.21664</c:v>
                </c:pt>
                <c:pt idx="270">
                  <c:v>0.21379999999999999</c:v>
                </c:pt>
                <c:pt idx="271">
                  <c:v>0.21160000000000001</c:v>
                </c:pt>
                <c:pt idx="272">
                  <c:v>0.21578</c:v>
                </c:pt>
                <c:pt idx="273">
                  <c:v>0.21212</c:v>
                </c:pt>
                <c:pt idx="274">
                  <c:v>0.21728</c:v>
                </c:pt>
                <c:pt idx="275">
                  <c:v>0.21595</c:v>
                </c:pt>
                <c:pt idx="276">
                  <c:v>0.21124999999999999</c:v>
                </c:pt>
                <c:pt idx="277">
                  <c:v>0.20615</c:v>
                </c:pt>
                <c:pt idx="278">
                  <c:v>0.21376000000000001</c:v>
                </c:pt>
                <c:pt idx="279">
                  <c:v>0.21190999999999999</c:v>
                </c:pt>
                <c:pt idx="280">
                  <c:v>0.21468000000000001</c:v>
                </c:pt>
                <c:pt idx="281">
                  <c:v>0.20891999999999999</c:v>
                </c:pt>
                <c:pt idx="282">
                  <c:v>0.21518999999999999</c:v>
                </c:pt>
                <c:pt idx="283">
                  <c:v>0.2215</c:v>
                </c:pt>
                <c:pt idx="284">
                  <c:v>0.21351999999999999</c:v>
                </c:pt>
                <c:pt idx="285">
                  <c:v>0.21481</c:v>
                </c:pt>
                <c:pt idx="286">
                  <c:v>0.21432999999999999</c:v>
                </c:pt>
                <c:pt idx="287">
                  <c:v>0.21615000000000001</c:v>
                </c:pt>
                <c:pt idx="288">
                  <c:v>0.20821000000000001</c:v>
                </c:pt>
                <c:pt idx="289">
                  <c:v>0.19941</c:v>
                </c:pt>
                <c:pt idx="290">
                  <c:v>0.21486</c:v>
                </c:pt>
                <c:pt idx="291">
                  <c:v>0.21906999999999999</c:v>
                </c:pt>
                <c:pt idx="292">
                  <c:v>0.24146999999999999</c:v>
                </c:pt>
                <c:pt idx="293">
                  <c:v>0.22441</c:v>
                </c:pt>
                <c:pt idx="294">
                  <c:v>0.19106999999999999</c:v>
                </c:pt>
                <c:pt idx="295">
                  <c:v>0.23474999999999999</c:v>
                </c:pt>
                <c:pt idx="296">
                  <c:v>0.24124000000000001</c:v>
                </c:pt>
                <c:pt idx="297">
                  <c:v>0.22323999999999999</c:v>
                </c:pt>
                <c:pt idx="298">
                  <c:v>0.24077999999999999</c:v>
                </c:pt>
                <c:pt idx="299">
                  <c:v>0.22781000000000001</c:v>
                </c:pt>
                <c:pt idx="300">
                  <c:v>0.21837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005-49FD-B3FC-925FD33CADDB}"/>
            </c:ext>
          </c:extLst>
        </c:ser>
        <c:ser>
          <c:idx val="1"/>
          <c:order val="1"/>
          <c:tx>
            <c:strRef>
              <c:f>Feuil1!$C$2</c:f>
              <c:strCache>
                <c:ptCount val="1"/>
                <c:pt idx="0">
                  <c:v>RB5 (25mg/L) +HBT</c:v>
                </c:pt>
              </c:strCache>
            </c:strRef>
          </c:tx>
          <c:spPr>
            <a:ln w="12700">
              <a:solidFill>
                <a:srgbClr val="FF6600"/>
              </a:solidFill>
              <a:prstDash val="solid"/>
            </a:ln>
          </c:spPr>
          <c:marker>
            <c:symbol val="none"/>
          </c:marker>
          <c:xVal>
            <c:numRef>
              <c:f>Feuil1!$A$3:$A$303</c:f>
              <c:numCache>
                <c:formatCode>General</c:formatCode>
                <c:ptCount val="301"/>
                <c:pt idx="0">
                  <c:v>800</c:v>
                </c:pt>
                <c:pt idx="1">
                  <c:v>798</c:v>
                </c:pt>
                <c:pt idx="2">
                  <c:v>796</c:v>
                </c:pt>
                <c:pt idx="3">
                  <c:v>794</c:v>
                </c:pt>
                <c:pt idx="4">
                  <c:v>792</c:v>
                </c:pt>
                <c:pt idx="5">
                  <c:v>790</c:v>
                </c:pt>
                <c:pt idx="6">
                  <c:v>788</c:v>
                </c:pt>
                <c:pt idx="7">
                  <c:v>786</c:v>
                </c:pt>
                <c:pt idx="8">
                  <c:v>784</c:v>
                </c:pt>
                <c:pt idx="9">
                  <c:v>782</c:v>
                </c:pt>
                <c:pt idx="10">
                  <c:v>780</c:v>
                </c:pt>
                <c:pt idx="11">
                  <c:v>778</c:v>
                </c:pt>
                <c:pt idx="12">
                  <c:v>776</c:v>
                </c:pt>
                <c:pt idx="13">
                  <c:v>774</c:v>
                </c:pt>
                <c:pt idx="14">
                  <c:v>772</c:v>
                </c:pt>
                <c:pt idx="15">
                  <c:v>770</c:v>
                </c:pt>
                <c:pt idx="16">
                  <c:v>768</c:v>
                </c:pt>
                <c:pt idx="17">
                  <c:v>766</c:v>
                </c:pt>
                <c:pt idx="18">
                  <c:v>764</c:v>
                </c:pt>
                <c:pt idx="19">
                  <c:v>762</c:v>
                </c:pt>
                <c:pt idx="20">
                  <c:v>760</c:v>
                </c:pt>
                <c:pt idx="21">
                  <c:v>758</c:v>
                </c:pt>
                <c:pt idx="22">
                  <c:v>756</c:v>
                </c:pt>
                <c:pt idx="23">
                  <c:v>754</c:v>
                </c:pt>
                <c:pt idx="24">
                  <c:v>752</c:v>
                </c:pt>
                <c:pt idx="25">
                  <c:v>750</c:v>
                </c:pt>
                <c:pt idx="26">
                  <c:v>748</c:v>
                </c:pt>
                <c:pt idx="27">
                  <c:v>746</c:v>
                </c:pt>
                <c:pt idx="28">
                  <c:v>744</c:v>
                </c:pt>
                <c:pt idx="29">
                  <c:v>742</c:v>
                </c:pt>
                <c:pt idx="30">
                  <c:v>740</c:v>
                </c:pt>
                <c:pt idx="31">
                  <c:v>738</c:v>
                </c:pt>
                <c:pt idx="32">
                  <c:v>736</c:v>
                </c:pt>
                <c:pt idx="33">
                  <c:v>734</c:v>
                </c:pt>
                <c:pt idx="34">
                  <c:v>732</c:v>
                </c:pt>
                <c:pt idx="35">
                  <c:v>730</c:v>
                </c:pt>
                <c:pt idx="36">
                  <c:v>728</c:v>
                </c:pt>
                <c:pt idx="37">
                  <c:v>726</c:v>
                </c:pt>
                <c:pt idx="38">
                  <c:v>724</c:v>
                </c:pt>
                <c:pt idx="39">
                  <c:v>722</c:v>
                </c:pt>
                <c:pt idx="40">
                  <c:v>720</c:v>
                </c:pt>
                <c:pt idx="41">
                  <c:v>718</c:v>
                </c:pt>
                <c:pt idx="42">
                  <c:v>716</c:v>
                </c:pt>
                <c:pt idx="43">
                  <c:v>714</c:v>
                </c:pt>
                <c:pt idx="44">
                  <c:v>712</c:v>
                </c:pt>
                <c:pt idx="45">
                  <c:v>710</c:v>
                </c:pt>
                <c:pt idx="46">
                  <c:v>708</c:v>
                </c:pt>
                <c:pt idx="47">
                  <c:v>706</c:v>
                </c:pt>
                <c:pt idx="48">
                  <c:v>704</c:v>
                </c:pt>
                <c:pt idx="49">
                  <c:v>702</c:v>
                </c:pt>
                <c:pt idx="50">
                  <c:v>700</c:v>
                </c:pt>
                <c:pt idx="51">
                  <c:v>698</c:v>
                </c:pt>
                <c:pt idx="52">
                  <c:v>696</c:v>
                </c:pt>
                <c:pt idx="53">
                  <c:v>694</c:v>
                </c:pt>
                <c:pt idx="54">
                  <c:v>692</c:v>
                </c:pt>
                <c:pt idx="55">
                  <c:v>690</c:v>
                </c:pt>
                <c:pt idx="56">
                  <c:v>688</c:v>
                </c:pt>
                <c:pt idx="57">
                  <c:v>686</c:v>
                </c:pt>
                <c:pt idx="58">
                  <c:v>684</c:v>
                </c:pt>
                <c:pt idx="59">
                  <c:v>682</c:v>
                </c:pt>
                <c:pt idx="60">
                  <c:v>680</c:v>
                </c:pt>
                <c:pt idx="61">
                  <c:v>678</c:v>
                </c:pt>
                <c:pt idx="62">
                  <c:v>676</c:v>
                </c:pt>
                <c:pt idx="63">
                  <c:v>674</c:v>
                </c:pt>
                <c:pt idx="64">
                  <c:v>672</c:v>
                </c:pt>
                <c:pt idx="65">
                  <c:v>670</c:v>
                </c:pt>
                <c:pt idx="66">
                  <c:v>668</c:v>
                </c:pt>
                <c:pt idx="67">
                  <c:v>666</c:v>
                </c:pt>
                <c:pt idx="68">
                  <c:v>664</c:v>
                </c:pt>
                <c:pt idx="69">
                  <c:v>662</c:v>
                </c:pt>
                <c:pt idx="70">
                  <c:v>660</c:v>
                </c:pt>
                <c:pt idx="71">
                  <c:v>658</c:v>
                </c:pt>
                <c:pt idx="72">
                  <c:v>656</c:v>
                </c:pt>
                <c:pt idx="73">
                  <c:v>654</c:v>
                </c:pt>
                <c:pt idx="74">
                  <c:v>652</c:v>
                </c:pt>
                <c:pt idx="75">
                  <c:v>650</c:v>
                </c:pt>
                <c:pt idx="76">
                  <c:v>648</c:v>
                </c:pt>
                <c:pt idx="77">
                  <c:v>646</c:v>
                </c:pt>
                <c:pt idx="78">
                  <c:v>644</c:v>
                </c:pt>
                <c:pt idx="79">
                  <c:v>642</c:v>
                </c:pt>
                <c:pt idx="80">
                  <c:v>640</c:v>
                </c:pt>
                <c:pt idx="81">
                  <c:v>638</c:v>
                </c:pt>
                <c:pt idx="82">
                  <c:v>636</c:v>
                </c:pt>
                <c:pt idx="83">
                  <c:v>634</c:v>
                </c:pt>
                <c:pt idx="84">
                  <c:v>632</c:v>
                </c:pt>
                <c:pt idx="85">
                  <c:v>630</c:v>
                </c:pt>
                <c:pt idx="86">
                  <c:v>628</c:v>
                </c:pt>
                <c:pt idx="87">
                  <c:v>626</c:v>
                </c:pt>
                <c:pt idx="88">
                  <c:v>624</c:v>
                </c:pt>
                <c:pt idx="89">
                  <c:v>622</c:v>
                </c:pt>
                <c:pt idx="90">
                  <c:v>620</c:v>
                </c:pt>
                <c:pt idx="91">
                  <c:v>618</c:v>
                </c:pt>
                <c:pt idx="92">
                  <c:v>616</c:v>
                </c:pt>
                <c:pt idx="93">
                  <c:v>614</c:v>
                </c:pt>
                <c:pt idx="94">
                  <c:v>612</c:v>
                </c:pt>
                <c:pt idx="95">
                  <c:v>610</c:v>
                </c:pt>
                <c:pt idx="96">
                  <c:v>608</c:v>
                </c:pt>
                <c:pt idx="97">
                  <c:v>606</c:v>
                </c:pt>
                <c:pt idx="98">
                  <c:v>604</c:v>
                </c:pt>
                <c:pt idx="99">
                  <c:v>602</c:v>
                </c:pt>
                <c:pt idx="100">
                  <c:v>600</c:v>
                </c:pt>
                <c:pt idx="101">
                  <c:v>598</c:v>
                </c:pt>
                <c:pt idx="102">
                  <c:v>596</c:v>
                </c:pt>
                <c:pt idx="103">
                  <c:v>594</c:v>
                </c:pt>
                <c:pt idx="104">
                  <c:v>592</c:v>
                </c:pt>
                <c:pt idx="105">
                  <c:v>590</c:v>
                </c:pt>
                <c:pt idx="106">
                  <c:v>588</c:v>
                </c:pt>
                <c:pt idx="107">
                  <c:v>586</c:v>
                </c:pt>
                <c:pt idx="108">
                  <c:v>584</c:v>
                </c:pt>
                <c:pt idx="109">
                  <c:v>582</c:v>
                </c:pt>
                <c:pt idx="110">
                  <c:v>580</c:v>
                </c:pt>
                <c:pt idx="111">
                  <c:v>578</c:v>
                </c:pt>
                <c:pt idx="112">
                  <c:v>576</c:v>
                </c:pt>
                <c:pt idx="113">
                  <c:v>574</c:v>
                </c:pt>
                <c:pt idx="114">
                  <c:v>572</c:v>
                </c:pt>
                <c:pt idx="115">
                  <c:v>570</c:v>
                </c:pt>
                <c:pt idx="116">
                  <c:v>568</c:v>
                </c:pt>
                <c:pt idx="117">
                  <c:v>566</c:v>
                </c:pt>
                <c:pt idx="118">
                  <c:v>564</c:v>
                </c:pt>
                <c:pt idx="119">
                  <c:v>562</c:v>
                </c:pt>
                <c:pt idx="120">
                  <c:v>560</c:v>
                </c:pt>
                <c:pt idx="121">
                  <c:v>558</c:v>
                </c:pt>
                <c:pt idx="122">
                  <c:v>556</c:v>
                </c:pt>
                <c:pt idx="123">
                  <c:v>554</c:v>
                </c:pt>
                <c:pt idx="124">
                  <c:v>552</c:v>
                </c:pt>
                <c:pt idx="125">
                  <c:v>550</c:v>
                </c:pt>
                <c:pt idx="126">
                  <c:v>548</c:v>
                </c:pt>
                <c:pt idx="127">
                  <c:v>546</c:v>
                </c:pt>
                <c:pt idx="128">
                  <c:v>544</c:v>
                </c:pt>
                <c:pt idx="129">
                  <c:v>542</c:v>
                </c:pt>
                <c:pt idx="130">
                  <c:v>540</c:v>
                </c:pt>
                <c:pt idx="131">
                  <c:v>538</c:v>
                </c:pt>
                <c:pt idx="132">
                  <c:v>536</c:v>
                </c:pt>
                <c:pt idx="133">
                  <c:v>534</c:v>
                </c:pt>
                <c:pt idx="134">
                  <c:v>532</c:v>
                </c:pt>
                <c:pt idx="135">
                  <c:v>530</c:v>
                </c:pt>
                <c:pt idx="136">
                  <c:v>528</c:v>
                </c:pt>
                <c:pt idx="137">
                  <c:v>526</c:v>
                </c:pt>
                <c:pt idx="138">
                  <c:v>524</c:v>
                </c:pt>
                <c:pt idx="139">
                  <c:v>522</c:v>
                </c:pt>
                <c:pt idx="140">
                  <c:v>520</c:v>
                </c:pt>
                <c:pt idx="141">
                  <c:v>518</c:v>
                </c:pt>
                <c:pt idx="142">
                  <c:v>516</c:v>
                </c:pt>
                <c:pt idx="143">
                  <c:v>514</c:v>
                </c:pt>
                <c:pt idx="144">
                  <c:v>512</c:v>
                </c:pt>
                <c:pt idx="145">
                  <c:v>510</c:v>
                </c:pt>
                <c:pt idx="146">
                  <c:v>508</c:v>
                </c:pt>
                <c:pt idx="147">
                  <c:v>506</c:v>
                </c:pt>
                <c:pt idx="148">
                  <c:v>504</c:v>
                </c:pt>
                <c:pt idx="149">
                  <c:v>502</c:v>
                </c:pt>
                <c:pt idx="150">
                  <c:v>500</c:v>
                </c:pt>
                <c:pt idx="151">
                  <c:v>498</c:v>
                </c:pt>
                <c:pt idx="152">
                  <c:v>496</c:v>
                </c:pt>
                <c:pt idx="153">
                  <c:v>494</c:v>
                </c:pt>
                <c:pt idx="154">
                  <c:v>492</c:v>
                </c:pt>
                <c:pt idx="155">
                  <c:v>490</c:v>
                </c:pt>
                <c:pt idx="156">
                  <c:v>488</c:v>
                </c:pt>
                <c:pt idx="157">
                  <c:v>486</c:v>
                </c:pt>
                <c:pt idx="158">
                  <c:v>484</c:v>
                </c:pt>
                <c:pt idx="159">
                  <c:v>482</c:v>
                </c:pt>
                <c:pt idx="160">
                  <c:v>480</c:v>
                </c:pt>
                <c:pt idx="161">
                  <c:v>478</c:v>
                </c:pt>
                <c:pt idx="162">
                  <c:v>476</c:v>
                </c:pt>
                <c:pt idx="163">
                  <c:v>474</c:v>
                </c:pt>
                <c:pt idx="164">
                  <c:v>472</c:v>
                </c:pt>
                <c:pt idx="165">
                  <c:v>470</c:v>
                </c:pt>
                <c:pt idx="166">
                  <c:v>468</c:v>
                </c:pt>
                <c:pt idx="167">
                  <c:v>466</c:v>
                </c:pt>
                <c:pt idx="168">
                  <c:v>464</c:v>
                </c:pt>
                <c:pt idx="169">
                  <c:v>462</c:v>
                </c:pt>
                <c:pt idx="170">
                  <c:v>460</c:v>
                </c:pt>
                <c:pt idx="171">
                  <c:v>458</c:v>
                </c:pt>
                <c:pt idx="172">
                  <c:v>456</c:v>
                </c:pt>
                <c:pt idx="173">
                  <c:v>454</c:v>
                </c:pt>
                <c:pt idx="174">
                  <c:v>452</c:v>
                </c:pt>
                <c:pt idx="175">
                  <c:v>450</c:v>
                </c:pt>
                <c:pt idx="176">
                  <c:v>448</c:v>
                </c:pt>
                <c:pt idx="177">
                  <c:v>446</c:v>
                </c:pt>
                <c:pt idx="178">
                  <c:v>444</c:v>
                </c:pt>
                <c:pt idx="179">
                  <c:v>442</c:v>
                </c:pt>
                <c:pt idx="180">
                  <c:v>440</c:v>
                </c:pt>
                <c:pt idx="181">
                  <c:v>438</c:v>
                </c:pt>
                <c:pt idx="182">
                  <c:v>436</c:v>
                </c:pt>
                <c:pt idx="183">
                  <c:v>434</c:v>
                </c:pt>
                <c:pt idx="184">
                  <c:v>432</c:v>
                </c:pt>
                <c:pt idx="185">
                  <c:v>430</c:v>
                </c:pt>
                <c:pt idx="186">
                  <c:v>428</c:v>
                </c:pt>
                <c:pt idx="187">
                  <c:v>426</c:v>
                </c:pt>
                <c:pt idx="188">
                  <c:v>424</c:v>
                </c:pt>
                <c:pt idx="189">
                  <c:v>422</c:v>
                </c:pt>
                <c:pt idx="190">
                  <c:v>420</c:v>
                </c:pt>
                <c:pt idx="191">
                  <c:v>418</c:v>
                </c:pt>
                <c:pt idx="192">
                  <c:v>416</c:v>
                </c:pt>
                <c:pt idx="193">
                  <c:v>414</c:v>
                </c:pt>
                <c:pt idx="194">
                  <c:v>412</c:v>
                </c:pt>
                <c:pt idx="195">
                  <c:v>410</c:v>
                </c:pt>
                <c:pt idx="196">
                  <c:v>408</c:v>
                </c:pt>
                <c:pt idx="197">
                  <c:v>406</c:v>
                </c:pt>
                <c:pt idx="198">
                  <c:v>404</c:v>
                </c:pt>
                <c:pt idx="199">
                  <c:v>402</c:v>
                </c:pt>
                <c:pt idx="200">
                  <c:v>400</c:v>
                </c:pt>
                <c:pt idx="201">
                  <c:v>398</c:v>
                </c:pt>
                <c:pt idx="202">
                  <c:v>396</c:v>
                </c:pt>
                <c:pt idx="203">
                  <c:v>394</c:v>
                </c:pt>
                <c:pt idx="204">
                  <c:v>392</c:v>
                </c:pt>
                <c:pt idx="205">
                  <c:v>390</c:v>
                </c:pt>
                <c:pt idx="206">
                  <c:v>388</c:v>
                </c:pt>
                <c:pt idx="207">
                  <c:v>386</c:v>
                </c:pt>
                <c:pt idx="208">
                  <c:v>384</c:v>
                </c:pt>
                <c:pt idx="209">
                  <c:v>382</c:v>
                </c:pt>
                <c:pt idx="210">
                  <c:v>380</c:v>
                </c:pt>
                <c:pt idx="211">
                  <c:v>378</c:v>
                </c:pt>
                <c:pt idx="212">
                  <c:v>376</c:v>
                </c:pt>
                <c:pt idx="213">
                  <c:v>374</c:v>
                </c:pt>
                <c:pt idx="214">
                  <c:v>372</c:v>
                </c:pt>
                <c:pt idx="215">
                  <c:v>370</c:v>
                </c:pt>
                <c:pt idx="216">
                  <c:v>368</c:v>
                </c:pt>
                <c:pt idx="217">
                  <c:v>366</c:v>
                </c:pt>
                <c:pt idx="218">
                  <c:v>364</c:v>
                </c:pt>
                <c:pt idx="219">
                  <c:v>362</c:v>
                </c:pt>
                <c:pt idx="220">
                  <c:v>360</c:v>
                </c:pt>
                <c:pt idx="221">
                  <c:v>358</c:v>
                </c:pt>
                <c:pt idx="222">
                  <c:v>356</c:v>
                </c:pt>
                <c:pt idx="223">
                  <c:v>354</c:v>
                </c:pt>
                <c:pt idx="224">
                  <c:v>352</c:v>
                </c:pt>
                <c:pt idx="225">
                  <c:v>350</c:v>
                </c:pt>
                <c:pt idx="226">
                  <c:v>348</c:v>
                </c:pt>
                <c:pt idx="227">
                  <c:v>346</c:v>
                </c:pt>
                <c:pt idx="228">
                  <c:v>344</c:v>
                </c:pt>
                <c:pt idx="229">
                  <c:v>342</c:v>
                </c:pt>
                <c:pt idx="230">
                  <c:v>340</c:v>
                </c:pt>
                <c:pt idx="231">
                  <c:v>338</c:v>
                </c:pt>
                <c:pt idx="232">
                  <c:v>336</c:v>
                </c:pt>
                <c:pt idx="233">
                  <c:v>334</c:v>
                </c:pt>
                <c:pt idx="234">
                  <c:v>332</c:v>
                </c:pt>
                <c:pt idx="235">
                  <c:v>330</c:v>
                </c:pt>
                <c:pt idx="236">
                  <c:v>328</c:v>
                </c:pt>
                <c:pt idx="237">
                  <c:v>326</c:v>
                </c:pt>
                <c:pt idx="238">
                  <c:v>324</c:v>
                </c:pt>
                <c:pt idx="239">
                  <c:v>322</c:v>
                </c:pt>
                <c:pt idx="240">
                  <c:v>320</c:v>
                </c:pt>
                <c:pt idx="241">
                  <c:v>318</c:v>
                </c:pt>
                <c:pt idx="242">
                  <c:v>316</c:v>
                </c:pt>
                <c:pt idx="243">
                  <c:v>314</c:v>
                </c:pt>
                <c:pt idx="244">
                  <c:v>312</c:v>
                </c:pt>
                <c:pt idx="245">
                  <c:v>310</c:v>
                </c:pt>
                <c:pt idx="246">
                  <c:v>308</c:v>
                </c:pt>
                <c:pt idx="247">
                  <c:v>306</c:v>
                </c:pt>
                <c:pt idx="248">
                  <c:v>304</c:v>
                </c:pt>
                <c:pt idx="249">
                  <c:v>302</c:v>
                </c:pt>
                <c:pt idx="250">
                  <c:v>300</c:v>
                </c:pt>
                <c:pt idx="251">
                  <c:v>298</c:v>
                </c:pt>
                <c:pt idx="252">
                  <c:v>296</c:v>
                </c:pt>
                <c:pt idx="253">
                  <c:v>294</c:v>
                </c:pt>
                <c:pt idx="254">
                  <c:v>292</c:v>
                </c:pt>
                <c:pt idx="255">
                  <c:v>290</c:v>
                </c:pt>
                <c:pt idx="256">
                  <c:v>288</c:v>
                </c:pt>
                <c:pt idx="257">
                  <c:v>286</c:v>
                </c:pt>
                <c:pt idx="258">
                  <c:v>284</c:v>
                </c:pt>
                <c:pt idx="259">
                  <c:v>282</c:v>
                </c:pt>
                <c:pt idx="260">
                  <c:v>280</c:v>
                </c:pt>
                <c:pt idx="261">
                  <c:v>278</c:v>
                </c:pt>
                <c:pt idx="262">
                  <c:v>276</c:v>
                </c:pt>
                <c:pt idx="263">
                  <c:v>274</c:v>
                </c:pt>
                <c:pt idx="264">
                  <c:v>272</c:v>
                </c:pt>
                <c:pt idx="265">
                  <c:v>270</c:v>
                </c:pt>
                <c:pt idx="266">
                  <c:v>268</c:v>
                </c:pt>
                <c:pt idx="267">
                  <c:v>266</c:v>
                </c:pt>
                <c:pt idx="268">
                  <c:v>264</c:v>
                </c:pt>
                <c:pt idx="269">
                  <c:v>262</c:v>
                </c:pt>
                <c:pt idx="270">
                  <c:v>260</c:v>
                </c:pt>
                <c:pt idx="271">
                  <c:v>258</c:v>
                </c:pt>
                <c:pt idx="272">
                  <c:v>256</c:v>
                </c:pt>
                <c:pt idx="273">
                  <c:v>254</c:v>
                </c:pt>
                <c:pt idx="274">
                  <c:v>252</c:v>
                </c:pt>
                <c:pt idx="275">
                  <c:v>250</c:v>
                </c:pt>
                <c:pt idx="276">
                  <c:v>248</c:v>
                </c:pt>
                <c:pt idx="277">
                  <c:v>246</c:v>
                </c:pt>
                <c:pt idx="278">
                  <c:v>244</c:v>
                </c:pt>
                <c:pt idx="279">
                  <c:v>242</c:v>
                </c:pt>
                <c:pt idx="280">
                  <c:v>240</c:v>
                </c:pt>
                <c:pt idx="281">
                  <c:v>238</c:v>
                </c:pt>
                <c:pt idx="282">
                  <c:v>236</c:v>
                </c:pt>
                <c:pt idx="283">
                  <c:v>234</c:v>
                </c:pt>
                <c:pt idx="284">
                  <c:v>232</c:v>
                </c:pt>
                <c:pt idx="285">
                  <c:v>230</c:v>
                </c:pt>
                <c:pt idx="286">
                  <c:v>228</c:v>
                </c:pt>
                <c:pt idx="287">
                  <c:v>226</c:v>
                </c:pt>
                <c:pt idx="288">
                  <c:v>224</c:v>
                </c:pt>
                <c:pt idx="289">
                  <c:v>222</c:v>
                </c:pt>
                <c:pt idx="290">
                  <c:v>220</c:v>
                </c:pt>
                <c:pt idx="291">
                  <c:v>218</c:v>
                </c:pt>
                <c:pt idx="292">
                  <c:v>216</c:v>
                </c:pt>
                <c:pt idx="293">
                  <c:v>214</c:v>
                </c:pt>
                <c:pt idx="294">
                  <c:v>212</c:v>
                </c:pt>
                <c:pt idx="295">
                  <c:v>210</c:v>
                </c:pt>
                <c:pt idx="296">
                  <c:v>208</c:v>
                </c:pt>
                <c:pt idx="297">
                  <c:v>206</c:v>
                </c:pt>
                <c:pt idx="298">
                  <c:v>204</c:v>
                </c:pt>
                <c:pt idx="299">
                  <c:v>202</c:v>
                </c:pt>
                <c:pt idx="300">
                  <c:v>200</c:v>
                </c:pt>
              </c:numCache>
            </c:numRef>
          </c:xVal>
          <c:yVal>
            <c:numRef>
              <c:f>Feuil1!$C$3:$C$303</c:f>
              <c:numCache>
                <c:formatCode>General</c:formatCode>
                <c:ptCount val="301"/>
                <c:pt idx="0">
                  <c:v>3.8400000000000001E-3</c:v>
                </c:pt>
                <c:pt idx="1">
                  <c:v>2.1199999999999999E-3</c:v>
                </c:pt>
                <c:pt idx="2">
                  <c:v>7.3000000000000001E-3</c:v>
                </c:pt>
                <c:pt idx="3">
                  <c:v>7.3299999999999997E-3</c:v>
                </c:pt>
                <c:pt idx="4">
                  <c:v>-2.2399999999999998E-3</c:v>
                </c:pt>
                <c:pt idx="5">
                  <c:v>-1.9000000000000001E-4</c:v>
                </c:pt>
                <c:pt idx="6">
                  <c:v>1.97E-3</c:v>
                </c:pt>
                <c:pt idx="7">
                  <c:v>1.4300000000000001E-3</c:v>
                </c:pt>
                <c:pt idx="8">
                  <c:v>3.5899999999999999E-3</c:v>
                </c:pt>
                <c:pt idx="9">
                  <c:v>2.98E-3</c:v>
                </c:pt>
                <c:pt idx="10">
                  <c:v>2.5500000000000002E-3</c:v>
                </c:pt>
                <c:pt idx="11">
                  <c:v>3.2100000000000002E-3</c:v>
                </c:pt>
                <c:pt idx="12">
                  <c:v>1.6900000000000001E-3</c:v>
                </c:pt>
                <c:pt idx="13">
                  <c:v>2.5400000000000002E-3</c:v>
                </c:pt>
                <c:pt idx="14">
                  <c:v>-4.1999999999999997E-3</c:v>
                </c:pt>
                <c:pt idx="15">
                  <c:v>2.9499999999999999E-3</c:v>
                </c:pt>
                <c:pt idx="16">
                  <c:v>5.5999999999999999E-3</c:v>
                </c:pt>
                <c:pt idx="17">
                  <c:v>5.8500000000000002E-3</c:v>
                </c:pt>
                <c:pt idx="18">
                  <c:v>-9.8999999999999999E-4</c:v>
                </c:pt>
                <c:pt idx="19">
                  <c:v>8.9899999999999997E-3</c:v>
                </c:pt>
                <c:pt idx="20">
                  <c:v>7.7999999999999999E-4</c:v>
                </c:pt>
                <c:pt idx="21">
                  <c:v>2.14E-3</c:v>
                </c:pt>
                <c:pt idx="22">
                  <c:v>-9.7000000000000005E-4</c:v>
                </c:pt>
                <c:pt idx="23">
                  <c:v>4.7200000000000002E-3</c:v>
                </c:pt>
                <c:pt idx="24">
                  <c:v>5.96E-3</c:v>
                </c:pt>
                <c:pt idx="25">
                  <c:v>-2.0799999999999998E-3</c:v>
                </c:pt>
                <c:pt idx="26">
                  <c:v>7.4000000000000003E-3</c:v>
                </c:pt>
                <c:pt idx="27">
                  <c:v>-1.1E-4</c:v>
                </c:pt>
                <c:pt idx="28">
                  <c:v>3.3500000000000001E-3</c:v>
                </c:pt>
                <c:pt idx="29">
                  <c:v>1.9499999999999999E-3</c:v>
                </c:pt>
                <c:pt idx="30">
                  <c:v>8.3999999999999995E-3</c:v>
                </c:pt>
                <c:pt idx="31">
                  <c:v>7.5900000000000004E-3</c:v>
                </c:pt>
                <c:pt idx="32">
                  <c:v>3.8700000000000002E-3</c:v>
                </c:pt>
                <c:pt idx="33">
                  <c:v>3.5799999999999998E-3</c:v>
                </c:pt>
                <c:pt idx="34">
                  <c:v>4.4999999999999997E-3</c:v>
                </c:pt>
                <c:pt idx="35">
                  <c:v>4.5700000000000003E-3</c:v>
                </c:pt>
                <c:pt idx="36">
                  <c:v>4.8799999999999998E-3</c:v>
                </c:pt>
                <c:pt idx="37">
                  <c:v>3.0500000000000002E-3</c:v>
                </c:pt>
                <c:pt idx="38">
                  <c:v>5.6299999999999996E-3</c:v>
                </c:pt>
                <c:pt idx="39">
                  <c:v>7.6099999999999996E-3</c:v>
                </c:pt>
                <c:pt idx="40">
                  <c:v>3.9699999999999996E-3</c:v>
                </c:pt>
                <c:pt idx="41">
                  <c:v>7.9100000000000004E-3</c:v>
                </c:pt>
                <c:pt idx="42">
                  <c:v>5.0800000000000003E-3</c:v>
                </c:pt>
                <c:pt idx="43">
                  <c:v>3.9100000000000003E-3</c:v>
                </c:pt>
                <c:pt idx="44">
                  <c:v>4.6699999999999997E-3</c:v>
                </c:pt>
                <c:pt idx="45">
                  <c:v>1.171E-2</c:v>
                </c:pt>
                <c:pt idx="46">
                  <c:v>8.7200000000000003E-3</c:v>
                </c:pt>
                <c:pt idx="47">
                  <c:v>8.77E-3</c:v>
                </c:pt>
                <c:pt idx="48">
                  <c:v>1.376E-2</c:v>
                </c:pt>
                <c:pt idx="49">
                  <c:v>1.5509999999999999E-2</c:v>
                </c:pt>
                <c:pt idx="50">
                  <c:v>1.5810000000000001E-2</c:v>
                </c:pt>
                <c:pt idx="51">
                  <c:v>1.908E-2</c:v>
                </c:pt>
                <c:pt idx="52">
                  <c:v>1.762E-2</c:v>
                </c:pt>
                <c:pt idx="53">
                  <c:v>2.085E-2</c:v>
                </c:pt>
                <c:pt idx="54">
                  <c:v>2.5239999999999999E-2</c:v>
                </c:pt>
                <c:pt idx="55">
                  <c:v>2.23E-2</c:v>
                </c:pt>
                <c:pt idx="56">
                  <c:v>3.2050000000000002E-2</c:v>
                </c:pt>
                <c:pt idx="57">
                  <c:v>3.1300000000000001E-2</c:v>
                </c:pt>
                <c:pt idx="58">
                  <c:v>4.1270000000000001E-2</c:v>
                </c:pt>
                <c:pt idx="59">
                  <c:v>4.5670000000000002E-2</c:v>
                </c:pt>
                <c:pt idx="60">
                  <c:v>5.2089999999999997E-2</c:v>
                </c:pt>
                <c:pt idx="61">
                  <c:v>5.7770000000000002E-2</c:v>
                </c:pt>
                <c:pt idx="62">
                  <c:v>6.2850000000000003E-2</c:v>
                </c:pt>
                <c:pt idx="63">
                  <c:v>7.4010000000000006E-2</c:v>
                </c:pt>
                <c:pt idx="64">
                  <c:v>8.2580000000000001E-2</c:v>
                </c:pt>
                <c:pt idx="65">
                  <c:v>9.5949999999999994E-2</c:v>
                </c:pt>
                <c:pt idx="66">
                  <c:v>0.1071</c:v>
                </c:pt>
                <c:pt idx="67">
                  <c:v>0.12057</c:v>
                </c:pt>
                <c:pt idx="68">
                  <c:v>0.13428999999999999</c:v>
                </c:pt>
                <c:pt idx="69">
                  <c:v>0.14954000000000001</c:v>
                </c:pt>
                <c:pt idx="70">
                  <c:v>0.16431000000000001</c:v>
                </c:pt>
                <c:pt idx="71">
                  <c:v>0.18201999999999999</c:v>
                </c:pt>
                <c:pt idx="72">
                  <c:v>0.20003000000000001</c:v>
                </c:pt>
                <c:pt idx="73">
                  <c:v>0.22600999999999999</c:v>
                </c:pt>
                <c:pt idx="74">
                  <c:v>0.24765000000000001</c:v>
                </c:pt>
                <c:pt idx="75">
                  <c:v>0.26944000000000001</c:v>
                </c:pt>
                <c:pt idx="76">
                  <c:v>0.29041</c:v>
                </c:pt>
                <c:pt idx="77">
                  <c:v>0.32139000000000001</c:v>
                </c:pt>
                <c:pt idx="78">
                  <c:v>0.34432000000000001</c:v>
                </c:pt>
                <c:pt idx="79">
                  <c:v>0.37168000000000001</c:v>
                </c:pt>
                <c:pt idx="80">
                  <c:v>0.39712999999999998</c:v>
                </c:pt>
                <c:pt idx="81">
                  <c:v>0.42293999999999998</c:v>
                </c:pt>
                <c:pt idx="82">
                  <c:v>0.45282</c:v>
                </c:pt>
                <c:pt idx="83">
                  <c:v>0.47560999999999998</c:v>
                </c:pt>
                <c:pt idx="84">
                  <c:v>0.50353000000000003</c:v>
                </c:pt>
                <c:pt idx="85">
                  <c:v>0.52759999999999996</c:v>
                </c:pt>
                <c:pt idx="86">
                  <c:v>0.55225000000000002</c:v>
                </c:pt>
                <c:pt idx="87">
                  <c:v>0.57421</c:v>
                </c:pt>
                <c:pt idx="88">
                  <c:v>0.59319</c:v>
                </c:pt>
                <c:pt idx="89">
                  <c:v>0.61012</c:v>
                </c:pt>
                <c:pt idx="90">
                  <c:v>0.62283999999999995</c:v>
                </c:pt>
                <c:pt idx="91">
                  <c:v>0.63629999999999998</c:v>
                </c:pt>
                <c:pt idx="92">
                  <c:v>0.64883000000000002</c:v>
                </c:pt>
                <c:pt idx="93">
                  <c:v>0.66003999999999996</c:v>
                </c:pt>
                <c:pt idx="94">
                  <c:v>0.66439999999999999</c:v>
                </c:pt>
                <c:pt idx="95">
                  <c:v>0.67218999999999995</c:v>
                </c:pt>
                <c:pt idx="96">
                  <c:v>0.67915999999999999</c:v>
                </c:pt>
                <c:pt idx="97">
                  <c:v>0.68106</c:v>
                </c:pt>
                <c:pt idx="98">
                  <c:v>0.68206999999999995</c:v>
                </c:pt>
                <c:pt idx="99">
                  <c:v>0.68833</c:v>
                </c:pt>
                <c:pt idx="100">
                  <c:v>0.68491000000000002</c:v>
                </c:pt>
                <c:pt idx="101">
                  <c:v>0.68764999999999998</c:v>
                </c:pt>
                <c:pt idx="102">
                  <c:v>0.68625000000000003</c:v>
                </c:pt>
                <c:pt idx="103">
                  <c:v>0.68130999999999997</c:v>
                </c:pt>
                <c:pt idx="104">
                  <c:v>0.67784</c:v>
                </c:pt>
                <c:pt idx="105">
                  <c:v>0.67496999999999996</c:v>
                </c:pt>
                <c:pt idx="106">
                  <c:v>0.67457</c:v>
                </c:pt>
                <c:pt idx="107">
                  <c:v>0.66546000000000005</c:v>
                </c:pt>
                <c:pt idx="108">
                  <c:v>0.65774999999999995</c:v>
                </c:pt>
                <c:pt idx="109">
                  <c:v>0.65154000000000001</c:v>
                </c:pt>
                <c:pt idx="110">
                  <c:v>0.64226000000000005</c:v>
                </c:pt>
                <c:pt idx="111">
                  <c:v>0.63441000000000003</c:v>
                </c:pt>
                <c:pt idx="112">
                  <c:v>0.62597000000000003</c:v>
                </c:pt>
                <c:pt idx="113">
                  <c:v>0.61431000000000002</c:v>
                </c:pt>
                <c:pt idx="114">
                  <c:v>0.60455999999999999</c:v>
                </c:pt>
                <c:pt idx="115">
                  <c:v>0.59140000000000004</c:v>
                </c:pt>
                <c:pt idx="116">
                  <c:v>0.57852000000000003</c:v>
                </c:pt>
                <c:pt idx="117">
                  <c:v>0.56318999999999997</c:v>
                </c:pt>
                <c:pt idx="118">
                  <c:v>0.55069000000000001</c:v>
                </c:pt>
                <c:pt idx="119">
                  <c:v>0.53786</c:v>
                </c:pt>
                <c:pt idx="120">
                  <c:v>0.52453000000000005</c:v>
                </c:pt>
                <c:pt idx="121">
                  <c:v>0.50924000000000003</c:v>
                </c:pt>
                <c:pt idx="122">
                  <c:v>0.49774000000000002</c:v>
                </c:pt>
                <c:pt idx="123">
                  <c:v>0.48388999999999999</c:v>
                </c:pt>
                <c:pt idx="124">
                  <c:v>0.46965000000000001</c:v>
                </c:pt>
                <c:pt idx="125">
                  <c:v>0.45884999999999998</c:v>
                </c:pt>
                <c:pt idx="126">
                  <c:v>0.44574999999999998</c:v>
                </c:pt>
                <c:pt idx="127">
                  <c:v>0.43356</c:v>
                </c:pt>
                <c:pt idx="128">
                  <c:v>0.42049999999999998</c:v>
                </c:pt>
                <c:pt idx="129">
                  <c:v>0.40889999999999999</c:v>
                </c:pt>
                <c:pt idx="130">
                  <c:v>0.39659</c:v>
                </c:pt>
                <c:pt idx="131">
                  <c:v>0.38419999999999999</c:v>
                </c:pt>
                <c:pt idx="132">
                  <c:v>0.37336000000000003</c:v>
                </c:pt>
                <c:pt idx="133">
                  <c:v>0.36225000000000002</c:v>
                </c:pt>
                <c:pt idx="134">
                  <c:v>0.35099000000000002</c:v>
                </c:pt>
                <c:pt idx="135">
                  <c:v>0.33940999999999999</c:v>
                </c:pt>
                <c:pt idx="136">
                  <c:v>0.33012999999999998</c:v>
                </c:pt>
                <c:pt idx="137">
                  <c:v>0.3201</c:v>
                </c:pt>
                <c:pt idx="138">
                  <c:v>0.30985000000000001</c:v>
                </c:pt>
                <c:pt idx="139">
                  <c:v>0.30079</c:v>
                </c:pt>
                <c:pt idx="140">
                  <c:v>0.29122999999999999</c:v>
                </c:pt>
                <c:pt idx="141">
                  <c:v>0.28193000000000001</c:v>
                </c:pt>
                <c:pt idx="142">
                  <c:v>0.27239999999999998</c:v>
                </c:pt>
                <c:pt idx="143">
                  <c:v>0.26512999999999998</c:v>
                </c:pt>
                <c:pt idx="144">
                  <c:v>0.25569999999999998</c:v>
                </c:pt>
                <c:pt idx="145">
                  <c:v>0.24945000000000001</c:v>
                </c:pt>
                <c:pt idx="146">
                  <c:v>0.24426999999999999</c:v>
                </c:pt>
                <c:pt idx="147">
                  <c:v>0.23877999999999999</c:v>
                </c:pt>
                <c:pt idx="148">
                  <c:v>0.23441999999999999</c:v>
                </c:pt>
                <c:pt idx="149">
                  <c:v>0.23050000000000001</c:v>
                </c:pt>
                <c:pt idx="150">
                  <c:v>0.22794</c:v>
                </c:pt>
                <c:pt idx="151">
                  <c:v>0.22528000000000001</c:v>
                </c:pt>
                <c:pt idx="152">
                  <c:v>0.22488</c:v>
                </c:pt>
                <c:pt idx="153">
                  <c:v>0.22453000000000001</c:v>
                </c:pt>
                <c:pt idx="154">
                  <c:v>0.22552</c:v>
                </c:pt>
                <c:pt idx="155">
                  <c:v>0.22600000000000001</c:v>
                </c:pt>
                <c:pt idx="156">
                  <c:v>0.22634000000000001</c:v>
                </c:pt>
                <c:pt idx="157">
                  <c:v>0.22641</c:v>
                </c:pt>
                <c:pt idx="158">
                  <c:v>0.22585</c:v>
                </c:pt>
                <c:pt idx="159">
                  <c:v>0.22459999999999999</c:v>
                </c:pt>
                <c:pt idx="160">
                  <c:v>0.22287000000000001</c:v>
                </c:pt>
                <c:pt idx="161">
                  <c:v>0.21987999999999999</c:v>
                </c:pt>
                <c:pt idx="162">
                  <c:v>0.21661</c:v>
                </c:pt>
                <c:pt idx="163">
                  <c:v>0.2135</c:v>
                </c:pt>
                <c:pt idx="164">
                  <c:v>0.21002999999999999</c:v>
                </c:pt>
                <c:pt idx="165">
                  <c:v>0.20677999999999999</c:v>
                </c:pt>
                <c:pt idx="166">
                  <c:v>0.20402000000000001</c:v>
                </c:pt>
                <c:pt idx="167">
                  <c:v>0.20119000000000001</c:v>
                </c:pt>
                <c:pt idx="168">
                  <c:v>0.19925999999999999</c:v>
                </c:pt>
                <c:pt idx="169">
                  <c:v>0.19788</c:v>
                </c:pt>
                <c:pt idx="170">
                  <c:v>0.19653000000000001</c:v>
                </c:pt>
                <c:pt idx="171">
                  <c:v>0.19575999999999999</c:v>
                </c:pt>
                <c:pt idx="172">
                  <c:v>0.19489000000000001</c:v>
                </c:pt>
                <c:pt idx="173">
                  <c:v>0.19403000000000001</c:v>
                </c:pt>
                <c:pt idx="174">
                  <c:v>0.19325000000000001</c:v>
                </c:pt>
                <c:pt idx="175">
                  <c:v>0.19181999999999999</c:v>
                </c:pt>
                <c:pt idx="176">
                  <c:v>0.19042999999999999</c:v>
                </c:pt>
                <c:pt idx="177">
                  <c:v>0.18942000000000001</c:v>
                </c:pt>
                <c:pt idx="178">
                  <c:v>0.18797</c:v>
                </c:pt>
                <c:pt idx="179">
                  <c:v>0.18715999999999999</c:v>
                </c:pt>
                <c:pt idx="180">
                  <c:v>0.18597</c:v>
                </c:pt>
                <c:pt idx="181">
                  <c:v>0.18473000000000001</c:v>
                </c:pt>
                <c:pt idx="182">
                  <c:v>0.18379000000000001</c:v>
                </c:pt>
                <c:pt idx="183">
                  <c:v>0.18299000000000001</c:v>
                </c:pt>
                <c:pt idx="184">
                  <c:v>0.18210999999999999</c:v>
                </c:pt>
                <c:pt idx="185">
                  <c:v>0.18179999999999999</c:v>
                </c:pt>
                <c:pt idx="186">
                  <c:v>0.18137</c:v>
                </c:pt>
                <c:pt idx="187">
                  <c:v>0.18099000000000001</c:v>
                </c:pt>
                <c:pt idx="188">
                  <c:v>0.18089</c:v>
                </c:pt>
                <c:pt idx="189">
                  <c:v>0.18099999999999999</c:v>
                </c:pt>
                <c:pt idx="190">
                  <c:v>0.18148</c:v>
                </c:pt>
                <c:pt idx="191">
                  <c:v>0.18149999999999999</c:v>
                </c:pt>
                <c:pt idx="192">
                  <c:v>0.18171000000000001</c:v>
                </c:pt>
                <c:pt idx="193">
                  <c:v>0.18260000000000001</c:v>
                </c:pt>
                <c:pt idx="194">
                  <c:v>0.18268000000000001</c:v>
                </c:pt>
                <c:pt idx="195">
                  <c:v>0.18404999999999999</c:v>
                </c:pt>
                <c:pt idx="196">
                  <c:v>0.18643000000000001</c:v>
                </c:pt>
                <c:pt idx="197">
                  <c:v>0.18931999999999999</c:v>
                </c:pt>
                <c:pt idx="198">
                  <c:v>0.19424</c:v>
                </c:pt>
                <c:pt idx="199">
                  <c:v>0.2001</c:v>
                </c:pt>
                <c:pt idx="200">
                  <c:v>0.20673</c:v>
                </c:pt>
                <c:pt idx="201">
                  <c:v>0.21382000000000001</c:v>
                </c:pt>
                <c:pt idx="202">
                  <c:v>0.22048000000000001</c:v>
                </c:pt>
                <c:pt idx="203">
                  <c:v>0.22461</c:v>
                </c:pt>
                <c:pt idx="204">
                  <c:v>0.22669</c:v>
                </c:pt>
                <c:pt idx="205">
                  <c:v>0.22616</c:v>
                </c:pt>
                <c:pt idx="206">
                  <c:v>0.22362000000000001</c:v>
                </c:pt>
                <c:pt idx="207">
                  <c:v>0.21945999999999999</c:v>
                </c:pt>
                <c:pt idx="208">
                  <c:v>0.21462999999999999</c:v>
                </c:pt>
                <c:pt idx="209">
                  <c:v>0.20882999999999999</c:v>
                </c:pt>
                <c:pt idx="210">
                  <c:v>0.20343</c:v>
                </c:pt>
                <c:pt idx="211">
                  <c:v>0.19781000000000001</c:v>
                </c:pt>
                <c:pt idx="212">
                  <c:v>0.19248000000000001</c:v>
                </c:pt>
                <c:pt idx="213">
                  <c:v>0.18676999999999999</c:v>
                </c:pt>
                <c:pt idx="214">
                  <c:v>0.18076</c:v>
                </c:pt>
                <c:pt idx="215">
                  <c:v>0.17485999999999999</c:v>
                </c:pt>
                <c:pt idx="216">
                  <c:v>0.16864000000000001</c:v>
                </c:pt>
                <c:pt idx="217">
                  <c:v>0.16377</c:v>
                </c:pt>
                <c:pt idx="218">
                  <c:v>0.15956000000000001</c:v>
                </c:pt>
                <c:pt idx="219">
                  <c:v>0.15722</c:v>
                </c:pt>
                <c:pt idx="220">
                  <c:v>0.15729000000000001</c:v>
                </c:pt>
                <c:pt idx="221">
                  <c:v>0.16048000000000001</c:v>
                </c:pt>
                <c:pt idx="222">
                  <c:v>0.16719000000000001</c:v>
                </c:pt>
                <c:pt idx="223">
                  <c:v>0.1774</c:v>
                </c:pt>
                <c:pt idx="224">
                  <c:v>0.19403999999999999</c:v>
                </c:pt>
                <c:pt idx="225">
                  <c:v>0.21378</c:v>
                </c:pt>
                <c:pt idx="226">
                  <c:v>0.24149999999999999</c:v>
                </c:pt>
                <c:pt idx="227">
                  <c:v>0.28055999999999998</c:v>
                </c:pt>
                <c:pt idx="228">
                  <c:v>0.32679999999999998</c:v>
                </c:pt>
                <c:pt idx="229">
                  <c:v>0.39859</c:v>
                </c:pt>
                <c:pt idx="230">
                  <c:v>0.50978000000000001</c:v>
                </c:pt>
                <c:pt idx="231">
                  <c:v>0.65776000000000001</c:v>
                </c:pt>
                <c:pt idx="232">
                  <c:v>0.88654999999999995</c:v>
                </c:pt>
                <c:pt idx="233">
                  <c:v>1.2541199999999999</c:v>
                </c:pt>
                <c:pt idx="234">
                  <c:v>1.73047</c:v>
                </c:pt>
                <c:pt idx="235">
                  <c:v>2.36835</c:v>
                </c:pt>
                <c:pt idx="236">
                  <c:v>2.8769499999999999</c:v>
                </c:pt>
                <c:pt idx="237">
                  <c:v>3.0678000000000001</c:v>
                </c:pt>
                <c:pt idx="238">
                  <c:v>3.14818</c:v>
                </c:pt>
                <c:pt idx="239">
                  <c:v>3.07437</c:v>
                </c:pt>
                <c:pt idx="240">
                  <c:v>3.2753999999999999</c:v>
                </c:pt>
                <c:pt idx="241">
                  <c:v>3.2809400000000002</c:v>
                </c:pt>
                <c:pt idx="242">
                  <c:v>3.3454700000000002</c:v>
                </c:pt>
                <c:pt idx="243">
                  <c:v>3.4378099999999998</c:v>
                </c:pt>
                <c:pt idx="244">
                  <c:v>3.5045799999999998</c:v>
                </c:pt>
                <c:pt idx="245">
                  <c:v>3.5668099999999998</c:v>
                </c:pt>
                <c:pt idx="246">
                  <c:v>3.5529000000000002</c:v>
                </c:pt>
                <c:pt idx="247">
                  <c:v>3.5778099999999999</c:v>
                </c:pt>
                <c:pt idx="248">
                  <c:v>3.5829399999999998</c:v>
                </c:pt>
                <c:pt idx="249">
                  <c:v>3.93377</c:v>
                </c:pt>
                <c:pt idx="250">
                  <c:v>3.8399299999999998</c:v>
                </c:pt>
                <c:pt idx="251">
                  <c:v>3.87791</c:v>
                </c:pt>
                <c:pt idx="252">
                  <c:v>3.8410500000000001</c:v>
                </c:pt>
                <c:pt idx="253">
                  <c:v>3.8085900000000001</c:v>
                </c:pt>
                <c:pt idx="254">
                  <c:v>3.5423499999999999</c:v>
                </c:pt>
                <c:pt idx="255">
                  <c:v>3.45322</c:v>
                </c:pt>
                <c:pt idx="256">
                  <c:v>3.34423</c:v>
                </c:pt>
                <c:pt idx="257">
                  <c:v>3.1591100000000001</c:v>
                </c:pt>
                <c:pt idx="258">
                  <c:v>3.0660599999999998</c:v>
                </c:pt>
                <c:pt idx="259">
                  <c:v>2.82369</c:v>
                </c:pt>
                <c:pt idx="260">
                  <c:v>2.6457999999999999</c:v>
                </c:pt>
                <c:pt idx="261">
                  <c:v>2.4200300000000001</c:v>
                </c:pt>
                <c:pt idx="262">
                  <c:v>2.15245</c:v>
                </c:pt>
                <c:pt idx="263">
                  <c:v>1.87425</c:v>
                </c:pt>
                <c:pt idx="264">
                  <c:v>1.57698</c:v>
                </c:pt>
                <c:pt idx="265">
                  <c:v>1.1806300000000001</c:v>
                </c:pt>
                <c:pt idx="266">
                  <c:v>0.78981999999999997</c:v>
                </c:pt>
                <c:pt idx="267">
                  <c:v>0.53576999999999997</c:v>
                </c:pt>
                <c:pt idx="268">
                  <c:v>0.4002</c:v>
                </c:pt>
                <c:pt idx="269">
                  <c:v>0.35426999999999997</c:v>
                </c:pt>
                <c:pt idx="270">
                  <c:v>0.32690000000000002</c:v>
                </c:pt>
                <c:pt idx="271">
                  <c:v>0.32843</c:v>
                </c:pt>
                <c:pt idx="272">
                  <c:v>0.35167999999999999</c:v>
                </c:pt>
                <c:pt idx="273">
                  <c:v>0.33548</c:v>
                </c:pt>
                <c:pt idx="274">
                  <c:v>0.31755</c:v>
                </c:pt>
                <c:pt idx="275">
                  <c:v>0.32073000000000002</c:v>
                </c:pt>
                <c:pt idx="276">
                  <c:v>0.29755999999999999</c:v>
                </c:pt>
                <c:pt idx="277">
                  <c:v>0.29409999999999997</c:v>
                </c:pt>
                <c:pt idx="278">
                  <c:v>0.30079</c:v>
                </c:pt>
                <c:pt idx="279">
                  <c:v>0.28795999999999999</c:v>
                </c:pt>
                <c:pt idx="280">
                  <c:v>0.30514000000000002</c:v>
                </c:pt>
                <c:pt idx="281">
                  <c:v>0.29519000000000001</c:v>
                </c:pt>
                <c:pt idx="282">
                  <c:v>0.29388999999999998</c:v>
                </c:pt>
                <c:pt idx="283">
                  <c:v>0.29942999999999997</c:v>
                </c:pt>
                <c:pt idx="284">
                  <c:v>0.30280000000000001</c:v>
                </c:pt>
                <c:pt idx="285">
                  <c:v>0.28664000000000001</c:v>
                </c:pt>
                <c:pt idx="286">
                  <c:v>0.28926000000000002</c:v>
                </c:pt>
                <c:pt idx="287">
                  <c:v>0.29404000000000002</c:v>
                </c:pt>
                <c:pt idx="288">
                  <c:v>0.31594</c:v>
                </c:pt>
                <c:pt idx="289">
                  <c:v>0.30273</c:v>
                </c:pt>
                <c:pt idx="290">
                  <c:v>0.31136000000000003</c:v>
                </c:pt>
                <c:pt idx="291">
                  <c:v>0.30876999999999999</c:v>
                </c:pt>
                <c:pt idx="292">
                  <c:v>0.34440999999999999</c:v>
                </c:pt>
                <c:pt idx="293">
                  <c:v>0.34086</c:v>
                </c:pt>
                <c:pt idx="294">
                  <c:v>0.34301999999999999</c:v>
                </c:pt>
                <c:pt idx="295">
                  <c:v>0.33559</c:v>
                </c:pt>
                <c:pt idx="296">
                  <c:v>0.32705000000000001</c:v>
                </c:pt>
                <c:pt idx="297">
                  <c:v>0.34548000000000001</c:v>
                </c:pt>
                <c:pt idx="298">
                  <c:v>0.37276999999999999</c:v>
                </c:pt>
                <c:pt idx="299">
                  <c:v>0.34819</c:v>
                </c:pt>
                <c:pt idx="300">
                  <c:v>0.33872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005-49FD-B3FC-925FD33CADDB}"/>
            </c:ext>
          </c:extLst>
        </c:ser>
        <c:ser>
          <c:idx val="2"/>
          <c:order val="2"/>
          <c:tx>
            <c:strRef>
              <c:f>Feuil1!$D$2</c:f>
              <c:strCache>
                <c:ptCount val="1"/>
                <c:pt idx="0">
                  <c:v>RB5 (25mg/L)+ supernatant</c:v>
                </c:pt>
              </c:strCache>
            </c:strRef>
          </c:tx>
          <c:spPr>
            <a:ln w="12700">
              <a:solidFill>
                <a:srgbClr val="969696"/>
              </a:solidFill>
              <a:prstDash val="solid"/>
            </a:ln>
          </c:spPr>
          <c:marker>
            <c:symbol val="none"/>
          </c:marker>
          <c:xVal>
            <c:numRef>
              <c:f>Feuil1!$A$3:$A$303</c:f>
              <c:numCache>
                <c:formatCode>General</c:formatCode>
                <c:ptCount val="301"/>
                <c:pt idx="0">
                  <c:v>800</c:v>
                </c:pt>
                <c:pt idx="1">
                  <c:v>798</c:v>
                </c:pt>
                <c:pt idx="2">
                  <c:v>796</c:v>
                </c:pt>
                <c:pt idx="3">
                  <c:v>794</c:v>
                </c:pt>
                <c:pt idx="4">
                  <c:v>792</c:v>
                </c:pt>
                <c:pt idx="5">
                  <c:v>790</c:v>
                </c:pt>
                <c:pt idx="6">
                  <c:v>788</c:v>
                </c:pt>
                <c:pt idx="7">
                  <c:v>786</c:v>
                </c:pt>
                <c:pt idx="8">
                  <c:v>784</c:v>
                </c:pt>
                <c:pt idx="9">
                  <c:v>782</c:v>
                </c:pt>
                <c:pt idx="10">
                  <c:v>780</c:v>
                </c:pt>
                <c:pt idx="11">
                  <c:v>778</c:v>
                </c:pt>
                <c:pt idx="12">
                  <c:v>776</c:v>
                </c:pt>
                <c:pt idx="13">
                  <c:v>774</c:v>
                </c:pt>
                <c:pt idx="14">
                  <c:v>772</c:v>
                </c:pt>
                <c:pt idx="15">
                  <c:v>770</c:v>
                </c:pt>
                <c:pt idx="16">
                  <c:v>768</c:v>
                </c:pt>
                <c:pt idx="17">
                  <c:v>766</c:v>
                </c:pt>
                <c:pt idx="18">
                  <c:v>764</c:v>
                </c:pt>
                <c:pt idx="19">
                  <c:v>762</c:v>
                </c:pt>
                <c:pt idx="20">
                  <c:v>760</c:v>
                </c:pt>
                <c:pt idx="21">
                  <c:v>758</c:v>
                </c:pt>
                <c:pt idx="22">
                  <c:v>756</c:v>
                </c:pt>
                <c:pt idx="23">
                  <c:v>754</c:v>
                </c:pt>
                <c:pt idx="24">
                  <c:v>752</c:v>
                </c:pt>
                <c:pt idx="25">
                  <c:v>750</c:v>
                </c:pt>
                <c:pt idx="26">
                  <c:v>748</c:v>
                </c:pt>
                <c:pt idx="27">
                  <c:v>746</c:v>
                </c:pt>
                <c:pt idx="28">
                  <c:v>744</c:v>
                </c:pt>
                <c:pt idx="29">
                  <c:v>742</c:v>
                </c:pt>
                <c:pt idx="30">
                  <c:v>740</c:v>
                </c:pt>
                <c:pt idx="31">
                  <c:v>738</c:v>
                </c:pt>
                <c:pt idx="32">
                  <c:v>736</c:v>
                </c:pt>
                <c:pt idx="33">
                  <c:v>734</c:v>
                </c:pt>
                <c:pt idx="34">
                  <c:v>732</c:v>
                </c:pt>
                <c:pt idx="35">
                  <c:v>730</c:v>
                </c:pt>
                <c:pt idx="36">
                  <c:v>728</c:v>
                </c:pt>
                <c:pt idx="37">
                  <c:v>726</c:v>
                </c:pt>
                <c:pt idx="38">
                  <c:v>724</c:v>
                </c:pt>
                <c:pt idx="39">
                  <c:v>722</c:v>
                </c:pt>
                <c:pt idx="40">
                  <c:v>720</c:v>
                </c:pt>
                <c:pt idx="41">
                  <c:v>718</c:v>
                </c:pt>
                <c:pt idx="42">
                  <c:v>716</c:v>
                </c:pt>
                <c:pt idx="43">
                  <c:v>714</c:v>
                </c:pt>
                <c:pt idx="44">
                  <c:v>712</c:v>
                </c:pt>
                <c:pt idx="45">
                  <c:v>710</c:v>
                </c:pt>
                <c:pt idx="46">
                  <c:v>708</c:v>
                </c:pt>
                <c:pt idx="47">
                  <c:v>706</c:v>
                </c:pt>
                <c:pt idx="48">
                  <c:v>704</c:v>
                </c:pt>
                <c:pt idx="49">
                  <c:v>702</c:v>
                </c:pt>
                <c:pt idx="50">
                  <c:v>700</c:v>
                </c:pt>
                <c:pt idx="51">
                  <c:v>698</c:v>
                </c:pt>
                <c:pt idx="52">
                  <c:v>696</c:v>
                </c:pt>
                <c:pt idx="53">
                  <c:v>694</c:v>
                </c:pt>
                <c:pt idx="54">
                  <c:v>692</c:v>
                </c:pt>
                <c:pt idx="55">
                  <c:v>690</c:v>
                </c:pt>
                <c:pt idx="56">
                  <c:v>688</c:v>
                </c:pt>
                <c:pt idx="57">
                  <c:v>686</c:v>
                </c:pt>
                <c:pt idx="58">
                  <c:v>684</c:v>
                </c:pt>
                <c:pt idx="59">
                  <c:v>682</c:v>
                </c:pt>
                <c:pt idx="60">
                  <c:v>680</c:v>
                </c:pt>
                <c:pt idx="61">
                  <c:v>678</c:v>
                </c:pt>
                <c:pt idx="62">
                  <c:v>676</c:v>
                </c:pt>
                <c:pt idx="63">
                  <c:v>674</c:v>
                </c:pt>
                <c:pt idx="64">
                  <c:v>672</c:v>
                </c:pt>
                <c:pt idx="65">
                  <c:v>670</c:v>
                </c:pt>
                <c:pt idx="66">
                  <c:v>668</c:v>
                </c:pt>
                <c:pt idx="67">
                  <c:v>666</c:v>
                </c:pt>
                <c:pt idx="68">
                  <c:v>664</c:v>
                </c:pt>
                <c:pt idx="69">
                  <c:v>662</c:v>
                </c:pt>
                <c:pt idx="70">
                  <c:v>660</c:v>
                </c:pt>
                <c:pt idx="71">
                  <c:v>658</c:v>
                </c:pt>
                <c:pt idx="72">
                  <c:v>656</c:v>
                </c:pt>
                <c:pt idx="73">
                  <c:v>654</c:v>
                </c:pt>
                <c:pt idx="74">
                  <c:v>652</c:v>
                </c:pt>
                <c:pt idx="75">
                  <c:v>650</c:v>
                </c:pt>
                <c:pt idx="76">
                  <c:v>648</c:v>
                </c:pt>
                <c:pt idx="77">
                  <c:v>646</c:v>
                </c:pt>
                <c:pt idx="78">
                  <c:v>644</c:v>
                </c:pt>
                <c:pt idx="79">
                  <c:v>642</c:v>
                </c:pt>
                <c:pt idx="80">
                  <c:v>640</c:v>
                </c:pt>
                <c:pt idx="81">
                  <c:v>638</c:v>
                </c:pt>
                <c:pt idx="82">
                  <c:v>636</c:v>
                </c:pt>
                <c:pt idx="83">
                  <c:v>634</c:v>
                </c:pt>
                <c:pt idx="84">
                  <c:v>632</c:v>
                </c:pt>
                <c:pt idx="85">
                  <c:v>630</c:v>
                </c:pt>
                <c:pt idx="86">
                  <c:v>628</c:v>
                </c:pt>
                <c:pt idx="87">
                  <c:v>626</c:v>
                </c:pt>
                <c:pt idx="88">
                  <c:v>624</c:v>
                </c:pt>
                <c:pt idx="89">
                  <c:v>622</c:v>
                </c:pt>
                <c:pt idx="90">
                  <c:v>620</c:v>
                </c:pt>
                <c:pt idx="91">
                  <c:v>618</c:v>
                </c:pt>
                <c:pt idx="92">
                  <c:v>616</c:v>
                </c:pt>
                <c:pt idx="93">
                  <c:v>614</c:v>
                </c:pt>
                <c:pt idx="94">
                  <c:v>612</c:v>
                </c:pt>
                <c:pt idx="95">
                  <c:v>610</c:v>
                </c:pt>
                <c:pt idx="96">
                  <c:v>608</c:v>
                </c:pt>
                <c:pt idx="97">
                  <c:v>606</c:v>
                </c:pt>
                <c:pt idx="98">
                  <c:v>604</c:v>
                </c:pt>
                <c:pt idx="99">
                  <c:v>602</c:v>
                </c:pt>
                <c:pt idx="100">
                  <c:v>600</c:v>
                </c:pt>
                <c:pt idx="101">
                  <c:v>598</c:v>
                </c:pt>
                <c:pt idx="102">
                  <c:v>596</c:v>
                </c:pt>
                <c:pt idx="103">
                  <c:v>594</c:v>
                </c:pt>
                <c:pt idx="104">
                  <c:v>592</c:v>
                </c:pt>
                <c:pt idx="105">
                  <c:v>590</c:v>
                </c:pt>
                <c:pt idx="106">
                  <c:v>588</c:v>
                </c:pt>
                <c:pt idx="107">
                  <c:v>586</c:v>
                </c:pt>
                <c:pt idx="108">
                  <c:v>584</c:v>
                </c:pt>
                <c:pt idx="109">
                  <c:v>582</c:v>
                </c:pt>
                <c:pt idx="110">
                  <c:v>580</c:v>
                </c:pt>
                <c:pt idx="111">
                  <c:v>578</c:v>
                </c:pt>
                <c:pt idx="112">
                  <c:v>576</c:v>
                </c:pt>
                <c:pt idx="113">
                  <c:v>574</c:v>
                </c:pt>
                <c:pt idx="114">
                  <c:v>572</c:v>
                </c:pt>
                <c:pt idx="115">
                  <c:v>570</c:v>
                </c:pt>
                <c:pt idx="116">
                  <c:v>568</c:v>
                </c:pt>
                <c:pt idx="117">
                  <c:v>566</c:v>
                </c:pt>
                <c:pt idx="118">
                  <c:v>564</c:v>
                </c:pt>
                <c:pt idx="119">
                  <c:v>562</c:v>
                </c:pt>
                <c:pt idx="120">
                  <c:v>560</c:v>
                </c:pt>
                <c:pt idx="121">
                  <c:v>558</c:v>
                </c:pt>
                <c:pt idx="122">
                  <c:v>556</c:v>
                </c:pt>
                <c:pt idx="123">
                  <c:v>554</c:v>
                </c:pt>
                <c:pt idx="124">
                  <c:v>552</c:v>
                </c:pt>
                <c:pt idx="125">
                  <c:v>550</c:v>
                </c:pt>
                <c:pt idx="126">
                  <c:v>548</c:v>
                </c:pt>
                <c:pt idx="127">
                  <c:v>546</c:v>
                </c:pt>
                <c:pt idx="128">
                  <c:v>544</c:v>
                </c:pt>
                <c:pt idx="129">
                  <c:v>542</c:v>
                </c:pt>
                <c:pt idx="130">
                  <c:v>540</c:v>
                </c:pt>
                <c:pt idx="131">
                  <c:v>538</c:v>
                </c:pt>
                <c:pt idx="132">
                  <c:v>536</c:v>
                </c:pt>
                <c:pt idx="133">
                  <c:v>534</c:v>
                </c:pt>
                <c:pt idx="134">
                  <c:v>532</c:v>
                </c:pt>
                <c:pt idx="135">
                  <c:v>530</c:v>
                </c:pt>
                <c:pt idx="136">
                  <c:v>528</c:v>
                </c:pt>
                <c:pt idx="137">
                  <c:v>526</c:v>
                </c:pt>
                <c:pt idx="138">
                  <c:v>524</c:v>
                </c:pt>
                <c:pt idx="139">
                  <c:v>522</c:v>
                </c:pt>
                <c:pt idx="140">
                  <c:v>520</c:v>
                </c:pt>
                <c:pt idx="141">
                  <c:v>518</c:v>
                </c:pt>
                <c:pt idx="142">
                  <c:v>516</c:v>
                </c:pt>
                <c:pt idx="143">
                  <c:v>514</c:v>
                </c:pt>
                <c:pt idx="144">
                  <c:v>512</c:v>
                </c:pt>
                <c:pt idx="145">
                  <c:v>510</c:v>
                </c:pt>
                <c:pt idx="146">
                  <c:v>508</c:v>
                </c:pt>
                <c:pt idx="147">
                  <c:v>506</c:v>
                </c:pt>
                <c:pt idx="148">
                  <c:v>504</c:v>
                </c:pt>
                <c:pt idx="149">
                  <c:v>502</c:v>
                </c:pt>
                <c:pt idx="150">
                  <c:v>500</c:v>
                </c:pt>
                <c:pt idx="151">
                  <c:v>498</c:v>
                </c:pt>
                <c:pt idx="152">
                  <c:v>496</c:v>
                </c:pt>
                <c:pt idx="153">
                  <c:v>494</c:v>
                </c:pt>
                <c:pt idx="154">
                  <c:v>492</c:v>
                </c:pt>
                <c:pt idx="155">
                  <c:v>490</c:v>
                </c:pt>
                <c:pt idx="156">
                  <c:v>488</c:v>
                </c:pt>
                <c:pt idx="157">
                  <c:v>486</c:v>
                </c:pt>
                <c:pt idx="158">
                  <c:v>484</c:v>
                </c:pt>
                <c:pt idx="159">
                  <c:v>482</c:v>
                </c:pt>
                <c:pt idx="160">
                  <c:v>480</c:v>
                </c:pt>
                <c:pt idx="161">
                  <c:v>478</c:v>
                </c:pt>
                <c:pt idx="162">
                  <c:v>476</c:v>
                </c:pt>
                <c:pt idx="163">
                  <c:v>474</c:v>
                </c:pt>
                <c:pt idx="164">
                  <c:v>472</c:v>
                </c:pt>
                <c:pt idx="165">
                  <c:v>470</c:v>
                </c:pt>
                <c:pt idx="166">
                  <c:v>468</c:v>
                </c:pt>
                <c:pt idx="167">
                  <c:v>466</c:v>
                </c:pt>
                <c:pt idx="168">
                  <c:v>464</c:v>
                </c:pt>
                <c:pt idx="169">
                  <c:v>462</c:v>
                </c:pt>
                <c:pt idx="170">
                  <c:v>460</c:v>
                </c:pt>
                <c:pt idx="171">
                  <c:v>458</c:v>
                </c:pt>
                <c:pt idx="172">
                  <c:v>456</c:v>
                </c:pt>
                <c:pt idx="173">
                  <c:v>454</c:v>
                </c:pt>
                <c:pt idx="174">
                  <c:v>452</c:v>
                </c:pt>
                <c:pt idx="175">
                  <c:v>450</c:v>
                </c:pt>
                <c:pt idx="176">
                  <c:v>448</c:v>
                </c:pt>
                <c:pt idx="177">
                  <c:v>446</c:v>
                </c:pt>
                <c:pt idx="178">
                  <c:v>444</c:v>
                </c:pt>
                <c:pt idx="179">
                  <c:v>442</c:v>
                </c:pt>
                <c:pt idx="180">
                  <c:v>440</c:v>
                </c:pt>
                <c:pt idx="181">
                  <c:v>438</c:v>
                </c:pt>
                <c:pt idx="182">
                  <c:v>436</c:v>
                </c:pt>
                <c:pt idx="183">
                  <c:v>434</c:v>
                </c:pt>
                <c:pt idx="184">
                  <c:v>432</c:v>
                </c:pt>
                <c:pt idx="185">
                  <c:v>430</c:v>
                </c:pt>
                <c:pt idx="186">
                  <c:v>428</c:v>
                </c:pt>
                <c:pt idx="187">
                  <c:v>426</c:v>
                </c:pt>
                <c:pt idx="188">
                  <c:v>424</c:v>
                </c:pt>
                <c:pt idx="189">
                  <c:v>422</c:v>
                </c:pt>
                <c:pt idx="190">
                  <c:v>420</c:v>
                </c:pt>
                <c:pt idx="191">
                  <c:v>418</c:v>
                </c:pt>
                <c:pt idx="192">
                  <c:v>416</c:v>
                </c:pt>
                <c:pt idx="193">
                  <c:v>414</c:v>
                </c:pt>
                <c:pt idx="194">
                  <c:v>412</c:v>
                </c:pt>
                <c:pt idx="195">
                  <c:v>410</c:v>
                </c:pt>
                <c:pt idx="196">
                  <c:v>408</c:v>
                </c:pt>
                <c:pt idx="197">
                  <c:v>406</c:v>
                </c:pt>
                <c:pt idx="198">
                  <c:v>404</c:v>
                </c:pt>
                <c:pt idx="199">
                  <c:v>402</c:v>
                </c:pt>
                <c:pt idx="200">
                  <c:v>400</c:v>
                </c:pt>
                <c:pt idx="201">
                  <c:v>398</c:v>
                </c:pt>
                <c:pt idx="202">
                  <c:v>396</c:v>
                </c:pt>
                <c:pt idx="203">
                  <c:v>394</c:v>
                </c:pt>
                <c:pt idx="204">
                  <c:v>392</c:v>
                </c:pt>
                <c:pt idx="205">
                  <c:v>390</c:v>
                </c:pt>
                <c:pt idx="206">
                  <c:v>388</c:v>
                </c:pt>
                <c:pt idx="207">
                  <c:v>386</c:v>
                </c:pt>
                <c:pt idx="208">
                  <c:v>384</c:v>
                </c:pt>
                <c:pt idx="209">
                  <c:v>382</c:v>
                </c:pt>
                <c:pt idx="210">
                  <c:v>380</c:v>
                </c:pt>
                <c:pt idx="211">
                  <c:v>378</c:v>
                </c:pt>
                <c:pt idx="212">
                  <c:v>376</c:v>
                </c:pt>
                <c:pt idx="213">
                  <c:v>374</c:v>
                </c:pt>
                <c:pt idx="214">
                  <c:v>372</c:v>
                </c:pt>
                <c:pt idx="215">
                  <c:v>370</c:v>
                </c:pt>
                <c:pt idx="216">
                  <c:v>368</c:v>
                </c:pt>
                <c:pt idx="217">
                  <c:v>366</c:v>
                </c:pt>
                <c:pt idx="218">
                  <c:v>364</c:v>
                </c:pt>
                <c:pt idx="219">
                  <c:v>362</c:v>
                </c:pt>
                <c:pt idx="220">
                  <c:v>360</c:v>
                </c:pt>
                <c:pt idx="221">
                  <c:v>358</c:v>
                </c:pt>
                <c:pt idx="222">
                  <c:v>356</c:v>
                </c:pt>
                <c:pt idx="223">
                  <c:v>354</c:v>
                </c:pt>
                <c:pt idx="224">
                  <c:v>352</c:v>
                </c:pt>
                <c:pt idx="225">
                  <c:v>350</c:v>
                </c:pt>
                <c:pt idx="226">
                  <c:v>348</c:v>
                </c:pt>
                <c:pt idx="227">
                  <c:v>346</c:v>
                </c:pt>
                <c:pt idx="228">
                  <c:v>344</c:v>
                </c:pt>
                <c:pt idx="229">
                  <c:v>342</c:v>
                </c:pt>
                <c:pt idx="230">
                  <c:v>340</c:v>
                </c:pt>
                <c:pt idx="231">
                  <c:v>338</c:v>
                </c:pt>
                <c:pt idx="232">
                  <c:v>336</c:v>
                </c:pt>
                <c:pt idx="233">
                  <c:v>334</c:v>
                </c:pt>
                <c:pt idx="234">
                  <c:v>332</c:v>
                </c:pt>
                <c:pt idx="235">
                  <c:v>330</c:v>
                </c:pt>
                <c:pt idx="236">
                  <c:v>328</c:v>
                </c:pt>
                <c:pt idx="237">
                  <c:v>326</c:v>
                </c:pt>
                <c:pt idx="238">
                  <c:v>324</c:v>
                </c:pt>
                <c:pt idx="239">
                  <c:v>322</c:v>
                </c:pt>
                <c:pt idx="240">
                  <c:v>320</c:v>
                </c:pt>
                <c:pt idx="241">
                  <c:v>318</c:v>
                </c:pt>
                <c:pt idx="242">
                  <c:v>316</c:v>
                </c:pt>
                <c:pt idx="243">
                  <c:v>314</c:v>
                </c:pt>
                <c:pt idx="244">
                  <c:v>312</c:v>
                </c:pt>
                <c:pt idx="245">
                  <c:v>310</c:v>
                </c:pt>
                <c:pt idx="246">
                  <c:v>308</c:v>
                </c:pt>
                <c:pt idx="247">
                  <c:v>306</c:v>
                </c:pt>
                <c:pt idx="248">
                  <c:v>304</c:v>
                </c:pt>
                <c:pt idx="249">
                  <c:v>302</c:v>
                </c:pt>
                <c:pt idx="250">
                  <c:v>300</c:v>
                </c:pt>
                <c:pt idx="251">
                  <c:v>298</c:v>
                </c:pt>
                <c:pt idx="252">
                  <c:v>296</c:v>
                </c:pt>
                <c:pt idx="253">
                  <c:v>294</c:v>
                </c:pt>
                <c:pt idx="254">
                  <c:v>292</c:v>
                </c:pt>
                <c:pt idx="255">
                  <c:v>290</c:v>
                </c:pt>
                <c:pt idx="256">
                  <c:v>288</c:v>
                </c:pt>
                <c:pt idx="257">
                  <c:v>286</c:v>
                </c:pt>
                <c:pt idx="258">
                  <c:v>284</c:v>
                </c:pt>
                <c:pt idx="259">
                  <c:v>282</c:v>
                </c:pt>
                <c:pt idx="260">
                  <c:v>280</c:v>
                </c:pt>
                <c:pt idx="261">
                  <c:v>278</c:v>
                </c:pt>
                <c:pt idx="262">
                  <c:v>276</c:v>
                </c:pt>
                <c:pt idx="263">
                  <c:v>274</c:v>
                </c:pt>
                <c:pt idx="264">
                  <c:v>272</c:v>
                </c:pt>
                <c:pt idx="265">
                  <c:v>270</c:v>
                </c:pt>
                <c:pt idx="266">
                  <c:v>268</c:v>
                </c:pt>
                <c:pt idx="267">
                  <c:v>266</c:v>
                </c:pt>
                <c:pt idx="268">
                  <c:v>264</c:v>
                </c:pt>
                <c:pt idx="269">
                  <c:v>262</c:v>
                </c:pt>
                <c:pt idx="270">
                  <c:v>260</c:v>
                </c:pt>
                <c:pt idx="271">
                  <c:v>258</c:v>
                </c:pt>
                <c:pt idx="272">
                  <c:v>256</c:v>
                </c:pt>
                <c:pt idx="273">
                  <c:v>254</c:v>
                </c:pt>
                <c:pt idx="274">
                  <c:v>252</c:v>
                </c:pt>
                <c:pt idx="275">
                  <c:v>250</c:v>
                </c:pt>
                <c:pt idx="276">
                  <c:v>248</c:v>
                </c:pt>
                <c:pt idx="277">
                  <c:v>246</c:v>
                </c:pt>
                <c:pt idx="278">
                  <c:v>244</c:v>
                </c:pt>
                <c:pt idx="279">
                  <c:v>242</c:v>
                </c:pt>
                <c:pt idx="280">
                  <c:v>240</c:v>
                </c:pt>
                <c:pt idx="281">
                  <c:v>238</c:v>
                </c:pt>
                <c:pt idx="282">
                  <c:v>236</c:v>
                </c:pt>
                <c:pt idx="283">
                  <c:v>234</c:v>
                </c:pt>
                <c:pt idx="284">
                  <c:v>232</c:v>
                </c:pt>
                <c:pt idx="285">
                  <c:v>230</c:v>
                </c:pt>
                <c:pt idx="286">
                  <c:v>228</c:v>
                </c:pt>
                <c:pt idx="287">
                  <c:v>226</c:v>
                </c:pt>
                <c:pt idx="288">
                  <c:v>224</c:v>
                </c:pt>
                <c:pt idx="289">
                  <c:v>222</c:v>
                </c:pt>
                <c:pt idx="290">
                  <c:v>220</c:v>
                </c:pt>
                <c:pt idx="291">
                  <c:v>218</c:v>
                </c:pt>
                <c:pt idx="292">
                  <c:v>216</c:v>
                </c:pt>
                <c:pt idx="293">
                  <c:v>214</c:v>
                </c:pt>
                <c:pt idx="294">
                  <c:v>212</c:v>
                </c:pt>
                <c:pt idx="295">
                  <c:v>210</c:v>
                </c:pt>
                <c:pt idx="296">
                  <c:v>208</c:v>
                </c:pt>
                <c:pt idx="297">
                  <c:v>206</c:v>
                </c:pt>
                <c:pt idx="298">
                  <c:v>204</c:v>
                </c:pt>
                <c:pt idx="299">
                  <c:v>202</c:v>
                </c:pt>
                <c:pt idx="300">
                  <c:v>200</c:v>
                </c:pt>
              </c:numCache>
            </c:numRef>
          </c:xVal>
          <c:yVal>
            <c:numRef>
              <c:f>Feuil1!$D$3:$D$303</c:f>
              <c:numCache>
                <c:formatCode>General</c:formatCode>
                <c:ptCount val="301"/>
                <c:pt idx="0">
                  <c:v>6.1900000000000002E-3</c:v>
                </c:pt>
                <c:pt idx="1">
                  <c:v>3.8999999999999998E-3</c:v>
                </c:pt>
                <c:pt idx="2">
                  <c:v>6.96E-3</c:v>
                </c:pt>
                <c:pt idx="3">
                  <c:v>4.5700000000000003E-3</c:v>
                </c:pt>
                <c:pt idx="4">
                  <c:v>1.4999999999999999E-4</c:v>
                </c:pt>
                <c:pt idx="5">
                  <c:v>1.2999999999999999E-4</c:v>
                </c:pt>
                <c:pt idx="6">
                  <c:v>9.8999999999999999E-4</c:v>
                </c:pt>
                <c:pt idx="7">
                  <c:v>4.7000000000000002E-3</c:v>
                </c:pt>
                <c:pt idx="8">
                  <c:v>4.7800000000000004E-3</c:v>
                </c:pt>
                <c:pt idx="9">
                  <c:v>9.6200000000000001E-3</c:v>
                </c:pt>
                <c:pt idx="10">
                  <c:v>3.8899999999999998E-3</c:v>
                </c:pt>
                <c:pt idx="11">
                  <c:v>9.3600000000000003E-3</c:v>
                </c:pt>
                <c:pt idx="12">
                  <c:v>4.4999999999999997E-3</c:v>
                </c:pt>
                <c:pt idx="13">
                  <c:v>-2.0600000000000002E-3</c:v>
                </c:pt>
                <c:pt idx="14">
                  <c:v>-4.4000000000000002E-4</c:v>
                </c:pt>
                <c:pt idx="15">
                  <c:v>5.2700000000000004E-3</c:v>
                </c:pt>
                <c:pt idx="16">
                  <c:v>5.0200000000000002E-3</c:v>
                </c:pt>
                <c:pt idx="17">
                  <c:v>5.0299999999999997E-3</c:v>
                </c:pt>
                <c:pt idx="18">
                  <c:v>1.25E-3</c:v>
                </c:pt>
                <c:pt idx="19">
                  <c:v>6.3800000000000003E-3</c:v>
                </c:pt>
                <c:pt idx="20">
                  <c:v>1.65E-3</c:v>
                </c:pt>
                <c:pt idx="21">
                  <c:v>5.7099999999999998E-3</c:v>
                </c:pt>
                <c:pt idx="22">
                  <c:v>3.5799999999999998E-3</c:v>
                </c:pt>
                <c:pt idx="23">
                  <c:v>4.6899999999999997E-3</c:v>
                </c:pt>
                <c:pt idx="24">
                  <c:v>7.8399999999999997E-3</c:v>
                </c:pt>
                <c:pt idx="25">
                  <c:v>7.43E-3</c:v>
                </c:pt>
                <c:pt idx="26">
                  <c:v>1.132E-2</c:v>
                </c:pt>
                <c:pt idx="27">
                  <c:v>8.7799999999999996E-3</c:v>
                </c:pt>
                <c:pt idx="28">
                  <c:v>2.6099999999999999E-3</c:v>
                </c:pt>
                <c:pt idx="29">
                  <c:v>3.1800000000000001E-3</c:v>
                </c:pt>
                <c:pt idx="30">
                  <c:v>5.62E-3</c:v>
                </c:pt>
                <c:pt idx="31">
                  <c:v>8.1499999999999993E-3</c:v>
                </c:pt>
                <c:pt idx="32">
                  <c:v>3.1900000000000001E-3</c:v>
                </c:pt>
                <c:pt idx="33">
                  <c:v>4.2300000000000003E-3</c:v>
                </c:pt>
                <c:pt idx="34">
                  <c:v>8.7399999999999995E-3</c:v>
                </c:pt>
                <c:pt idx="35">
                  <c:v>8.4600000000000005E-3</c:v>
                </c:pt>
                <c:pt idx="36">
                  <c:v>8.4499999999999992E-3</c:v>
                </c:pt>
                <c:pt idx="37">
                  <c:v>6.3299999999999997E-3</c:v>
                </c:pt>
                <c:pt idx="38">
                  <c:v>3.7200000000000002E-3</c:v>
                </c:pt>
                <c:pt idx="39">
                  <c:v>7.1500000000000001E-3</c:v>
                </c:pt>
                <c:pt idx="40">
                  <c:v>8.1399999999999997E-3</c:v>
                </c:pt>
                <c:pt idx="41">
                  <c:v>1.065E-2</c:v>
                </c:pt>
                <c:pt idx="42">
                  <c:v>5.79E-3</c:v>
                </c:pt>
                <c:pt idx="43">
                  <c:v>8.6E-3</c:v>
                </c:pt>
                <c:pt idx="44">
                  <c:v>3.6800000000000001E-3</c:v>
                </c:pt>
                <c:pt idx="45">
                  <c:v>1.009E-2</c:v>
                </c:pt>
                <c:pt idx="46">
                  <c:v>8.77E-3</c:v>
                </c:pt>
                <c:pt idx="47">
                  <c:v>8.1899999999999994E-3</c:v>
                </c:pt>
                <c:pt idx="48">
                  <c:v>1.55E-2</c:v>
                </c:pt>
                <c:pt idx="49">
                  <c:v>1.119E-2</c:v>
                </c:pt>
                <c:pt idx="50">
                  <c:v>1.172E-2</c:v>
                </c:pt>
                <c:pt idx="51">
                  <c:v>1.431E-2</c:v>
                </c:pt>
                <c:pt idx="52">
                  <c:v>1.6990000000000002E-2</c:v>
                </c:pt>
                <c:pt idx="53">
                  <c:v>1.0120000000000001E-2</c:v>
                </c:pt>
                <c:pt idx="54">
                  <c:v>1.8530000000000001E-2</c:v>
                </c:pt>
                <c:pt idx="55">
                  <c:v>1.7639999999999999E-2</c:v>
                </c:pt>
                <c:pt idx="56">
                  <c:v>2.035E-2</c:v>
                </c:pt>
                <c:pt idx="57">
                  <c:v>2.2190000000000001E-2</c:v>
                </c:pt>
                <c:pt idx="58">
                  <c:v>2.7820000000000001E-2</c:v>
                </c:pt>
                <c:pt idx="59">
                  <c:v>2.6190000000000001E-2</c:v>
                </c:pt>
                <c:pt idx="60">
                  <c:v>3.0839999999999999E-2</c:v>
                </c:pt>
                <c:pt idx="61">
                  <c:v>3.1890000000000002E-2</c:v>
                </c:pt>
                <c:pt idx="62">
                  <c:v>3.4950000000000002E-2</c:v>
                </c:pt>
                <c:pt idx="63">
                  <c:v>4.317E-2</c:v>
                </c:pt>
                <c:pt idx="64">
                  <c:v>4.5560000000000003E-2</c:v>
                </c:pt>
                <c:pt idx="65">
                  <c:v>5.4330000000000003E-2</c:v>
                </c:pt>
                <c:pt idx="66">
                  <c:v>6.268E-2</c:v>
                </c:pt>
                <c:pt idx="67">
                  <c:v>6.7729999999999999E-2</c:v>
                </c:pt>
                <c:pt idx="68">
                  <c:v>7.6579999999999995E-2</c:v>
                </c:pt>
                <c:pt idx="69">
                  <c:v>8.0689999999999998E-2</c:v>
                </c:pt>
                <c:pt idx="70">
                  <c:v>8.6629999999999999E-2</c:v>
                </c:pt>
                <c:pt idx="71">
                  <c:v>9.7939999999999999E-2</c:v>
                </c:pt>
                <c:pt idx="72">
                  <c:v>0.10847999999999999</c:v>
                </c:pt>
                <c:pt idx="73">
                  <c:v>0.11734</c:v>
                </c:pt>
                <c:pt idx="74">
                  <c:v>0.13255</c:v>
                </c:pt>
                <c:pt idx="75">
                  <c:v>0.14185</c:v>
                </c:pt>
                <c:pt idx="76">
                  <c:v>0.1525</c:v>
                </c:pt>
                <c:pt idx="77">
                  <c:v>0.16889000000000001</c:v>
                </c:pt>
                <c:pt idx="78">
                  <c:v>0.18134</c:v>
                </c:pt>
                <c:pt idx="79">
                  <c:v>0.19792000000000001</c:v>
                </c:pt>
                <c:pt idx="80">
                  <c:v>0.20816999999999999</c:v>
                </c:pt>
                <c:pt idx="81">
                  <c:v>0.22128999999999999</c:v>
                </c:pt>
                <c:pt idx="82">
                  <c:v>0.23643</c:v>
                </c:pt>
                <c:pt idx="83">
                  <c:v>0.24851999999999999</c:v>
                </c:pt>
                <c:pt idx="84">
                  <c:v>0.26379000000000002</c:v>
                </c:pt>
                <c:pt idx="85">
                  <c:v>0.27565000000000001</c:v>
                </c:pt>
                <c:pt idx="86">
                  <c:v>0.29011999999999999</c:v>
                </c:pt>
                <c:pt idx="87">
                  <c:v>0.30204999999999999</c:v>
                </c:pt>
                <c:pt idx="88">
                  <c:v>0.31358000000000003</c:v>
                </c:pt>
                <c:pt idx="89">
                  <c:v>0.32085999999999998</c:v>
                </c:pt>
                <c:pt idx="90">
                  <c:v>0.32621</c:v>
                </c:pt>
                <c:pt idx="91">
                  <c:v>0.33634999999999998</c:v>
                </c:pt>
                <c:pt idx="92">
                  <c:v>0.34183000000000002</c:v>
                </c:pt>
                <c:pt idx="93">
                  <c:v>0.34903000000000001</c:v>
                </c:pt>
                <c:pt idx="94">
                  <c:v>0.35065000000000002</c:v>
                </c:pt>
                <c:pt idx="95">
                  <c:v>0.35577999999999999</c:v>
                </c:pt>
                <c:pt idx="96">
                  <c:v>0.36047000000000001</c:v>
                </c:pt>
                <c:pt idx="97">
                  <c:v>0.36321999999999999</c:v>
                </c:pt>
                <c:pt idx="98">
                  <c:v>0.36125000000000002</c:v>
                </c:pt>
                <c:pt idx="99">
                  <c:v>0.36643999999999999</c:v>
                </c:pt>
                <c:pt idx="100">
                  <c:v>0.36735000000000001</c:v>
                </c:pt>
                <c:pt idx="101">
                  <c:v>0.37069999999999997</c:v>
                </c:pt>
                <c:pt idx="102">
                  <c:v>0.37170999999999998</c:v>
                </c:pt>
                <c:pt idx="103">
                  <c:v>0.37030999999999997</c:v>
                </c:pt>
                <c:pt idx="104">
                  <c:v>0.37248999999999999</c:v>
                </c:pt>
                <c:pt idx="105">
                  <c:v>0.37586000000000003</c:v>
                </c:pt>
                <c:pt idx="106">
                  <c:v>0.37867000000000001</c:v>
                </c:pt>
                <c:pt idx="107">
                  <c:v>0.38140000000000002</c:v>
                </c:pt>
                <c:pt idx="108">
                  <c:v>0.38373000000000002</c:v>
                </c:pt>
                <c:pt idx="109">
                  <c:v>0.38915</c:v>
                </c:pt>
                <c:pt idx="110">
                  <c:v>0.39223000000000002</c:v>
                </c:pt>
                <c:pt idx="111">
                  <c:v>0.39901999999999999</c:v>
                </c:pt>
                <c:pt idx="112">
                  <c:v>0.40608</c:v>
                </c:pt>
                <c:pt idx="113">
                  <c:v>0.41055000000000003</c:v>
                </c:pt>
                <c:pt idx="114">
                  <c:v>0.41576000000000002</c:v>
                </c:pt>
                <c:pt idx="115">
                  <c:v>0.41986000000000001</c:v>
                </c:pt>
                <c:pt idx="116">
                  <c:v>0.42444999999999999</c:v>
                </c:pt>
                <c:pt idx="117">
                  <c:v>0.42515999999999998</c:v>
                </c:pt>
                <c:pt idx="118">
                  <c:v>0.42470999999999998</c:v>
                </c:pt>
                <c:pt idx="119">
                  <c:v>0.42380000000000001</c:v>
                </c:pt>
                <c:pt idx="120">
                  <c:v>0.41897000000000001</c:v>
                </c:pt>
                <c:pt idx="121">
                  <c:v>0.41624</c:v>
                </c:pt>
                <c:pt idx="122">
                  <c:v>0.41241</c:v>
                </c:pt>
                <c:pt idx="123">
                  <c:v>0.40508</c:v>
                </c:pt>
                <c:pt idx="124">
                  <c:v>0.40010000000000001</c:v>
                </c:pt>
                <c:pt idx="125">
                  <c:v>0.39612999999999998</c:v>
                </c:pt>
                <c:pt idx="126">
                  <c:v>0.38811000000000001</c:v>
                </c:pt>
                <c:pt idx="127">
                  <c:v>0.38083</c:v>
                </c:pt>
                <c:pt idx="128">
                  <c:v>0.37407000000000001</c:v>
                </c:pt>
                <c:pt idx="129">
                  <c:v>0.36925999999999998</c:v>
                </c:pt>
                <c:pt idx="130">
                  <c:v>0.36399999999999999</c:v>
                </c:pt>
                <c:pt idx="131">
                  <c:v>0.36035</c:v>
                </c:pt>
                <c:pt idx="132">
                  <c:v>0.35697000000000001</c:v>
                </c:pt>
                <c:pt idx="133">
                  <c:v>0.35414000000000001</c:v>
                </c:pt>
                <c:pt idx="134">
                  <c:v>0.35083999999999999</c:v>
                </c:pt>
                <c:pt idx="135">
                  <c:v>0.34827999999999998</c:v>
                </c:pt>
                <c:pt idx="136">
                  <c:v>0.34558</c:v>
                </c:pt>
                <c:pt idx="137">
                  <c:v>0.34216999999999997</c:v>
                </c:pt>
                <c:pt idx="138">
                  <c:v>0.33744000000000002</c:v>
                </c:pt>
                <c:pt idx="139">
                  <c:v>0.33279999999999998</c:v>
                </c:pt>
                <c:pt idx="140">
                  <c:v>0.32639000000000001</c:v>
                </c:pt>
                <c:pt idx="141">
                  <c:v>0.31929999999999997</c:v>
                </c:pt>
                <c:pt idx="142">
                  <c:v>0.31145</c:v>
                </c:pt>
                <c:pt idx="143">
                  <c:v>0.30525000000000002</c:v>
                </c:pt>
                <c:pt idx="144">
                  <c:v>0.29660999999999998</c:v>
                </c:pt>
                <c:pt idx="145">
                  <c:v>0.28860999999999998</c:v>
                </c:pt>
                <c:pt idx="146">
                  <c:v>0.28283999999999998</c:v>
                </c:pt>
                <c:pt idx="147">
                  <c:v>0.27629999999999999</c:v>
                </c:pt>
                <c:pt idx="148">
                  <c:v>0.27145000000000002</c:v>
                </c:pt>
                <c:pt idx="149">
                  <c:v>0.26597999999999999</c:v>
                </c:pt>
                <c:pt idx="150">
                  <c:v>0.26193</c:v>
                </c:pt>
                <c:pt idx="151">
                  <c:v>0.25883</c:v>
                </c:pt>
                <c:pt idx="152">
                  <c:v>0.25630999999999998</c:v>
                </c:pt>
                <c:pt idx="153">
                  <c:v>0.25407999999999997</c:v>
                </c:pt>
                <c:pt idx="154">
                  <c:v>0.25164999999999998</c:v>
                </c:pt>
                <c:pt idx="155">
                  <c:v>0.24959999999999999</c:v>
                </c:pt>
                <c:pt idx="156">
                  <c:v>0.24745</c:v>
                </c:pt>
                <c:pt idx="157">
                  <c:v>0.24498</c:v>
                </c:pt>
                <c:pt idx="158">
                  <c:v>0.24185999999999999</c:v>
                </c:pt>
                <c:pt idx="159">
                  <c:v>0.23845</c:v>
                </c:pt>
                <c:pt idx="160">
                  <c:v>0.23505999999999999</c:v>
                </c:pt>
                <c:pt idx="161">
                  <c:v>0.23042000000000001</c:v>
                </c:pt>
                <c:pt idx="162">
                  <c:v>0.22592999999999999</c:v>
                </c:pt>
                <c:pt idx="163">
                  <c:v>0.22212999999999999</c:v>
                </c:pt>
                <c:pt idx="164">
                  <c:v>0.21843000000000001</c:v>
                </c:pt>
                <c:pt idx="165">
                  <c:v>0.21486</c:v>
                </c:pt>
                <c:pt idx="166">
                  <c:v>0.21210000000000001</c:v>
                </c:pt>
                <c:pt idx="167">
                  <c:v>0.20910999999999999</c:v>
                </c:pt>
                <c:pt idx="168">
                  <c:v>0.20729</c:v>
                </c:pt>
                <c:pt idx="169">
                  <c:v>0.2056</c:v>
                </c:pt>
                <c:pt idx="170">
                  <c:v>0.20416000000000001</c:v>
                </c:pt>
                <c:pt idx="171">
                  <c:v>0.20327000000000001</c:v>
                </c:pt>
                <c:pt idx="172">
                  <c:v>0.20224</c:v>
                </c:pt>
                <c:pt idx="173">
                  <c:v>0.20132</c:v>
                </c:pt>
                <c:pt idx="174">
                  <c:v>0.20064000000000001</c:v>
                </c:pt>
                <c:pt idx="175">
                  <c:v>0.19952</c:v>
                </c:pt>
                <c:pt idx="176">
                  <c:v>0.19867000000000001</c:v>
                </c:pt>
                <c:pt idx="177">
                  <c:v>0.19838</c:v>
                </c:pt>
                <c:pt idx="178">
                  <c:v>0.19843</c:v>
                </c:pt>
                <c:pt idx="179">
                  <c:v>0.19893</c:v>
                </c:pt>
                <c:pt idx="180">
                  <c:v>0.20039999999999999</c:v>
                </c:pt>
                <c:pt idx="181">
                  <c:v>0.20211000000000001</c:v>
                </c:pt>
                <c:pt idx="182">
                  <c:v>0.20452000000000001</c:v>
                </c:pt>
                <c:pt idx="183">
                  <c:v>0.20760000000000001</c:v>
                </c:pt>
                <c:pt idx="184">
                  <c:v>0.21115</c:v>
                </c:pt>
                <c:pt idx="185">
                  <c:v>0.21492</c:v>
                </c:pt>
                <c:pt idx="186">
                  <c:v>0.21873000000000001</c:v>
                </c:pt>
                <c:pt idx="187">
                  <c:v>0.22228999999999999</c:v>
                </c:pt>
                <c:pt idx="188">
                  <c:v>0.22558</c:v>
                </c:pt>
                <c:pt idx="189">
                  <c:v>0.22883999999999999</c:v>
                </c:pt>
                <c:pt idx="190">
                  <c:v>0.23169000000000001</c:v>
                </c:pt>
                <c:pt idx="191">
                  <c:v>0.23375000000000001</c:v>
                </c:pt>
                <c:pt idx="192">
                  <c:v>0.23602000000000001</c:v>
                </c:pt>
                <c:pt idx="193">
                  <c:v>0.23809</c:v>
                </c:pt>
                <c:pt idx="194">
                  <c:v>0.23956</c:v>
                </c:pt>
                <c:pt idx="195">
                  <c:v>0.24185000000000001</c:v>
                </c:pt>
                <c:pt idx="196">
                  <c:v>0.24446000000000001</c:v>
                </c:pt>
                <c:pt idx="197">
                  <c:v>0.24757000000000001</c:v>
                </c:pt>
                <c:pt idx="198">
                  <c:v>0.25128</c:v>
                </c:pt>
                <c:pt idx="199">
                  <c:v>0.25584000000000001</c:v>
                </c:pt>
                <c:pt idx="200">
                  <c:v>0.26089000000000001</c:v>
                </c:pt>
                <c:pt idx="201">
                  <c:v>0.26563999999999999</c:v>
                </c:pt>
                <c:pt idx="202">
                  <c:v>0.27066000000000001</c:v>
                </c:pt>
                <c:pt idx="203">
                  <c:v>0.27410000000000001</c:v>
                </c:pt>
                <c:pt idx="204">
                  <c:v>0.27682000000000001</c:v>
                </c:pt>
                <c:pt idx="205">
                  <c:v>0.27843000000000001</c:v>
                </c:pt>
                <c:pt idx="206">
                  <c:v>0.27842</c:v>
                </c:pt>
                <c:pt idx="207">
                  <c:v>0.27814</c:v>
                </c:pt>
                <c:pt idx="208">
                  <c:v>0.27745999999999998</c:v>
                </c:pt>
                <c:pt idx="209">
                  <c:v>0.27687</c:v>
                </c:pt>
                <c:pt idx="210">
                  <c:v>0.27622000000000002</c:v>
                </c:pt>
                <c:pt idx="211">
                  <c:v>0.27504000000000001</c:v>
                </c:pt>
                <c:pt idx="212">
                  <c:v>0.27439999999999998</c:v>
                </c:pt>
                <c:pt idx="213">
                  <c:v>0.27403</c:v>
                </c:pt>
                <c:pt idx="214">
                  <c:v>0.27310000000000001</c:v>
                </c:pt>
                <c:pt idx="215">
                  <c:v>0.27407999999999999</c:v>
                </c:pt>
                <c:pt idx="216">
                  <c:v>0.27484999999999998</c:v>
                </c:pt>
                <c:pt idx="217">
                  <c:v>0.27688000000000001</c:v>
                </c:pt>
                <c:pt idx="218">
                  <c:v>0.28178999999999998</c:v>
                </c:pt>
                <c:pt idx="219">
                  <c:v>0.28738999999999998</c:v>
                </c:pt>
                <c:pt idx="220">
                  <c:v>0.29481000000000002</c:v>
                </c:pt>
                <c:pt idx="221">
                  <c:v>0.30507000000000001</c:v>
                </c:pt>
                <c:pt idx="222">
                  <c:v>0.31448999999999999</c:v>
                </c:pt>
                <c:pt idx="223">
                  <c:v>0.32362000000000002</c:v>
                </c:pt>
                <c:pt idx="224">
                  <c:v>0.33239000000000002</c:v>
                </c:pt>
                <c:pt idx="225">
                  <c:v>0.33906999999999998</c:v>
                </c:pt>
                <c:pt idx="226">
                  <c:v>0.34542</c:v>
                </c:pt>
                <c:pt idx="227">
                  <c:v>0.35093000000000002</c:v>
                </c:pt>
                <c:pt idx="228">
                  <c:v>0.35671999999999998</c:v>
                </c:pt>
                <c:pt idx="229">
                  <c:v>0.3634</c:v>
                </c:pt>
                <c:pt idx="230">
                  <c:v>0.37269000000000002</c:v>
                </c:pt>
                <c:pt idx="231">
                  <c:v>0.38202999999999998</c:v>
                </c:pt>
                <c:pt idx="232">
                  <c:v>0.39382</c:v>
                </c:pt>
                <c:pt idx="233">
                  <c:v>0.40666999999999998</c:v>
                </c:pt>
                <c:pt idx="234">
                  <c:v>0.41922999999999999</c:v>
                </c:pt>
                <c:pt idx="235">
                  <c:v>0.43308999999999997</c:v>
                </c:pt>
                <c:pt idx="236">
                  <c:v>0.44692999999999999</c:v>
                </c:pt>
                <c:pt idx="237">
                  <c:v>0.45871000000000001</c:v>
                </c:pt>
                <c:pt idx="238">
                  <c:v>0.47005999999999998</c:v>
                </c:pt>
                <c:pt idx="239">
                  <c:v>0.48114000000000001</c:v>
                </c:pt>
                <c:pt idx="240">
                  <c:v>0.49049999999999999</c:v>
                </c:pt>
                <c:pt idx="241">
                  <c:v>0.49830000000000002</c:v>
                </c:pt>
                <c:pt idx="242">
                  <c:v>0.50555000000000005</c:v>
                </c:pt>
                <c:pt idx="243">
                  <c:v>0.51234999999999997</c:v>
                </c:pt>
                <c:pt idx="244">
                  <c:v>0.51970000000000005</c:v>
                </c:pt>
                <c:pt idx="245">
                  <c:v>0.52710999999999997</c:v>
                </c:pt>
                <c:pt idx="246">
                  <c:v>0.53552999999999995</c:v>
                </c:pt>
                <c:pt idx="247">
                  <c:v>0.54593000000000003</c:v>
                </c:pt>
                <c:pt idx="248">
                  <c:v>0.55510000000000004</c:v>
                </c:pt>
                <c:pt idx="249">
                  <c:v>0.56411999999999995</c:v>
                </c:pt>
                <c:pt idx="250">
                  <c:v>0.57245999999999997</c:v>
                </c:pt>
                <c:pt idx="251">
                  <c:v>0.5806</c:v>
                </c:pt>
                <c:pt idx="252">
                  <c:v>0.58816000000000002</c:v>
                </c:pt>
                <c:pt idx="253">
                  <c:v>0.59709999999999996</c:v>
                </c:pt>
                <c:pt idx="254">
                  <c:v>0.60599999999999998</c:v>
                </c:pt>
                <c:pt idx="255">
                  <c:v>0.61377000000000004</c:v>
                </c:pt>
                <c:pt idx="256">
                  <c:v>0.62246000000000001</c:v>
                </c:pt>
                <c:pt idx="257">
                  <c:v>0.63134000000000001</c:v>
                </c:pt>
                <c:pt idx="258">
                  <c:v>0.63919999999999999</c:v>
                </c:pt>
                <c:pt idx="259">
                  <c:v>0.65003999999999995</c:v>
                </c:pt>
                <c:pt idx="260">
                  <c:v>0.65934000000000004</c:v>
                </c:pt>
                <c:pt idx="261">
                  <c:v>0.66869999999999996</c:v>
                </c:pt>
                <c:pt idx="262">
                  <c:v>0.67710999999999999</c:v>
                </c:pt>
                <c:pt idx="263">
                  <c:v>0.68669000000000002</c:v>
                </c:pt>
                <c:pt idx="264">
                  <c:v>0.67720999999999998</c:v>
                </c:pt>
                <c:pt idx="265">
                  <c:v>0.64007999999999998</c:v>
                </c:pt>
                <c:pt idx="266">
                  <c:v>0.52876999999999996</c:v>
                </c:pt>
                <c:pt idx="267">
                  <c:v>0.42087000000000002</c:v>
                </c:pt>
                <c:pt idx="268">
                  <c:v>0.34222999999999998</c:v>
                </c:pt>
                <c:pt idx="269">
                  <c:v>0.31319000000000002</c:v>
                </c:pt>
                <c:pt idx="270">
                  <c:v>0.30576999999999999</c:v>
                </c:pt>
                <c:pt idx="271">
                  <c:v>0.30320999999999998</c:v>
                </c:pt>
                <c:pt idx="272">
                  <c:v>0.31080999999999998</c:v>
                </c:pt>
                <c:pt idx="273">
                  <c:v>0.30482999999999999</c:v>
                </c:pt>
                <c:pt idx="274">
                  <c:v>0.29826999999999998</c:v>
                </c:pt>
                <c:pt idx="275">
                  <c:v>0.30347000000000002</c:v>
                </c:pt>
                <c:pt idx="276">
                  <c:v>0.29099000000000003</c:v>
                </c:pt>
                <c:pt idx="277">
                  <c:v>0.28665000000000002</c:v>
                </c:pt>
                <c:pt idx="278">
                  <c:v>0.28460000000000002</c:v>
                </c:pt>
                <c:pt idx="279">
                  <c:v>0.28108</c:v>
                </c:pt>
                <c:pt idx="280">
                  <c:v>0.28867999999999999</c:v>
                </c:pt>
                <c:pt idx="281">
                  <c:v>0.28748000000000001</c:v>
                </c:pt>
                <c:pt idx="282">
                  <c:v>0.29116999999999998</c:v>
                </c:pt>
                <c:pt idx="283">
                  <c:v>0.29537999999999998</c:v>
                </c:pt>
                <c:pt idx="284">
                  <c:v>0.28150999999999998</c:v>
                </c:pt>
                <c:pt idx="285">
                  <c:v>0.28497</c:v>
                </c:pt>
                <c:pt idx="286">
                  <c:v>0.27576000000000001</c:v>
                </c:pt>
                <c:pt idx="287">
                  <c:v>0.27722999999999998</c:v>
                </c:pt>
                <c:pt idx="288">
                  <c:v>0.28569</c:v>
                </c:pt>
                <c:pt idx="289">
                  <c:v>0.27433999999999997</c:v>
                </c:pt>
                <c:pt idx="290">
                  <c:v>0.29518</c:v>
                </c:pt>
                <c:pt idx="291">
                  <c:v>0.27195000000000003</c:v>
                </c:pt>
                <c:pt idx="292">
                  <c:v>0.28249999999999997</c:v>
                </c:pt>
                <c:pt idx="293">
                  <c:v>0.30438999999999999</c:v>
                </c:pt>
                <c:pt idx="294">
                  <c:v>0.30598999999999998</c:v>
                </c:pt>
                <c:pt idx="295">
                  <c:v>0.32490000000000002</c:v>
                </c:pt>
                <c:pt idx="296">
                  <c:v>0.27800000000000002</c:v>
                </c:pt>
                <c:pt idx="297">
                  <c:v>0.28372000000000003</c:v>
                </c:pt>
                <c:pt idx="298">
                  <c:v>0.29683999999999999</c:v>
                </c:pt>
                <c:pt idx="299">
                  <c:v>0.33034999999999998</c:v>
                </c:pt>
                <c:pt idx="300">
                  <c:v>0.2838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D005-49FD-B3FC-925FD33CADDB}"/>
            </c:ext>
          </c:extLst>
        </c:ser>
        <c:ser>
          <c:idx val="3"/>
          <c:order val="3"/>
          <c:tx>
            <c:strRef>
              <c:f>Feuil1!$E$2</c:f>
              <c:strCache>
                <c:ptCount val="1"/>
                <c:pt idx="0">
                  <c:v>RB5 (25mg/L)+HBT+ supernatant</c:v>
                </c:pt>
              </c:strCache>
            </c:strRef>
          </c:tx>
          <c:spPr>
            <a:ln w="12700">
              <a:solidFill>
                <a:srgbClr val="FFCC00"/>
              </a:solidFill>
              <a:prstDash val="solid"/>
            </a:ln>
          </c:spPr>
          <c:marker>
            <c:symbol val="none"/>
          </c:marker>
          <c:xVal>
            <c:numRef>
              <c:f>Feuil1!$A$3:$A$303</c:f>
              <c:numCache>
                <c:formatCode>General</c:formatCode>
                <c:ptCount val="301"/>
                <c:pt idx="0">
                  <c:v>800</c:v>
                </c:pt>
                <c:pt idx="1">
                  <c:v>798</c:v>
                </c:pt>
                <c:pt idx="2">
                  <c:v>796</c:v>
                </c:pt>
                <c:pt idx="3">
                  <c:v>794</c:v>
                </c:pt>
                <c:pt idx="4">
                  <c:v>792</c:v>
                </c:pt>
                <c:pt idx="5">
                  <c:v>790</c:v>
                </c:pt>
                <c:pt idx="6">
                  <c:v>788</c:v>
                </c:pt>
                <c:pt idx="7">
                  <c:v>786</c:v>
                </c:pt>
                <c:pt idx="8">
                  <c:v>784</c:v>
                </c:pt>
                <c:pt idx="9">
                  <c:v>782</c:v>
                </c:pt>
                <c:pt idx="10">
                  <c:v>780</c:v>
                </c:pt>
                <c:pt idx="11">
                  <c:v>778</c:v>
                </c:pt>
                <c:pt idx="12">
                  <c:v>776</c:v>
                </c:pt>
                <c:pt idx="13">
                  <c:v>774</c:v>
                </c:pt>
                <c:pt idx="14">
                  <c:v>772</c:v>
                </c:pt>
                <c:pt idx="15">
                  <c:v>770</c:v>
                </c:pt>
                <c:pt idx="16">
                  <c:v>768</c:v>
                </c:pt>
                <c:pt idx="17">
                  <c:v>766</c:v>
                </c:pt>
                <c:pt idx="18">
                  <c:v>764</c:v>
                </c:pt>
                <c:pt idx="19">
                  <c:v>762</c:v>
                </c:pt>
                <c:pt idx="20">
                  <c:v>760</c:v>
                </c:pt>
                <c:pt idx="21">
                  <c:v>758</c:v>
                </c:pt>
                <c:pt idx="22">
                  <c:v>756</c:v>
                </c:pt>
                <c:pt idx="23">
                  <c:v>754</c:v>
                </c:pt>
                <c:pt idx="24">
                  <c:v>752</c:v>
                </c:pt>
                <c:pt idx="25">
                  <c:v>750</c:v>
                </c:pt>
                <c:pt idx="26">
                  <c:v>748</c:v>
                </c:pt>
                <c:pt idx="27">
                  <c:v>746</c:v>
                </c:pt>
                <c:pt idx="28">
                  <c:v>744</c:v>
                </c:pt>
                <c:pt idx="29">
                  <c:v>742</c:v>
                </c:pt>
                <c:pt idx="30">
                  <c:v>740</c:v>
                </c:pt>
                <c:pt idx="31">
                  <c:v>738</c:v>
                </c:pt>
                <c:pt idx="32">
                  <c:v>736</c:v>
                </c:pt>
                <c:pt idx="33">
                  <c:v>734</c:v>
                </c:pt>
                <c:pt idx="34">
                  <c:v>732</c:v>
                </c:pt>
                <c:pt idx="35">
                  <c:v>730</c:v>
                </c:pt>
                <c:pt idx="36">
                  <c:v>728</c:v>
                </c:pt>
                <c:pt idx="37">
                  <c:v>726</c:v>
                </c:pt>
                <c:pt idx="38">
                  <c:v>724</c:v>
                </c:pt>
                <c:pt idx="39">
                  <c:v>722</c:v>
                </c:pt>
                <c:pt idx="40">
                  <c:v>720</c:v>
                </c:pt>
                <c:pt idx="41">
                  <c:v>718</c:v>
                </c:pt>
                <c:pt idx="42">
                  <c:v>716</c:v>
                </c:pt>
                <c:pt idx="43">
                  <c:v>714</c:v>
                </c:pt>
                <c:pt idx="44">
                  <c:v>712</c:v>
                </c:pt>
                <c:pt idx="45">
                  <c:v>710</c:v>
                </c:pt>
                <c:pt idx="46">
                  <c:v>708</c:v>
                </c:pt>
                <c:pt idx="47">
                  <c:v>706</c:v>
                </c:pt>
                <c:pt idx="48">
                  <c:v>704</c:v>
                </c:pt>
                <c:pt idx="49">
                  <c:v>702</c:v>
                </c:pt>
                <c:pt idx="50">
                  <c:v>700</c:v>
                </c:pt>
                <c:pt idx="51">
                  <c:v>698</c:v>
                </c:pt>
                <c:pt idx="52">
                  <c:v>696</c:v>
                </c:pt>
                <c:pt idx="53">
                  <c:v>694</c:v>
                </c:pt>
                <c:pt idx="54">
                  <c:v>692</c:v>
                </c:pt>
                <c:pt idx="55">
                  <c:v>690</c:v>
                </c:pt>
                <c:pt idx="56">
                  <c:v>688</c:v>
                </c:pt>
                <c:pt idx="57">
                  <c:v>686</c:v>
                </c:pt>
                <c:pt idx="58">
                  <c:v>684</c:v>
                </c:pt>
                <c:pt idx="59">
                  <c:v>682</c:v>
                </c:pt>
                <c:pt idx="60">
                  <c:v>680</c:v>
                </c:pt>
                <c:pt idx="61">
                  <c:v>678</c:v>
                </c:pt>
                <c:pt idx="62">
                  <c:v>676</c:v>
                </c:pt>
                <c:pt idx="63">
                  <c:v>674</c:v>
                </c:pt>
                <c:pt idx="64">
                  <c:v>672</c:v>
                </c:pt>
                <c:pt idx="65">
                  <c:v>670</c:v>
                </c:pt>
                <c:pt idx="66">
                  <c:v>668</c:v>
                </c:pt>
                <c:pt idx="67">
                  <c:v>666</c:v>
                </c:pt>
                <c:pt idx="68">
                  <c:v>664</c:v>
                </c:pt>
                <c:pt idx="69">
                  <c:v>662</c:v>
                </c:pt>
                <c:pt idx="70">
                  <c:v>660</c:v>
                </c:pt>
                <c:pt idx="71">
                  <c:v>658</c:v>
                </c:pt>
                <c:pt idx="72">
                  <c:v>656</c:v>
                </c:pt>
                <c:pt idx="73">
                  <c:v>654</c:v>
                </c:pt>
                <c:pt idx="74">
                  <c:v>652</c:v>
                </c:pt>
                <c:pt idx="75">
                  <c:v>650</c:v>
                </c:pt>
                <c:pt idx="76">
                  <c:v>648</c:v>
                </c:pt>
                <c:pt idx="77">
                  <c:v>646</c:v>
                </c:pt>
                <c:pt idx="78">
                  <c:v>644</c:v>
                </c:pt>
                <c:pt idx="79">
                  <c:v>642</c:v>
                </c:pt>
                <c:pt idx="80">
                  <c:v>640</c:v>
                </c:pt>
                <c:pt idx="81">
                  <c:v>638</c:v>
                </c:pt>
                <c:pt idx="82">
                  <c:v>636</c:v>
                </c:pt>
                <c:pt idx="83">
                  <c:v>634</c:v>
                </c:pt>
                <c:pt idx="84">
                  <c:v>632</c:v>
                </c:pt>
                <c:pt idx="85">
                  <c:v>630</c:v>
                </c:pt>
                <c:pt idx="86">
                  <c:v>628</c:v>
                </c:pt>
                <c:pt idx="87">
                  <c:v>626</c:v>
                </c:pt>
                <c:pt idx="88">
                  <c:v>624</c:v>
                </c:pt>
                <c:pt idx="89">
                  <c:v>622</c:v>
                </c:pt>
                <c:pt idx="90">
                  <c:v>620</c:v>
                </c:pt>
                <c:pt idx="91">
                  <c:v>618</c:v>
                </c:pt>
                <c:pt idx="92">
                  <c:v>616</c:v>
                </c:pt>
                <c:pt idx="93">
                  <c:v>614</c:v>
                </c:pt>
                <c:pt idx="94">
                  <c:v>612</c:v>
                </c:pt>
                <c:pt idx="95">
                  <c:v>610</c:v>
                </c:pt>
                <c:pt idx="96">
                  <c:v>608</c:v>
                </c:pt>
                <c:pt idx="97">
                  <c:v>606</c:v>
                </c:pt>
                <c:pt idx="98">
                  <c:v>604</c:v>
                </c:pt>
                <c:pt idx="99">
                  <c:v>602</c:v>
                </c:pt>
                <c:pt idx="100">
                  <c:v>600</c:v>
                </c:pt>
                <c:pt idx="101">
                  <c:v>598</c:v>
                </c:pt>
                <c:pt idx="102">
                  <c:v>596</c:v>
                </c:pt>
                <c:pt idx="103">
                  <c:v>594</c:v>
                </c:pt>
                <c:pt idx="104">
                  <c:v>592</c:v>
                </c:pt>
                <c:pt idx="105">
                  <c:v>590</c:v>
                </c:pt>
                <c:pt idx="106">
                  <c:v>588</c:v>
                </c:pt>
                <c:pt idx="107">
                  <c:v>586</c:v>
                </c:pt>
                <c:pt idx="108">
                  <c:v>584</c:v>
                </c:pt>
                <c:pt idx="109">
                  <c:v>582</c:v>
                </c:pt>
                <c:pt idx="110">
                  <c:v>580</c:v>
                </c:pt>
                <c:pt idx="111">
                  <c:v>578</c:v>
                </c:pt>
                <c:pt idx="112">
                  <c:v>576</c:v>
                </c:pt>
                <c:pt idx="113">
                  <c:v>574</c:v>
                </c:pt>
                <c:pt idx="114">
                  <c:v>572</c:v>
                </c:pt>
                <c:pt idx="115">
                  <c:v>570</c:v>
                </c:pt>
                <c:pt idx="116">
                  <c:v>568</c:v>
                </c:pt>
                <c:pt idx="117">
                  <c:v>566</c:v>
                </c:pt>
                <c:pt idx="118">
                  <c:v>564</c:v>
                </c:pt>
                <c:pt idx="119">
                  <c:v>562</c:v>
                </c:pt>
                <c:pt idx="120">
                  <c:v>560</c:v>
                </c:pt>
                <c:pt idx="121">
                  <c:v>558</c:v>
                </c:pt>
                <c:pt idx="122">
                  <c:v>556</c:v>
                </c:pt>
                <c:pt idx="123">
                  <c:v>554</c:v>
                </c:pt>
                <c:pt idx="124">
                  <c:v>552</c:v>
                </c:pt>
                <c:pt idx="125">
                  <c:v>550</c:v>
                </c:pt>
                <c:pt idx="126">
                  <c:v>548</c:v>
                </c:pt>
                <c:pt idx="127">
                  <c:v>546</c:v>
                </c:pt>
                <c:pt idx="128">
                  <c:v>544</c:v>
                </c:pt>
                <c:pt idx="129">
                  <c:v>542</c:v>
                </c:pt>
                <c:pt idx="130">
                  <c:v>540</c:v>
                </c:pt>
                <c:pt idx="131">
                  <c:v>538</c:v>
                </c:pt>
                <c:pt idx="132">
                  <c:v>536</c:v>
                </c:pt>
                <c:pt idx="133">
                  <c:v>534</c:v>
                </c:pt>
                <c:pt idx="134">
                  <c:v>532</c:v>
                </c:pt>
                <c:pt idx="135">
                  <c:v>530</c:v>
                </c:pt>
                <c:pt idx="136">
                  <c:v>528</c:v>
                </c:pt>
                <c:pt idx="137">
                  <c:v>526</c:v>
                </c:pt>
                <c:pt idx="138">
                  <c:v>524</c:v>
                </c:pt>
                <c:pt idx="139">
                  <c:v>522</c:v>
                </c:pt>
                <c:pt idx="140">
                  <c:v>520</c:v>
                </c:pt>
                <c:pt idx="141">
                  <c:v>518</c:v>
                </c:pt>
                <c:pt idx="142">
                  <c:v>516</c:v>
                </c:pt>
                <c:pt idx="143">
                  <c:v>514</c:v>
                </c:pt>
                <c:pt idx="144">
                  <c:v>512</c:v>
                </c:pt>
                <c:pt idx="145">
                  <c:v>510</c:v>
                </c:pt>
                <c:pt idx="146">
                  <c:v>508</c:v>
                </c:pt>
                <c:pt idx="147">
                  <c:v>506</c:v>
                </c:pt>
                <c:pt idx="148">
                  <c:v>504</c:v>
                </c:pt>
                <c:pt idx="149">
                  <c:v>502</c:v>
                </c:pt>
                <c:pt idx="150">
                  <c:v>500</c:v>
                </c:pt>
                <c:pt idx="151">
                  <c:v>498</c:v>
                </c:pt>
                <c:pt idx="152">
                  <c:v>496</c:v>
                </c:pt>
                <c:pt idx="153">
                  <c:v>494</c:v>
                </c:pt>
                <c:pt idx="154">
                  <c:v>492</c:v>
                </c:pt>
                <c:pt idx="155">
                  <c:v>490</c:v>
                </c:pt>
                <c:pt idx="156">
                  <c:v>488</c:v>
                </c:pt>
                <c:pt idx="157">
                  <c:v>486</c:v>
                </c:pt>
                <c:pt idx="158">
                  <c:v>484</c:v>
                </c:pt>
                <c:pt idx="159">
                  <c:v>482</c:v>
                </c:pt>
                <c:pt idx="160">
                  <c:v>480</c:v>
                </c:pt>
                <c:pt idx="161">
                  <c:v>478</c:v>
                </c:pt>
                <c:pt idx="162">
                  <c:v>476</c:v>
                </c:pt>
                <c:pt idx="163">
                  <c:v>474</c:v>
                </c:pt>
                <c:pt idx="164">
                  <c:v>472</c:v>
                </c:pt>
                <c:pt idx="165">
                  <c:v>470</c:v>
                </c:pt>
                <c:pt idx="166">
                  <c:v>468</c:v>
                </c:pt>
                <c:pt idx="167">
                  <c:v>466</c:v>
                </c:pt>
                <c:pt idx="168">
                  <c:v>464</c:v>
                </c:pt>
                <c:pt idx="169">
                  <c:v>462</c:v>
                </c:pt>
                <c:pt idx="170">
                  <c:v>460</c:v>
                </c:pt>
                <c:pt idx="171">
                  <c:v>458</c:v>
                </c:pt>
                <c:pt idx="172">
                  <c:v>456</c:v>
                </c:pt>
                <c:pt idx="173">
                  <c:v>454</c:v>
                </c:pt>
                <c:pt idx="174">
                  <c:v>452</c:v>
                </c:pt>
                <c:pt idx="175">
                  <c:v>450</c:v>
                </c:pt>
                <c:pt idx="176">
                  <c:v>448</c:v>
                </c:pt>
                <c:pt idx="177">
                  <c:v>446</c:v>
                </c:pt>
                <c:pt idx="178">
                  <c:v>444</c:v>
                </c:pt>
                <c:pt idx="179">
                  <c:v>442</c:v>
                </c:pt>
                <c:pt idx="180">
                  <c:v>440</c:v>
                </c:pt>
                <c:pt idx="181">
                  <c:v>438</c:v>
                </c:pt>
                <c:pt idx="182">
                  <c:v>436</c:v>
                </c:pt>
                <c:pt idx="183">
                  <c:v>434</c:v>
                </c:pt>
                <c:pt idx="184">
                  <c:v>432</c:v>
                </c:pt>
                <c:pt idx="185">
                  <c:v>430</c:v>
                </c:pt>
                <c:pt idx="186">
                  <c:v>428</c:v>
                </c:pt>
                <c:pt idx="187">
                  <c:v>426</c:v>
                </c:pt>
                <c:pt idx="188">
                  <c:v>424</c:v>
                </c:pt>
                <c:pt idx="189">
                  <c:v>422</c:v>
                </c:pt>
                <c:pt idx="190">
                  <c:v>420</c:v>
                </c:pt>
                <c:pt idx="191">
                  <c:v>418</c:v>
                </c:pt>
                <c:pt idx="192">
                  <c:v>416</c:v>
                </c:pt>
                <c:pt idx="193">
                  <c:v>414</c:v>
                </c:pt>
                <c:pt idx="194">
                  <c:v>412</c:v>
                </c:pt>
                <c:pt idx="195">
                  <c:v>410</c:v>
                </c:pt>
                <c:pt idx="196">
                  <c:v>408</c:v>
                </c:pt>
                <c:pt idx="197">
                  <c:v>406</c:v>
                </c:pt>
                <c:pt idx="198">
                  <c:v>404</c:v>
                </c:pt>
                <c:pt idx="199">
                  <c:v>402</c:v>
                </c:pt>
                <c:pt idx="200">
                  <c:v>400</c:v>
                </c:pt>
                <c:pt idx="201">
                  <c:v>398</c:v>
                </c:pt>
                <c:pt idx="202">
                  <c:v>396</c:v>
                </c:pt>
                <c:pt idx="203">
                  <c:v>394</c:v>
                </c:pt>
                <c:pt idx="204">
                  <c:v>392</c:v>
                </c:pt>
                <c:pt idx="205">
                  <c:v>390</c:v>
                </c:pt>
                <c:pt idx="206">
                  <c:v>388</c:v>
                </c:pt>
                <c:pt idx="207">
                  <c:v>386</c:v>
                </c:pt>
                <c:pt idx="208">
                  <c:v>384</c:v>
                </c:pt>
                <c:pt idx="209">
                  <c:v>382</c:v>
                </c:pt>
                <c:pt idx="210">
                  <c:v>380</c:v>
                </c:pt>
                <c:pt idx="211">
                  <c:v>378</c:v>
                </c:pt>
                <c:pt idx="212">
                  <c:v>376</c:v>
                </c:pt>
                <c:pt idx="213">
                  <c:v>374</c:v>
                </c:pt>
                <c:pt idx="214">
                  <c:v>372</c:v>
                </c:pt>
                <c:pt idx="215">
                  <c:v>370</c:v>
                </c:pt>
                <c:pt idx="216">
                  <c:v>368</c:v>
                </c:pt>
                <c:pt idx="217">
                  <c:v>366</c:v>
                </c:pt>
                <c:pt idx="218">
                  <c:v>364</c:v>
                </c:pt>
                <c:pt idx="219">
                  <c:v>362</c:v>
                </c:pt>
                <c:pt idx="220">
                  <c:v>360</c:v>
                </c:pt>
                <c:pt idx="221">
                  <c:v>358</c:v>
                </c:pt>
                <c:pt idx="222">
                  <c:v>356</c:v>
                </c:pt>
                <c:pt idx="223">
                  <c:v>354</c:v>
                </c:pt>
                <c:pt idx="224">
                  <c:v>352</c:v>
                </c:pt>
                <c:pt idx="225">
                  <c:v>350</c:v>
                </c:pt>
                <c:pt idx="226">
                  <c:v>348</c:v>
                </c:pt>
                <c:pt idx="227">
                  <c:v>346</c:v>
                </c:pt>
                <c:pt idx="228">
                  <c:v>344</c:v>
                </c:pt>
                <c:pt idx="229">
                  <c:v>342</c:v>
                </c:pt>
                <c:pt idx="230">
                  <c:v>340</c:v>
                </c:pt>
                <c:pt idx="231">
                  <c:v>338</c:v>
                </c:pt>
                <c:pt idx="232">
                  <c:v>336</c:v>
                </c:pt>
                <c:pt idx="233">
                  <c:v>334</c:v>
                </c:pt>
                <c:pt idx="234">
                  <c:v>332</c:v>
                </c:pt>
                <c:pt idx="235">
                  <c:v>330</c:v>
                </c:pt>
                <c:pt idx="236">
                  <c:v>328</c:v>
                </c:pt>
                <c:pt idx="237">
                  <c:v>326</c:v>
                </c:pt>
                <c:pt idx="238">
                  <c:v>324</c:v>
                </c:pt>
                <c:pt idx="239">
                  <c:v>322</c:v>
                </c:pt>
                <c:pt idx="240">
                  <c:v>320</c:v>
                </c:pt>
                <c:pt idx="241">
                  <c:v>318</c:v>
                </c:pt>
                <c:pt idx="242">
                  <c:v>316</c:v>
                </c:pt>
                <c:pt idx="243">
                  <c:v>314</c:v>
                </c:pt>
                <c:pt idx="244">
                  <c:v>312</c:v>
                </c:pt>
                <c:pt idx="245">
                  <c:v>310</c:v>
                </c:pt>
                <c:pt idx="246">
                  <c:v>308</c:v>
                </c:pt>
                <c:pt idx="247">
                  <c:v>306</c:v>
                </c:pt>
                <c:pt idx="248">
                  <c:v>304</c:v>
                </c:pt>
                <c:pt idx="249">
                  <c:v>302</c:v>
                </c:pt>
                <c:pt idx="250">
                  <c:v>300</c:v>
                </c:pt>
                <c:pt idx="251">
                  <c:v>298</c:v>
                </c:pt>
                <c:pt idx="252">
                  <c:v>296</c:v>
                </c:pt>
                <c:pt idx="253">
                  <c:v>294</c:v>
                </c:pt>
                <c:pt idx="254">
                  <c:v>292</c:v>
                </c:pt>
                <c:pt idx="255">
                  <c:v>290</c:v>
                </c:pt>
                <c:pt idx="256">
                  <c:v>288</c:v>
                </c:pt>
                <c:pt idx="257">
                  <c:v>286</c:v>
                </c:pt>
                <c:pt idx="258">
                  <c:v>284</c:v>
                </c:pt>
                <c:pt idx="259">
                  <c:v>282</c:v>
                </c:pt>
                <c:pt idx="260">
                  <c:v>280</c:v>
                </c:pt>
                <c:pt idx="261">
                  <c:v>278</c:v>
                </c:pt>
                <c:pt idx="262">
                  <c:v>276</c:v>
                </c:pt>
                <c:pt idx="263">
                  <c:v>274</c:v>
                </c:pt>
                <c:pt idx="264">
                  <c:v>272</c:v>
                </c:pt>
                <c:pt idx="265">
                  <c:v>270</c:v>
                </c:pt>
                <c:pt idx="266">
                  <c:v>268</c:v>
                </c:pt>
                <c:pt idx="267">
                  <c:v>266</c:v>
                </c:pt>
                <c:pt idx="268">
                  <c:v>264</c:v>
                </c:pt>
                <c:pt idx="269">
                  <c:v>262</c:v>
                </c:pt>
                <c:pt idx="270">
                  <c:v>260</c:v>
                </c:pt>
                <c:pt idx="271">
                  <c:v>258</c:v>
                </c:pt>
                <c:pt idx="272">
                  <c:v>256</c:v>
                </c:pt>
                <c:pt idx="273">
                  <c:v>254</c:v>
                </c:pt>
                <c:pt idx="274">
                  <c:v>252</c:v>
                </c:pt>
                <c:pt idx="275">
                  <c:v>250</c:v>
                </c:pt>
                <c:pt idx="276">
                  <c:v>248</c:v>
                </c:pt>
                <c:pt idx="277">
                  <c:v>246</c:v>
                </c:pt>
                <c:pt idx="278">
                  <c:v>244</c:v>
                </c:pt>
                <c:pt idx="279">
                  <c:v>242</c:v>
                </c:pt>
                <c:pt idx="280">
                  <c:v>240</c:v>
                </c:pt>
                <c:pt idx="281">
                  <c:v>238</c:v>
                </c:pt>
                <c:pt idx="282">
                  <c:v>236</c:v>
                </c:pt>
                <c:pt idx="283">
                  <c:v>234</c:v>
                </c:pt>
                <c:pt idx="284">
                  <c:v>232</c:v>
                </c:pt>
                <c:pt idx="285">
                  <c:v>230</c:v>
                </c:pt>
                <c:pt idx="286">
                  <c:v>228</c:v>
                </c:pt>
                <c:pt idx="287">
                  <c:v>226</c:v>
                </c:pt>
                <c:pt idx="288">
                  <c:v>224</c:v>
                </c:pt>
                <c:pt idx="289">
                  <c:v>222</c:v>
                </c:pt>
                <c:pt idx="290">
                  <c:v>220</c:v>
                </c:pt>
                <c:pt idx="291">
                  <c:v>218</c:v>
                </c:pt>
                <c:pt idx="292">
                  <c:v>216</c:v>
                </c:pt>
                <c:pt idx="293">
                  <c:v>214</c:v>
                </c:pt>
                <c:pt idx="294">
                  <c:v>212</c:v>
                </c:pt>
                <c:pt idx="295">
                  <c:v>210</c:v>
                </c:pt>
                <c:pt idx="296">
                  <c:v>208</c:v>
                </c:pt>
                <c:pt idx="297">
                  <c:v>206</c:v>
                </c:pt>
                <c:pt idx="298">
                  <c:v>204</c:v>
                </c:pt>
                <c:pt idx="299">
                  <c:v>202</c:v>
                </c:pt>
                <c:pt idx="300">
                  <c:v>200</c:v>
                </c:pt>
              </c:numCache>
            </c:numRef>
          </c:xVal>
          <c:yVal>
            <c:numRef>
              <c:f>Feuil1!$E$3:$E$303</c:f>
              <c:numCache>
                <c:formatCode>General</c:formatCode>
                <c:ptCount val="301"/>
                <c:pt idx="0">
                  <c:v>1.057E-2</c:v>
                </c:pt>
                <c:pt idx="1">
                  <c:v>7.0200000000000002E-3</c:v>
                </c:pt>
                <c:pt idx="2">
                  <c:v>7.2199999999999999E-3</c:v>
                </c:pt>
                <c:pt idx="3">
                  <c:v>4.8399999999999997E-3</c:v>
                </c:pt>
                <c:pt idx="4">
                  <c:v>9.7000000000000003E-3</c:v>
                </c:pt>
                <c:pt idx="5">
                  <c:v>8.6199999999999992E-3</c:v>
                </c:pt>
                <c:pt idx="6">
                  <c:v>6.7600000000000004E-3</c:v>
                </c:pt>
                <c:pt idx="7">
                  <c:v>6.4099999999999999E-3</c:v>
                </c:pt>
                <c:pt idx="8">
                  <c:v>8.3499999999999998E-3</c:v>
                </c:pt>
                <c:pt idx="9">
                  <c:v>1.312E-2</c:v>
                </c:pt>
                <c:pt idx="10">
                  <c:v>6.7299999999999999E-3</c:v>
                </c:pt>
                <c:pt idx="11">
                  <c:v>4.0299999999999997E-3</c:v>
                </c:pt>
                <c:pt idx="12">
                  <c:v>2.7799999999999999E-3</c:v>
                </c:pt>
                <c:pt idx="13">
                  <c:v>3.3999999999999998E-3</c:v>
                </c:pt>
                <c:pt idx="14">
                  <c:v>6.8900000000000003E-3</c:v>
                </c:pt>
                <c:pt idx="15">
                  <c:v>5.64E-3</c:v>
                </c:pt>
                <c:pt idx="16">
                  <c:v>1.141E-2</c:v>
                </c:pt>
                <c:pt idx="17">
                  <c:v>1.282E-2</c:v>
                </c:pt>
                <c:pt idx="18">
                  <c:v>4.3600000000000002E-3</c:v>
                </c:pt>
                <c:pt idx="19">
                  <c:v>1.269E-2</c:v>
                </c:pt>
                <c:pt idx="20">
                  <c:v>6.0400000000000002E-3</c:v>
                </c:pt>
                <c:pt idx="21">
                  <c:v>1.004E-2</c:v>
                </c:pt>
                <c:pt idx="22">
                  <c:v>6.6499999999999997E-3</c:v>
                </c:pt>
                <c:pt idx="23">
                  <c:v>7.0400000000000003E-3</c:v>
                </c:pt>
                <c:pt idx="24">
                  <c:v>1.523E-2</c:v>
                </c:pt>
                <c:pt idx="25">
                  <c:v>9.1999999999999998E-3</c:v>
                </c:pt>
                <c:pt idx="26">
                  <c:v>1.478E-2</c:v>
                </c:pt>
                <c:pt idx="27">
                  <c:v>1.1390000000000001E-2</c:v>
                </c:pt>
                <c:pt idx="28">
                  <c:v>9.5300000000000003E-3</c:v>
                </c:pt>
                <c:pt idx="29">
                  <c:v>1.0359999999999999E-2</c:v>
                </c:pt>
                <c:pt idx="30">
                  <c:v>1.37E-2</c:v>
                </c:pt>
                <c:pt idx="31">
                  <c:v>7.77E-3</c:v>
                </c:pt>
                <c:pt idx="32">
                  <c:v>9.4599999999999997E-3</c:v>
                </c:pt>
                <c:pt idx="33">
                  <c:v>1.3820000000000001E-2</c:v>
                </c:pt>
                <c:pt idx="34">
                  <c:v>1.321E-2</c:v>
                </c:pt>
                <c:pt idx="35">
                  <c:v>1.389E-2</c:v>
                </c:pt>
                <c:pt idx="36">
                  <c:v>1.5570000000000001E-2</c:v>
                </c:pt>
                <c:pt idx="37">
                  <c:v>1.3169999999999999E-2</c:v>
                </c:pt>
                <c:pt idx="38">
                  <c:v>1.3050000000000001E-2</c:v>
                </c:pt>
                <c:pt idx="39">
                  <c:v>1.2E-2</c:v>
                </c:pt>
                <c:pt idx="40">
                  <c:v>1.302E-2</c:v>
                </c:pt>
                <c:pt idx="41">
                  <c:v>1.444E-2</c:v>
                </c:pt>
                <c:pt idx="42">
                  <c:v>1.1299999999999999E-2</c:v>
                </c:pt>
                <c:pt idx="43">
                  <c:v>9.9900000000000006E-3</c:v>
                </c:pt>
                <c:pt idx="44">
                  <c:v>1.133E-2</c:v>
                </c:pt>
                <c:pt idx="45">
                  <c:v>1.592E-2</c:v>
                </c:pt>
                <c:pt idx="46">
                  <c:v>1.8859999999999998E-2</c:v>
                </c:pt>
                <c:pt idx="47">
                  <c:v>1.3050000000000001E-2</c:v>
                </c:pt>
                <c:pt idx="48">
                  <c:v>1.5480000000000001E-2</c:v>
                </c:pt>
                <c:pt idx="49">
                  <c:v>1.8960000000000001E-2</c:v>
                </c:pt>
                <c:pt idx="50">
                  <c:v>1.9019999999999999E-2</c:v>
                </c:pt>
                <c:pt idx="51">
                  <c:v>1.7139999999999999E-2</c:v>
                </c:pt>
                <c:pt idx="52">
                  <c:v>1.8610000000000002E-2</c:v>
                </c:pt>
                <c:pt idx="53">
                  <c:v>1.983E-2</c:v>
                </c:pt>
                <c:pt idx="54">
                  <c:v>2.2040000000000001E-2</c:v>
                </c:pt>
                <c:pt idx="55">
                  <c:v>1.8489999999999999E-2</c:v>
                </c:pt>
                <c:pt idx="56">
                  <c:v>2.1760000000000002E-2</c:v>
                </c:pt>
                <c:pt idx="57">
                  <c:v>1.9810000000000001E-2</c:v>
                </c:pt>
                <c:pt idx="58">
                  <c:v>2.0650000000000002E-2</c:v>
                </c:pt>
                <c:pt idx="59">
                  <c:v>0.02</c:v>
                </c:pt>
                <c:pt idx="60">
                  <c:v>2.4289999999999999E-2</c:v>
                </c:pt>
                <c:pt idx="61">
                  <c:v>2.4840000000000001E-2</c:v>
                </c:pt>
                <c:pt idx="62">
                  <c:v>2.1850000000000001E-2</c:v>
                </c:pt>
                <c:pt idx="63">
                  <c:v>2.7099999999999999E-2</c:v>
                </c:pt>
                <c:pt idx="64">
                  <c:v>2.6259999999999999E-2</c:v>
                </c:pt>
                <c:pt idx="65">
                  <c:v>2.9690000000000001E-2</c:v>
                </c:pt>
                <c:pt idx="66">
                  <c:v>3.1759999999999997E-2</c:v>
                </c:pt>
                <c:pt idx="67">
                  <c:v>3.218E-2</c:v>
                </c:pt>
                <c:pt idx="68">
                  <c:v>3.4630000000000001E-2</c:v>
                </c:pt>
                <c:pt idx="69">
                  <c:v>2.9510000000000002E-2</c:v>
                </c:pt>
                <c:pt idx="70">
                  <c:v>3.2309999999999998E-2</c:v>
                </c:pt>
                <c:pt idx="71">
                  <c:v>3.2739999999999998E-2</c:v>
                </c:pt>
                <c:pt idx="72">
                  <c:v>3.6020000000000003E-2</c:v>
                </c:pt>
                <c:pt idx="73">
                  <c:v>3.8390000000000001E-2</c:v>
                </c:pt>
                <c:pt idx="74">
                  <c:v>4.0960000000000003E-2</c:v>
                </c:pt>
                <c:pt idx="75">
                  <c:v>4.0349999999999997E-2</c:v>
                </c:pt>
                <c:pt idx="76">
                  <c:v>4.2110000000000002E-2</c:v>
                </c:pt>
                <c:pt idx="77">
                  <c:v>4.6269999999999999E-2</c:v>
                </c:pt>
                <c:pt idx="78">
                  <c:v>4.761E-2</c:v>
                </c:pt>
                <c:pt idx="79">
                  <c:v>4.9700000000000001E-2</c:v>
                </c:pt>
                <c:pt idx="80">
                  <c:v>5.1729999999999998E-2</c:v>
                </c:pt>
                <c:pt idx="81">
                  <c:v>5.389E-2</c:v>
                </c:pt>
                <c:pt idx="82">
                  <c:v>5.5719999999999999E-2</c:v>
                </c:pt>
                <c:pt idx="83">
                  <c:v>5.772E-2</c:v>
                </c:pt>
                <c:pt idx="84">
                  <c:v>6.3740000000000005E-2</c:v>
                </c:pt>
                <c:pt idx="85">
                  <c:v>6.1190000000000001E-2</c:v>
                </c:pt>
                <c:pt idx="86">
                  <c:v>6.6890000000000005E-2</c:v>
                </c:pt>
                <c:pt idx="87">
                  <c:v>7.2370000000000004E-2</c:v>
                </c:pt>
                <c:pt idx="88">
                  <c:v>7.4450000000000002E-2</c:v>
                </c:pt>
                <c:pt idx="89">
                  <c:v>7.6490000000000002E-2</c:v>
                </c:pt>
                <c:pt idx="90">
                  <c:v>7.6859999999999998E-2</c:v>
                </c:pt>
                <c:pt idx="91">
                  <c:v>8.1140000000000004E-2</c:v>
                </c:pt>
                <c:pt idx="92">
                  <c:v>8.3610000000000004E-2</c:v>
                </c:pt>
                <c:pt idx="93">
                  <c:v>9.0260000000000007E-2</c:v>
                </c:pt>
                <c:pt idx="94">
                  <c:v>9.2609999999999998E-2</c:v>
                </c:pt>
                <c:pt idx="95">
                  <c:v>9.5399999999999999E-2</c:v>
                </c:pt>
                <c:pt idx="96">
                  <c:v>9.8229999999999998E-2</c:v>
                </c:pt>
                <c:pt idx="97">
                  <c:v>0.10353999999999999</c:v>
                </c:pt>
                <c:pt idx="98">
                  <c:v>0.10476000000000001</c:v>
                </c:pt>
                <c:pt idx="99">
                  <c:v>0.11249000000000001</c:v>
                </c:pt>
                <c:pt idx="100">
                  <c:v>0.11362</c:v>
                </c:pt>
                <c:pt idx="101">
                  <c:v>0.12112000000000001</c:v>
                </c:pt>
                <c:pt idx="102">
                  <c:v>0.12411</c:v>
                </c:pt>
                <c:pt idx="103">
                  <c:v>0.12825</c:v>
                </c:pt>
                <c:pt idx="104">
                  <c:v>0.13097</c:v>
                </c:pt>
                <c:pt idx="105">
                  <c:v>0.13574</c:v>
                </c:pt>
                <c:pt idx="106">
                  <c:v>0.14607999999999999</c:v>
                </c:pt>
                <c:pt idx="107">
                  <c:v>0.15001</c:v>
                </c:pt>
                <c:pt idx="108">
                  <c:v>0.15325</c:v>
                </c:pt>
                <c:pt idx="109">
                  <c:v>0.15725</c:v>
                </c:pt>
                <c:pt idx="110">
                  <c:v>0.16309000000000001</c:v>
                </c:pt>
                <c:pt idx="111">
                  <c:v>0.17079</c:v>
                </c:pt>
                <c:pt idx="112">
                  <c:v>0.17423</c:v>
                </c:pt>
                <c:pt idx="113">
                  <c:v>0.18043999999999999</c:v>
                </c:pt>
                <c:pt idx="114">
                  <c:v>0.18570999999999999</c:v>
                </c:pt>
                <c:pt idx="115">
                  <c:v>0.18923000000000001</c:v>
                </c:pt>
                <c:pt idx="116">
                  <c:v>0.1966</c:v>
                </c:pt>
                <c:pt idx="117">
                  <c:v>0.20000999999999999</c:v>
                </c:pt>
                <c:pt idx="118">
                  <c:v>0.20435</c:v>
                </c:pt>
                <c:pt idx="119">
                  <c:v>0.21190000000000001</c:v>
                </c:pt>
                <c:pt idx="120">
                  <c:v>0.21528</c:v>
                </c:pt>
                <c:pt idx="121">
                  <c:v>0.22119</c:v>
                </c:pt>
                <c:pt idx="122">
                  <c:v>0.22663</c:v>
                </c:pt>
                <c:pt idx="123">
                  <c:v>0.23149</c:v>
                </c:pt>
                <c:pt idx="124">
                  <c:v>0.23704</c:v>
                </c:pt>
                <c:pt idx="125">
                  <c:v>0.24521999999999999</c:v>
                </c:pt>
                <c:pt idx="126">
                  <c:v>0.24915000000000001</c:v>
                </c:pt>
                <c:pt idx="127">
                  <c:v>0.25364999999999999</c:v>
                </c:pt>
                <c:pt idx="128">
                  <c:v>0.25945000000000001</c:v>
                </c:pt>
                <c:pt idx="129">
                  <c:v>0.26529000000000003</c:v>
                </c:pt>
                <c:pt idx="130">
                  <c:v>0.27093</c:v>
                </c:pt>
                <c:pt idx="131">
                  <c:v>0.27761999999999998</c:v>
                </c:pt>
                <c:pt idx="132">
                  <c:v>0.28331000000000001</c:v>
                </c:pt>
                <c:pt idx="133">
                  <c:v>0.29009000000000001</c:v>
                </c:pt>
                <c:pt idx="134">
                  <c:v>0.29604000000000003</c:v>
                </c:pt>
                <c:pt idx="135">
                  <c:v>0.30368000000000001</c:v>
                </c:pt>
                <c:pt idx="136">
                  <c:v>0.30885000000000001</c:v>
                </c:pt>
                <c:pt idx="137">
                  <c:v>0.31558999999999998</c:v>
                </c:pt>
                <c:pt idx="138">
                  <c:v>0.32352999999999998</c:v>
                </c:pt>
                <c:pt idx="139">
                  <c:v>0.33013999999999999</c:v>
                </c:pt>
                <c:pt idx="140">
                  <c:v>0.33860000000000001</c:v>
                </c:pt>
                <c:pt idx="141">
                  <c:v>0.34553</c:v>
                </c:pt>
                <c:pt idx="142">
                  <c:v>0.35258</c:v>
                </c:pt>
                <c:pt idx="143">
                  <c:v>0.36059999999999998</c:v>
                </c:pt>
                <c:pt idx="144">
                  <c:v>0.36876999999999999</c:v>
                </c:pt>
                <c:pt idx="145">
                  <c:v>0.37583</c:v>
                </c:pt>
                <c:pt idx="146">
                  <c:v>0.38391999999999998</c:v>
                </c:pt>
                <c:pt idx="147">
                  <c:v>0.39267000000000002</c:v>
                </c:pt>
                <c:pt idx="148">
                  <c:v>0.40151999999999999</c:v>
                </c:pt>
                <c:pt idx="149">
                  <c:v>0.40950999999999999</c:v>
                </c:pt>
                <c:pt idx="150">
                  <c:v>0.41657</c:v>
                </c:pt>
                <c:pt idx="151">
                  <c:v>0.42588999999999999</c:v>
                </c:pt>
                <c:pt idx="152">
                  <c:v>0.43439</c:v>
                </c:pt>
                <c:pt idx="153">
                  <c:v>0.443</c:v>
                </c:pt>
                <c:pt idx="154">
                  <c:v>0.45161000000000001</c:v>
                </c:pt>
                <c:pt idx="155">
                  <c:v>0.46029999999999999</c:v>
                </c:pt>
                <c:pt idx="156">
                  <c:v>0.46816000000000002</c:v>
                </c:pt>
                <c:pt idx="157">
                  <c:v>0.47655999999999998</c:v>
                </c:pt>
                <c:pt idx="158">
                  <c:v>0.48508000000000001</c:v>
                </c:pt>
                <c:pt idx="159">
                  <c:v>0.49259999999999998</c:v>
                </c:pt>
                <c:pt idx="160">
                  <c:v>0.50117999999999996</c:v>
                </c:pt>
                <c:pt idx="161">
                  <c:v>0.50951999999999997</c:v>
                </c:pt>
                <c:pt idx="162">
                  <c:v>0.51675000000000004</c:v>
                </c:pt>
                <c:pt idx="163">
                  <c:v>0.52517000000000003</c:v>
                </c:pt>
                <c:pt idx="164">
                  <c:v>0.53271999999999997</c:v>
                </c:pt>
                <c:pt idx="165">
                  <c:v>0.54005999999999998</c:v>
                </c:pt>
                <c:pt idx="166">
                  <c:v>0.54764000000000002</c:v>
                </c:pt>
                <c:pt idx="167">
                  <c:v>0.55452000000000001</c:v>
                </c:pt>
                <c:pt idx="168">
                  <c:v>0.56150999999999995</c:v>
                </c:pt>
                <c:pt idx="169">
                  <c:v>0.56916999999999995</c:v>
                </c:pt>
                <c:pt idx="170">
                  <c:v>0.57589999999999997</c:v>
                </c:pt>
                <c:pt idx="171">
                  <c:v>0.58238000000000001</c:v>
                </c:pt>
                <c:pt idx="172">
                  <c:v>0.58987999999999996</c:v>
                </c:pt>
                <c:pt idx="173">
                  <c:v>0.59706000000000004</c:v>
                </c:pt>
                <c:pt idx="174">
                  <c:v>0.60306999999999999</c:v>
                </c:pt>
                <c:pt idx="175">
                  <c:v>0.60992999999999997</c:v>
                </c:pt>
                <c:pt idx="176">
                  <c:v>0.61594000000000004</c:v>
                </c:pt>
                <c:pt idx="177">
                  <c:v>0.62199000000000004</c:v>
                </c:pt>
                <c:pt idx="178">
                  <c:v>0.62883999999999995</c:v>
                </c:pt>
                <c:pt idx="179">
                  <c:v>0.63558000000000003</c:v>
                </c:pt>
                <c:pt idx="180">
                  <c:v>0.64210999999999996</c:v>
                </c:pt>
                <c:pt idx="181">
                  <c:v>0.64858000000000005</c:v>
                </c:pt>
                <c:pt idx="182">
                  <c:v>0.65576000000000001</c:v>
                </c:pt>
                <c:pt idx="183">
                  <c:v>0.66288999999999998</c:v>
                </c:pt>
                <c:pt idx="184">
                  <c:v>0.67040999999999995</c:v>
                </c:pt>
                <c:pt idx="185">
                  <c:v>0.67793999999999999</c:v>
                </c:pt>
                <c:pt idx="186">
                  <c:v>0.68601000000000001</c:v>
                </c:pt>
                <c:pt idx="187">
                  <c:v>0.69416</c:v>
                </c:pt>
                <c:pt idx="188">
                  <c:v>0.70225000000000004</c:v>
                </c:pt>
                <c:pt idx="189">
                  <c:v>0.71162000000000003</c:v>
                </c:pt>
                <c:pt idx="190">
                  <c:v>0.72048999999999996</c:v>
                </c:pt>
                <c:pt idx="191">
                  <c:v>0.72972999999999999</c:v>
                </c:pt>
                <c:pt idx="192">
                  <c:v>0.74034999999999995</c:v>
                </c:pt>
                <c:pt idx="193">
                  <c:v>0.75097999999999998</c:v>
                </c:pt>
                <c:pt idx="194">
                  <c:v>0.76114999999999999</c:v>
                </c:pt>
                <c:pt idx="195">
                  <c:v>0.77285999999999999</c:v>
                </c:pt>
                <c:pt idx="196">
                  <c:v>0.78393999999999997</c:v>
                </c:pt>
                <c:pt idx="197">
                  <c:v>0.79605999999999999</c:v>
                </c:pt>
                <c:pt idx="198">
                  <c:v>0.80896000000000001</c:v>
                </c:pt>
                <c:pt idx="199">
                  <c:v>0.82235000000000003</c:v>
                </c:pt>
                <c:pt idx="200">
                  <c:v>0.83553999999999995</c:v>
                </c:pt>
                <c:pt idx="201">
                  <c:v>0.85048999999999997</c:v>
                </c:pt>
                <c:pt idx="202">
                  <c:v>0.86578999999999995</c:v>
                </c:pt>
                <c:pt idx="203">
                  <c:v>0.88017999999999996</c:v>
                </c:pt>
                <c:pt idx="204">
                  <c:v>0.89685999999999999</c:v>
                </c:pt>
                <c:pt idx="205">
                  <c:v>0.91313</c:v>
                </c:pt>
                <c:pt idx="206">
                  <c:v>0.93074000000000001</c:v>
                </c:pt>
                <c:pt idx="207">
                  <c:v>0.94769000000000003</c:v>
                </c:pt>
                <c:pt idx="208">
                  <c:v>0.96555000000000002</c:v>
                </c:pt>
                <c:pt idx="209">
                  <c:v>0.98426999999999998</c:v>
                </c:pt>
                <c:pt idx="210">
                  <c:v>1.0053099999999999</c:v>
                </c:pt>
                <c:pt idx="211">
                  <c:v>1.0254099999999999</c:v>
                </c:pt>
                <c:pt idx="212">
                  <c:v>1.04572</c:v>
                </c:pt>
                <c:pt idx="213">
                  <c:v>1.06921</c:v>
                </c:pt>
                <c:pt idx="214">
                  <c:v>1.09324</c:v>
                </c:pt>
                <c:pt idx="215">
                  <c:v>1.1200699999999999</c:v>
                </c:pt>
                <c:pt idx="216">
                  <c:v>1.1457999999999999</c:v>
                </c:pt>
                <c:pt idx="217">
                  <c:v>1.17045</c:v>
                </c:pt>
                <c:pt idx="218">
                  <c:v>1.20262</c:v>
                </c:pt>
                <c:pt idx="219">
                  <c:v>1.2296899999999999</c:v>
                </c:pt>
                <c:pt idx="220">
                  <c:v>1.2588600000000001</c:v>
                </c:pt>
                <c:pt idx="221">
                  <c:v>1.29559</c:v>
                </c:pt>
                <c:pt idx="222">
                  <c:v>1.3281700000000001</c:v>
                </c:pt>
                <c:pt idx="223">
                  <c:v>1.3637900000000001</c:v>
                </c:pt>
                <c:pt idx="224">
                  <c:v>1.4072499999999999</c:v>
                </c:pt>
                <c:pt idx="225">
                  <c:v>1.4467300000000001</c:v>
                </c:pt>
                <c:pt idx="226">
                  <c:v>1.49701</c:v>
                </c:pt>
                <c:pt idx="227">
                  <c:v>1.5593399999999999</c:v>
                </c:pt>
                <c:pt idx="228">
                  <c:v>1.6217699999999999</c:v>
                </c:pt>
                <c:pt idx="229">
                  <c:v>1.70539</c:v>
                </c:pt>
                <c:pt idx="230">
                  <c:v>1.8198799999999999</c:v>
                </c:pt>
                <c:pt idx="231">
                  <c:v>1.9557500000000001</c:v>
                </c:pt>
                <c:pt idx="232">
                  <c:v>2.14039</c:v>
                </c:pt>
                <c:pt idx="233">
                  <c:v>2.4079600000000001</c:v>
                </c:pt>
                <c:pt idx="234">
                  <c:v>2.7360699999999998</c:v>
                </c:pt>
                <c:pt idx="235">
                  <c:v>3.0328900000000001</c:v>
                </c:pt>
                <c:pt idx="236">
                  <c:v>3.21156</c:v>
                </c:pt>
                <c:pt idx="237">
                  <c:v>3.4445600000000001</c:v>
                </c:pt>
                <c:pt idx="238">
                  <c:v>3.3589899999999999</c:v>
                </c:pt>
                <c:pt idx="239">
                  <c:v>3.4120200000000001</c:v>
                </c:pt>
                <c:pt idx="240">
                  <c:v>3.5744699999999998</c:v>
                </c:pt>
                <c:pt idx="241">
                  <c:v>3.5790099999999998</c:v>
                </c:pt>
                <c:pt idx="242">
                  <c:v>3.8595100000000002</c:v>
                </c:pt>
                <c:pt idx="243">
                  <c:v>3.90686</c:v>
                </c:pt>
                <c:pt idx="244">
                  <c:v>3.85412</c:v>
                </c:pt>
                <c:pt idx="245">
                  <c:v>4.0931499999999996</c:v>
                </c:pt>
                <c:pt idx="246">
                  <c:v>4.1584099999999999</c:v>
                </c:pt>
                <c:pt idx="247">
                  <c:v>4.0704000000000002</c:v>
                </c:pt>
                <c:pt idx="248">
                  <c:v>4.40388</c:v>
                </c:pt>
                <c:pt idx="249">
                  <c:v>4.1863000000000001</c:v>
                </c:pt>
                <c:pt idx="250">
                  <c:v>4.0395200000000004</c:v>
                </c:pt>
                <c:pt idx="251">
                  <c:v>5.0000099999999996</c:v>
                </c:pt>
                <c:pt idx="252">
                  <c:v>5.0000099999999996</c:v>
                </c:pt>
                <c:pt idx="253">
                  <c:v>4.1009599999999997</c:v>
                </c:pt>
                <c:pt idx="254">
                  <c:v>3.9151400000000001</c:v>
                </c:pt>
                <c:pt idx="255">
                  <c:v>3.98861</c:v>
                </c:pt>
                <c:pt idx="256">
                  <c:v>3.8973399999999998</c:v>
                </c:pt>
                <c:pt idx="257">
                  <c:v>3.6821299999999999</c:v>
                </c:pt>
                <c:pt idx="258">
                  <c:v>3.5544799999999999</c:v>
                </c:pt>
                <c:pt idx="259">
                  <c:v>3.39554</c:v>
                </c:pt>
                <c:pt idx="260">
                  <c:v>3.1676000000000002</c:v>
                </c:pt>
                <c:pt idx="261">
                  <c:v>2.9556200000000001</c:v>
                </c:pt>
                <c:pt idx="262">
                  <c:v>2.6335799999999998</c:v>
                </c:pt>
                <c:pt idx="263">
                  <c:v>2.4147799999999999</c:v>
                </c:pt>
                <c:pt idx="264">
                  <c:v>2.0959500000000002</c:v>
                </c:pt>
                <c:pt idx="265">
                  <c:v>1.67252</c:v>
                </c:pt>
                <c:pt idx="266">
                  <c:v>1.27519</c:v>
                </c:pt>
                <c:pt idx="267">
                  <c:v>1.0173399999999999</c:v>
                </c:pt>
                <c:pt idx="268">
                  <c:v>0.8629</c:v>
                </c:pt>
                <c:pt idx="269">
                  <c:v>0.81852999999999998</c:v>
                </c:pt>
                <c:pt idx="270">
                  <c:v>0.77956999999999999</c:v>
                </c:pt>
                <c:pt idx="271">
                  <c:v>0.78966999999999998</c:v>
                </c:pt>
                <c:pt idx="272">
                  <c:v>0.77266000000000001</c:v>
                </c:pt>
                <c:pt idx="273">
                  <c:v>0.75927</c:v>
                </c:pt>
                <c:pt idx="274">
                  <c:v>0.73109000000000002</c:v>
                </c:pt>
                <c:pt idx="275">
                  <c:v>0.70808000000000004</c:v>
                </c:pt>
                <c:pt idx="276">
                  <c:v>0.69803999999999999</c:v>
                </c:pt>
                <c:pt idx="277">
                  <c:v>0.68855</c:v>
                </c:pt>
                <c:pt idx="278">
                  <c:v>0.68176999999999999</c:v>
                </c:pt>
                <c:pt idx="279">
                  <c:v>0.68669000000000002</c:v>
                </c:pt>
                <c:pt idx="280">
                  <c:v>0.66061999999999999</c:v>
                </c:pt>
                <c:pt idx="281">
                  <c:v>0.67379999999999995</c:v>
                </c:pt>
                <c:pt idx="282">
                  <c:v>0.67905000000000004</c:v>
                </c:pt>
                <c:pt idx="283">
                  <c:v>0.64824000000000004</c:v>
                </c:pt>
                <c:pt idx="284">
                  <c:v>0.63504000000000005</c:v>
                </c:pt>
                <c:pt idx="285">
                  <c:v>0.63290000000000002</c:v>
                </c:pt>
                <c:pt idx="286">
                  <c:v>0.63280000000000003</c:v>
                </c:pt>
                <c:pt idx="287">
                  <c:v>0.64444999999999997</c:v>
                </c:pt>
                <c:pt idx="288">
                  <c:v>0.64583000000000002</c:v>
                </c:pt>
                <c:pt idx="289">
                  <c:v>0.63058000000000003</c:v>
                </c:pt>
                <c:pt idx="290">
                  <c:v>0.62573999999999996</c:v>
                </c:pt>
                <c:pt idx="291">
                  <c:v>0.66947999999999996</c:v>
                </c:pt>
                <c:pt idx="292">
                  <c:v>0.67696000000000001</c:v>
                </c:pt>
                <c:pt idx="293">
                  <c:v>0.65780000000000005</c:v>
                </c:pt>
                <c:pt idx="294">
                  <c:v>0.75704000000000005</c:v>
                </c:pt>
                <c:pt idx="295">
                  <c:v>0.67610999999999999</c:v>
                </c:pt>
                <c:pt idx="296">
                  <c:v>0.64244999999999997</c:v>
                </c:pt>
                <c:pt idx="297">
                  <c:v>0.63644999999999996</c:v>
                </c:pt>
                <c:pt idx="298">
                  <c:v>0.64683999999999997</c:v>
                </c:pt>
                <c:pt idx="299">
                  <c:v>0.69028999999999996</c:v>
                </c:pt>
                <c:pt idx="300">
                  <c:v>0.59994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D005-49FD-B3FC-925FD33CADDB}"/>
            </c:ext>
          </c:extLst>
        </c:ser>
        <c:ser>
          <c:idx val="4"/>
          <c:order val="4"/>
          <c:tx>
            <c:strRef>
              <c:f>Feuil1!$F$2</c:f>
              <c:strCache>
                <c:ptCount val="1"/>
                <c:pt idx="0">
                  <c:v>HBT+ supernatant</c:v>
                </c:pt>
              </c:strCache>
            </c:strRef>
          </c:tx>
          <c:spPr>
            <a:ln w="12700">
              <a:solidFill>
                <a:srgbClr val="33CCCC"/>
              </a:solidFill>
              <a:prstDash val="solid"/>
            </a:ln>
          </c:spPr>
          <c:marker>
            <c:symbol val="none"/>
          </c:marker>
          <c:xVal>
            <c:numRef>
              <c:f>Feuil1!$A$3:$A$303</c:f>
              <c:numCache>
                <c:formatCode>General</c:formatCode>
                <c:ptCount val="301"/>
                <c:pt idx="0">
                  <c:v>800</c:v>
                </c:pt>
                <c:pt idx="1">
                  <c:v>798</c:v>
                </c:pt>
                <c:pt idx="2">
                  <c:v>796</c:v>
                </c:pt>
                <c:pt idx="3">
                  <c:v>794</c:v>
                </c:pt>
                <c:pt idx="4">
                  <c:v>792</c:v>
                </c:pt>
                <c:pt idx="5">
                  <c:v>790</c:v>
                </c:pt>
                <c:pt idx="6">
                  <c:v>788</c:v>
                </c:pt>
                <c:pt idx="7">
                  <c:v>786</c:v>
                </c:pt>
                <c:pt idx="8">
                  <c:v>784</c:v>
                </c:pt>
                <c:pt idx="9">
                  <c:v>782</c:v>
                </c:pt>
                <c:pt idx="10">
                  <c:v>780</c:v>
                </c:pt>
                <c:pt idx="11">
                  <c:v>778</c:v>
                </c:pt>
                <c:pt idx="12">
                  <c:v>776</c:v>
                </c:pt>
                <c:pt idx="13">
                  <c:v>774</c:v>
                </c:pt>
                <c:pt idx="14">
                  <c:v>772</c:v>
                </c:pt>
                <c:pt idx="15">
                  <c:v>770</c:v>
                </c:pt>
                <c:pt idx="16">
                  <c:v>768</c:v>
                </c:pt>
                <c:pt idx="17">
                  <c:v>766</c:v>
                </c:pt>
                <c:pt idx="18">
                  <c:v>764</c:v>
                </c:pt>
                <c:pt idx="19">
                  <c:v>762</c:v>
                </c:pt>
                <c:pt idx="20">
                  <c:v>760</c:v>
                </c:pt>
                <c:pt idx="21">
                  <c:v>758</c:v>
                </c:pt>
                <c:pt idx="22">
                  <c:v>756</c:v>
                </c:pt>
                <c:pt idx="23">
                  <c:v>754</c:v>
                </c:pt>
                <c:pt idx="24">
                  <c:v>752</c:v>
                </c:pt>
                <c:pt idx="25">
                  <c:v>750</c:v>
                </c:pt>
                <c:pt idx="26">
                  <c:v>748</c:v>
                </c:pt>
                <c:pt idx="27">
                  <c:v>746</c:v>
                </c:pt>
                <c:pt idx="28">
                  <c:v>744</c:v>
                </c:pt>
                <c:pt idx="29">
                  <c:v>742</c:v>
                </c:pt>
                <c:pt idx="30">
                  <c:v>740</c:v>
                </c:pt>
                <c:pt idx="31">
                  <c:v>738</c:v>
                </c:pt>
                <c:pt idx="32">
                  <c:v>736</c:v>
                </c:pt>
                <c:pt idx="33">
                  <c:v>734</c:v>
                </c:pt>
                <c:pt idx="34">
                  <c:v>732</c:v>
                </c:pt>
                <c:pt idx="35">
                  <c:v>730</c:v>
                </c:pt>
                <c:pt idx="36">
                  <c:v>728</c:v>
                </c:pt>
                <c:pt idx="37">
                  <c:v>726</c:v>
                </c:pt>
                <c:pt idx="38">
                  <c:v>724</c:v>
                </c:pt>
                <c:pt idx="39">
                  <c:v>722</c:v>
                </c:pt>
                <c:pt idx="40">
                  <c:v>720</c:v>
                </c:pt>
                <c:pt idx="41">
                  <c:v>718</c:v>
                </c:pt>
                <c:pt idx="42">
                  <c:v>716</c:v>
                </c:pt>
                <c:pt idx="43">
                  <c:v>714</c:v>
                </c:pt>
                <c:pt idx="44">
                  <c:v>712</c:v>
                </c:pt>
                <c:pt idx="45">
                  <c:v>710</c:v>
                </c:pt>
                <c:pt idx="46">
                  <c:v>708</c:v>
                </c:pt>
                <c:pt idx="47">
                  <c:v>706</c:v>
                </c:pt>
                <c:pt idx="48">
                  <c:v>704</c:v>
                </c:pt>
                <c:pt idx="49">
                  <c:v>702</c:v>
                </c:pt>
                <c:pt idx="50">
                  <c:v>700</c:v>
                </c:pt>
                <c:pt idx="51">
                  <c:v>698</c:v>
                </c:pt>
                <c:pt idx="52">
                  <c:v>696</c:v>
                </c:pt>
                <c:pt idx="53">
                  <c:v>694</c:v>
                </c:pt>
                <c:pt idx="54">
                  <c:v>692</c:v>
                </c:pt>
                <c:pt idx="55">
                  <c:v>690</c:v>
                </c:pt>
                <c:pt idx="56">
                  <c:v>688</c:v>
                </c:pt>
                <c:pt idx="57">
                  <c:v>686</c:v>
                </c:pt>
                <c:pt idx="58">
                  <c:v>684</c:v>
                </c:pt>
                <c:pt idx="59">
                  <c:v>682</c:v>
                </c:pt>
                <c:pt idx="60">
                  <c:v>680</c:v>
                </c:pt>
                <c:pt idx="61">
                  <c:v>678</c:v>
                </c:pt>
                <c:pt idx="62">
                  <c:v>676</c:v>
                </c:pt>
                <c:pt idx="63">
                  <c:v>674</c:v>
                </c:pt>
                <c:pt idx="64">
                  <c:v>672</c:v>
                </c:pt>
                <c:pt idx="65">
                  <c:v>670</c:v>
                </c:pt>
                <c:pt idx="66">
                  <c:v>668</c:v>
                </c:pt>
                <c:pt idx="67">
                  <c:v>666</c:v>
                </c:pt>
                <c:pt idx="68">
                  <c:v>664</c:v>
                </c:pt>
                <c:pt idx="69">
                  <c:v>662</c:v>
                </c:pt>
                <c:pt idx="70">
                  <c:v>660</c:v>
                </c:pt>
                <c:pt idx="71">
                  <c:v>658</c:v>
                </c:pt>
                <c:pt idx="72">
                  <c:v>656</c:v>
                </c:pt>
                <c:pt idx="73">
                  <c:v>654</c:v>
                </c:pt>
                <c:pt idx="74">
                  <c:v>652</c:v>
                </c:pt>
                <c:pt idx="75">
                  <c:v>650</c:v>
                </c:pt>
                <c:pt idx="76">
                  <c:v>648</c:v>
                </c:pt>
                <c:pt idx="77">
                  <c:v>646</c:v>
                </c:pt>
                <c:pt idx="78">
                  <c:v>644</c:v>
                </c:pt>
                <c:pt idx="79">
                  <c:v>642</c:v>
                </c:pt>
                <c:pt idx="80">
                  <c:v>640</c:v>
                </c:pt>
                <c:pt idx="81">
                  <c:v>638</c:v>
                </c:pt>
                <c:pt idx="82">
                  <c:v>636</c:v>
                </c:pt>
                <c:pt idx="83">
                  <c:v>634</c:v>
                </c:pt>
                <c:pt idx="84">
                  <c:v>632</c:v>
                </c:pt>
                <c:pt idx="85">
                  <c:v>630</c:v>
                </c:pt>
                <c:pt idx="86">
                  <c:v>628</c:v>
                </c:pt>
                <c:pt idx="87">
                  <c:v>626</c:v>
                </c:pt>
                <c:pt idx="88">
                  <c:v>624</c:v>
                </c:pt>
                <c:pt idx="89">
                  <c:v>622</c:v>
                </c:pt>
                <c:pt idx="90">
                  <c:v>620</c:v>
                </c:pt>
                <c:pt idx="91">
                  <c:v>618</c:v>
                </c:pt>
                <c:pt idx="92">
                  <c:v>616</c:v>
                </c:pt>
                <c:pt idx="93">
                  <c:v>614</c:v>
                </c:pt>
                <c:pt idx="94">
                  <c:v>612</c:v>
                </c:pt>
                <c:pt idx="95">
                  <c:v>610</c:v>
                </c:pt>
                <c:pt idx="96">
                  <c:v>608</c:v>
                </c:pt>
                <c:pt idx="97">
                  <c:v>606</c:v>
                </c:pt>
                <c:pt idx="98">
                  <c:v>604</c:v>
                </c:pt>
                <c:pt idx="99">
                  <c:v>602</c:v>
                </c:pt>
                <c:pt idx="100">
                  <c:v>600</c:v>
                </c:pt>
                <c:pt idx="101">
                  <c:v>598</c:v>
                </c:pt>
                <c:pt idx="102">
                  <c:v>596</c:v>
                </c:pt>
                <c:pt idx="103">
                  <c:v>594</c:v>
                </c:pt>
                <c:pt idx="104">
                  <c:v>592</c:v>
                </c:pt>
                <c:pt idx="105">
                  <c:v>590</c:v>
                </c:pt>
                <c:pt idx="106">
                  <c:v>588</c:v>
                </c:pt>
                <c:pt idx="107">
                  <c:v>586</c:v>
                </c:pt>
                <c:pt idx="108">
                  <c:v>584</c:v>
                </c:pt>
                <c:pt idx="109">
                  <c:v>582</c:v>
                </c:pt>
                <c:pt idx="110">
                  <c:v>580</c:v>
                </c:pt>
                <c:pt idx="111">
                  <c:v>578</c:v>
                </c:pt>
                <c:pt idx="112">
                  <c:v>576</c:v>
                </c:pt>
                <c:pt idx="113">
                  <c:v>574</c:v>
                </c:pt>
                <c:pt idx="114">
                  <c:v>572</c:v>
                </c:pt>
                <c:pt idx="115">
                  <c:v>570</c:v>
                </c:pt>
                <c:pt idx="116">
                  <c:v>568</c:v>
                </c:pt>
                <c:pt idx="117">
                  <c:v>566</c:v>
                </c:pt>
                <c:pt idx="118">
                  <c:v>564</c:v>
                </c:pt>
                <c:pt idx="119">
                  <c:v>562</c:v>
                </c:pt>
                <c:pt idx="120">
                  <c:v>560</c:v>
                </c:pt>
                <c:pt idx="121">
                  <c:v>558</c:v>
                </c:pt>
                <c:pt idx="122">
                  <c:v>556</c:v>
                </c:pt>
                <c:pt idx="123">
                  <c:v>554</c:v>
                </c:pt>
                <c:pt idx="124">
                  <c:v>552</c:v>
                </c:pt>
                <c:pt idx="125">
                  <c:v>550</c:v>
                </c:pt>
                <c:pt idx="126">
                  <c:v>548</c:v>
                </c:pt>
                <c:pt idx="127">
                  <c:v>546</c:v>
                </c:pt>
                <c:pt idx="128">
                  <c:v>544</c:v>
                </c:pt>
                <c:pt idx="129">
                  <c:v>542</c:v>
                </c:pt>
                <c:pt idx="130">
                  <c:v>540</c:v>
                </c:pt>
                <c:pt idx="131">
                  <c:v>538</c:v>
                </c:pt>
                <c:pt idx="132">
                  <c:v>536</c:v>
                </c:pt>
                <c:pt idx="133">
                  <c:v>534</c:v>
                </c:pt>
                <c:pt idx="134">
                  <c:v>532</c:v>
                </c:pt>
                <c:pt idx="135">
                  <c:v>530</c:v>
                </c:pt>
                <c:pt idx="136">
                  <c:v>528</c:v>
                </c:pt>
                <c:pt idx="137">
                  <c:v>526</c:v>
                </c:pt>
                <c:pt idx="138">
                  <c:v>524</c:v>
                </c:pt>
                <c:pt idx="139">
                  <c:v>522</c:v>
                </c:pt>
                <c:pt idx="140">
                  <c:v>520</c:v>
                </c:pt>
                <c:pt idx="141">
                  <c:v>518</c:v>
                </c:pt>
                <c:pt idx="142">
                  <c:v>516</c:v>
                </c:pt>
                <c:pt idx="143">
                  <c:v>514</c:v>
                </c:pt>
                <c:pt idx="144">
                  <c:v>512</c:v>
                </c:pt>
                <c:pt idx="145">
                  <c:v>510</c:v>
                </c:pt>
                <c:pt idx="146">
                  <c:v>508</c:v>
                </c:pt>
                <c:pt idx="147">
                  <c:v>506</c:v>
                </c:pt>
                <c:pt idx="148">
                  <c:v>504</c:v>
                </c:pt>
                <c:pt idx="149">
                  <c:v>502</c:v>
                </c:pt>
                <c:pt idx="150">
                  <c:v>500</c:v>
                </c:pt>
                <c:pt idx="151">
                  <c:v>498</c:v>
                </c:pt>
                <c:pt idx="152">
                  <c:v>496</c:v>
                </c:pt>
                <c:pt idx="153">
                  <c:v>494</c:v>
                </c:pt>
                <c:pt idx="154">
                  <c:v>492</c:v>
                </c:pt>
                <c:pt idx="155">
                  <c:v>490</c:v>
                </c:pt>
                <c:pt idx="156">
                  <c:v>488</c:v>
                </c:pt>
                <c:pt idx="157">
                  <c:v>486</c:v>
                </c:pt>
                <c:pt idx="158">
                  <c:v>484</c:v>
                </c:pt>
                <c:pt idx="159">
                  <c:v>482</c:v>
                </c:pt>
                <c:pt idx="160">
                  <c:v>480</c:v>
                </c:pt>
                <c:pt idx="161">
                  <c:v>478</c:v>
                </c:pt>
                <c:pt idx="162">
                  <c:v>476</c:v>
                </c:pt>
                <c:pt idx="163">
                  <c:v>474</c:v>
                </c:pt>
                <c:pt idx="164">
                  <c:v>472</c:v>
                </c:pt>
                <c:pt idx="165">
                  <c:v>470</c:v>
                </c:pt>
                <c:pt idx="166">
                  <c:v>468</c:v>
                </c:pt>
                <c:pt idx="167">
                  <c:v>466</c:v>
                </c:pt>
                <c:pt idx="168">
                  <c:v>464</c:v>
                </c:pt>
                <c:pt idx="169">
                  <c:v>462</c:v>
                </c:pt>
                <c:pt idx="170">
                  <c:v>460</c:v>
                </c:pt>
                <c:pt idx="171">
                  <c:v>458</c:v>
                </c:pt>
                <c:pt idx="172">
                  <c:v>456</c:v>
                </c:pt>
                <c:pt idx="173">
                  <c:v>454</c:v>
                </c:pt>
                <c:pt idx="174">
                  <c:v>452</c:v>
                </c:pt>
                <c:pt idx="175">
                  <c:v>450</c:v>
                </c:pt>
                <c:pt idx="176">
                  <c:v>448</c:v>
                </c:pt>
                <c:pt idx="177">
                  <c:v>446</c:v>
                </c:pt>
                <c:pt idx="178">
                  <c:v>444</c:v>
                </c:pt>
                <c:pt idx="179">
                  <c:v>442</c:v>
                </c:pt>
                <c:pt idx="180">
                  <c:v>440</c:v>
                </c:pt>
                <c:pt idx="181">
                  <c:v>438</c:v>
                </c:pt>
                <c:pt idx="182">
                  <c:v>436</c:v>
                </c:pt>
                <c:pt idx="183">
                  <c:v>434</c:v>
                </c:pt>
                <c:pt idx="184">
                  <c:v>432</c:v>
                </c:pt>
                <c:pt idx="185">
                  <c:v>430</c:v>
                </c:pt>
                <c:pt idx="186">
                  <c:v>428</c:v>
                </c:pt>
                <c:pt idx="187">
                  <c:v>426</c:v>
                </c:pt>
                <c:pt idx="188">
                  <c:v>424</c:v>
                </c:pt>
                <c:pt idx="189">
                  <c:v>422</c:v>
                </c:pt>
                <c:pt idx="190">
                  <c:v>420</c:v>
                </c:pt>
                <c:pt idx="191">
                  <c:v>418</c:v>
                </c:pt>
                <c:pt idx="192">
                  <c:v>416</c:v>
                </c:pt>
                <c:pt idx="193">
                  <c:v>414</c:v>
                </c:pt>
                <c:pt idx="194">
                  <c:v>412</c:v>
                </c:pt>
                <c:pt idx="195">
                  <c:v>410</c:v>
                </c:pt>
                <c:pt idx="196">
                  <c:v>408</c:v>
                </c:pt>
                <c:pt idx="197">
                  <c:v>406</c:v>
                </c:pt>
                <c:pt idx="198">
                  <c:v>404</c:v>
                </c:pt>
                <c:pt idx="199">
                  <c:v>402</c:v>
                </c:pt>
                <c:pt idx="200">
                  <c:v>400</c:v>
                </c:pt>
                <c:pt idx="201">
                  <c:v>398</c:v>
                </c:pt>
                <c:pt idx="202">
                  <c:v>396</c:v>
                </c:pt>
                <c:pt idx="203">
                  <c:v>394</c:v>
                </c:pt>
                <c:pt idx="204">
                  <c:v>392</c:v>
                </c:pt>
                <c:pt idx="205">
                  <c:v>390</c:v>
                </c:pt>
                <c:pt idx="206">
                  <c:v>388</c:v>
                </c:pt>
                <c:pt idx="207">
                  <c:v>386</c:v>
                </c:pt>
                <c:pt idx="208">
                  <c:v>384</c:v>
                </c:pt>
                <c:pt idx="209">
                  <c:v>382</c:v>
                </c:pt>
                <c:pt idx="210">
                  <c:v>380</c:v>
                </c:pt>
                <c:pt idx="211">
                  <c:v>378</c:v>
                </c:pt>
                <c:pt idx="212">
                  <c:v>376</c:v>
                </c:pt>
                <c:pt idx="213">
                  <c:v>374</c:v>
                </c:pt>
                <c:pt idx="214">
                  <c:v>372</c:v>
                </c:pt>
                <c:pt idx="215">
                  <c:v>370</c:v>
                </c:pt>
                <c:pt idx="216">
                  <c:v>368</c:v>
                </c:pt>
                <c:pt idx="217">
                  <c:v>366</c:v>
                </c:pt>
                <c:pt idx="218">
                  <c:v>364</c:v>
                </c:pt>
                <c:pt idx="219">
                  <c:v>362</c:v>
                </c:pt>
                <c:pt idx="220">
                  <c:v>360</c:v>
                </c:pt>
                <c:pt idx="221">
                  <c:v>358</c:v>
                </c:pt>
                <c:pt idx="222">
                  <c:v>356</c:v>
                </c:pt>
                <c:pt idx="223">
                  <c:v>354</c:v>
                </c:pt>
                <c:pt idx="224">
                  <c:v>352</c:v>
                </c:pt>
                <c:pt idx="225">
                  <c:v>350</c:v>
                </c:pt>
                <c:pt idx="226">
                  <c:v>348</c:v>
                </c:pt>
                <c:pt idx="227">
                  <c:v>346</c:v>
                </c:pt>
                <c:pt idx="228">
                  <c:v>344</c:v>
                </c:pt>
                <c:pt idx="229">
                  <c:v>342</c:v>
                </c:pt>
                <c:pt idx="230">
                  <c:v>340</c:v>
                </c:pt>
                <c:pt idx="231">
                  <c:v>338</c:v>
                </c:pt>
                <c:pt idx="232">
                  <c:v>336</c:v>
                </c:pt>
                <c:pt idx="233">
                  <c:v>334</c:v>
                </c:pt>
                <c:pt idx="234">
                  <c:v>332</c:v>
                </c:pt>
                <c:pt idx="235">
                  <c:v>330</c:v>
                </c:pt>
                <c:pt idx="236">
                  <c:v>328</c:v>
                </c:pt>
                <c:pt idx="237">
                  <c:v>326</c:v>
                </c:pt>
                <c:pt idx="238">
                  <c:v>324</c:v>
                </c:pt>
                <c:pt idx="239">
                  <c:v>322</c:v>
                </c:pt>
                <c:pt idx="240">
                  <c:v>320</c:v>
                </c:pt>
                <c:pt idx="241">
                  <c:v>318</c:v>
                </c:pt>
                <c:pt idx="242">
                  <c:v>316</c:v>
                </c:pt>
                <c:pt idx="243">
                  <c:v>314</c:v>
                </c:pt>
                <c:pt idx="244">
                  <c:v>312</c:v>
                </c:pt>
                <c:pt idx="245">
                  <c:v>310</c:v>
                </c:pt>
                <c:pt idx="246">
                  <c:v>308</c:v>
                </c:pt>
                <c:pt idx="247">
                  <c:v>306</c:v>
                </c:pt>
                <c:pt idx="248">
                  <c:v>304</c:v>
                </c:pt>
                <c:pt idx="249">
                  <c:v>302</c:v>
                </c:pt>
                <c:pt idx="250">
                  <c:v>300</c:v>
                </c:pt>
                <c:pt idx="251">
                  <c:v>298</c:v>
                </c:pt>
                <c:pt idx="252">
                  <c:v>296</c:v>
                </c:pt>
                <c:pt idx="253">
                  <c:v>294</c:v>
                </c:pt>
                <c:pt idx="254">
                  <c:v>292</c:v>
                </c:pt>
                <c:pt idx="255">
                  <c:v>290</c:v>
                </c:pt>
                <c:pt idx="256">
                  <c:v>288</c:v>
                </c:pt>
                <c:pt idx="257">
                  <c:v>286</c:v>
                </c:pt>
                <c:pt idx="258">
                  <c:v>284</c:v>
                </c:pt>
                <c:pt idx="259">
                  <c:v>282</c:v>
                </c:pt>
                <c:pt idx="260">
                  <c:v>280</c:v>
                </c:pt>
                <c:pt idx="261">
                  <c:v>278</c:v>
                </c:pt>
                <c:pt idx="262">
                  <c:v>276</c:v>
                </c:pt>
                <c:pt idx="263">
                  <c:v>274</c:v>
                </c:pt>
                <c:pt idx="264">
                  <c:v>272</c:v>
                </c:pt>
                <c:pt idx="265">
                  <c:v>270</c:v>
                </c:pt>
                <c:pt idx="266">
                  <c:v>268</c:v>
                </c:pt>
                <c:pt idx="267">
                  <c:v>266</c:v>
                </c:pt>
                <c:pt idx="268">
                  <c:v>264</c:v>
                </c:pt>
                <c:pt idx="269">
                  <c:v>262</c:v>
                </c:pt>
                <c:pt idx="270">
                  <c:v>260</c:v>
                </c:pt>
                <c:pt idx="271">
                  <c:v>258</c:v>
                </c:pt>
                <c:pt idx="272">
                  <c:v>256</c:v>
                </c:pt>
                <c:pt idx="273">
                  <c:v>254</c:v>
                </c:pt>
                <c:pt idx="274">
                  <c:v>252</c:v>
                </c:pt>
                <c:pt idx="275">
                  <c:v>250</c:v>
                </c:pt>
                <c:pt idx="276">
                  <c:v>248</c:v>
                </c:pt>
                <c:pt idx="277">
                  <c:v>246</c:v>
                </c:pt>
                <c:pt idx="278">
                  <c:v>244</c:v>
                </c:pt>
                <c:pt idx="279">
                  <c:v>242</c:v>
                </c:pt>
                <c:pt idx="280">
                  <c:v>240</c:v>
                </c:pt>
                <c:pt idx="281">
                  <c:v>238</c:v>
                </c:pt>
                <c:pt idx="282">
                  <c:v>236</c:v>
                </c:pt>
                <c:pt idx="283">
                  <c:v>234</c:v>
                </c:pt>
                <c:pt idx="284">
                  <c:v>232</c:v>
                </c:pt>
                <c:pt idx="285">
                  <c:v>230</c:v>
                </c:pt>
                <c:pt idx="286">
                  <c:v>228</c:v>
                </c:pt>
                <c:pt idx="287">
                  <c:v>226</c:v>
                </c:pt>
                <c:pt idx="288">
                  <c:v>224</c:v>
                </c:pt>
                <c:pt idx="289">
                  <c:v>222</c:v>
                </c:pt>
                <c:pt idx="290">
                  <c:v>220</c:v>
                </c:pt>
                <c:pt idx="291">
                  <c:v>218</c:v>
                </c:pt>
                <c:pt idx="292">
                  <c:v>216</c:v>
                </c:pt>
                <c:pt idx="293">
                  <c:v>214</c:v>
                </c:pt>
                <c:pt idx="294">
                  <c:v>212</c:v>
                </c:pt>
                <c:pt idx="295">
                  <c:v>210</c:v>
                </c:pt>
                <c:pt idx="296">
                  <c:v>208</c:v>
                </c:pt>
                <c:pt idx="297">
                  <c:v>206</c:v>
                </c:pt>
                <c:pt idx="298">
                  <c:v>204</c:v>
                </c:pt>
                <c:pt idx="299">
                  <c:v>202</c:v>
                </c:pt>
                <c:pt idx="300">
                  <c:v>200</c:v>
                </c:pt>
              </c:numCache>
            </c:numRef>
          </c:xVal>
          <c:yVal>
            <c:numRef>
              <c:f>Feuil1!$F$3:$F$303</c:f>
              <c:numCache>
                <c:formatCode>General</c:formatCode>
                <c:ptCount val="301"/>
                <c:pt idx="0">
                  <c:v>1.5049999999999999E-2</c:v>
                </c:pt>
                <c:pt idx="1">
                  <c:v>1.7069999999999998E-2</c:v>
                </c:pt>
                <c:pt idx="2">
                  <c:v>1.7340000000000001E-2</c:v>
                </c:pt>
                <c:pt idx="3">
                  <c:v>1.6369999999999999E-2</c:v>
                </c:pt>
                <c:pt idx="4">
                  <c:v>1.6150000000000001E-2</c:v>
                </c:pt>
                <c:pt idx="5">
                  <c:v>1.7250000000000001E-2</c:v>
                </c:pt>
                <c:pt idx="6">
                  <c:v>1.6629999999999999E-2</c:v>
                </c:pt>
                <c:pt idx="7">
                  <c:v>1.519E-2</c:v>
                </c:pt>
                <c:pt idx="8">
                  <c:v>1.8700000000000001E-2</c:v>
                </c:pt>
                <c:pt idx="9">
                  <c:v>2.2939999999999999E-2</c:v>
                </c:pt>
                <c:pt idx="10">
                  <c:v>2.1080000000000002E-2</c:v>
                </c:pt>
                <c:pt idx="11">
                  <c:v>1.46E-2</c:v>
                </c:pt>
                <c:pt idx="12">
                  <c:v>1.436E-2</c:v>
                </c:pt>
                <c:pt idx="13">
                  <c:v>1.042E-2</c:v>
                </c:pt>
                <c:pt idx="14">
                  <c:v>1.2500000000000001E-2</c:v>
                </c:pt>
                <c:pt idx="15">
                  <c:v>1.5089999999999999E-2</c:v>
                </c:pt>
                <c:pt idx="16">
                  <c:v>1.4919999999999999E-2</c:v>
                </c:pt>
                <c:pt idx="17">
                  <c:v>2.1010000000000001E-2</c:v>
                </c:pt>
                <c:pt idx="18">
                  <c:v>1.6760000000000001E-2</c:v>
                </c:pt>
                <c:pt idx="19">
                  <c:v>2.145E-2</c:v>
                </c:pt>
                <c:pt idx="20">
                  <c:v>1.4760000000000001E-2</c:v>
                </c:pt>
                <c:pt idx="21">
                  <c:v>1.856E-2</c:v>
                </c:pt>
                <c:pt idx="22">
                  <c:v>1.508E-2</c:v>
                </c:pt>
                <c:pt idx="23">
                  <c:v>2.2040000000000001E-2</c:v>
                </c:pt>
                <c:pt idx="24">
                  <c:v>1.9290000000000002E-2</c:v>
                </c:pt>
                <c:pt idx="25">
                  <c:v>1.7520000000000001E-2</c:v>
                </c:pt>
                <c:pt idx="26">
                  <c:v>2.4969999999999999E-2</c:v>
                </c:pt>
                <c:pt idx="27">
                  <c:v>1.6930000000000001E-2</c:v>
                </c:pt>
                <c:pt idx="28">
                  <c:v>2.1399999999999999E-2</c:v>
                </c:pt>
                <c:pt idx="29">
                  <c:v>2.1440000000000001E-2</c:v>
                </c:pt>
                <c:pt idx="30">
                  <c:v>2.1999999999999999E-2</c:v>
                </c:pt>
                <c:pt idx="31">
                  <c:v>2.0060000000000001E-2</c:v>
                </c:pt>
                <c:pt idx="32">
                  <c:v>1.4579999999999999E-2</c:v>
                </c:pt>
                <c:pt idx="33">
                  <c:v>1.804E-2</c:v>
                </c:pt>
                <c:pt idx="34">
                  <c:v>2.383E-2</c:v>
                </c:pt>
                <c:pt idx="35">
                  <c:v>2.5139999999999999E-2</c:v>
                </c:pt>
                <c:pt idx="36">
                  <c:v>2.3E-2</c:v>
                </c:pt>
                <c:pt idx="37">
                  <c:v>2.0799999999999999E-2</c:v>
                </c:pt>
                <c:pt idx="38">
                  <c:v>1.9290000000000002E-2</c:v>
                </c:pt>
                <c:pt idx="39">
                  <c:v>1.78E-2</c:v>
                </c:pt>
                <c:pt idx="40">
                  <c:v>2.0140000000000002E-2</c:v>
                </c:pt>
                <c:pt idx="41">
                  <c:v>2.435E-2</c:v>
                </c:pt>
                <c:pt idx="42">
                  <c:v>2.1760000000000002E-2</c:v>
                </c:pt>
                <c:pt idx="43">
                  <c:v>2.0240000000000001E-2</c:v>
                </c:pt>
                <c:pt idx="44">
                  <c:v>2.163E-2</c:v>
                </c:pt>
                <c:pt idx="45">
                  <c:v>2.7529999999999999E-2</c:v>
                </c:pt>
                <c:pt idx="46">
                  <c:v>2.734E-2</c:v>
                </c:pt>
                <c:pt idx="47">
                  <c:v>2.0119999999999999E-2</c:v>
                </c:pt>
                <c:pt idx="48">
                  <c:v>2.198E-2</c:v>
                </c:pt>
                <c:pt idx="49">
                  <c:v>2.691E-2</c:v>
                </c:pt>
                <c:pt idx="50">
                  <c:v>2.4889999999999999E-2</c:v>
                </c:pt>
                <c:pt idx="51">
                  <c:v>2.7230000000000001E-2</c:v>
                </c:pt>
                <c:pt idx="52">
                  <c:v>2.6040000000000001E-2</c:v>
                </c:pt>
                <c:pt idx="53">
                  <c:v>2.334E-2</c:v>
                </c:pt>
                <c:pt idx="54">
                  <c:v>2.8000000000000001E-2</c:v>
                </c:pt>
                <c:pt idx="55">
                  <c:v>2.299E-2</c:v>
                </c:pt>
                <c:pt idx="56">
                  <c:v>2.946E-2</c:v>
                </c:pt>
                <c:pt idx="57">
                  <c:v>2.7740000000000001E-2</c:v>
                </c:pt>
                <c:pt idx="58">
                  <c:v>2.93E-2</c:v>
                </c:pt>
                <c:pt idx="59">
                  <c:v>3.015E-2</c:v>
                </c:pt>
                <c:pt idx="60">
                  <c:v>3.0849999999999999E-2</c:v>
                </c:pt>
                <c:pt idx="61">
                  <c:v>2.8830000000000001E-2</c:v>
                </c:pt>
                <c:pt idx="62">
                  <c:v>2.896E-2</c:v>
                </c:pt>
                <c:pt idx="63">
                  <c:v>3.1879999999999999E-2</c:v>
                </c:pt>
                <c:pt idx="64">
                  <c:v>3.0689999999999999E-2</c:v>
                </c:pt>
                <c:pt idx="65">
                  <c:v>3.4759999999999999E-2</c:v>
                </c:pt>
                <c:pt idx="66">
                  <c:v>3.7519999999999998E-2</c:v>
                </c:pt>
                <c:pt idx="67">
                  <c:v>3.5139999999999998E-2</c:v>
                </c:pt>
                <c:pt idx="68">
                  <c:v>3.678E-2</c:v>
                </c:pt>
                <c:pt idx="69">
                  <c:v>3.5110000000000002E-2</c:v>
                </c:pt>
                <c:pt idx="70">
                  <c:v>3.7600000000000001E-2</c:v>
                </c:pt>
                <c:pt idx="71">
                  <c:v>3.7170000000000002E-2</c:v>
                </c:pt>
                <c:pt idx="72">
                  <c:v>3.721E-2</c:v>
                </c:pt>
                <c:pt idx="73">
                  <c:v>4.2299999999999997E-2</c:v>
                </c:pt>
                <c:pt idx="74">
                  <c:v>3.8920000000000003E-2</c:v>
                </c:pt>
                <c:pt idx="75">
                  <c:v>4.0899999999999999E-2</c:v>
                </c:pt>
                <c:pt idx="76">
                  <c:v>4.1200000000000001E-2</c:v>
                </c:pt>
                <c:pt idx="77">
                  <c:v>4.4299999999999999E-2</c:v>
                </c:pt>
                <c:pt idx="78">
                  <c:v>4.4970000000000003E-2</c:v>
                </c:pt>
                <c:pt idx="79">
                  <c:v>4.8070000000000002E-2</c:v>
                </c:pt>
                <c:pt idx="80">
                  <c:v>4.8219999999999999E-2</c:v>
                </c:pt>
                <c:pt idx="81">
                  <c:v>4.725E-2</c:v>
                </c:pt>
                <c:pt idx="82">
                  <c:v>5.1299999999999998E-2</c:v>
                </c:pt>
                <c:pt idx="83">
                  <c:v>4.861E-2</c:v>
                </c:pt>
                <c:pt idx="84">
                  <c:v>5.1990000000000001E-2</c:v>
                </c:pt>
                <c:pt idx="85">
                  <c:v>5.2229999999999999E-2</c:v>
                </c:pt>
                <c:pt idx="86">
                  <c:v>5.5100000000000003E-2</c:v>
                </c:pt>
                <c:pt idx="87">
                  <c:v>5.8049999999999997E-2</c:v>
                </c:pt>
                <c:pt idx="88">
                  <c:v>5.8869999999999999E-2</c:v>
                </c:pt>
                <c:pt idx="89">
                  <c:v>5.8040000000000001E-2</c:v>
                </c:pt>
                <c:pt idx="90">
                  <c:v>5.7140000000000003E-2</c:v>
                </c:pt>
                <c:pt idx="91">
                  <c:v>6.0859999999999997E-2</c:v>
                </c:pt>
                <c:pt idx="92">
                  <c:v>6.1199999999999997E-2</c:v>
                </c:pt>
                <c:pt idx="93">
                  <c:v>6.4960000000000004E-2</c:v>
                </c:pt>
                <c:pt idx="94">
                  <c:v>6.6059999999999994E-2</c:v>
                </c:pt>
                <c:pt idx="95">
                  <c:v>6.6000000000000003E-2</c:v>
                </c:pt>
                <c:pt idx="96">
                  <c:v>6.7900000000000002E-2</c:v>
                </c:pt>
                <c:pt idx="97">
                  <c:v>7.2120000000000004E-2</c:v>
                </c:pt>
                <c:pt idx="98">
                  <c:v>7.0669999999999997E-2</c:v>
                </c:pt>
                <c:pt idx="99">
                  <c:v>7.4190000000000006E-2</c:v>
                </c:pt>
                <c:pt idx="100">
                  <c:v>7.3050000000000004E-2</c:v>
                </c:pt>
                <c:pt idx="101">
                  <c:v>7.7939999999999995E-2</c:v>
                </c:pt>
                <c:pt idx="102">
                  <c:v>7.9250000000000001E-2</c:v>
                </c:pt>
                <c:pt idx="103">
                  <c:v>7.8979999999999995E-2</c:v>
                </c:pt>
                <c:pt idx="104">
                  <c:v>8.2680000000000003E-2</c:v>
                </c:pt>
                <c:pt idx="105">
                  <c:v>8.2780000000000006E-2</c:v>
                </c:pt>
                <c:pt idx="106">
                  <c:v>8.6499999999999994E-2</c:v>
                </c:pt>
                <c:pt idx="107">
                  <c:v>8.8429999999999995E-2</c:v>
                </c:pt>
                <c:pt idx="108">
                  <c:v>9.1569999999999999E-2</c:v>
                </c:pt>
                <c:pt idx="109">
                  <c:v>9.0469999999999995E-2</c:v>
                </c:pt>
                <c:pt idx="110">
                  <c:v>9.4130000000000005E-2</c:v>
                </c:pt>
                <c:pt idx="111">
                  <c:v>9.8760000000000001E-2</c:v>
                </c:pt>
                <c:pt idx="112">
                  <c:v>0.10011</c:v>
                </c:pt>
                <c:pt idx="113">
                  <c:v>0.10208</c:v>
                </c:pt>
                <c:pt idx="114">
                  <c:v>0.10456</c:v>
                </c:pt>
                <c:pt idx="115">
                  <c:v>0.10727</c:v>
                </c:pt>
                <c:pt idx="116">
                  <c:v>0.10956</c:v>
                </c:pt>
                <c:pt idx="117">
                  <c:v>0.11101</c:v>
                </c:pt>
                <c:pt idx="118">
                  <c:v>0.11484</c:v>
                </c:pt>
                <c:pt idx="119">
                  <c:v>0.11922000000000001</c:v>
                </c:pt>
                <c:pt idx="120">
                  <c:v>0.11974</c:v>
                </c:pt>
                <c:pt idx="121">
                  <c:v>0.12245</c:v>
                </c:pt>
                <c:pt idx="122">
                  <c:v>0.12723999999999999</c:v>
                </c:pt>
                <c:pt idx="123">
                  <c:v>0.13006999999999999</c:v>
                </c:pt>
                <c:pt idx="124">
                  <c:v>0.13324</c:v>
                </c:pt>
                <c:pt idx="125">
                  <c:v>0.13832</c:v>
                </c:pt>
                <c:pt idx="126">
                  <c:v>0.14224000000000001</c:v>
                </c:pt>
                <c:pt idx="127">
                  <c:v>0.14446999999999999</c:v>
                </c:pt>
                <c:pt idx="128">
                  <c:v>0.14888000000000001</c:v>
                </c:pt>
                <c:pt idx="129">
                  <c:v>0.15315999999999999</c:v>
                </c:pt>
                <c:pt idx="130">
                  <c:v>0.15778</c:v>
                </c:pt>
                <c:pt idx="131">
                  <c:v>0.16152</c:v>
                </c:pt>
                <c:pt idx="132">
                  <c:v>0.16635</c:v>
                </c:pt>
                <c:pt idx="133">
                  <c:v>0.17129</c:v>
                </c:pt>
                <c:pt idx="134">
                  <c:v>0.17577999999999999</c:v>
                </c:pt>
                <c:pt idx="135">
                  <c:v>0.18179000000000001</c:v>
                </c:pt>
                <c:pt idx="136">
                  <c:v>0.18589</c:v>
                </c:pt>
                <c:pt idx="137">
                  <c:v>0.19137999999999999</c:v>
                </c:pt>
                <c:pt idx="138">
                  <c:v>0.19782</c:v>
                </c:pt>
                <c:pt idx="139">
                  <c:v>0.20258000000000001</c:v>
                </c:pt>
                <c:pt idx="140">
                  <c:v>0.21015</c:v>
                </c:pt>
                <c:pt idx="141">
                  <c:v>0.21543999999999999</c:v>
                </c:pt>
                <c:pt idx="142">
                  <c:v>0.22153</c:v>
                </c:pt>
                <c:pt idx="143">
                  <c:v>0.22755</c:v>
                </c:pt>
                <c:pt idx="144">
                  <c:v>0.23380999999999999</c:v>
                </c:pt>
                <c:pt idx="145">
                  <c:v>0.23971000000000001</c:v>
                </c:pt>
                <c:pt idx="146">
                  <c:v>0.24567</c:v>
                </c:pt>
                <c:pt idx="147">
                  <c:v>0.25394</c:v>
                </c:pt>
                <c:pt idx="148">
                  <c:v>0.26229999999999998</c:v>
                </c:pt>
                <c:pt idx="149">
                  <c:v>0.26867000000000002</c:v>
                </c:pt>
                <c:pt idx="150">
                  <c:v>0.27605000000000002</c:v>
                </c:pt>
                <c:pt idx="151">
                  <c:v>0.28403</c:v>
                </c:pt>
                <c:pt idx="152">
                  <c:v>0.29178999999999999</c:v>
                </c:pt>
                <c:pt idx="153">
                  <c:v>0.30010999999999999</c:v>
                </c:pt>
                <c:pt idx="154">
                  <c:v>0.30703000000000003</c:v>
                </c:pt>
                <c:pt idx="155">
                  <c:v>0.31485000000000002</c:v>
                </c:pt>
                <c:pt idx="156">
                  <c:v>0.32236999999999999</c:v>
                </c:pt>
                <c:pt idx="157">
                  <c:v>0.3301</c:v>
                </c:pt>
                <c:pt idx="158">
                  <c:v>0.33804000000000001</c:v>
                </c:pt>
                <c:pt idx="159">
                  <c:v>0.34516000000000002</c:v>
                </c:pt>
                <c:pt idx="160">
                  <c:v>0.35381000000000001</c:v>
                </c:pt>
                <c:pt idx="161">
                  <c:v>0.3619</c:v>
                </c:pt>
                <c:pt idx="162">
                  <c:v>0.36953999999999998</c:v>
                </c:pt>
                <c:pt idx="163">
                  <c:v>0.37802000000000002</c:v>
                </c:pt>
                <c:pt idx="164">
                  <c:v>0.38621</c:v>
                </c:pt>
                <c:pt idx="165">
                  <c:v>0.39389000000000002</c:v>
                </c:pt>
                <c:pt idx="166">
                  <c:v>0.40179999999999999</c:v>
                </c:pt>
                <c:pt idx="167">
                  <c:v>0.40944999999999998</c:v>
                </c:pt>
                <c:pt idx="168">
                  <c:v>0.41737999999999997</c:v>
                </c:pt>
                <c:pt idx="169">
                  <c:v>0.42627999999999999</c:v>
                </c:pt>
                <c:pt idx="170">
                  <c:v>0.43390000000000001</c:v>
                </c:pt>
                <c:pt idx="171">
                  <c:v>0.44151000000000001</c:v>
                </c:pt>
                <c:pt idx="172">
                  <c:v>0.45051999999999998</c:v>
                </c:pt>
                <c:pt idx="173">
                  <c:v>0.45893</c:v>
                </c:pt>
                <c:pt idx="174">
                  <c:v>0.46650000000000003</c:v>
                </c:pt>
                <c:pt idx="175">
                  <c:v>0.47554000000000002</c:v>
                </c:pt>
                <c:pt idx="176">
                  <c:v>0.48325000000000001</c:v>
                </c:pt>
                <c:pt idx="177">
                  <c:v>0.49123</c:v>
                </c:pt>
                <c:pt idx="178">
                  <c:v>0.50012999999999996</c:v>
                </c:pt>
                <c:pt idx="179">
                  <c:v>0.50882000000000005</c:v>
                </c:pt>
                <c:pt idx="180">
                  <c:v>0.51707000000000003</c:v>
                </c:pt>
                <c:pt idx="181">
                  <c:v>0.52639000000000002</c:v>
                </c:pt>
                <c:pt idx="182">
                  <c:v>0.53527999999999998</c:v>
                </c:pt>
                <c:pt idx="183">
                  <c:v>0.54476999999999998</c:v>
                </c:pt>
                <c:pt idx="184">
                  <c:v>0.55422000000000005</c:v>
                </c:pt>
                <c:pt idx="185">
                  <c:v>0.56403000000000003</c:v>
                </c:pt>
                <c:pt idx="186">
                  <c:v>0.57435999999999998</c:v>
                </c:pt>
                <c:pt idx="187">
                  <c:v>0.58459000000000005</c:v>
                </c:pt>
                <c:pt idx="188">
                  <c:v>0.59455999999999998</c:v>
                </c:pt>
                <c:pt idx="189">
                  <c:v>0.60601000000000005</c:v>
                </c:pt>
                <c:pt idx="190">
                  <c:v>0.61668000000000001</c:v>
                </c:pt>
                <c:pt idx="191">
                  <c:v>0.62780999999999998</c:v>
                </c:pt>
                <c:pt idx="192">
                  <c:v>0.64034999999999997</c:v>
                </c:pt>
                <c:pt idx="193">
                  <c:v>0.65276000000000001</c:v>
                </c:pt>
                <c:pt idx="194">
                  <c:v>0.66405000000000003</c:v>
                </c:pt>
                <c:pt idx="195">
                  <c:v>0.6774</c:v>
                </c:pt>
                <c:pt idx="196">
                  <c:v>0.68996999999999997</c:v>
                </c:pt>
                <c:pt idx="197">
                  <c:v>0.70323999999999998</c:v>
                </c:pt>
                <c:pt idx="198">
                  <c:v>0.71679000000000004</c:v>
                </c:pt>
                <c:pt idx="199">
                  <c:v>0.73070999999999997</c:v>
                </c:pt>
                <c:pt idx="200">
                  <c:v>0.74490999999999996</c:v>
                </c:pt>
                <c:pt idx="201">
                  <c:v>0.76014000000000004</c:v>
                </c:pt>
                <c:pt idx="202">
                  <c:v>0.77593999999999996</c:v>
                </c:pt>
                <c:pt idx="203">
                  <c:v>0.79117000000000004</c:v>
                </c:pt>
                <c:pt idx="204">
                  <c:v>0.80864000000000003</c:v>
                </c:pt>
                <c:pt idx="205">
                  <c:v>0.82550000000000001</c:v>
                </c:pt>
                <c:pt idx="206">
                  <c:v>0.84419999999999995</c:v>
                </c:pt>
                <c:pt idx="207">
                  <c:v>0.86284000000000005</c:v>
                </c:pt>
                <c:pt idx="208">
                  <c:v>0.88290000000000002</c:v>
                </c:pt>
                <c:pt idx="209">
                  <c:v>0.90310000000000001</c:v>
                </c:pt>
                <c:pt idx="210">
                  <c:v>0.92762</c:v>
                </c:pt>
                <c:pt idx="211">
                  <c:v>0.95081000000000004</c:v>
                </c:pt>
                <c:pt idx="212">
                  <c:v>0.97389999999999999</c:v>
                </c:pt>
                <c:pt idx="213">
                  <c:v>1.0012799999999999</c:v>
                </c:pt>
                <c:pt idx="214">
                  <c:v>1.02878</c:v>
                </c:pt>
                <c:pt idx="215">
                  <c:v>1.05884</c:v>
                </c:pt>
                <c:pt idx="216">
                  <c:v>1.08874</c:v>
                </c:pt>
                <c:pt idx="217">
                  <c:v>1.11711</c:v>
                </c:pt>
                <c:pt idx="218">
                  <c:v>1.1520999999999999</c:v>
                </c:pt>
                <c:pt idx="219">
                  <c:v>1.18161</c:v>
                </c:pt>
                <c:pt idx="220">
                  <c:v>1.2115100000000001</c:v>
                </c:pt>
                <c:pt idx="221">
                  <c:v>1.2491399999999999</c:v>
                </c:pt>
                <c:pt idx="222">
                  <c:v>1.28138</c:v>
                </c:pt>
                <c:pt idx="223">
                  <c:v>1.3153300000000001</c:v>
                </c:pt>
                <c:pt idx="224">
                  <c:v>1.3554299999999999</c:v>
                </c:pt>
                <c:pt idx="225">
                  <c:v>1.39411</c:v>
                </c:pt>
                <c:pt idx="226">
                  <c:v>1.4381900000000001</c:v>
                </c:pt>
                <c:pt idx="227">
                  <c:v>1.49491</c:v>
                </c:pt>
                <c:pt idx="228">
                  <c:v>1.54941</c:v>
                </c:pt>
                <c:pt idx="229">
                  <c:v>1.6231</c:v>
                </c:pt>
                <c:pt idx="230">
                  <c:v>1.7248399999999999</c:v>
                </c:pt>
                <c:pt idx="231">
                  <c:v>1.84711</c:v>
                </c:pt>
                <c:pt idx="232">
                  <c:v>2.0216699999999999</c:v>
                </c:pt>
                <c:pt idx="233">
                  <c:v>2.2789700000000002</c:v>
                </c:pt>
                <c:pt idx="234">
                  <c:v>2.5878299999999999</c:v>
                </c:pt>
                <c:pt idx="235">
                  <c:v>2.9167200000000002</c:v>
                </c:pt>
                <c:pt idx="236">
                  <c:v>3.19597</c:v>
                </c:pt>
                <c:pt idx="237">
                  <c:v>3.51532</c:v>
                </c:pt>
                <c:pt idx="238">
                  <c:v>3.3766400000000001</c:v>
                </c:pt>
                <c:pt idx="239">
                  <c:v>3.3872200000000001</c:v>
                </c:pt>
                <c:pt idx="240">
                  <c:v>3.4695</c:v>
                </c:pt>
                <c:pt idx="241">
                  <c:v>3.5060199999999999</c:v>
                </c:pt>
                <c:pt idx="242">
                  <c:v>3.6666400000000001</c:v>
                </c:pt>
                <c:pt idx="243">
                  <c:v>3.85466</c:v>
                </c:pt>
                <c:pt idx="244">
                  <c:v>3.7082799999999998</c:v>
                </c:pt>
                <c:pt idx="245">
                  <c:v>3.8114499999999998</c:v>
                </c:pt>
                <c:pt idx="246">
                  <c:v>4.0556599999999996</c:v>
                </c:pt>
                <c:pt idx="247">
                  <c:v>4.0584899999999999</c:v>
                </c:pt>
                <c:pt idx="248">
                  <c:v>4.0690999999999997</c:v>
                </c:pt>
                <c:pt idx="249">
                  <c:v>4.4164099999999999</c:v>
                </c:pt>
                <c:pt idx="250">
                  <c:v>4.1652800000000001</c:v>
                </c:pt>
                <c:pt idx="251">
                  <c:v>3.9983300000000002</c:v>
                </c:pt>
                <c:pt idx="252">
                  <c:v>4.61456</c:v>
                </c:pt>
                <c:pt idx="253">
                  <c:v>5.0000099999999996</c:v>
                </c:pt>
                <c:pt idx="254">
                  <c:v>3.9496600000000002</c:v>
                </c:pt>
                <c:pt idx="255">
                  <c:v>3.8420800000000002</c:v>
                </c:pt>
                <c:pt idx="256">
                  <c:v>3.7841200000000002</c:v>
                </c:pt>
                <c:pt idx="257">
                  <c:v>3.5737100000000002</c:v>
                </c:pt>
                <c:pt idx="258">
                  <c:v>3.5047999999999999</c:v>
                </c:pt>
                <c:pt idx="259">
                  <c:v>3.2550300000000001</c:v>
                </c:pt>
                <c:pt idx="260">
                  <c:v>3.05159</c:v>
                </c:pt>
                <c:pt idx="261">
                  <c:v>2.84822</c:v>
                </c:pt>
                <c:pt idx="262">
                  <c:v>2.57254</c:v>
                </c:pt>
                <c:pt idx="263">
                  <c:v>2.27217</c:v>
                </c:pt>
                <c:pt idx="264">
                  <c:v>1.97729</c:v>
                </c:pt>
                <c:pt idx="265">
                  <c:v>1.5693699999999999</c:v>
                </c:pt>
                <c:pt idx="266">
                  <c:v>1.16004</c:v>
                </c:pt>
                <c:pt idx="267">
                  <c:v>0.92174</c:v>
                </c:pt>
                <c:pt idx="268">
                  <c:v>0.76173000000000002</c:v>
                </c:pt>
                <c:pt idx="269">
                  <c:v>0.69499999999999995</c:v>
                </c:pt>
                <c:pt idx="270">
                  <c:v>0.69469999999999998</c:v>
                </c:pt>
                <c:pt idx="271">
                  <c:v>0.69027000000000005</c:v>
                </c:pt>
                <c:pt idx="272">
                  <c:v>0.65112000000000003</c:v>
                </c:pt>
                <c:pt idx="273">
                  <c:v>0.63527999999999996</c:v>
                </c:pt>
                <c:pt idx="274">
                  <c:v>0.62278999999999995</c:v>
                </c:pt>
                <c:pt idx="275">
                  <c:v>0.60241999999999996</c:v>
                </c:pt>
                <c:pt idx="276">
                  <c:v>0.58975999999999995</c:v>
                </c:pt>
                <c:pt idx="277">
                  <c:v>0.58252999999999999</c:v>
                </c:pt>
                <c:pt idx="278">
                  <c:v>0.55730000000000002</c:v>
                </c:pt>
                <c:pt idx="279">
                  <c:v>0.56391999999999998</c:v>
                </c:pt>
                <c:pt idx="280">
                  <c:v>0.55042000000000002</c:v>
                </c:pt>
                <c:pt idx="281">
                  <c:v>0.55139000000000005</c:v>
                </c:pt>
                <c:pt idx="282">
                  <c:v>0.55386000000000002</c:v>
                </c:pt>
                <c:pt idx="283">
                  <c:v>0.54459000000000002</c:v>
                </c:pt>
                <c:pt idx="284">
                  <c:v>0.53385000000000005</c:v>
                </c:pt>
                <c:pt idx="285">
                  <c:v>0.52100999999999997</c:v>
                </c:pt>
                <c:pt idx="286">
                  <c:v>0.51339000000000001</c:v>
                </c:pt>
                <c:pt idx="287">
                  <c:v>0.53073999999999999</c:v>
                </c:pt>
                <c:pt idx="288">
                  <c:v>0.54490000000000005</c:v>
                </c:pt>
                <c:pt idx="289">
                  <c:v>0.51887000000000005</c:v>
                </c:pt>
                <c:pt idx="290">
                  <c:v>0.49774000000000002</c:v>
                </c:pt>
                <c:pt idx="291">
                  <c:v>0.54627999999999999</c:v>
                </c:pt>
                <c:pt idx="292">
                  <c:v>0.55147000000000002</c:v>
                </c:pt>
                <c:pt idx="293">
                  <c:v>0.60684000000000005</c:v>
                </c:pt>
                <c:pt idx="294">
                  <c:v>0.59379000000000004</c:v>
                </c:pt>
                <c:pt idx="295">
                  <c:v>0.64661000000000002</c:v>
                </c:pt>
                <c:pt idx="296">
                  <c:v>0.56932000000000005</c:v>
                </c:pt>
                <c:pt idx="297">
                  <c:v>0.54986999999999997</c:v>
                </c:pt>
                <c:pt idx="298">
                  <c:v>0.56833</c:v>
                </c:pt>
                <c:pt idx="299">
                  <c:v>0.60197999999999996</c:v>
                </c:pt>
                <c:pt idx="300">
                  <c:v>0.52720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D005-49FD-B3FC-925FD33CADDB}"/>
            </c:ext>
          </c:extLst>
        </c:ser>
        <c:ser>
          <c:idx val="5"/>
          <c:order val="5"/>
          <c:tx>
            <c:strRef>
              <c:f>Feuil1!$G$2</c:f>
              <c:strCache>
                <c:ptCount val="1"/>
                <c:pt idx="0">
                  <c:v>4.5 mM HBT</c:v>
                </c:pt>
              </c:strCache>
            </c:strRef>
          </c:tx>
          <c:spPr>
            <a:ln w="12700">
              <a:solidFill>
                <a:srgbClr val="339966"/>
              </a:solidFill>
              <a:prstDash val="solid"/>
            </a:ln>
          </c:spPr>
          <c:marker>
            <c:symbol val="none"/>
          </c:marker>
          <c:xVal>
            <c:numRef>
              <c:f>Feuil1!$A$3:$A$303</c:f>
              <c:numCache>
                <c:formatCode>General</c:formatCode>
                <c:ptCount val="301"/>
                <c:pt idx="0">
                  <c:v>800</c:v>
                </c:pt>
                <c:pt idx="1">
                  <c:v>798</c:v>
                </c:pt>
                <c:pt idx="2">
                  <c:v>796</c:v>
                </c:pt>
                <c:pt idx="3">
                  <c:v>794</c:v>
                </c:pt>
                <c:pt idx="4">
                  <c:v>792</c:v>
                </c:pt>
                <c:pt idx="5">
                  <c:v>790</c:v>
                </c:pt>
                <c:pt idx="6">
                  <c:v>788</c:v>
                </c:pt>
                <c:pt idx="7">
                  <c:v>786</c:v>
                </c:pt>
                <c:pt idx="8">
                  <c:v>784</c:v>
                </c:pt>
                <c:pt idx="9">
                  <c:v>782</c:v>
                </c:pt>
                <c:pt idx="10">
                  <c:v>780</c:v>
                </c:pt>
                <c:pt idx="11">
                  <c:v>778</c:v>
                </c:pt>
                <c:pt idx="12">
                  <c:v>776</c:v>
                </c:pt>
                <c:pt idx="13">
                  <c:v>774</c:v>
                </c:pt>
                <c:pt idx="14">
                  <c:v>772</c:v>
                </c:pt>
                <c:pt idx="15">
                  <c:v>770</c:v>
                </c:pt>
                <c:pt idx="16">
                  <c:v>768</c:v>
                </c:pt>
                <c:pt idx="17">
                  <c:v>766</c:v>
                </c:pt>
                <c:pt idx="18">
                  <c:v>764</c:v>
                </c:pt>
                <c:pt idx="19">
                  <c:v>762</c:v>
                </c:pt>
                <c:pt idx="20">
                  <c:v>760</c:v>
                </c:pt>
                <c:pt idx="21">
                  <c:v>758</c:v>
                </c:pt>
                <c:pt idx="22">
                  <c:v>756</c:v>
                </c:pt>
                <c:pt idx="23">
                  <c:v>754</c:v>
                </c:pt>
                <c:pt idx="24">
                  <c:v>752</c:v>
                </c:pt>
                <c:pt idx="25">
                  <c:v>750</c:v>
                </c:pt>
                <c:pt idx="26">
                  <c:v>748</c:v>
                </c:pt>
                <c:pt idx="27">
                  <c:v>746</c:v>
                </c:pt>
                <c:pt idx="28">
                  <c:v>744</c:v>
                </c:pt>
                <c:pt idx="29">
                  <c:v>742</c:v>
                </c:pt>
                <c:pt idx="30">
                  <c:v>740</c:v>
                </c:pt>
                <c:pt idx="31">
                  <c:v>738</c:v>
                </c:pt>
                <c:pt idx="32">
                  <c:v>736</c:v>
                </c:pt>
                <c:pt idx="33">
                  <c:v>734</c:v>
                </c:pt>
                <c:pt idx="34">
                  <c:v>732</c:v>
                </c:pt>
                <c:pt idx="35">
                  <c:v>730</c:v>
                </c:pt>
                <c:pt idx="36">
                  <c:v>728</c:v>
                </c:pt>
                <c:pt idx="37">
                  <c:v>726</c:v>
                </c:pt>
                <c:pt idx="38">
                  <c:v>724</c:v>
                </c:pt>
                <c:pt idx="39">
                  <c:v>722</c:v>
                </c:pt>
                <c:pt idx="40">
                  <c:v>720</c:v>
                </c:pt>
                <c:pt idx="41">
                  <c:v>718</c:v>
                </c:pt>
                <c:pt idx="42">
                  <c:v>716</c:v>
                </c:pt>
                <c:pt idx="43">
                  <c:v>714</c:v>
                </c:pt>
                <c:pt idx="44">
                  <c:v>712</c:v>
                </c:pt>
                <c:pt idx="45">
                  <c:v>710</c:v>
                </c:pt>
                <c:pt idx="46">
                  <c:v>708</c:v>
                </c:pt>
                <c:pt idx="47">
                  <c:v>706</c:v>
                </c:pt>
                <c:pt idx="48">
                  <c:v>704</c:v>
                </c:pt>
                <c:pt idx="49">
                  <c:v>702</c:v>
                </c:pt>
                <c:pt idx="50">
                  <c:v>700</c:v>
                </c:pt>
                <c:pt idx="51">
                  <c:v>698</c:v>
                </c:pt>
                <c:pt idx="52">
                  <c:v>696</c:v>
                </c:pt>
                <c:pt idx="53">
                  <c:v>694</c:v>
                </c:pt>
                <c:pt idx="54">
                  <c:v>692</c:v>
                </c:pt>
                <c:pt idx="55">
                  <c:v>690</c:v>
                </c:pt>
                <c:pt idx="56">
                  <c:v>688</c:v>
                </c:pt>
                <c:pt idx="57">
                  <c:v>686</c:v>
                </c:pt>
                <c:pt idx="58">
                  <c:v>684</c:v>
                </c:pt>
                <c:pt idx="59">
                  <c:v>682</c:v>
                </c:pt>
                <c:pt idx="60">
                  <c:v>680</c:v>
                </c:pt>
                <c:pt idx="61">
                  <c:v>678</c:v>
                </c:pt>
                <c:pt idx="62">
                  <c:v>676</c:v>
                </c:pt>
                <c:pt idx="63">
                  <c:v>674</c:v>
                </c:pt>
                <c:pt idx="64">
                  <c:v>672</c:v>
                </c:pt>
                <c:pt idx="65">
                  <c:v>670</c:v>
                </c:pt>
                <c:pt idx="66">
                  <c:v>668</c:v>
                </c:pt>
                <c:pt idx="67">
                  <c:v>666</c:v>
                </c:pt>
                <c:pt idx="68">
                  <c:v>664</c:v>
                </c:pt>
                <c:pt idx="69">
                  <c:v>662</c:v>
                </c:pt>
                <c:pt idx="70">
                  <c:v>660</c:v>
                </c:pt>
                <c:pt idx="71">
                  <c:v>658</c:v>
                </c:pt>
                <c:pt idx="72">
                  <c:v>656</c:v>
                </c:pt>
                <c:pt idx="73">
                  <c:v>654</c:v>
                </c:pt>
                <c:pt idx="74">
                  <c:v>652</c:v>
                </c:pt>
                <c:pt idx="75">
                  <c:v>650</c:v>
                </c:pt>
                <c:pt idx="76">
                  <c:v>648</c:v>
                </c:pt>
                <c:pt idx="77">
                  <c:v>646</c:v>
                </c:pt>
                <c:pt idx="78">
                  <c:v>644</c:v>
                </c:pt>
                <c:pt idx="79">
                  <c:v>642</c:v>
                </c:pt>
                <c:pt idx="80">
                  <c:v>640</c:v>
                </c:pt>
                <c:pt idx="81">
                  <c:v>638</c:v>
                </c:pt>
                <c:pt idx="82">
                  <c:v>636</c:v>
                </c:pt>
                <c:pt idx="83">
                  <c:v>634</c:v>
                </c:pt>
                <c:pt idx="84">
                  <c:v>632</c:v>
                </c:pt>
                <c:pt idx="85">
                  <c:v>630</c:v>
                </c:pt>
                <c:pt idx="86">
                  <c:v>628</c:v>
                </c:pt>
                <c:pt idx="87">
                  <c:v>626</c:v>
                </c:pt>
                <c:pt idx="88">
                  <c:v>624</c:v>
                </c:pt>
                <c:pt idx="89">
                  <c:v>622</c:v>
                </c:pt>
                <c:pt idx="90">
                  <c:v>620</c:v>
                </c:pt>
                <c:pt idx="91">
                  <c:v>618</c:v>
                </c:pt>
                <c:pt idx="92">
                  <c:v>616</c:v>
                </c:pt>
                <c:pt idx="93">
                  <c:v>614</c:v>
                </c:pt>
                <c:pt idx="94">
                  <c:v>612</c:v>
                </c:pt>
                <c:pt idx="95">
                  <c:v>610</c:v>
                </c:pt>
                <c:pt idx="96">
                  <c:v>608</c:v>
                </c:pt>
                <c:pt idx="97">
                  <c:v>606</c:v>
                </c:pt>
                <c:pt idx="98">
                  <c:v>604</c:v>
                </c:pt>
                <c:pt idx="99">
                  <c:v>602</c:v>
                </c:pt>
                <c:pt idx="100">
                  <c:v>600</c:v>
                </c:pt>
                <c:pt idx="101">
                  <c:v>598</c:v>
                </c:pt>
                <c:pt idx="102">
                  <c:v>596</c:v>
                </c:pt>
                <c:pt idx="103">
                  <c:v>594</c:v>
                </c:pt>
                <c:pt idx="104">
                  <c:v>592</c:v>
                </c:pt>
                <c:pt idx="105">
                  <c:v>590</c:v>
                </c:pt>
                <c:pt idx="106">
                  <c:v>588</c:v>
                </c:pt>
                <c:pt idx="107">
                  <c:v>586</c:v>
                </c:pt>
                <c:pt idx="108">
                  <c:v>584</c:v>
                </c:pt>
                <c:pt idx="109">
                  <c:v>582</c:v>
                </c:pt>
                <c:pt idx="110">
                  <c:v>580</c:v>
                </c:pt>
                <c:pt idx="111">
                  <c:v>578</c:v>
                </c:pt>
                <c:pt idx="112">
                  <c:v>576</c:v>
                </c:pt>
                <c:pt idx="113">
                  <c:v>574</c:v>
                </c:pt>
                <c:pt idx="114">
                  <c:v>572</c:v>
                </c:pt>
                <c:pt idx="115">
                  <c:v>570</c:v>
                </c:pt>
                <c:pt idx="116">
                  <c:v>568</c:v>
                </c:pt>
                <c:pt idx="117">
                  <c:v>566</c:v>
                </c:pt>
                <c:pt idx="118">
                  <c:v>564</c:v>
                </c:pt>
                <c:pt idx="119">
                  <c:v>562</c:v>
                </c:pt>
                <c:pt idx="120">
                  <c:v>560</c:v>
                </c:pt>
                <c:pt idx="121">
                  <c:v>558</c:v>
                </c:pt>
                <c:pt idx="122">
                  <c:v>556</c:v>
                </c:pt>
                <c:pt idx="123">
                  <c:v>554</c:v>
                </c:pt>
                <c:pt idx="124">
                  <c:v>552</c:v>
                </c:pt>
                <c:pt idx="125">
                  <c:v>550</c:v>
                </c:pt>
                <c:pt idx="126">
                  <c:v>548</c:v>
                </c:pt>
                <c:pt idx="127">
                  <c:v>546</c:v>
                </c:pt>
                <c:pt idx="128">
                  <c:v>544</c:v>
                </c:pt>
                <c:pt idx="129">
                  <c:v>542</c:v>
                </c:pt>
                <c:pt idx="130">
                  <c:v>540</c:v>
                </c:pt>
                <c:pt idx="131">
                  <c:v>538</c:v>
                </c:pt>
                <c:pt idx="132">
                  <c:v>536</c:v>
                </c:pt>
                <c:pt idx="133">
                  <c:v>534</c:v>
                </c:pt>
                <c:pt idx="134">
                  <c:v>532</c:v>
                </c:pt>
                <c:pt idx="135">
                  <c:v>530</c:v>
                </c:pt>
                <c:pt idx="136">
                  <c:v>528</c:v>
                </c:pt>
                <c:pt idx="137">
                  <c:v>526</c:v>
                </c:pt>
                <c:pt idx="138">
                  <c:v>524</c:v>
                </c:pt>
                <c:pt idx="139">
                  <c:v>522</c:v>
                </c:pt>
                <c:pt idx="140">
                  <c:v>520</c:v>
                </c:pt>
                <c:pt idx="141">
                  <c:v>518</c:v>
                </c:pt>
                <c:pt idx="142">
                  <c:v>516</c:v>
                </c:pt>
                <c:pt idx="143">
                  <c:v>514</c:v>
                </c:pt>
                <c:pt idx="144">
                  <c:v>512</c:v>
                </c:pt>
                <c:pt idx="145">
                  <c:v>510</c:v>
                </c:pt>
                <c:pt idx="146">
                  <c:v>508</c:v>
                </c:pt>
                <c:pt idx="147">
                  <c:v>506</c:v>
                </c:pt>
                <c:pt idx="148">
                  <c:v>504</c:v>
                </c:pt>
                <c:pt idx="149">
                  <c:v>502</c:v>
                </c:pt>
                <c:pt idx="150">
                  <c:v>500</c:v>
                </c:pt>
                <c:pt idx="151">
                  <c:v>498</c:v>
                </c:pt>
                <c:pt idx="152">
                  <c:v>496</c:v>
                </c:pt>
                <c:pt idx="153">
                  <c:v>494</c:v>
                </c:pt>
                <c:pt idx="154">
                  <c:v>492</c:v>
                </c:pt>
                <c:pt idx="155">
                  <c:v>490</c:v>
                </c:pt>
                <c:pt idx="156">
                  <c:v>488</c:v>
                </c:pt>
                <c:pt idx="157">
                  <c:v>486</c:v>
                </c:pt>
                <c:pt idx="158">
                  <c:v>484</c:v>
                </c:pt>
                <c:pt idx="159">
                  <c:v>482</c:v>
                </c:pt>
                <c:pt idx="160">
                  <c:v>480</c:v>
                </c:pt>
                <c:pt idx="161">
                  <c:v>478</c:v>
                </c:pt>
                <c:pt idx="162">
                  <c:v>476</c:v>
                </c:pt>
                <c:pt idx="163">
                  <c:v>474</c:v>
                </c:pt>
                <c:pt idx="164">
                  <c:v>472</c:v>
                </c:pt>
                <c:pt idx="165">
                  <c:v>470</c:v>
                </c:pt>
                <c:pt idx="166">
                  <c:v>468</c:v>
                </c:pt>
                <c:pt idx="167">
                  <c:v>466</c:v>
                </c:pt>
                <c:pt idx="168">
                  <c:v>464</c:v>
                </c:pt>
                <c:pt idx="169">
                  <c:v>462</c:v>
                </c:pt>
                <c:pt idx="170">
                  <c:v>460</c:v>
                </c:pt>
                <c:pt idx="171">
                  <c:v>458</c:v>
                </c:pt>
                <c:pt idx="172">
                  <c:v>456</c:v>
                </c:pt>
                <c:pt idx="173">
                  <c:v>454</c:v>
                </c:pt>
                <c:pt idx="174">
                  <c:v>452</c:v>
                </c:pt>
                <c:pt idx="175">
                  <c:v>450</c:v>
                </c:pt>
                <c:pt idx="176">
                  <c:v>448</c:v>
                </c:pt>
                <c:pt idx="177">
                  <c:v>446</c:v>
                </c:pt>
                <c:pt idx="178">
                  <c:v>444</c:v>
                </c:pt>
                <c:pt idx="179">
                  <c:v>442</c:v>
                </c:pt>
                <c:pt idx="180">
                  <c:v>440</c:v>
                </c:pt>
                <c:pt idx="181">
                  <c:v>438</c:v>
                </c:pt>
                <c:pt idx="182">
                  <c:v>436</c:v>
                </c:pt>
                <c:pt idx="183">
                  <c:v>434</c:v>
                </c:pt>
                <c:pt idx="184">
                  <c:v>432</c:v>
                </c:pt>
                <c:pt idx="185">
                  <c:v>430</c:v>
                </c:pt>
                <c:pt idx="186">
                  <c:v>428</c:v>
                </c:pt>
                <c:pt idx="187">
                  <c:v>426</c:v>
                </c:pt>
                <c:pt idx="188">
                  <c:v>424</c:v>
                </c:pt>
                <c:pt idx="189">
                  <c:v>422</c:v>
                </c:pt>
                <c:pt idx="190">
                  <c:v>420</c:v>
                </c:pt>
                <c:pt idx="191">
                  <c:v>418</c:v>
                </c:pt>
                <c:pt idx="192">
                  <c:v>416</c:v>
                </c:pt>
                <c:pt idx="193">
                  <c:v>414</c:v>
                </c:pt>
                <c:pt idx="194">
                  <c:v>412</c:v>
                </c:pt>
                <c:pt idx="195">
                  <c:v>410</c:v>
                </c:pt>
                <c:pt idx="196">
                  <c:v>408</c:v>
                </c:pt>
                <c:pt idx="197">
                  <c:v>406</c:v>
                </c:pt>
                <c:pt idx="198">
                  <c:v>404</c:v>
                </c:pt>
                <c:pt idx="199">
                  <c:v>402</c:v>
                </c:pt>
                <c:pt idx="200">
                  <c:v>400</c:v>
                </c:pt>
                <c:pt idx="201">
                  <c:v>398</c:v>
                </c:pt>
                <c:pt idx="202">
                  <c:v>396</c:v>
                </c:pt>
                <c:pt idx="203">
                  <c:v>394</c:v>
                </c:pt>
                <c:pt idx="204">
                  <c:v>392</c:v>
                </c:pt>
                <c:pt idx="205">
                  <c:v>390</c:v>
                </c:pt>
                <c:pt idx="206">
                  <c:v>388</c:v>
                </c:pt>
                <c:pt idx="207">
                  <c:v>386</c:v>
                </c:pt>
                <c:pt idx="208">
                  <c:v>384</c:v>
                </c:pt>
                <c:pt idx="209">
                  <c:v>382</c:v>
                </c:pt>
                <c:pt idx="210">
                  <c:v>380</c:v>
                </c:pt>
                <c:pt idx="211">
                  <c:v>378</c:v>
                </c:pt>
                <c:pt idx="212">
                  <c:v>376</c:v>
                </c:pt>
                <c:pt idx="213">
                  <c:v>374</c:v>
                </c:pt>
                <c:pt idx="214">
                  <c:v>372</c:v>
                </c:pt>
                <c:pt idx="215">
                  <c:v>370</c:v>
                </c:pt>
                <c:pt idx="216">
                  <c:v>368</c:v>
                </c:pt>
                <c:pt idx="217">
                  <c:v>366</c:v>
                </c:pt>
                <c:pt idx="218">
                  <c:v>364</c:v>
                </c:pt>
                <c:pt idx="219">
                  <c:v>362</c:v>
                </c:pt>
                <c:pt idx="220">
                  <c:v>360</c:v>
                </c:pt>
                <c:pt idx="221">
                  <c:v>358</c:v>
                </c:pt>
                <c:pt idx="222">
                  <c:v>356</c:v>
                </c:pt>
                <c:pt idx="223">
                  <c:v>354</c:v>
                </c:pt>
                <c:pt idx="224">
                  <c:v>352</c:v>
                </c:pt>
                <c:pt idx="225">
                  <c:v>350</c:v>
                </c:pt>
                <c:pt idx="226">
                  <c:v>348</c:v>
                </c:pt>
                <c:pt idx="227">
                  <c:v>346</c:v>
                </c:pt>
                <c:pt idx="228">
                  <c:v>344</c:v>
                </c:pt>
                <c:pt idx="229">
                  <c:v>342</c:v>
                </c:pt>
                <c:pt idx="230">
                  <c:v>340</c:v>
                </c:pt>
                <c:pt idx="231">
                  <c:v>338</c:v>
                </c:pt>
                <c:pt idx="232">
                  <c:v>336</c:v>
                </c:pt>
                <c:pt idx="233">
                  <c:v>334</c:v>
                </c:pt>
                <c:pt idx="234">
                  <c:v>332</c:v>
                </c:pt>
                <c:pt idx="235">
                  <c:v>330</c:v>
                </c:pt>
                <c:pt idx="236">
                  <c:v>328</c:v>
                </c:pt>
                <c:pt idx="237">
                  <c:v>326</c:v>
                </c:pt>
                <c:pt idx="238">
                  <c:v>324</c:v>
                </c:pt>
                <c:pt idx="239">
                  <c:v>322</c:v>
                </c:pt>
                <c:pt idx="240">
                  <c:v>320</c:v>
                </c:pt>
                <c:pt idx="241">
                  <c:v>318</c:v>
                </c:pt>
                <c:pt idx="242">
                  <c:v>316</c:v>
                </c:pt>
                <c:pt idx="243">
                  <c:v>314</c:v>
                </c:pt>
                <c:pt idx="244">
                  <c:v>312</c:v>
                </c:pt>
                <c:pt idx="245">
                  <c:v>310</c:v>
                </c:pt>
                <c:pt idx="246">
                  <c:v>308</c:v>
                </c:pt>
                <c:pt idx="247">
                  <c:v>306</c:v>
                </c:pt>
                <c:pt idx="248">
                  <c:v>304</c:v>
                </c:pt>
                <c:pt idx="249">
                  <c:v>302</c:v>
                </c:pt>
                <c:pt idx="250">
                  <c:v>300</c:v>
                </c:pt>
                <c:pt idx="251">
                  <c:v>298</c:v>
                </c:pt>
                <c:pt idx="252">
                  <c:v>296</c:v>
                </c:pt>
                <c:pt idx="253">
                  <c:v>294</c:v>
                </c:pt>
                <c:pt idx="254">
                  <c:v>292</c:v>
                </c:pt>
                <c:pt idx="255">
                  <c:v>290</c:v>
                </c:pt>
                <c:pt idx="256">
                  <c:v>288</c:v>
                </c:pt>
                <c:pt idx="257">
                  <c:v>286</c:v>
                </c:pt>
                <c:pt idx="258">
                  <c:v>284</c:v>
                </c:pt>
                <c:pt idx="259">
                  <c:v>282</c:v>
                </c:pt>
                <c:pt idx="260">
                  <c:v>280</c:v>
                </c:pt>
                <c:pt idx="261">
                  <c:v>278</c:v>
                </c:pt>
                <c:pt idx="262">
                  <c:v>276</c:v>
                </c:pt>
                <c:pt idx="263">
                  <c:v>274</c:v>
                </c:pt>
                <c:pt idx="264">
                  <c:v>272</c:v>
                </c:pt>
                <c:pt idx="265">
                  <c:v>270</c:v>
                </c:pt>
                <c:pt idx="266">
                  <c:v>268</c:v>
                </c:pt>
                <c:pt idx="267">
                  <c:v>266</c:v>
                </c:pt>
                <c:pt idx="268">
                  <c:v>264</c:v>
                </c:pt>
                <c:pt idx="269">
                  <c:v>262</c:v>
                </c:pt>
                <c:pt idx="270">
                  <c:v>260</c:v>
                </c:pt>
                <c:pt idx="271">
                  <c:v>258</c:v>
                </c:pt>
                <c:pt idx="272">
                  <c:v>256</c:v>
                </c:pt>
                <c:pt idx="273">
                  <c:v>254</c:v>
                </c:pt>
                <c:pt idx="274">
                  <c:v>252</c:v>
                </c:pt>
                <c:pt idx="275">
                  <c:v>250</c:v>
                </c:pt>
                <c:pt idx="276">
                  <c:v>248</c:v>
                </c:pt>
                <c:pt idx="277">
                  <c:v>246</c:v>
                </c:pt>
                <c:pt idx="278">
                  <c:v>244</c:v>
                </c:pt>
                <c:pt idx="279">
                  <c:v>242</c:v>
                </c:pt>
                <c:pt idx="280">
                  <c:v>240</c:v>
                </c:pt>
                <c:pt idx="281">
                  <c:v>238</c:v>
                </c:pt>
                <c:pt idx="282">
                  <c:v>236</c:v>
                </c:pt>
                <c:pt idx="283">
                  <c:v>234</c:v>
                </c:pt>
                <c:pt idx="284">
                  <c:v>232</c:v>
                </c:pt>
                <c:pt idx="285">
                  <c:v>230</c:v>
                </c:pt>
                <c:pt idx="286">
                  <c:v>228</c:v>
                </c:pt>
                <c:pt idx="287">
                  <c:v>226</c:v>
                </c:pt>
                <c:pt idx="288">
                  <c:v>224</c:v>
                </c:pt>
                <c:pt idx="289">
                  <c:v>222</c:v>
                </c:pt>
                <c:pt idx="290">
                  <c:v>220</c:v>
                </c:pt>
                <c:pt idx="291">
                  <c:v>218</c:v>
                </c:pt>
                <c:pt idx="292">
                  <c:v>216</c:v>
                </c:pt>
                <c:pt idx="293">
                  <c:v>214</c:v>
                </c:pt>
                <c:pt idx="294">
                  <c:v>212</c:v>
                </c:pt>
                <c:pt idx="295">
                  <c:v>210</c:v>
                </c:pt>
                <c:pt idx="296">
                  <c:v>208</c:v>
                </c:pt>
                <c:pt idx="297">
                  <c:v>206</c:v>
                </c:pt>
                <c:pt idx="298">
                  <c:v>204</c:v>
                </c:pt>
                <c:pt idx="299">
                  <c:v>202</c:v>
                </c:pt>
                <c:pt idx="300">
                  <c:v>200</c:v>
                </c:pt>
              </c:numCache>
            </c:numRef>
          </c:xVal>
          <c:yVal>
            <c:numRef>
              <c:f>Feuil1!$G$3:$G$303</c:f>
              <c:numCache>
                <c:formatCode>General</c:formatCode>
                <c:ptCount val="301"/>
                <c:pt idx="0">
                  <c:v>3.29E-3</c:v>
                </c:pt>
                <c:pt idx="1">
                  <c:v>4.4000000000000003E-3</c:v>
                </c:pt>
                <c:pt idx="2">
                  <c:v>2.7499999999999998E-3</c:v>
                </c:pt>
                <c:pt idx="3">
                  <c:v>5.0699999999999999E-3</c:v>
                </c:pt>
                <c:pt idx="4">
                  <c:v>2.1900000000000001E-3</c:v>
                </c:pt>
                <c:pt idx="5">
                  <c:v>2.3800000000000002E-3</c:v>
                </c:pt>
                <c:pt idx="6">
                  <c:v>8.4000000000000003E-4</c:v>
                </c:pt>
                <c:pt idx="7">
                  <c:v>6.3000000000000003E-4</c:v>
                </c:pt>
                <c:pt idx="8">
                  <c:v>1.16E-3</c:v>
                </c:pt>
                <c:pt idx="9">
                  <c:v>7.7099999999999998E-3</c:v>
                </c:pt>
                <c:pt idx="10">
                  <c:v>8.1300000000000001E-3</c:v>
                </c:pt>
                <c:pt idx="11">
                  <c:v>6.0200000000000002E-3</c:v>
                </c:pt>
                <c:pt idx="12">
                  <c:v>3.8500000000000001E-3</c:v>
                </c:pt>
                <c:pt idx="13">
                  <c:v>-9.8999999999999999E-4</c:v>
                </c:pt>
                <c:pt idx="14">
                  <c:v>7.4799999999999997E-3</c:v>
                </c:pt>
                <c:pt idx="15">
                  <c:v>2.0600000000000002E-3</c:v>
                </c:pt>
                <c:pt idx="16">
                  <c:v>3.3500000000000001E-3</c:v>
                </c:pt>
                <c:pt idx="17">
                  <c:v>7.7099999999999998E-3</c:v>
                </c:pt>
                <c:pt idx="18">
                  <c:v>-1.15E-3</c:v>
                </c:pt>
                <c:pt idx="19">
                  <c:v>4.6100000000000004E-3</c:v>
                </c:pt>
                <c:pt idx="20">
                  <c:v>1.67E-3</c:v>
                </c:pt>
                <c:pt idx="21">
                  <c:v>8.9899999999999997E-3</c:v>
                </c:pt>
                <c:pt idx="22">
                  <c:v>1.7799999999999999E-3</c:v>
                </c:pt>
                <c:pt idx="23">
                  <c:v>3.3E-3</c:v>
                </c:pt>
                <c:pt idx="24">
                  <c:v>9.1599999999999997E-3</c:v>
                </c:pt>
                <c:pt idx="25">
                  <c:v>3.0500000000000002E-3</c:v>
                </c:pt>
                <c:pt idx="26">
                  <c:v>5.1500000000000001E-3</c:v>
                </c:pt>
                <c:pt idx="27">
                  <c:v>-2.8500000000000001E-3</c:v>
                </c:pt>
                <c:pt idx="28">
                  <c:v>5.9699999999999996E-3</c:v>
                </c:pt>
                <c:pt idx="29">
                  <c:v>1.83E-3</c:v>
                </c:pt>
                <c:pt idx="30">
                  <c:v>7.1300000000000001E-3</c:v>
                </c:pt>
                <c:pt idx="31">
                  <c:v>7.2700000000000004E-3</c:v>
                </c:pt>
                <c:pt idx="32">
                  <c:v>-8.8000000000000003E-4</c:v>
                </c:pt>
                <c:pt idx="33">
                  <c:v>3.14E-3</c:v>
                </c:pt>
                <c:pt idx="34">
                  <c:v>4.0699999999999998E-3</c:v>
                </c:pt>
                <c:pt idx="35">
                  <c:v>3.8600000000000001E-3</c:v>
                </c:pt>
                <c:pt idx="36">
                  <c:v>4.8199999999999996E-3</c:v>
                </c:pt>
                <c:pt idx="37">
                  <c:v>-1.4400000000000001E-3</c:v>
                </c:pt>
                <c:pt idx="38">
                  <c:v>4.0000000000000003E-5</c:v>
                </c:pt>
                <c:pt idx="39">
                  <c:v>6.4700000000000001E-3</c:v>
                </c:pt>
                <c:pt idx="40">
                  <c:v>4.8500000000000001E-3</c:v>
                </c:pt>
                <c:pt idx="41">
                  <c:v>1.0030000000000001E-2</c:v>
                </c:pt>
                <c:pt idx="42">
                  <c:v>4.8999999999999998E-4</c:v>
                </c:pt>
                <c:pt idx="43">
                  <c:v>3.6800000000000001E-3</c:v>
                </c:pt>
                <c:pt idx="44">
                  <c:v>6.2E-4</c:v>
                </c:pt>
                <c:pt idx="45">
                  <c:v>7.7999999999999996E-3</c:v>
                </c:pt>
                <c:pt idx="46">
                  <c:v>4.3E-3</c:v>
                </c:pt>
                <c:pt idx="47">
                  <c:v>2.5500000000000002E-3</c:v>
                </c:pt>
                <c:pt idx="48">
                  <c:v>3.0699999999999998E-3</c:v>
                </c:pt>
                <c:pt idx="49">
                  <c:v>8.6800000000000002E-3</c:v>
                </c:pt>
                <c:pt idx="50">
                  <c:v>4.2599999999999999E-3</c:v>
                </c:pt>
                <c:pt idx="51">
                  <c:v>4.62E-3</c:v>
                </c:pt>
                <c:pt idx="52">
                  <c:v>6.4099999999999999E-3</c:v>
                </c:pt>
                <c:pt idx="53">
                  <c:v>7.5000000000000002E-4</c:v>
                </c:pt>
                <c:pt idx="54">
                  <c:v>4.3099999999999996E-3</c:v>
                </c:pt>
                <c:pt idx="55">
                  <c:v>8.8000000000000003E-4</c:v>
                </c:pt>
                <c:pt idx="56">
                  <c:v>1.81E-3</c:v>
                </c:pt>
                <c:pt idx="57">
                  <c:v>4.4600000000000004E-3</c:v>
                </c:pt>
                <c:pt idx="58">
                  <c:v>6.2300000000000003E-3</c:v>
                </c:pt>
                <c:pt idx="59">
                  <c:v>3.0999999999999999E-3</c:v>
                </c:pt>
                <c:pt idx="60">
                  <c:v>4.7999999999999996E-3</c:v>
                </c:pt>
                <c:pt idx="61">
                  <c:v>5.4999999999999997E-3</c:v>
                </c:pt>
                <c:pt idx="62">
                  <c:v>2.5300000000000001E-3</c:v>
                </c:pt>
                <c:pt idx="63">
                  <c:v>5.4000000000000003E-3</c:v>
                </c:pt>
                <c:pt idx="64">
                  <c:v>4.4200000000000003E-3</c:v>
                </c:pt>
                <c:pt idx="65">
                  <c:v>8.0499999999999999E-3</c:v>
                </c:pt>
                <c:pt idx="66">
                  <c:v>7.2300000000000003E-3</c:v>
                </c:pt>
                <c:pt idx="67">
                  <c:v>6.3200000000000001E-3</c:v>
                </c:pt>
                <c:pt idx="68">
                  <c:v>7.0499999999999998E-3</c:v>
                </c:pt>
                <c:pt idx="69">
                  <c:v>6.5100000000000002E-3</c:v>
                </c:pt>
                <c:pt idx="70">
                  <c:v>3.9300000000000003E-3</c:v>
                </c:pt>
                <c:pt idx="71">
                  <c:v>3.15E-3</c:v>
                </c:pt>
                <c:pt idx="72">
                  <c:v>4.6899999999999997E-3</c:v>
                </c:pt>
                <c:pt idx="73">
                  <c:v>7.2100000000000003E-3</c:v>
                </c:pt>
                <c:pt idx="74">
                  <c:v>4.3899999999999998E-3</c:v>
                </c:pt>
                <c:pt idx="75">
                  <c:v>5.5300000000000002E-3</c:v>
                </c:pt>
                <c:pt idx="76">
                  <c:v>1.8699999999999999E-3</c:v>
                </c:pt>
                <c:pt idx="77">
                  <c:v>5.0299999999999997E-3</c:v>
                </c:pt>
                <c:pt idx="78">
                  <c:v>4.1099999999999999E-3</c:v>
                </c:pt>
                <c:pt idx="79">
                  <c:v>8.2199999999999999E-3</c:v>
                </c:pt>
                <c:pt idx="80">
                  <c:v>4.9199999999999999E-3</c:v>
                </c:pt>
                <c:pt idx="81">
                  <c:v>3.96E-3</c:v>
                </c:pt>
                <c:pt idx="82">
                  <c:v>7.2300000000000003E-3</c:v>
                </c:pt>
                <c:pt idx="83">
                  <c:v>4.6499999999999996E-3</c:v>
                </c:pt>
                <c:pt idx="84">
                  <c:v>7.1700000000000002E-3</c:v>
                </c:pt>
                <c:pt idx="85">
                  <c:v>6.1799999999999997E-3</c:v>
                </c:pt>
                <c:pt idx="86">
                  <c:v>4.8199999999999996E-3</c:v>
                </c:pt>
                <c:pt idx="87">
                  <c:v>7.26E-3</c:v>
                </c:pt>
                <c:pt idx="88">
                  <c:v>9.4199999999999996E-3</c:v>
                </c:pt>
                <c:pt idx="89">
                  <c:v>9.6399999999999993E-3</c:v>
                </c:pt>
                <c:pt idx="90">
                  <c:v>4.8599999999999997E-3</c:v>
                </c:pt>
                <c:pt idx="91">
                  <c:v>8.5699999999999995E-3</c:v>
                </c:pt>
                <c:pt idx="92">
                  <c:v>6.1599999999999997E-3</c:v>
                </c:pt>
                <c:pt idx="93">
                  <c:v>7.1199999999999996E-3</c:v>
                </c:pt>
                <c:pt idx="94">
                  <c:v>6.6E-3</c:v>
                </c:pt>
                <c:pt idx="95">
                  <c:v>6.7099999999999998E-3</c:v>
                </c:pt>
                <c:pt idx="96">
                  <c:v>7.0200000000000002E-3</c:v>
                </c:pt>
                <c:pt idx="97">
                  <c:v>7.2199999999999999E-3</c:v>
                </c:pt>
                <c:pt idx="98">
                  <c:v>4.7200000000000002E-3</c:v>
                </c:pt>
                <c:pt idx="99">
                  <c:v>6.6E-3</c:v>
                </c:pt>
                <c:pt idx="100">
                  <c:v>5.4000000000000003E-3</c:v>
                </c:pt>
                <c:pt idx="101">
                  <c:v>7.1900000000000002E-3</c:v>
                </c:pt>
                <c:pt idx="102">
                  <c:v>7.3499999999999998E-3</c:v>
                </c:pt>
                <c:pt idx="103">
                  <c:v>3.5599999999999998E-3</c:v>
                </c:pt>
                <c:pt idx="104">
                  <c:v>5.3200000000000001E-3</c:v>
                </c:pt>
                <c:pt idx="105">
                  <c:v>6.0099999999999997E-3</c:v>
                </c:pt>
                <c:pt idx="106">
                  <c:v>8.6700000000000006E-3</c:v>
                </c:pt>
                <c:pt idx="107">
                  <c:v>4.9300000000000004E-3</c:v>
                </c:pt>
                <c:pt idx="108">
                  <c:v>6.5399999999999998E-3</c:v>
                </c:pt>
                <c:pt idx="109">
                  <c:v>6.8999999999999999E-3</c:v>
                </c:pt>
                <c:pt idx="110">
                  <c:v>4.5500000000000002E-3</c:v>
                </c:pt>
                <c:pt idx="111">
                  <c:v>7.3699999999999998E-3</c:v>
                </c:pt>
                <c:pt idx="112">
                  <c:v>7.9600000000000001E-3</c:v>
                </c:pt>
                <c:pt idx="113">
                  <c:v>6.9100000000000003E-3</c:v>
                </c:pt>
                <c:pt idx="114">
                  <c:v>7.6600000000000001E-3</c:v>
                </c:pt>
                <c:pt idx="115">
                  <c:v>8.0000000000000002E-3</c:v>
                </c:pt>
                <c:pt idx="116">
                  <c:v>7.1900000000000002E-3</c:v>
                </c:pt>
                <c:pt idx="117">
                  <c:v>6.5500000000000003E-3</c:v>
                </c:pt>
                <c:pt idx="118">
                  <c:v>6.8500000000000002E-3</c:v>
                </c:pt>
                <c:pt idx="119">
                  <c:v>7.0600000000000003E-3</c:v>
                </c:pt>
                <c:pt idx="120">
                  <c:v>7.0299999999999998E-3</c:v>
                </c:pt>
                <c:pt idx="121">
                  <c:v>7.8100000000000001E-3</c:v>
                </c:pt>
                <c:pt idx="122">
                  <c:v>9.1000000000000004E-3</c:v>
                </c:pt>
                <c:pt idx="123">
                  <c:v>7.4599999999999996E-3</c:v>
                </c:pt>
                <c:pt idx="124">
                  <c:v>5.2199999999999998E-3</c:v>
                </c:pt>
                <c:pt idx="125">
                  <c:v>7.3699999999999998E-3</c:v>
                </c:pt>
                <c:pt idx="126">
                  <c:v>7.7600000000000004E-3</c:v>
                </c:pt>
                <c:pt idx="127">
                  <c:v>7.9900000000000006E-3</c:v>
                </c:pt>
                <c:pt idx="128">
                  <c:v>6.7099999999999998E-3</c:v>
                </c:pt>
                <c:pt idx="129">
                  <c:v>7.5599999999999999E-3</c:v>
                </c:pt>
                <c:pt idx="130">
                  <c:v>6.8500000000000002E-3</c:v>
                </c:pt>
                <c:pt idx="131">
                  <c:v>7.45E-3</c:v>
                </c:pt>
                <c:pt idx="132">
                  <c:v>6.8599999999999998E-3</c:v>
                </c:pt>
                <c:pt idx="133">
                  <c:v>7.9799999999999992E-3</c:v>
                </c:pt>
                <c:pt idx="134">
                  <c:v>7.8600000000000007E-3</c:v>
                </c:pt>
                <c:pt idx="135">
                  <c:v>7.8499999999999993E-3</c:v>
                </c:pt>
                <c:pt idx="136">
                  <c:v>7.8700000000000003E-3</c:v>
                </c:pt>
                <c:pt idx="137">
                  <c:v>8.3400000000000002E-3</c:v>
                </c:pt>
                <c:pt idx="138">
                  <c:v>8.3800000000000003E-3</c:v>
                </c:pt>
                <c:pt idx="139">
                  <c:v>8.6999999999999994E-3</c:v>
                </c:pt>
                <c:pt idx="140">
                  <c:v>9.3600000000000003E-3</c:v>
                </c:pt>
                <c:pt idx="141">
                  <c:v>7.9500000000000005E-3</c:v>
                </c:pt>
                <c:pt idx="142">
                  <c:v>8.5199999999999998E-3</c:v>
                </c:pt>
                <c:pt idx="143">
                  <c:v>8.0999999999999996E-3</c:v>
                </c:pt>
                <c:pt idx="144">
                  <c:v>9.1699999999999993E-3</c:v>
                </c:pt>
                <c:pt idx="145">
                  <c:v>8.94E-3</c:v>
                </c:pt>
                <c:pt idx="146">
                  <c:v>7.6600000000000001E-3</c:v>
                </c:pt>
                <c:pt idx="147">
                  <c:v>8.2500000000000004E-3</c:v>
                </c:pt>
                <c:pt idx="148">
                  <c:v>8.0199999999999994E-3</c:v>
                </c:pt>
                <c:pt idx="149">
                  <c:v>7.7200000000000003E-3</c:v>
                </c:pt>
                <c:pt idx="150">
                  <c:v>7.7600000000000004E-3</c:v>
                </c:pt>
                <c:pt idx="151">
                  <c:v>8.8800000000000007E-3</c:v>
                </c:pt>
                <c:pt idx="152">
                  <c:v>8.5699999999999995E-3</c:v>
                </c:pt>
                <c:pt idx="153">
                  <c:v>8.7200000000000003E-3</c:v>
                </c:pt>
                <c:pt idx="154">
                  <c:v>9.3200000000000002E-3</c:v>
                </c:pt>
                <c:pt idx="155">
                  <c:v>9.2300000000000004E-3</c:v>
                </c:pt>
                <c:pt idx="156">
                  <c:v>9.3200000000000002E-3</c:v>
                </c:pt>
                <c:pt idx="157">
                  <c:v>9.5200000000000007E-3</c:v>
                </c:pt>
                <c:pt idx="158">
                  <c:v>9.4199999999999996E-3</c:v>
                </c:pt>
                <c:pt idx="159">
                  <c:v>9.4400000000000005E-3</c:v>
                </c:pt>
                <c:pt idx="160">
                  <c:v>1.0019999999999999E-2</c:v>
                </c:pt>
                <c:pt idx="161">
                  <c:v>9.8499999999999994E-3</c:v>
                </c:pt>
                <c:pt idx="162">
                  <c:v>9.5999999999999992E-3</c:v>
                </c:pt>
                <c:pt idx="163">
                  <c:v>9.8899999999999995E-3</c:v>
                </c:pt>
                <c:pt idx="164">
                  <c:v>1.0149999999999999E-2</c:v>
                </c:pt>
                <c:pt idx="165">
                  <c:v>1.0279999999999999E-2</c:v>
                </c:pt>
                <c:pt idx="166">
                  <c:v>1.0540000000000001E-2</c:v>
                </c:pt>
                <c:pt idx="167">
                  <c:v>1.0189999999999999E-2</c:v>
                </c:pt>
                <c:pt idx="168">
                  <c:v>1.059E-2</c:v>
                </c:pt>
                <c:pt idx="169">
                  <c:v>1.057E-2</c:v>
                </c:pt>
                <c:pt idx="170">
                  <c:v>1.0489999999999999E-2</c:v>
                </c:pt>
                <c:pt idx="171">
                  <c:v>1.044E-2</c:v>
                </c:pt>
                <c:pt idx="172">
                  <c:v>1.068E-2</c:v>
                </c:pt>
                <c:pt idx="173">
                  <c:v>1.1209999999999999E-2</c:v>
                </c:pt>
                <c:pt idx="174">
                  <c:v>1.145E-2</c:v>
                </c:pt>
                <c:pt idx="175">
                  <c:v>1.146E-2</c:v>
                </c:pt>
                <c:pt idx="176">
                  <c:v>1.145E-2</c:v>
                </c:pt>
                <c:pt idx="177">
                  <c:v>1.15E-2</c:v>
                </c:pt>
                <c:pt idx="178">
                  <c:v>1.155E-2</c:v>
                </c:pt>
                <c:pt idx="179">
                  <c:v>1.205E-2</c:v>
                </c:pt>
                <c:pt idx="180">
                  <c:v>1.208E-2</c:v>
                </c:pt>
                <c:pt idx="181">
                  <c:v>1.23E-2</c:v>
                </c:pt>
                <c:pt idx="182">
                  <c:v>1.252E-2</c:v>
                </c:pt>
                <c:pt idx="183">
                  <c:v>1.2619999999999999E-2</c:v>
                </c:pt>
                <c:pt idx="184">
                  <c:v>1.2999999999999999E-2</c:v>
                </c:pt>
                <c:pt idx="185">
                  <c:v>1.3429999999999999E-2</c:v>
                </c:pt>
                <c:pt idx="186">
                  <c:v>1.367E-2</c:v>
                </c:pt>
                <c:pt idx="187">
                  <c:v>1.387E-2</c:v>
                </c:pt>
                <c:pt idx="188">
                  <c:v>1.406E-2</c:v>
                </c:pt>
                <c:pt idx="189">
                  <c:v>1.4420000000000001E-2</c:v>
                </c:pt>
                <c:pt idx="190">
                  <c:v>1.473E-2</c:v>
                </c:pt>
                <c:pt idx="191">
                  <c:v>1.4880000000000001E-2</c:v>
                </c:pt>
                <c:pt idx="192">
                  <c:v>1.49E-2</c:v>
                </c:pt>
                <c:pt idx="193">
                  <c:v>1.5689999999999999E-2</c:v>
                </c:pt>
                <c:pt idx="194">
                  <c:v>1.5469999999999999E-2</c:v>
                </c:pt>
                <c:pt idx="195">
                  <c:v>1.5820000000000001E-2</c:v>
                </c:pt>
                <c:pt idx="196">
                  <c:v>1.6379999999999999E-2</c:v>
                </c:pt>
                <c:pt idx="197">
                  <c:v>1.687E-2</c:v>
                </c:pt>
                <c:pt idx="198">
                  <c:v>1.6879999999999999E-2</c:v>
                </c:pt>
                <c:pt idx="199">
                  <c:v>1.787E-2</c:v>
                </c:pt>
                <c:pt idx="200">
                  <c:v>1.8169999999999999E-2</c:v>
                </c:pt>
                <c:pt idx="201">
                  <c:v>1.847E-2</c:v>
                </c:pt>
                <c:pt idx="202">
                  <c:v>1.8859999999999998E-2</c:v>
                </c:pt>
                <c:pt idx="203">
                  <c:v>1.915E-2</c:v>
                </c:pt>
                <c:pt idx="204">
                  <c:v>1.966E-2</c:v>
                </c:pt>
                <c:pt idx="205">
                  <c:v>2.0039999999999999E-2</c:v>
                </c:pt>
                <c:pt idx="206">
                  <c:v>2.0119999999999999E-2</c:v>
                </c:pt>
                <c:pt idx="207">
                  <c:v>2.0959999999999999E-2</c:v>
                </c:pt>
                <c:pt idx="208">
                  <c:v>2.1229999999999999E-2</c:v>
                </c:pt>
                <c:pt idx="209">
                  <c:v>2.1839999999999998E-2</c:v>
                </c:pt>
                <c:pt idx="210">
                  <c:v>2.2499999999999999E-2</c:v>
                </c:pt>
                <c:pt idx="211">
                  <c:v>2.2700000000000001E-2</c:v>
                </c:pt>
                <c:pt idx="212">
                  <c:v>2.3109999999999999E-2</c:v>
                </c:pt>
                <c:pt idx="213">
                  <c:v>2.4219999999999998E-2</c:v>
                </c:pt>
                <c:pt idx="214">
                  <c:v>2.427E-2</c:v>
                </c:pt>
                <c:pt idx="215">
                  <c:v>2.5669999999999998E-2</c:v>
                </c:pt>
                <c:pt idx="216">
                  <c:v>2.6030000000000001E-2</c:v>
                </c:pt>
                <c:pt idx="217">
                  <c:v>2.7230000000000001E-2</c:v>
                </c:pt>
                <c:pt idx="218">
                  <c:v>2.835E-2</c:v>
                </c:pt>
                <c:pt idx="219">
                  <c:v>2.9170000000000001E-2</c:v>
                </c:pt>
                <c:pt idx="220">
                  <c:v>3.0980000000000001E-2</c:v>
                </c:pt>
                <c:pt idx="221">
                  <c:v>3.4009999999999999E-2</c:v>
                </c:pt>
                <c:pt idx="222">
                  <c:v>3.7870000000000001E-2</c:v>
                </c:pt>
                <c:pt idx="223">
                  <c:v>4.3090000000000003E-2</c:v>
                </c:pt>
                <c:pt idx="224">
                  <c:v>5.169E-2</c:v>
                </c:pt>
                <c:pt idx="225">
                  <c:v>6.2979999999999994E-2</c:v>
                </c:pt>
                <c:pt idx="226">
                  <c:v>7.9960000000000003E-2</c:v>
                </c:pt>
                <c:pt idx="227">
                  <c:v>0.10687000000000001</c:v>
                </c:pt>
                <c:pt idx="228">
                  <c:v>0.14038</c:v>
                </c:pt>
                <c:pt idx="229">
                  <c:v>0.19503999999999999</c:v>
                </c:pt>
                <c:pt idx="230">
                  <c:v>0.28310000000000002</c:v>
                </c:pt>
                <c:pt idx="231">
                  <c:v>0.40134999999999998</c:v>
                </c:pt>
                <c:pt idx="232">
                  <c:v>0.5927</c:v>
                </c:pt>
                <c:pt idx="233">
                  <c:v>0.90824000000000005</c:v>
                </c:pt>
                <c:pt idx="234">
                  <c:v>1.3364400000000001</c:v>
                </c:pt>
                <c:pt idx="235">
                  <c:v>1.9765900000000001</c:v>
                </c:pt>
                <c:pt idx="236">
                  <c:v>2.6201599999999998</c:v>
                </c:pt>
                <c:pt idx="237">
                  <c:v>2.8941699999999999</c:v>
                </c:pt>
                <c:pt idx="238">
                  <c:v>2.99275</c:v>
                </c:pt>
                <c:pt idx="239">
                  <c:v>2.93493</c:v>
                </c:pt>
                <c:pt idx="240">
                  <c:v>3.0587200000000001</c:v>
                </c:pt>
                <c:pt idx="241">
                  <c:v>3.06284</c:v>
                </c:pt>
                <c:pt idx="242">
                  <c:v>3.1576599999999999</c:v>
                </c:pt>
                <c:pt idx="243">
                  <c:v>3.1947899999999998</c:v>
                </c:pt>
                <c:pt idx="244">
                  <c:v>3.2364899999999999</c:v>
                </c:pt>
                <c:pt idx="245">
                  <c:v>3.3009900000000001</c:v>
                </c:pt>
                <c:pt idx="246">
                  <c:v>3.34768</c:v>
                </c:pt>
                <c:pt idx="247">
                  <c:v>3.4077199999999999</c:v>
                </c:pt>
                <c:pt idx="248">
                  <c:v>3.3931399999999998</c:v>
                </c:pt>
                <c:pt idx="249">
                  <c:v>3.4904700000000002</c:v>
                </c:pt>
                <c:pt idx="250">
                  <c:v>3.5632700000000002</c:v>
                </c:pt>
                <c:pt idx="251">
                  <c:v>3.6419800000000002</c:v>
                </c:pt>
                <c:pt idx="252">
                  <c:v>3.5105900000000001</c:v>
                </c:pt>
                <c:pt idx="253">
                  <c:v>3.4695</c:v>
                </c:pt>
                <c:pt idx="254">
                  <c:v>3.3531200000000001</c:v>
                </c:pt>
                <c:pt idx="255">
                  <c:v>3.22</c:v>
                </c:pt>
                <c:pt idx="256">
                  <c:v>3.06976</c:v>
                </c:pt>
                <c:pt idx="257">
                  <c:v>2.9674499999999999</c:v>
                </c:pt>
                <c:pt idx="258">
                  <c:v>2.8225699999999998</c:v>
                </c:pt>
                <c:pt idx="259">
                  <c:v>2.6480700000000001</c:v>
                </c:pt>
                <c:pt idx="260">
                  <c:v>2.4494099999999999</c:v>
                </c:pt>
                <c:pt idx="261">
                  <c:v>2.2415600000000002</c:v>
                </c:pt>
                <c:pt idx="262">
                  <c:v>1.97587</c:v>
                </c:pt>
                <c:pt idx="263">
                  <c:v>1.69818</c:v>
                </c:pt>
                <c:pt idx="264">
                  <c:v>1.3917299999999999</c:v>
                </c:pt>
                <c:pt idx="265">
                  <c:v>1.0007299999999999</c:v>
                </c:pt>
                <c:pt idx="266">
                  <c:v>0.60597000000000001</c:v>
                </c:pt>
                <c:pt idx="267">
                  <c:v>0.34599000000000002</c:v>
                </c:pt>
                <c:pt idx="268">
                  <c:v>0.20810999999999999</c:v>
                </c:pt>
                <c:pt idx="269">
                  <c:v>0.15936</c:v>
                </c:pt>
                <c:pt idx="270">
                  <c:v>0.13599</c:v>
                </c:pt>
                <c:pt idx="271">
                  <c:v>0.14105999999999999</c:v>
                </c:pt>
                <c:pt idx="272">
                  <c:v>0.14863000000000001</c:v>
                </c:pt>
                <c:pt idx="273">
                  <c:v>0.13824</c:v>
                </c:pt>
                <c:pt idx="274">
                  <c:v>0.12520000000000001</c:v>
                </c:pt>
                <c:pt idx="275">
                  <c:v>0.12003</c:v>
                </c:pt>
                <c:pt idx="276">
                  <c:v>9.7390000000000004E-2</c:v>
                </c:pt>
                <c:pt idx="277">
                  <c:v>9.3399999999999997E-2</c:v>
                </c:pt>
                <c:pt idx="278">
                  <c:v>9.9809999999999996E-2</c:v>
                </c:pt>
                <c:pt idx="279">
                  <c:v>8.8819999999999996E-2</c:v>
                </c:pt>
                <c:pt idx="280">
                  <c:v>9.4520000000000007E-2</c:v>
                </c:pt>
                <c:pt idx="281">
                  <c:v>9.9460000000000007E-2</c:v>
                </c:pt>
                <c:pt idx="282">
                  <c:v>0.10501000000000001</c:v>
                </c:pt>
                <c:pt idx="283">
                  <c:v>0.10262</c:v>
                </c:pt>
                <c:pt idx="284">
                  <c:v>8.9560000000000001E-2</c:v>
                </c:pt>
                <c:pt idx="285">
                  <c:v>8.3070000000000005E-2</c:v>
                </c:pt>
                <c:pt idx="286">
                  <c:v>8.4599999999999995E-2</c:v>
                </c:pt>
                <c:pt idx="287">
                  <c:v>9.3939999999999996E-2</c:v>
                </c:pt>
                <c:pt idx="288">
                  <c:v>0.10498</c:v>
                </c:pt>
                <c:pt idx="289">
                  <c:v>0.10219</c:v>
                </c:pt>
                <c:pt idx="290">
                  <c:v>0.12249</c:v>
                </c:pt>
                <c:pt idx="291">
                  <c:v>0.13514000000000001</c:v>
                </c:pt>
                <c:pt idx="292">
                  <c:v>0.14834</c:v>
                </c:pt>
                <c:pt idx="293">
                  <c:v>0.13217999999999999</c:v>
                </c:pt>
                <c:pt idx="294">
                  <c:v>0.13755000000000001</c:v>
                </c:pt>
                <c:pt idx="295">
                  <c:v>0.15973000000000001</c:v>
                </c:pt>
                <c:pt idx="296">
                  <c:v>0.11906</c:v>
                </c:pt>
                <c:pt idx="297">
                  <c:v>0.13403000000000001</c:v>
                </c:pt>
                <c:pt idx="298">
                  <c:v>0.14646999999999999</c:v>
                </c:pt>
                <c:pt idx="299">
                  <c:v>0.1641</c:v>
                </c:pt>
                <c:pt idx="300">
                  <c:v>0.1427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D005-49FD-B3FC-925FD33CAD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3877152"/>
        <c:axId val="1"/>
      </c:scatterChart>
      <c:valAx>
        <c:axId val="363877152"/>
        <c:scaling>
          <c:orientation val="minMax"/>
          <c:max val="800"/>
          <c:min val="200"/>
        </c:scaling>
        <c:delete val="0"/>
        <c:axPos val="b"/>
        <c:title>
          <c:tx>
            <c:rich>
              <a:bodyPr/>
              <a:lstStyle/>
              <a:p>
                <a:pPr>
                  <a:defRPr b="1"/>
                </a:pPr>
                <a:r>
                  <a:rPr lang="fr-FR" b="1"/>
                  <a:t>Wavelength (nm)</a:t>
                </a:r>
              </a:p>
            </c:rich>
          </c:tx>
          <c:layout>
            <c:manualLayout>
              <c:xMode val="edge"/>
              <c:yMode val="edge"/>
              <c:x val="0.43796529538680545"/>
              <c:y val="0.94564399904557384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ln w="3175">
            <a:solidFill>
              <a:srgbClr val="C0C0C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fr-FR"/>
          </a:p>
        </c:txPr>
        <c:crossAx val="1"/>
        <c:crosses val="autoZero"/>
        <c:crossBetween val="midCat"/>
        <c:majorUnit val="50"/>
      </c:valAx>
      <c:valAx>
        <c:axId val="1"/>
        <c:scaling>
          <c:orientation val="minMax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b="1"/>
                </a:pPr>
                <a:r>
                  <a:rPr lang="fr-FR" b="1"/>
                  <a:t>Absorbance</a:t>
                </a:r>
              </a:p>
            </c:rich>
          </c:tx>
          <c:layout>
            <c:manualLayout>
              <c:xMode val="edge"/>
              <c:yMode val="edge"/>
              <c:x val="1.1037527593818985E-2"/>
              <c:y val="0.33680555555555558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ln w="3175">
            <a:solidFill>
              <a:srgbClr val="C0C0C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fr-FR"/>
          </a:p>
        </c:txPr>
        <c:crossAx val="363877152"/>
        <c:crosses val="autoZero"/>
        <c:crossBetween val="midCat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20227907157791716"/>
          <c:y val="2.1465044142209497E-3"/>
          <c:w val="0.42694890230882154"/>
          <c:h val="0.29166666666666669"/>
        </c:manualLayout>
      </c:layout>
      <c:overlay val="0"/>
      <c:spPr>
        <a:noFill/>
        <a:ln w="25400">
          <a:noFill/>
        </a:ln>
      </c:spPr>
    </c:legend>
    <c:plotVisOnly val="1"/>
    <c:dispBlanksAs val="gap"/>
    <c:showDLblsOverMax val="0"/>
  </c:chart>
  <c:spPr>
    <a:solidFill>
      <a:srgbClr val="FFFFFF"/>
    </a:solidFill>
    <a:ln w="12700">
      <a:solidFill>
        <a:schemeClr val="bg1"/>
      </a:solidFill>
      <a:prstDash val="solid"/>
    </a:ln>
  </c:spPr>
  <c:txPr>
    <a:bodyPr/>
    <a:lstStyle/>
    <a:p>
      <a:pPr>
        <a:defRPr sz="1100" b="0" i="0" u="none" strike="noStrike" baseline="0">
          <a:solidFill>
            <a:srgbClr val="000000"/>
          </a:solidFill>
          <a:latin typeface="Palatino Linotype" panose="02040502050505030304" pitchFamily="18" charset="0"/>
          <a:ea typeface="Times New Roman"/>
          <a:cs typeface="Times New Roman"/>
        </a:defRPr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811796890502752"/>
          <c:y val="8.0008935053331093E-2"/>
          <c:w val="0.7418784863970096"/>
          <c:h val="0.6605595577148600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Feuil1!$B$1</c:f>
              <c:strCache>
                <c:ptCount val="1"/>
                <c:pt idx="0">
                  <c:v>RB5 (25 mg/L)</c:v>
                </c:pt>
              </c:strCache>
            </c:strRef>
          </c:tx>
          <c:spPr>
            <a:ln w="12700">
              <a:solidFill>
                <a:srgbClr val="666699"/>
              </a:solidFill>
              <a:prstDash val="solid"/>
            </a:ln>
          </c:spPr>
          <c:marker>
            <c:symbol val="none"/>
          </c:marker>
          <c:xVal>
            <c:numRef>
              <c:f>Feuil1!$A$2:$A$302</c:f>
              <c:numCache>
                <c:formatCode>General</c:formatCode>
                <c:ptCount val="301"/>
                <c:pt idx="0">
                  <c:v>800</c:v>
                </c:pt>
                <c:pt idx="1">
                  <c:v>798</c:v>
                </c:pt>
                <c:pt idx="2">
                  <c:v>796</c:v>
                </c:pt>
                <c:pt idx="3">
                  <c:v>794</c:v>
                </c:pt>
                <c:pt idx="4">
                  <c:v>792</c:v>
                </c:pt>
                <c:pt idx="5">
                  <c:v>790</c:v>
                </c:pt>
                <c:pt idx="6">
                  <c:v>788</c:v>
                </c:pt>
                <c:pt idx="7">
                  <c:v>786</c:v>
                </c:pt>
                <c:pt idx="8">
                  <c:v>784</c:v>
                </c:pt>
                <c:pt idx="9">
                  <c:v>782</c:v>
                </c:pt>
                <c:pt idx="10">
                  <c:v>780</c:v>
                </c:pt>
                <c:pt idx="11">
                  <c:v>778</c:v>
                </c:pt>
                <c:pt idx="12">
                  <c:v>776</c:v>
                </c:pt>
                <c:pt idx="13">
                  <c:v>774</c:v>
                </c:pt>
                <c:pt idx="14">
                  <c:v>772</c:v>
                </c:pt>
                <c:pt idx="15">
                  <c:v>770</c:v>
                </c:pt>
                <c:pt idx="16">
                  <c:v>768</c:v>
                </c:pt>
                <c:pt idx="17">
                  <c:v>766</c:v>
                </c:pt>
                <c:pt idx="18">
                  <c:v>764</c:v>
                </c:pt>
                <c:pt idx="19">
                  <c:v>762</c:v>
                </c:pt>
                <c:pt idx="20">
                  <c:v>760</c:v>
                </c:pt>
                <c:pt idx="21">
                  <c:v>758</c:v>
                </c:pt>
                <c:pt idx="22">
                  <c:v>756</c:v>
                </c:pt>
                <c:pt idx="23">
                  <c:v>754</c:v>
                </c:pt>
                <c:pt idx="24">
                  <c:v>752</c:v>
                </c:pt>
                <c:pt idx="25">
                  <c:v>750</c:v>
                </c:pt>
                <c:pt idx="26">
                  <c:v>748</c:v>
                </c:pt>
                <c:pt idx="27">
                  <c:v>746</c:v>
                </c:pt>
                <c:pt idx="28">
                  <c:v>744</c:v>
                </c:pt>
                <c:pt idx="29">
                  <c:v>742</c:v>
                </c:pt>
                <c:pt idx="30">
                  <c:v>740</c:v>
                </c:pt>
                <c:pt idx="31">
                  <c:v>738</c:v>
                </c:pt>
                <c:pt idx="32">
                  <c:v>736</c:v>
                </c:pt>
                <c:pt idx="33">
                  <c:v>734</c:v>
                </c:pt>
                <c:pt idx="34">
                  <c:v>732</c:v>
                </c:pt>
                <c:pt idx="35">
                  <c:v>730</c:v>
                </c:pt>
                <c:pt idx="36">
                  <c:v>728</c:v>
                </c:pt>
                <c:pt idx="37">
                  <c:v>726</c:v>
                </c:pt>
                <c:pt idx="38">
                  <c:v>724</c:v>
                </c:pt>
                <c:pt idx="39">
                  <c:v>722</c:v>
                </c:pt>
                <c:pt idx="40">
                  <c:v>720</c:v>
                </c:pt>
                <c:pt idx="41">
                  <c:v>718</c:v>
                </c:pt>
                <c:pt idx="42">
                  <c:v>716</c:v>
                </c:pt>
                <c:pt idx="43">
                  <c:v>714</c:v>
                </c:pt>
                <c:pt idx="44">
                  <c:v>712</c:v>
                </c:pt>
                <c:pt idx="45">
                  <c:v>710</c:v>
                </c:pt>
                <c:pt idx="46">
                  <c:v>708</c:v>
                </c:pt>
                <c:pt idx="47">
                  <c:v>706</c:v>
                </c:pt>
                <c:pt idx="48">
                  <c:v>704</c:v>
                </c:pt>
                <c:pt idx="49">
                  <c:v>702</c:v>
                </c:pt>
                <c:pt idx="50">
                  <c:v>700</c:v>
                </c:pt>
                <c:pt idx="51">
                  <c:v>698</c:v>
                </c:pt>
                <c:pt idx="52">
                  <c:v>696</c:v>
                </c:pt>
                <c:pt idx="53">
                  <c:v>694</c:v>
                </c:pt>
                <c:pt idx="54">
                  <c:v>692</c:v>
                </c:pt>
                <c:pt idx="55">
                  <c:v>690</c:v>
                </c:pt>
                <c:pt idx="56">
                  <c:v>688</c:v>
                </c:pt>
                <c:pt idx="57">
                  <c:v>686</c:v>
                </c:pt>
                <c:pt idx="58">
                  <c:v>684</c:v>
                </c:pt>
                <c:pt idx="59">
                  <c:v>682</c:v>
                </c:pt>
                <c:pt idx="60">
                  <c:v>680</c:v>
                </c:pt>
                <c:pt idx="61">
                  <c:v>678</c:v>
                </c:pt>
                <c:pt idx="62">
                  <c:v>676</c:v>
                </c:pt>
                <c:pt idx="63">
                  <c:v>674</c:v>
                </c:pt>
                <c:pt idx="64">
                  <c:v>672</c:v>
                </c:pt>
                <c:pt idx="65">
                  <c:v>670</c:v>
                </c:pt>
                <c:pt idx="66">
                  <c:v>668</c:v>
                </c:pt>
                <c:pt idx="67">
                  <c:v>666</c:v>
                </c:pt>
                <c:pt idx="68">
                  <c:v>664</c:v>
                </c:pt>
                <c:pt idx="69">
                  <c:v>662</c:v>
                </c:pt>
                <c:pt idx="70">
                  <c:v>660</c:v>
                </c:pt>
                <c:pt idx="71">
                  <c:v>658</c:v>
                </c:pt>
                <c:pt idx="72">
                  <c:v>656</c:v>
                </c:pt>
                <c:pt idx="73">
                  <c:v>654</c:v>
                </c:pt>
                <c:pt idx="74">
                  <c:v>652</c:v>
                </c:pt>
                <c:pt idx="75">
                  <c:v>650</c:v>
                </c:pt>
                <c:pt idx="76">
                  <c:v>648</c:v>
                </c:pt>
                <c:pt idx="77">
                  <c:v>646</c:v>
                </c:pt>
                <c:pt idx="78">
                  <c:v>644</c:v>
                </c:pt>
                <c:pt idx="79">
                  <c:v>642</c:v>
                </c:pt>
                <c:pt idx="80">
                  <c:v>640</c:v>
                </c:pt>
                <c:pt idx="81">
                  <c:v>638</c:v>
                </c:pt>
                <c:pt idx="82">
                  <c:v>636</c:v>
                </c:pt>
                <c:pt idx="83">
                  <c:v>634</c:v>
                </c:pt>
                <c:pt idx="84">
                  <c:v>632</c:v>
                </c:pt>
                <c:pt idx="85">
                  <c:v>630</c:v>
                </c:pt>
                <c:pt idx="86">
                  <c:v>628</c:v>
                </c:pt>
                <c:pt idx="87">
                  <c:v>626</c:v>
                </c:pt>
                <c:pt idx="88">
                  <c:v>624</c:v>
                </c:pt>
                <c:pt idx="89">
                  <c:v>622</c:v>
                </c:pt>
                <c:pt idx="90">
                  <c:v>620</c:v>
                </c:pt>
                <c:pt idx="91">
                  <c:v>618</c:v>
                </c:pt>
                <c:pt idx="92">
                  <c:v>616</c:v>
                </c:pt>
                <c:pt idx="93">
                  <c:v>614</c:v>
                </c:pt>
                <c:pt idx="94">
                  <c:v>612</c:v>
                </c:pt>
                <c:pt idx="95">
                  <c:v>610</c:v>
                </c:pt>
                <c:pt idx="96">
                  <c:v>608</c:v>
                </c:pt>
                <c:pt idx="97">
                  <c:v>606</c:v>
                </c:pt>
                <c:pt idx="98">
                  <c:v>604</c:v>
                </c:pt>
                <c:pt idx="99">
                  <c:v>602</c:v>
                </c:pt>
                <c:pt idx="100">
                  <c:v>600</c:v>
                </c:pt>
                <c:pt idx="101">
                  <c:v>598</c:v>
                </c:pt>
                <c:pt idx="102">
                  <c:v>596</c:v>
                </c:pt>
                <c:pt idx="103">
                  <c:v>594</c:v>
                </c:pt>
                <c:pt idx="104">
                  <c:v>592</c:v>
                </c:pt>
                <c:pt idx="105">
                  <c:v>590</c:v>
                </c:pt>
                <c:pt idx="106">
                  <c:v>588</c:v>
                </c:pt>
                <c:pt idx="107">
                  <c:v>586</c:v>
                </c:pt>
                <c:pt idx="108">
                  <c:v>584</c:v>
                </c:pt>
                <c:pt idx="109">
                  <c:v>582</c:v>
                </c:pt>
                <c:pt idx="110">
                  <c:v>580</c:v>
                </c:pt>
                <c:pt idx="111">
                  <c:v>578</c:v>
                </c:pt>
                <c:pt idx="112">
                  <c:v>576</c:v>
                </c:pt>
                <c:pt idx="113">
                  <c:v>574</c:v>
                </c:pt>
                <c:pt idx="114">
                  <c:v>572</c:v>
                </c:pt>
                <c:pt idx="115">
                  <c:v>570</c:v>
                </c:pt>
                <c:pt idx="116">
                  <c:v>568</c:v>
                </c:pt>
                <c:pt idx="117">
                  <c:v>566</c:v>
                </c:pt>
                <c:pt idx="118">
                  <c:v>564</c:v>
                </c:pt>
                <c:pt idx="119">
                  <c:v>562</c:v>
                </c:pt>
                <c:pt idx="120">
                  <c:v>560</c:v>
                </c:pt>
                <c:pt idx="121">
                  <c:v>558</c:v>
                </c:pt>
                <c:pt idx="122">
                  <c:v>556</c:v>
                </c:pt>
                <c:pt idx="123">
                  <c:v>554</c:v>
                </c:pt>
                <c:pt idx="124">
                  <c:v>552</c:v>
                </c:pt>
                <c:pt idx="125">
                  <c:v>550</c:v>
                </c:pt>
                <c:pt idx="126">
                  <c:v>548</c:v>
                </c:pt>
                <c:pt idx="127">
                  <c:v>546</c:v>
                </c:pt>
                <c:pt idx="128">
                  <c:v>544</c:v>
                </c:pt>
                <c:pt idx="129">
                  <c:v>542</c:v>
                </c:pt>
                <c:pt idx="130">
                  <c:v>540</c:v>
                </c:pt>
                <c:pt idx="131">
                  <c:v>538</c:v>
                </c:pt>
                <c:pt idx="132">
                  <c:v>536</c:v>
                </c:pt>
                <c:pt idx="133">
                  <c:v>534</c:v>
                </c:pt>
                <c:pt idx="134">
                  <c:v>532</c:v>
                </c:pt>
                <c:pt idx="135">
                  <c:v>530</c:v>
                </c:pt>
                <c:pt idx="136">
                  <c:v>528</c:v>
                </c:pt>
                <c:pt idx="137">
                  <c:v>526</c:v>
                </c:pt>
                <c:pt idx="138">
                  <c:v>524</c:v>
                </c:pt>
                <c:pt idx="139">
                  <c:v>522</c:v>
                </c:pt>
                <c:pt idx="140">
                  <c:v>520</c:v>
                </c:pt>
                <c:pt idx="141">
                  <c:v>518</c:v>
                </c:pt>
                <c:pt idx="142">
                  <c:v>516</c:v>
                </c:pt>
                <c:pt idx="143">
                  <c:v>514</c:v>
                </c:pt>
                <c:pt idx="144">
                  <c:v>512</c:v>
                </c:pt>
                <c:pt idx="145">
                  <c:v>510</c:v>
                </c:pt>
                <c:pt idx="146">
                  <c:v>508</c:v>
                </c:pt>
                <c:pt idx="147">
                  <c:v>506</c:v>
                </c:pt>
                <c:pt idx="148">
                  <c:v>504</c:v>
                </c:pt>
                <c:pt idx="149">
                  <c:v>502</c:v>
                </c:pt>
                <c:pt idx="150">
                  <c:v>500</c:v>
                </c:pt>
                <c:pt idx="151">
                  <c:v>498</c:v>
                </c:pt>
                <c:pt idx="152">
                  <c:v>496</c:v>
                </c:pt>
                <c:pt idx="153">
                  <c:v>494</c:v>
                </c:pt>
                <c:pt idx="154">
                  <c:v>492</c:v>
                </c:pt>
                <c:pt idx="155">
                  <c:v>490</c:v>
                </c:pt>
                <c:pt idx="156">
                  <c:v>488</c:v>
                </c:pt>
                <c:pt idx="157">
                  <c:v>486</c:v>
                </c:pt>
                <c:pt idx="158">
                  <c:v>484</c:v>
                </c:pt>
                <c:pt idx="159">
                  <c:v>482</c:v>
                </c:pt>
                <c:pt idx="160">
                  <c:v>480</c:v>
                </c:pt>
                <c:pt idx="161">
                  <c:v>478</c:v>
                </c:pt>
                <c:pt idx="162">
                  <c:v>476</c:v>
                </c:pt>
                <c:pt idx="163">
                  <c:v>474</c:v>
                </c:pt>
                <c:pt idx="164">
                  <c:v>472</c:v>
                </c:pt>
                <c:pt idx="165">
                  <c:v>470</c:v>
                </c:pt>
                <c:pt idx="166">
                  <c:v>468</c:v>
                </c:pt>
                <c:pt idx="167">
                  <c:v>466</c:v>
                </c:pt>
                <c:pt idx="168">
                  <c:v>464</c:v>
                </c:pt>
                <c:pt idx="169">
                  <c:v>462</c:v>
                </c:pt>
                <c:pt idx="170">
                  <c:v>460</c:v>
                </c:pt>
                <c:pt idx="171">
                  <c:v>458</c:v>
                </c:pt>
                <c:pt idx="172">
                  <c:v>456</c:v>
                </c:pt>
                <c:pt idx="173">
                  <c:v>454</c:v>
                </c:pt>
                <c:pt idx="174">
                  <c:v>452</c:v>
                </c:pt>
                <c:pt idx="175">
                  <c:v>450</c:v>
                </c:pt>
                <c:pt idx="176">
                  <c:v>448</c:v>
                </c:pt>
                <c:pt idx="177">
                  <c:v>446</c:v>
                </c:pt>
                <c:pt idx="178">
                  <c:v>444</c:v>
                </c:pt>
                <c:pt idx="179">
                  <c:v>442</c:v>
                </c:pt>
                <c:pt idx="180">
                  <c:v>440</c:v>
                </c:pt>
                <c:pt idx="181">
                  <c:v>438</c:v>
                </c:pt>
                <c:pt idx="182">
                  <c:v>436</c:v>
                </c:pt>
                <c:pt idx="183">
                  <c:v>434</c:v>
                </c:pt>
                <c:pt idx="184">
                  <c:v>432</c:v>
                </c:pt>
                <c:pt idx="185">
                  <c:v>430</c:v>
                </c:pt>
                <c:pt idx="186">
                  <c:v>428</c:v>
                </c:pt>
                <c:pt idx="187">
                  <c:v>426</c:v>
                </c:pt>
                <c:pt idx="188">
                  <c:v>424</c:v>
                </c:pt>
                <c:pt idx="189">
                  <c:v>422</c:v>
                </c:pt>
                <c:pt idx="190">
                  <c:v>420</c:v>
                </c:pt>
                <c:pt idx="191">
                  <c:v>418</c:v>
                </c:pt>
                <c:pt idx="192">
                  <c:v>416</c:v>
                </c:pt>
                <c:pt idx="193">
                  <c:v>414</c:v>
                </c:pt>
                <c:pt idx="194">
                  <c:v>412</c:v>
                </c:pt>
                <c:pt idx="195">
                  <c:v>410</c:v>
                </c:pt>
                <c:pt idx="196">
                  <c:v>408</c:v>
                </c:pt>
                <c:pt idx="197">
                  <c:v>406</c:v>
                </c:pt>
                <c:pt idx="198">
                  <c:v>404</c:v>
                </c:pt>
                <c:pt idx="199">
                  <c:v>402</c:v>
                </c:pt>
                <c:pt idx="200">
                  <c:v>400</c:v>
                </c:pt>
                <c:pt idx="201">
                  <c:v>398</c:v>
                </c:pt>
                <c:pt idx="202">
                  <c:v>396</c:v>
                </c:pt>
                <c:pt idx="203">
                  <c:v>394</c:v>
                </c:pt>
                <c:pt idx="204">
                  <c:v>392</c:v>
                </c:pt>
                <c:pt idx="205">
                  <c:v>390</c:v>
                </c:pt>
                <c:pt idx="206">
                  <c:v>388</c:v>
                </c:pt>
                <c:pt idx="207">
                  <c:v>386</c:v>
                </c:pt>
                <c:pt idx="208">
                  <c:v>384</c:v>
                </c:pt>
                <c:pt idx="209">
                  <c:v>382</c:v>
                </c:pt>
                <c:pt idx="210">
                  <c:v>380</c:v>
                </c:pt>
                <c:pt idx="211">
                  <c:v>378</c:v>
                </c:pt>
                <c:pt idx="212">
                  <c:v>376</c:v>
                </c:pt>
                <c:pt idx="213">
                  <c:v>374</c:v>
                </c:pt>
                <c:pt idx="214">
                  <c:v>372</c:v>
                </c:pt>
                <c:pt idx="215">
                  <c:v>370</c:v>
                </c:pt>
                <c:pt idx="216">
                  <c:v>368</c:v>
                </c:pt>
                <c:pt idx="217">
                  <c:v>366</c:v>
                </c:pt>
                <c:pt idx="218">
                  <c:v>364</c:v>
                </c:pt>
                <c:pt idx="219">
                  <c:v>362</c:v>
                </c:pt>
                <c:pt idx="220">
                  <c:v>360</c:v>
                </c:pt>
                <c:pt idx="221">
                  <c:v>358</c:v>
                </c:pt>
                <c:pt idx="222">
                  <c:v>356</c:v>
                </c:pt>
                <c:pt idx="223">
                  <c:v>354</c:v>
                </c:pt>
                <c:pt idx="224">
                  <c:v>352</c:v>
                </c:pt>
                <c:pt idx="225">
                  <c:v>350</c:v>
                </c:pt>
                <c:pt idx="226">
                  <c:v>348</c:v>
                </c:pt>
                <c:pt idx="227">
                  <c:v>346</c:v>
                </c:pt>
                <c:pt idx="228">
                  <c:v>344</c:v>
                </c:pt>
                <c:pt idx="229">
                  <c:v>342</c:v>
                </c:pt>
                <c:pt idx="230">
                  <c:v>340</c:v>
                </c:pt>
                <c:pt idx="231">
                  <c:v>338</c:v>
                </c:pt>
                <c:pt idx="232">
                  <c:v>336</c:v>
                </c:pt>
                <c:pt idx="233">
                  <c:v>334</c:v>
                </c:pt>
                <c:pt idx="234">
                  <c:v>332</c:v>
                </c:pt>
                <c:pt idx="235">
                  <c:v>330</c:v>
                </c:pt>
                <c:pt idx="236">
                  <c:v>328</c:v>
                </c:pt>
                <c:pt idx="237">
                  <c:v>326</c:v>
                </c:pt>
                <c:pt idx="238">
                  <c:v>324</c:v>
                </c:pt>
                <c:pt idx="239">
                  <c:v>322</c:v>
                </c:pt>
                <c:pt idx="240">
                  <c:v>320</c:v>
                </c:pt>
                <c:pt idx="241">
                  <c:v>318</c:v>
                </c:pt>
                <c:pt idx="242">
                  <c:v>316</c:v>
                </c:pt>
                <c:pt idx="243">
                  <c:v>314</c:v>
                </c:pt>
                <c:pt idx="244">
                  <c:v>312</c:v>
                </c:pt>
                <c:pt idx="245">
                  <c:v>310</c:v>
                </c:pt>
                <c:pt idx="246">
                  <c:v>308</c:v>
                </c:pt>
                <c:pt idx="247">
                  <c:v>306</c:v>
                </c:pt>
                <c:pt idx="248">
                  <c:v>304</c:v>
                </c:pt>
                <c:pt idx="249">
                  <c:v>302</c:v>
                </c:pt>
                <c:pt idx="250">
                  <c:v>300</c:v>
                </c:pt>
                <c:pt idx="251">
                  <c:v>298</c:v>
                </c:pt>
                <c:pt idx="252">
                  <c:v>296</c:v>
                </c:pt>
                <c:pt idx="253">
                  <c:v>294</c:v>
                </c:pt>
                <c:pt idx="254">
                  <c:v>292</c:v>
                </c:pt>
                <c:pt idx="255">
                  <c:v>290</c:v>
                </c:pt>
                <c:pt idx="256">
                  <c:v>288</c:v>
                </c:pt>
                <c:pt idx="257">
                  <c:v>286</c:v>
                </c:pt>
                <c:pt idx="258">
                  <c:v>284</c:v>
                </c:pt>
                <c:pt idx="259">
                  <c:v>282</c:v>
                </c:pt>
                <c:pt idx="260">
                  <c:v>280</c:v>
                </c:pt>
                <c:pt idx="261">
                  <c:v>278</c:v>
                </c:pt>
                <c:pt idx="262">
                  <c:v>276</c:v>
                </c:pt>
                <c:pt idx="263">
                  <c:v>274</c:v>
                </c:pt>
                <c:pt idx="264">
                  <c:v>272</c:v>
                </c:pt>
                <c:pt idx="265">
                  <c:v>270</c:v>
                </c:pt>
                <c:pt idx="266">
                  <c:v>268</c:v>
                </c:pt>
                <c:pt idx="267">
                  <c:v>266</c:v>
                </c:pt>
                <c:pt idx="268">
                  <c:v>264</c:v>
                </c:pt>
                <c:pt idx="269">
                  <c:v>262</c:v>
                </c:pt>
                <c:pt idx="270">
                  <c:v>260</c:v>
                </c:pt>
                <c:pt idx="271">
                  <c:v>258</c:v>
                </c:pt>
                <c:pt idx="272">
                  <c:v>256</c:v>
                </c:pt>
                <c:pt idx="273">
                  <c:v>254</c:v>
                </c:pt>
                <c:pt idx="274">
                  <c:v>252</c:v>
                </c:pt>
                <c:pt idx="275">
                  <c:v>250</c:v>
                </c:pt>
                <c:pt idx="276">
                  <c:v>248</c:v>
                </c:pt>
                <c:pt idx="277">
                  <c:v>246</c:v>
                </c:pt>
                <c:pt idx="278">
                  <c:v>244</c:v>
                </c:pt>
                <c:pt idx="279">
                  <c:v>242</c:v>
                </c:pt>
                <c:pt idx="280">
                  <c:v>240</c:v>
                </c:pt>
                <c:pt idx="281">
                  <c:v>238</c:v>
                </c:pt>
                <c:pt idx="282">
                  <c:v>236</c:v>
                </c:pt>
                <c:pt idx="283">
                  <c:v>234</c:v>
                </c:pt>
                <c:pt idx="284">
                  <c:v>232</c:v>
                </c:pt>
                <c:pt idx="285">
                  <c:v>230</c:v>
                </c:pt>
                <c:pt idx="286">
                  <c:v>228</c:v>
                </c:pt>
                <c:pt idx="287">
                  <c:v>226</c:v>
                </c:pt>
                <c:pt idx="288">
                  <c:v>224</c:v>
                </c:pt>
                <c:pt idx="289">
                  <c:v>222</c:v>
                </c:pt>
                <c:pt idx="290">
                  <c:v>220</c:v>
                </c:pt>
                <c:pt idx="291">
                  <c:v>218</c:v>
                </c:pt>
                <c:pt idx="292">
                  <c:v>216</c:v>
                </c:pt>
                <c:pt idx="293">
                  <c:v>214</c:v>
                </c:pt>
                <c:pt idx="294">
                  <c:v>212</c:v>
                </c:pt>
                <c:pt idx="295">
                  <c:v>210</c:v>
                </c:pt>
                <c:pt idx="296">
                  <c:v>208</c:v>
                </c:pt>
                <c:pt idx="297">
                  <c:v>206</c:v>
                </c:pt>
                <c:pt idx="298">
                  <c:v>204</c:v>
                </c:pt>
                <c:pt idx="299">
                  <c:v>202</c:v>
                </c:pt>
                <c:pt idx="300">
                  <c:v>200</c:v>
                </c:pt>
              </c:numCache>
            </c:numRef>
          </c:xVal>
          <c:yVal>
            <c:numRef>
              <c:f>Feuil1!$B$2:$B$302</c:f>
              <c:numCache>
                <c:formatCode>General</c:formatCode>
                <c:ptCount val="301"/>
                <c:pt idx="0">
                  <c:v>7.8500000000000132E-3</c:v>
                </c:pt>
                <c:pt idx="1">
                  <c:v>-3.6000000000000103E-3</c:v>
                </c:pt>
                <c:pt idx="2">
                  <c:v>3.640000000000013E-3</c:v>
                </c:pt>
                <c:pt idx="3">
                  <c:v>2.5200000000000066E-3</c:v>
                </c:pt>
                <c:pt idx="4">
                  <c:v>3.640000000000013E-3</c:v>
                </c:pt>
                <c:pt idx="5">
                  <c:v>3.8600000000000097E-3</c:v>
                </c:pt>
                <c:pt idx="6">
                  <c:v>-3.5400000000000106E-3</c:v>
                </c:pt>
                <c:pt idx="7">
                  <c:v>-4.8000000000000083E-3</c:v>
                </c:pt>
                <c:pt idx="8">
                  <c:v>3.9100000000000011E-3</c:v>
                </c:pt>
                <c:pt idx="9">
                  <c:v>6.8800000000000146E-3</c:v>
                </c:pt>
                <c:pt idx="10">
                  <c:v>2.7400000000000098E-3</c:v>
                </c:pt>
                <c:pt idx="11">
                  <c:v>4.3100000000000013E-3</c:v>
                </c:pt>
                <c:pt idx="12">
                  <c:v>-1.0700000000000048E-3</c:v>
                </c:pt>
                <c:pt idx="13">
                  <c:v>8.5000000000000288E-4</c:v>
                </c:pt>
                <c:pt idx="14">
                  <c:v>-2.4900000000000039E-3</c:v>
                </c:pt>
                <c:pt idx="15">
                  <c:v>-5.400000000000025E-4</c:v>
                </c:pt>
                <c:pt idx="16">
                  <c:v>1.7100000000000058E-3</c:v>
                </c:pt>
                <c:pt idx="17">
                  <c:v>7.5800000000000225E-3</c:v>
                </c:pt>
                <c:pt idx="18">
                  <c:v>-1.1000000000000056E-4</c:v>
                </c:pt>
                <c:pt idx="19">
                  <c:v>8.7500000000000182E-3</c:v>
                </c:pt>
                <c:pt idx="20">
                  <c:v>-1.1500000000000052E-3</c:v>
                </c:pt>
                <c:pt idx="21">
                  <c:v>2.4800000000000065E-3</c:v>
                </c:pt>
                <c:pt idx="22">
                  <c:v>-2.4800000000000065E-3</c:v>
                </c:pt>
                <c:pt idx="23">
                  <c:v>2.5400000000000067E-3</c:v>
                </c:pt>
                <c:pt idx="24">
                  <c:v>4.9500000000000134E-3</c:v>
                </c:pt>
                <c:pt idx="25">
                  <c:v>1.3200000000000052E-3</c:v>
                </c:pt>
                <c:pt idx="26">
                  <c:v>6.2400000000000172E-3</c:v>
                </c:pt>
                <c:pt idx="27">
                  <c:v>-3.8500000000000049E-3</c:v>
                </c:pt>
                <c:pt idx="28">
                  <c:v>6.2500000000000151E-3</c:v>
                </c:pt>
                <c:pt idx="29">
                  <c:v>1.7100000000000058E-3</c:v>
                </c:pt>
                <c:pt idx="30">
                  <c:v>5.7300000000000198E-3</c:v>
                </c:pt>
                <c:pt idx="31">
                  <c:v>7.980000000000027E-3</c:v>
                </c:pt>
                <c:pt idx="32">
                  <c:v>3.5000000000000141E-4</c:v>
                </c:pt>
                <c:pt idx="33">
                  <c:v>4.8800000000000111E-3</c:v>
                </c:pt>
                <c:pt idx="34">
                  <c:v>1.8100000000000065E-3</c:v>
                </c:pt>
                <c:pt idx="35">
                  <c:v>-4.0000000000000132E-4</c:v>
                </c:pt>
                <c:pt idx="36">
                  <c:v>2.9200000000000072E-3</c:v>
                </c:pt>
                <c:pt idx="37">
                  <c:v>5.1500000000000061E-3</c:v>
                </c:pt>
                <c:pt idx="38">
                  <c:v>-2.3000000000000071E-4</c:v>
                </c:pt>
                <c:pt idx="39">
                  <c:v>6.1600000000000014E-3</c:v>
                </c:pt>
                <c:pt idx="40">
                  <c:v>3.2700000000000103E-3</c:v>
                </c:pt>
                <c:pt idx="41">
                  <c:v>7.2300000000000272E-3</c:v>
                </c:pt>
                <c:pt idx="42">
                  <c:v>5.0400000000000124E-3</c:v>
                </c:pt>
                <c:pt idx="43">
                  <c:v>4.2100000000000123E-3</c:v>
                </c:pt>
                <c:pt idx="44">
                  <c:v>-5.5000000000000188E-4</c:v>
                </c:pt>
                <c:pt idx="45">
                  <c:v>9.1100000000000226E-3</c:v>
                </c:pt>
                <c:pt idx="46">
                  <c:v>9.8000000000000361E-3</c:v>
                </c:pt>
                <c:pt idx="47">
                  <c:v>7.3900000000000129E-3</c:v>
                </c:pt>
                <c:pt idx="48">
                  <c:v>1.0010000000000002E-2</c:v>
                </c:pt>
                <c:pt idx="49">
                  <c:v>1.3780000000000054E-2</c:v>
                </c:pt>
                <c:pt idx="50">
                  <c:v>1.3820000000000056E-2</c:v>
                </c:pt>
                <c:pt idx="51">
                  <c:v>1.4720000000000032E-2</c:v>
                </c:pt>
                <c:pt idx="52">
                  <c:v>1.7650000000000034E-2</c:v>
                </c:pt>
                <c:pt idx="53">
                  <c:v>1.3830000000000035E-2</c:v>
                </c:pt>
                <c:pt idx="54">
                  <c:v>2.3789999999999999E-2</c:v>
                </c:pt>
                <c:pt idx="55">
                  <c:v>1.9400000000000053E-2</c:v>
                </c:pt>
                <c:pt idx="56">
                  <c:v>2.6260000000000009E-2</c:v>
                </c:pt>
                <c:pt idx="57">
                  <c:v>2.8909999999999998E-2</c:v>
                </c:pt>
                <c:pt idx="58">
                  <c:v>3.5950000000000051E-2</c:v>
                </c:pt>
                <c:pt idx="59">
                  <c:v>3.5900000000000071E-2</c:v>
                </c:pt>
                <c:pt idx="60">
                  <c:v>4.2420000000000034E-2</c:v>
                </c:pt>
                <c:pt idx="61">
                  <c:v>4.8189999999999997E-2</c:v>
                </c:pt>
                <c:pt idx="62">
                  <c:v>5.2370000000000111E-2</c:v>
                </c:pt>
                <c:pt idx="63">
                  <c:v>6.1330000000000121E-2</c:v>
                </c:pt>
                <c:pt idx="64">
                  <c:v>6.9890000000000216E-2</c:v>
                </c:pt>
                <c:pt idx="65">
                  <c:v>8.0830000000000068E-2</c:v>
                </c:pt>
                <c:pt idx="66">
                  <c:v>9.1910000000000006E-2</c:v>
                </c:pt>
                <c:pt idx="67">
                  <c:v>0.10353000000000002</c:v>
                </c:pt>
                <c:pt idx="68">
                  <c:v>0.1168700000000001</c:v>
                </c:pt>
                <c:pt idx="69">
                  <c:v>0.12716</c:v>
                </c:pt>
                <c:pt idx="70">
                  <c:v>0.14133000000000001</c:v>
                </c:pt>
                <c:pt idx="71">
                  <c:v>0.15912999999999999</c:v>
                </c:pt>
                <c:pt idx="72">
                  <c:v>0.17438999999999999</c:v>
                </c:pt>
                <c:pt idx="73">
                  <c:v>0.19303000000000026</c:v>
                </c:pt>
                <c:pt idx="74">
                  <c:v>0.21391000000000063</c:v>
                </c:pt>
                <c:pt idx="75">
                  <c:v>0.23175999999999999</c:v>
                </c:pt>
                <c:pt idx="76">
                  <c:v>0.25423999999999997</c:v>
                </c:pt>
                <c:pt idx="77">
                  <c:v>0.27885000000000032</c:v>
                </c:pt>
                <c:pt idx="78">
                  <c:v>0.30208000000000101</c:v>
                </c:pt>
                <c:pt idx="79">
                  <c:v>0.33099000000000089</c:v>
                </c:pt>
                <c:pt idx="80">
                  <c:v>0.35255000000000031</c:v>
                </c:pt>
                <c:pt idx="81">
                  <c:v>0.37162000000000089</c:v>
                </c:pt>
                <c:pt idx="82">
                  <c:v>0.40141000000000032</c:v>
                </c:pt>
                <c:pt idx="83">
                  <c:v>0.42212000000000038</c:v>
                </c:pt>
                <c:pt idx="84">
                  <c:v>0.44784000000000057</c:v>
                </c:pt>
                <c:pt idx="85">
                  <c:v>0.47072000000000008</c:v>
                </c:pt>
                <c:pt idx="86">
                  <c:v>0.49347000000000102</c:v>
                </c:pt>
                <c:pt idx="87">
                  <c:v>0.51473999999999998</c:v>
                </c:pt>
                <c:pt idx="88">
                  <c:v>0.53261000000000003</c:v>
                </c:pt>
                <c:pt idx="89">
                  <c:v>0.54803999999999997</c:v>
                </c:pt>
                <c:pt idx="90">
                  <c:v>0.56105000000000005</c:v>
                </c:pt>
                <c:pt idx="91">
                  <c:v>0.57023999999999997</c:v>
                </c:pt>
                <c:pt idx="92">
                  <c:v>0.58445999999999909</c:v>
                </c:pt>
                <c:pt idx="93">
                  <c:v>0.59379000000000104</c:v>
                </c:pt>
                <c:pt idx="94">
                  <c:v>0.60168000000000155</c:v>
                </c:pt>
                <c:pt idx="95">
                  <c:v>0.60857000000000061</c:v>
                </c:pt>
                <c:pt idx="96">
                  <c:v>0.61570000000000202</c:v>
                </c:pt>
                <c:pt idx="97">
                  <c:v>0.61670000000000202</c:v>
                </c:pt>
                <c:pt idx="98">
                  <c:v>0.61986000000000063</c:v>
                </c:pt>
                <c:pt idx="99">
                  <c:v>0.62500999999999995</c:v>
                </c:pt>
                <c:pt idx="100">
                  <c:v>0.62238000000000004</c:v>
                </c:pt>
                <c:pt idx="101">
                  <c:v>0.62421000000000004</c:v>
                </c:pt>
                <c:pt idx="102">
                  <c:v>0.6240200000000018</c:v>
                </c:pt>
                <c:pt idx="103">
                  <c:v>0.61911000000000005</c:v>
                </c:pt>
                <c:pt idx="104">
                  <c:v>0.61564000000000241</c:v>
                </c:pt>
                <c:pt idx="105">
                  <c:v>0.61246</c:v>
                </c:pt>
                <c:pt idx="106">
                  <c:v>0.61158000000000001</c:v>
                </c:pt>
                <c:pt idx="107">
                  <c:v>0.60731000000000002</c:v>
                </c:pt>
                <c:pt idx="108">
                  <c:v>0.59934999999999949</c:v>
                </c:pt>
                <c:pt idx="109">
                  <c:v>0.5922499999999995</c:v>
                </c:pt>
                <c:pt idx="110">
                  <c:v>0.58627999999999958</c:v>
                </c:pt>
                <c:pt idx="111">
                  <c:v>0.57882000000000178</c:v>
                </c:pt>
                <c:pt idx="112">
                  <c:v>0.57030999999999998</c:v>
                </c:pt>
                <c:pt idx="113">
                  <c:v>0.55939000000000005</c:v>
                </c:pt>
                <c:pt idx="114">
                  <c:v>0.55071000000000003</c:v>
                </c:pt>
                <c:pt idx="115">
                  <c:v>0.53965000000000063</c:v>
                </c:pt>
                <c:pt idx="116">
                  <c:v>0.52866999999999997</c:v>
                </c:pt>
                <c:pt idx="117">
                  <c:v>0.5145999999999995</c:v>
                </c:pt>
                <c:pt idx="118">
                  <c:v>0.5027199999999995</c:v>
                </c:pt>
                <c:pt idx="119">
                  <c:v>0.49129</c:v>
                </c:pt>
                <c:pt idx="120">
                  <c:v>0.47847000000000089</c:v>
                </c:pt>
                <c:pt idx="121">
                  <c:v>0.46587000000000089</c:v>
                </c:pt>
                <c:pt idx="122">
                  <c:v>0.45521</c:v>
                </c:pt>
                <c:pt idx="123">
                  <c:v>0.44296000000000052</c:v>
                </c:pt>
                <c:pt idx="124">
                  <c:v>0.43028000000000038</c:v>
                </c:pt>
                <c:pt idx="125">
                  <c:v>0.41882000000000114</c:v>
                </c:pt>
                <c:pt idx="126">
                  <c:v>0.40786000000000078</c:v>
                </c:pt>
                <c:pt idx="127">
                  <c:v>0.39529000000000031</c:v>
                </c:pt>
                <c:pt idx="128">
                  <c:v>0.38424000000000008</c:v>
                </c:pt>
                <c:pt idx="129">
                  <c:v>0.37297000000000102</c:v>
                </c:pt>
                <c:pt idx="130">
                  <c:v>0.36195000000000038</c:v>
                </c:pt>
                <c:pt idx="131">
                  <c:v>0.35137000000000101</c:v>
                </c:pt>
                <c:pt idx="132">
                  <c:v>0.34065000000000051</c:v>
                </c:pt>
                <c:pt idx="133">
                  <c:v>0.33056000000000102</c:v>
                </c:pt>
                <c:pt idx="134">
                  <c:v>0.32133000000000089</c:v>
                </c:pt>
                <c:pt idx="135">
                  <c:v>0.30947000000000102</c:v>
                </c:pt>
                <c:pt idx="136">
                  <c:v>0.30074000000000001</c:v>
                </c:pt>
                <c:pt idx="137">
                  <c:v>0.29110000000000008</c:v>
                </c:pt>
                <c:pt idx="138">
                  <c:v>0.28170000000000001</c:v>
                </c:pt>
                <c:pt idx="139">
                  <c:v>0.27365</c:v>
                </c:pt>
                <c:pt idx="140">
                  <c:v>0.26529999999999998</c:v>
                </c:pt>
                <c:pt idx="141">
                  <c:v>0.25661</c:v>
                </c:pt>
                <c:pt idx="142">
                  <c:v>0.24794000000000069</c:v>
                </c:pt>
                <c:pt idx="143">
                  <c:v>0.24048000000000042</c:v>
                </c:pt>
                <c:pt idx="144">
                  <c:v>0.23219000000000001</c:v>
                </c:pt>
                <c:pt idx="145">
                  <c:v>0.22617999999999988</c:v>
                </c:pt>
                <c:pt idx="146">
                  <c:v>0.22017999999999988</c:v>
                </c:pt>
                <c:pt idx="147">
                  <c:v>0.21530000000000021</c:v>
                </c:pt>
                <c:pt idx="148">
                  <c:v>0.21252000000000001</c:v>
                </c:pt>
                <c:pt idx="149">
                  <c:v>0.20802000000000001</c:v>
                </c:pt>
                <c:pt idx="150">
                  <c:v>0.20407</c:v>
                </c:pt>
                <c:pt idx="151">
                  <c:v>0.20277000000000001</c:v>
                </c:pt>
                <c:pt idx="152">
                  <c:v>0.20250000000000001</c:v>
                </c:pt>
                <c:pt idx="153">
                  <c:v>0.20133000000000001</c:v>
                </c:pt>
                <c:pt idx="154">
                  <c:v>0.20199000000000042</c:v>
                </c:pt>
                <c:pt idx="155">
                  <c:v>0.20207</c:v>
                </c:pt>
                <c:pt idx="156">
                  <c:v>0.20252000000000001</c:v>
                </c:pt>
                <c:pt idx="157">
                  <c:v>0.2026</c:v>
                </c:pt>
                <c:pt idx="158">
                  <c:v>0.20211999999999999</c:v>
                </c:pt>
                <c:pt idx="159">
                  <c:v>0.20102</c:v>
                </c:pt>
                <c:pt idx="160">
                  <c:v>0.19940000000000049</c:v>
                </c:pt>
                <c:pt idx="161">
                  <c:v>0.19709000000000035</c:v>
                </c:pt>
                <c:pt idx="162">
                  <c:v>0.19361000000000025</c:v>
                </c:pt>
                <c:pt idx="163">
                  <c:v>0.19086000000000022</c:v>
                </c:pt>
                <c:pt idx="164">
                  <c:v>0.18774000000000063</c:v>
                </c:pt>
                <c:pt idx="165">
                  <c:v>0.18470000000000042</c:v>
                </c:pt>
                <c:pt idx="166">
                  <c:v>0.18243000000000048</c:v>
                </c:pt>
                <c:pt idx="167">
                  <c:v>0.17947000000000021</c:v>
                </c:pt>
                <c:pt idx="168">
                  <c:v>0.17788000000000001</c:v>
                </c:pt>
                <c:pt idx="169">
                  <c:v>0.17610999999999999</c:v>
                </c:pt>
                <c:pt idx="170">
                  <c:v>0.17496000000000048</c:v>
                </c:pt>
                <c:pt idx="171">
                  <c:v>0.17401000000000039</c:v>
                </c:pt>
                <c:pt idx="172">
                  <c:v>0.17330999999999999</c:v>
                </c:pt>
                <c:pt idx="173">
                  <c:v>0.17266000000000001</c:v>
                </c:pt>
                <c:pt idx="174">
                  <c:v>0.17169000000000001</c:v>
                </c:pt>
                <c:pt idx="175">
                  <c:v>0.17041000000000048</c:v>
                </c:pt>
                <c:pt idx="176">
                  <c:v>0.16933000000000026</c:v>
                </c:pt>
                <c:pt idx="177">
                  <c:v>0.16819000000000026</c:v>
                </c:pt>
                <c:pt idx="178">
                  <c:v>0.16664000000000029</c:v>
                </c:pt>
                <c:pt idx="179">
                  <c:v>0.16592000000000034</c:v>
                </c:pt>
                <c:pt idx="180">
                  <c:v>0.16489000000000026</c:v>
                </c:pt>
                <c:pt idx="181">
                  <c:v>0.16388000000000019</c:v>
                </c:pt>
                <c:pt idx="182">
                  <c:v>0.16306000000000029</c:v>
                </c:pt>
                <c:pt idx="183">
                  <c:v>0.16233000000000022</c:v>
                </c:pt>
                <c:pt idx="184">
                  <c:v>0.16142000000000026</c:v>
                </c:pt>
                <c:pt idx="185">
                  <c:v>0.1609000000000004</c:v>
                </c:pt>
                <c:pt idx="186">
                  <c:v>0.16028000000000026</c:v>
                </c:pt>
                <c:pt idx="187">
                  <c:v>0.15998000000000054</c:v>
                </c:pt>
                <c:pt idx="188">
                  <c:v>0.15985000000000021</c:v>
                </c:pt>
                <c:pt idx="189">
                  <c:v>0.15982000000000021</c:v>
                </c:pt>
                <c:pt idx="190">
                  <c:v>0.16005000000000019</c:v>
                </c:pt>
                <c:pt idx="191">
                  <c:v>0.16002000000000019</c:v>
                </c:pt>
                <c:pt idx="192">
                  <c:v>0.16012999999999997</c:v>
                </c:pt>
                <c:pt idx="193">
                  <c:v>0.16086999999999999</c:v>
                </c:pt>
                <c:pt idx="194">
                  <c:v>0.16088000000000019</c:v>
                </c:pt>
                <c:pt idx="195">
                  <c:v>0.16192000000000026</c:v>
                </c:pt>
                <c:pt idx="196">
                  <c:v>0.16348000000000029</c:v>
                </c:pt>
                <c:pt idx="197">
                  <c:v>0.16614000000000029</c:v>
                </c:pt>
                <c:pt idx="198">
                  <c:v>0.16998000000000044</c:v>
                </c:pt>
                <c:pt idx="199">
                  <c:v>0.17549000000000048</c:v>
                </c:pt>
                <c:pt idx="200">
                  <c:v>0.18165999999999999</c:v>
                </c:pt>
                <c:pt idx="201">
                  <c:v>0.18821000000000063</c:v>
                </c:pt>
                <c:pt idx="202">
                  <c:v>0.19475000000000026</c:v>
                </c:pt>
                <c:pt idx="203">
                  <c:v>0.19894000000000067</c:v>
                </c:pt>
                <c:pt idx="204">
                  <c:v>0.20089000000000001</c:v>
                </c:pt>
                <c:pt idx="205">
                  <c:v>0.20093000000000039</c:v>
                </c:pt>
                <c:pt idx="206">
                  <c:v>0.19873000000000043</c:v>
                </c:pt>
                <c:pt idx="207">
                  <c:v>0.19517999999999988</c:v>
                </c:pt>
                <c:pt idx="208">
                  <c:v>0.19045000000000026</c:v>
                </c:pt>
                <c:pt idx="209">
                  <c:v>0.18551000000000048</c:v>
                </c:pt>
                <c:pt idx="210">
                  <c:v>0.18020000000000042</c:v>
                </c:pt>
                <c:pt idx="211">
                  <c:v>0.17488000000000001</c:v>
                </c:pt>
                <c:pt idx="212">
                  <c:v>0.17</c:v>
                </c:pt>
                <c:pt idx="213">
                  <c:v>0.16466999999999998</c:v>
                </c:pt>
                <c:pt idx="214">
                  <c:v>0.15853000000000048</c:v>
                </c:pt>
                <c:pt idx="215">
                  <c:v>0.15282000000000001</c:v>
                </c:pt>
                <c:pt idx="216">
                  <c:v>0.14675000000000021</c:v>
                </c:pt>
                <c:pt idx="217">
                  <c:v>0.14158000000000001</c:v>
                </c:pt>
                <c:pt idx="218">
                  <c:v>0.13621000000000039</c:v>
                </c:pt>
                <c:pt idx="219">
                  <c:v>0.13272</c:v>
                </c:pt>
                <c:pt idx="220">
                  <c:v>0.13091000000000041</c:v>
                </c:pt>
                <c:pt idx="221">
                  <c:v>0.13069</c:v>
                </c:pt>
                <c:pt idx="222">
                  <c:v>0.13295000000000001</c:v>
                </c:pt>
                <c:pt idx="223">
                  <c:v>0.13674000000000042</c:v>
                </c:pt>
                <c:pt idx="224">
                  <c:v>0.14282</c:v>
                </c:pt>
                <c:pt idx="225">
                  <c:v>0.14960999999999999</c:v>
                </c:pt>
                <c:pt idx="226">
                  <c:v>0.15733000000000039</c:v>
                </c:pt>
                <c:pt idx="227">
                  <c:v>0.16529000000000044</c:v>
                </c:pt>
                <c:pt idx="228">
                  <c:v>0.17288999999999999</c:v>
                </c:pt>
                <c:pt idx="229">
                  <c:v>0.18280000000000021</c:v>
                </c:pt>
                <c:pt idx="230">
                  <c:v>0.19632000000000019</c:v>
                </c:pt>
                <c:pt idx="231">
                  <c:v>0.21080000000000004</c:v>
                </c:pt>
                <c:pt idx="232">
                  <c:v>0.22983000000000026</c:v>
                </c:pt>
                <c:pt idx="233">
                  <c:v>0.25256000000000001</c:v>
                </c:pt>
                <c:pt idx="234">
                  <c:v>0.27553</c:v>
                </c:pt>
                <c:pt idx="235">
                  <c:v>0.30126000000000008</c:v>
                </c:pt>
                <c:pt idx="236">
                  <c:v>0.3275000000000009</c:v>
                </c:pt>
                <c:pt idx="237">
                  <c:v>0.35011000000000031</c:v>
                </c:pt>
                <c:pt idx="238">
                  <c:v>0.37077000000000032</c:v>
                </c:pt>
                <c:pt idx="239">
                  <c:v>0.3891100000000009</c:v>
                </c:pt>
                <c:pt idx="240">
                  <c:v>0.40375</c:v>
                </c:pt>
                <c:pt idx="241">
                  <c:v>0.41396000000000038</c:v>
                </c:pt>
                <c:pt idx="242">
                  <c:v>0.42318000000000078</c:v>
                </c:pt>
                <c:pt idx="243">
                  <c:v>0.42911000000000032</c:v>
                </c:pt>
                <c:pt idx="244">
                  <c:v>0.43426000000000031</c:v>
                </c:pt>
                <c:pt idx="245">
                  <c:v>0.43644000000000038</c:v>
                </c:pt>
                <c:pt idx="246">
                  <c:v>0.43643000000000032</c:v>
                </c:pt>
                <c:pt idx="247">
                  <c:v>0.43459000000000031</c:v>
                </c:pt>
                <c:pt idx="248">
                  <c:v>0.43061000000000038</c:v>
                </c:pt>
                <c:pt idx="249">
                  <c:v>0.42659000000000002</c:v>
                </c:pt>
                <c:pt idx="250">
                  <c:v>0.41970000000000002</c:v>
                </c:pt>
                <c:pt idx="251">
                  <c:v>0.41266000000000008</c:v>
                </c:pt>
                <c:pt idx="252">
                  <c:v>0.40448000000000089</c:v>
                </c:pt>
                <c:pt idx="253">
                  <c:v>0.39459000000000038</c:v>
                </c:pt>
                <c:pt idx="254">
                  <c:v>0.38371000000000038</c:v>
                </c:pt>
                <c:pt idx="255">
                  <c:v>0.37329000000000001</c:v>
                </c:pt>
                <c:pt idx="256">
                  <c:v>0.35926000000000002</c:v>
                </c:pt>
                <c:pt idx="257">
                  <c:v>0.34842000000000134</c:v>
                </c:pt>
                <c:pt idx="258">
                  <c:v>0.3356000000000009</c:v>
                </c:pt>
                <c:pt idx="259">
                  <c:v>0.3236100000000009</c:v>
                </c:pt>
                <c:pt idx="260">
                  <c:v>0.31418000000000101</c:v>
                </c:pt>
                <c:pt idx="261">
                  <c:v>0.3044100000000009</c:v>
                </c:pt>
                <c:pt idx="262">
                  <c:v>0.29617000000000032</c:v>
                </c:pt>
                <c:pt idx="263">
                  <c:v>0.29552000000000089</c:v>
                </c:pt>
                <c:pt idx="264">
                  <c:v>0.28783000000000031</c:v>
                </c:pt>
                <c:pt idx="265">
                  <c:v>0.28834000000000032</c:v>
                </c:pt>
                <c:pt idx="266">
                  <c:v>0.26113000000000003</c:v>
                </c:pt>
                <c:pt idx="267">
                  <c:v>0.24501000000000048</c:v>
                </c:pt>
                <c:pt idx="268">
                  <c:v>0.23133000000000001</c:v>
                </c:pt>
                <c:pt idx="269">
                  <c:v>0.21664000000000042</c:v>
                </c:pt>
                <c:pt idx="270">
                  <c:v>0.21380000000000021</c:v>
                </c:pt>
                <c:pt idx="271">
                  <c:v>0.21160000000000001</c:v>
                </c:pt>
                <c:pt idx="272">
                  <c:v>0.21578000000000042</c:v>
                </c:pt>
                <c:pt idx="273">
                  <c:v>0.21212</c:v>
                </c:pt>
                <c:pt idx="274">
                  <c:v>0.21728000000000042</c:v>
                </c:pt>
                <c:pt idx="275">
                  <c:v>0.21595000000000042</c:v>
                </c:pt>
                <c:pt idx="276">
                  <c:v>0.21125000000000024</c:v>
                </c:pt>
                <c:pt idx="277">
                  <c:v>0.20615</c:v>
                </c:pt>
                <c:pt idx="278">
                  <c:v>0.21376000000000048</c:v>
                </c:pt>
                <c:pt idx="279">
                  <c:v>0.21191000000000054</c:v>
                </c:pt>
                <c:pt idx="280">
                  <c:v>0.21468000000000001</c:v>
                </c:pt>
                <c:pt idx="281">
                  <c:v>0.20892000000000024</c:v>
                </c:pt>
                <c:pt idx="282">
                  <c:v>0.21518999999999999</c:v>
                </c:pt>
                <c:pt idx="283">
                  <c:v>0.22150000000000022</c:v>
                </c:pt>
                <c:pt idx="284">
                  <c:v>0.21352000000000004</c:v>
                </c:pt>
                <c:pt idx="285">
                  <c:v>0.21481000000000042</c:v>
                </c:pt>
                <c:pt idx="286">
                  <c:v>0.21432999999999999</c:v>
                </c:pt>
                <c:pt idx="287">
                  <c:v>0.21615000000000001</c:v>
                </c:pt>
                <c:pt idx="288">
                  <c:v>0.20821000000000048</c:v>
                </c:pt>
                <c:pt idx="289">
                  <c:v>0.19941000000000061</c:v>
                </c:pt>
                <c:pt idx="290">
                  <c:v>0.21486000000000038</c:v>
                </c:pt>
                <c:pt idx="291">
                  <c:v>0.21907000000000001</c:v>
                </c:pt>
                <c:pt idx="292">
                  <c:v>0.24147000000000021</c:v>
                </c:pt>
                <c:pt idx="293">
                  <c:v>0.2244100000000005</c:v>
                </c:pt>
                <c:pt idx="294">
                  <c:v>0.19107000000000018</c:v>
                </c:pt>
                <c:pt idx="295">
                  <c:v>0.23475000000000001</c:v>
                </c:pt>
                <c:pt idx="296">
                  <c:v>0.24124000000000054</c:v>
                </c:pt>
                <c:pt idx="297">
                  <c:v>0.22324000000000049</c:v>
                </c:pt>
                <c:pt idx="298">
                  <c:v>0.24077999999999999</c:v>
                </c:pt>
                <c:pt idx="299">
                  <c:v>0.22781000000000035</c:v>
                </c:pt>
                <c:pt idx="300">
                  <c:v>0.21837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01B-4127-A621-24501A84C0B5}"/>
            </c:ext>
          </c:extLst>
        </c:ser>
        <c:ser>
          <c:idx val="1"/>
          <c:order val="1"/>
          <c:tx>
            <c:strRef>
              <c:f>Feuil1!$C$1</c:f>
              <c:strCache>
                <c:ptCount val="1"/>
                <c:pt idx="0">
                  <c:v>RB5 (25mg/L) +HBT</c:v>
                </c:pt>
              </c:strCache>
            </c:strRef>
          </c:tx>
          <c:spPr>
            <a:ln w="12700">
              <a:solidFill>
                <a:srgbClr val="FF6600"/>
              </a:solidFill>
              <a:prstDash val="solid"/>
            </a:ln>
          </c:spPr>
          <c:marker>
            <c:symbol val="none"/>
          </c:marker>
          <c:xVal>
            <c:numRef>
              <c:f>Feuil1!$A$2:$A$302</c:f>
              <c:numCache>
                <c:formatCode>General</c:formatCode>
                <c:ptCount val="301"/>
                <c:pt idx="0">
                  <c:v>800</c:v>
                </c:pt>
                <c:pt idx="1">
                  <c:v>798</c:v>
                </c:pt>
                <c:pt idx="2">
                  <c:v>796</c:v>
                </c:pt>
                <c:pt idx="3">
                  <c:v>794</c:v>
                </c:pt>
                <c:pt idx="4">
                  <c:v>792</c:v>
                </c:pt>
                <c:pt idx="5">
                  <c:v>790</c:v>
                </c:pt>
                <c:pt idx="6">
                  <c:v>788</c:v>
                </c:pt>
                <c:pt idx="7">
                  <c:v>786</c:v>
                </c:pt>
                <c:pt idx="8">
                  <c:v>784</c:v>
                </c:pt>
                <c:pt idx="9">
                  <c:v>782</c:v>
                </c:pt>
                <c:pt idx="10">
                  <c:v>780</c:v>
                </c:pt>
                <c:pt idx="11">
                  <c:v>778</c:v>
                </c:pt>
                <c:pt idx="12">
                  <c:v>776</c:v>
                </c:pt>
                <c:pt idx="13">
                  <c:v>774</c:v>
                </c:pt>
                <c:pt idx="14">
                  <c:v>772</c:v>
                </c:pt>
                <c:pt idx="15">
                  <c:v>770</c:v>
                </c:pt>
                <c:pt idx="16">
                  <c:v>768</c:v>
                </c:pt>
                <c:pt idx="17">
                  <c:v>766</c:v>
                </c:pt>
                <c:pt idx="18">
                  <c:v>764</c:v>
                </c:pt>
                <c:pt idx="19">
                  <c:v>762</c:v>
                </c:pt>
                <c:pt idx="20">
                  <c:v>760</c:v>
                </c:pt>
                <c:pt idx="21">
                  <c:v>758</c:v>
                </c:pt>
                <c:pt idx="22">
                  <c:v>756</c:v>
                </c:pt>
                <c:pt idx="23">
                  <c:v>754</c:v>
                </c:pt>
                <c:pt idx="24">
                  <c:v>752</c:v>
                </c:pt>
                <c:pt idx="25">
                  <c:v>750</c:v>
                </c:pt>
                <c:pt idx="26">
                  <c:v>748</c:v>
                </c:pt>
                <c:pt idx="27">
                  <c:v>746</c:v>
                </c:pt>
                <c:pt idx="28">
                  <c:v>744</c:v>
                </c:pt>
                <c:pt idx="29">
                  <c:v>742</c:v>
                </c:pt>
                <c:pt idx="30">
                  <c:v>740</c:v>
                </c:pt>
                <c:pt idx="31">
                  <c:v>738</c:v>
                </c:pt>
                <c:pt idx="32">
                  <c:v>736</c:v>
                </c:pt>
                <c:pt idx="33">
                  <c:v>734</c:v>
                </c:pt>
                <c:pt idx="34">
                  <c:v>732</c:v>
                </c:pt>
                <c:pt idx="35">
                  <c:v>730</c:v>
                </c:pt>
                <c:pt idx="36">
                  <c:v>728</c:v>
                </c:pt>
                <c:pt idx="37">
                  <c:v>726</c:v>
                </c:pt>
                <c:pt idx="38">
                  <c:v>724</c:v>
                </c:pt>
                <c:pt idx="39">
                  <c:v>722</c:v>
                </c:pt>
                <c:pt idx="40">
                  <c:v>720</c:v>
                </c:pt>
                <c:pt idx="41">
                  <c:v>718</c:v>
                </c:pt>
                <c:pt idx="42">
                  <c:v>716</c:v>
                </c:pt>
                <c:pt idx="43">
                  <c:v>714</c:v>
                </c:pt>
                <c:pt idx="44">
                  <c:v>712</c:v>
                </c:pt>
                <c:pt idx="45">
                  <c:v>710</c:v>
                </c:pt>
                <c:pt idx="46">
                  <c:v>708</c:v>
                </c:pt>
                <c:pt idx="47">
                  <c:v>706</c:v>
                </c:pt>
                <c:pt idx="48">
                  <c:v>704</c:v>
                </c:pt>
                <c:pt idx="49">
                  <c:v>702</c:v>
                </c:pt>
                <c:pt idx="50">
                  <c:v>700</c:v>
                </c:pt>
                <c:pt idx="51">
                  <c:v>698</c:v>
                </c:pt>
                <c:pt idx="52">
                  <c:v>696</c:v>
                </c:pt>
                <c:pt idx="53">
                  <c:v>694</c:v>
                </c:pt>
                <c:pt idx="54">
                  <c:v>692</c:v>
                </c:pt>
                <c:pt idx="55">
                  <c:v>690</c:v>
                </c:pt>
                <c:pt idx="56">
                  <c:v>688</c:v>
                </c:pt>
                <c:pt idx="57">
                  <c:v>686</c:v>
                </c:pt>
                <c:pt idx="58">
                  <c:v>684</c:v>
                </c:pt>
                <c:pt idx="59">
                  <c:v>682</c:v>
                </c:pt>
                <c:pt idx="60">
                  <c:v>680</c:v>
                </c:pt>
                <c:pt idx="61">
                  <c:v>678</c:v>
                </c:pt>
                <c:pt idx="62">
                  <c:v>676</c:v>
                </c:pt>
                <c:pt idx="63">
                  <c:v>674</c:v>
                </c:pt>
                <c:pt idx="64">
                  <c:v>672</c:v>
                </c:pt>
                <c:pt idx="65">
                  <c:v>670</c:v>
                </c:pt>
                <c:pt idx="66">
                  <c:v>668</c:v>
                </c:pt>
                <c:pt idx="67">
                  <c:v>666</c:v>
                </c:pt>
                <c:pt idx="68">
                  <c:v>664</c:v>
                </c:pt>
                <c:pt idx="69">
                  <c:v>662</c:v>
                </c:pt>
                <c:pt idx="70">
                  <c:v>660</c:v>
                </c:pt>
                <c:pt idx="71">
                  <c:v>658</c:v>
                </c:pt>
                <c:pt idx="72">
                  <c:v>656</c:v>
                </c:pt>
                <c:pt idx="73">
                  <c:v>654</c:v>
                </c:pt>
                <c:pt idx="74">
                  <c:v>652</c:v>
                </c:pt>
                <c:pt idx="75">
                  <c:v>650</c:v>
                </c:pt>
                <c:pt idx="76">
                  <c:v>648</c:v>
                </c:pt>
                <c:pt idx="77">
                  <c:v>646</c:v>
                </c:pt>
                <c:pt idx="78">
                  <c:v>644</c:v>
                </c:pt>
                <c:pt idx="79">
                  <c:v>642</c:v>
                </c:pt>
                <c:pt idx="80">
                  <c:v>640</c:v>
                </c:pt>
                <c:pt idx="81">
                  <c:v>638</c:v>
                </c:pt>
                <c:pt idx="82">
                  <c:v>636</c:v>
                </c:pt>
                <c:pt idx="83">
                  <c:v>634</c:v>
                </c:pt>
                <c:pt idx="84">
                  <c:v>632</c:v>
                </c:pt>
                <c:pt idx="85">
                  <c:v>630</c:v>
                </c:pt>
                <c:pt idx="86">
                  <c:v>628</c:v>
                </c:pt>
                <c:pt idx="87">
                  <c:v>626</c:v>
                </c:pt>
                <c:pt idx="88">
                  <c:v>624</c:v>
                </c:pt>
                <c:pt idx="89">
                  <c:v>622</c:v>
                </c:pt>
                <c:pt idx="90">
                  <c:v>620</c:v>
                </c:pt>
                <c:pt idx="91">
                  <c:v>618</c:v>
                </c:pt>
                <c:pt idx="92">
                  <c:v>616</c:v>
                </c:pt>
                <c:pt idx="93">
                  <c:v>614</c:v>
                </c:pt>
                <c:pt idx="94">
                  <c:v>612</c:v>
                </c:pt>
                <c:pt idx="95">
                  <c:v>610</c:v>
                </c:pt>
                <c:pt idx="96">
                  <c:v>608</c:v>
                </c:pt>
                <c:pt idx="97">
                  <c:v>606</c:v>
                </c:pt>
                <c:pt idx="98">
                  <c:v>604</c:v>
                </c:pt>
                <c:pt idx="99">
                  <c:v>602</c:v>
                </c:pt>
                <c:pt idx="100">
                  <c:v>600</c:v>
                </c:pt>
                <c:pt idx="101">
                  <c:v>598</c:v>
                </c:pt>
                <c:pt idx="102">
                  <c:v>596</c:v>
                </c:pt>
                <c:pt idx="103">
                  <c:v>594</c:v>
                </c:pt>
                <c:pt idx="104">
                  <c:v>592</c:v>
                </c:pt>
                <c:pt idx="105">
                  <c:v>590</c:v>
                </c:pt>
                <c:pt idx="106">
                  <c:v>588</c:v>
                </c:pt>
                <c:pt idx="107">
                  <c:v>586</c:v>
                </c:pt>
                <c:pt idx="108">
                  <c:v>584</c:v>
                </c:pt>
                <c:pt idx="109">
                  <c:v>582</c:v>
                </c:pt>
                <c:pt idx="110">
                  <c:v>580</c:v>
                </c:pt>
                <c:pt idx="111">
                  <c:v>578</c:v>
                </c:pt>
                <c:pt idx="112">
                  <c:v>576</c:v>
                </c:pt>
                <c:pt idx="113">
                  <c:v>574</c:v>
                </c:pt>
                <c:pt idx="114">
                  <c:v>572</c:v>
                </c:pt>
                <c:pt idx="115">
                  <c:v>570</c:v>
                </c:pt>
                <c:pt idx="116">
                  <c:v>568</c:v>
                </c:pt>
                <c:pt idx="117">
                  <c:v>566</c:v>
                </c:pt>
                <c:pt idx="118">
                  <c:v>564</c:v>
                </c:pt>
                <c:pt idx="119">
                  <c:v>562</c:v>
                </c:pt>
                <c:pt idx="120">
                  <c:v>560</c:v>
                </c:pt>
                <c:pt idx="121">
                  <c:v>558</c:v>
                </c:pt>
                <c:pt idx="122">
                  <c:v>556</c:v>
                </c:pt>
                <c:pt idx="123">
                  <c:v>554</c:v>
                </c:pt>
                <c:pt idx="124">
                  <c:v>552</c:v>
                </c:pt>
                <c:pt idx="125">
                  <c:v>550</c:v>
                </c:pt>
                <c:pt idx="126">
                  <c:v>548</c:v>
                </c:pt>
                <c:pt idx="127">
                  <c:v>546</c:v>
                </c:pt>
                <c:pt idx="128">
                  <c:v>544</c:v>
                </c:pt>
                <c:pt idx="129">
                  <c:v>542</c:v>
                </c:pt>
                <c:pt idx="130">
                  <c:v>540</c:v>
                </c:pt>
                <c:pt idx="131">
                  <c:v>538</c:v>
                </c:pt>
                <c:pt idx="132">
                  <c:v>536</c:v>
                </c:pt>
                <c:pt idx="133">
                  <c:v>534</c:v>
                </c:pt>
                <c:pt idx="134">
                  <c:v>532</c:v>
                </c:pt>
                <c:pt idx="135">
                  <c:v>530</c:v>
                </c:pt>
                <c:pt idx="136">
                  <c:v>528</c:v>
                </c:pt>
                <c:pt idx="137">
                  <c:v>526</c:v>
                </c:pt>
                <c:pt idx="138">
                  <c:v>524</c:v>
                </c:pt>
                <c:pt idx="139">
                  <c:v>522</c:v>
                </c:pt>
                <c:pt idx="140">
                  <c:v>520</c:v>
                </c:pt>
                <c:pt idx="141">
                  <c:v>518</c:v>
                </c:pt>
                <c:pt idx="142">
                  <c:v>516</c:v>
                </c:pt>
                <c:pt idx="143">
                  <c:v>514</c:v>
                </c:pt>
                <c:pt idx="144">
                  <c:v>512</c:v>
                </c:pt>
                <c:pt idx="145">
                  <c:v>510</c:v>
                </c:pt>
                <c:pt idx="146">
                  <c:v>508</c:v>
                </c:pt>
                <c:pt idx="147">
                  <c:v>506</c:v>
                </c:pt>
                <c:pt idx="148">
                  <c:v>504</c:v>
                </c:pt>
                <c:pt idx="149">
                  <c:v>502</c:v>
                </c:pt>
                <c:pt idx="150">
                  <c:v>500</c:v>
                </c:pt>
                <c:pt idx="151">
                  <c:v>498</c:v>
                </c:pt>
                <c:pt idx="152">
                  <c:v>496</c:v>
                </c:pt>
                <c:pt idx="153">
                  <c:v>494</c:v>
                </c:pt>
                <c:pt idx="154">
                  <c:v>492</c:v>
                </c:pt>
                <c:pt idx="155">
                  <c:v>490</c:v>
                </c:pt>
                <c:pt idx="156">
                  <c:v>488</c:v>
                </c:pt>
                <c:pt idx="157">
                  <c:v>486</c:v>
                </c:pt>
                <c:pt idx="158">
                  <c:v>484</c:v>
                </c:pt>
                <c:pt idx="159">
                  <c:v>482</c:v>
                </c:pt>
                <c:pt idx="160">
                  <c:v>480</c:v>
                </c:pt>
                <c:pt idx="161">
                  <c:v>478</c:v>
                </c:pt>
                <c:pt idx="162">
                  <c:v>476</c:v>
                </c:pt>
                <c:pt idx="163">
                  <c:v>474</c:v>
                </c:pt>
                <c:pt idx="164">
                  <c:v>472</c:v>
                </c:pt>
                <c:pt idx="165">
                  <c:v>470</c:v>
                </c:pt>
                <c:pt idx="166">
                  <c:v>468</c:v>
                </c:pt>
                <c:pt idx="167">
                  <c:v>466</c:v>
                </c:pt>
                <c:pt idx="168">
                  <c:v>464</c:v>
                </c:pt>
                <c:pt idx="169">
                  <c:v>462</c:v>
                </c:pt>
                <c:pt idx="170">
                  <c:v>460</c:v>
                </c:pt>
                <c:pt idx="171">
                  <c:v>458</c:v>
                </c:pt>
                <c:pt idx="172">
                  <c:v>456</c:v>
                </c:pt>
                <c:pt idx="173">
                  <c:v>454</c:v>
                </c:pt>
                <c:pt idx="174">
                  <c:v>452</c:v>
                </c:pt>
                <c:pt idx="175">
                  <c:v>450</c:v>
                </c:pt>
                <c:pt idx="176">
                  <c:v>448</c:v>
                </c:pt>
                <c:pt idx="177">
                  <c:v>446</c:v>
                </c:pt>
                <c:pt idx="178">
                  <c:v>444</c:v>
                </c:pt>
                <c:pt idx="179">
                  <c:v>442</c:v>
                </c:pt>
                <c:pt idx="180">
                  <c:v>440</c:v>
                </c:pt>
                <c:pt idx="181">
                  <c:v>438</c:v>
                </c:pt>
                <c:pt idx="182">
                  <c:v>436</c:v>
                </c:pt>
                <c:pt idx="183">
                  <c:v>434</c:v>
                </c:pt>
                <c:pt idx="184">
                  <c:v>432</c:v>
                </c:pt>
                <c:pt idx="185">
                  <c:v>430</c:v>
                </c:pt>
                <c:pt idx="186">
                  <c:v>428</c:v>
                </c:pt>
                <c:pt idx="187">
                  <c:v>426</c:v>
                </c:pt>
                <c:pt idx="188">
                  <c:v>424</c:v>
                </c:pt>
                <c:pt idx="189">
                  <c:v>422</c:v>
                </c:pt>
                <c:pt idx="190">
                  <c:v>420</c:v>
                </c:pt>
                <c:pt idx="191">
                  <c:v>418</c:v>
                </c:pt>
                <c:pt idx="192">
                  <c:v>416</c:v>
                </c:pt>
                <c:pt idx="193">
                  <c:v>414</c:v>
                </c:pt>
                <c:pt idx="194">
                  <c:v>412</c:v>
                </c:pt>
                <c:pt idx="195">
                  <c:v>410</c:v>
                </c:pt>
                <c:pt idx="196">
                  <c:v>408</c:v>
                </c:pt>
                <c:pt idx="197">
                  <c:v>406</c:v>
                </c:pt>
                <c:pt idx="198">
                  <c:v>404</c:v>
                </c:pt>
                <c:pt idx="199">
                  <c:v>402</c:v>
                </c:pt>
                <c:pt idx="200">
                  <c:v>400</c:v>
                </c:pt>
                <c:pt idx="201">
                  <c:v>398</c:v>
                </c:pt>
                <c:pt idx="202">
                  <c:v>396</c:v>
                </c:pt>
                <c:pt idx="203">
                  <c:v>394</c:v>
                </c:pt>
                <c:pt idx="204">
                  <c:v>392</c:v>
                </c:pt>
                <c:pt idx="205">
                  <c:v>390</c:v>
                </c:pt>
                <c:pt idx="206">
                  <c:v>388</c:v>
                </c:pt>
                <c:pt idx="207">
                  <c:v>386</c:v>
                </c:pt>
                <c:pt idx="208">
                  <c:v>384</c:v>
                </c:pt>
                <c:pt idx="209">
                  <c:v>382</c:v>
                </c:pt>
                <c:pt idx="210">
                  <c:v>380</c:v>
                </c:pt>
                <c:pt idx="211">
                  <c:v>378</c:v>
                </c:pt>
                <c:pt idx="212">
                  <c:v>376</c:v>
                </c:pt>
                <c:pt idx="213">
                  <c:v>374</c:v>
                </c:pt>
                <c:pt idx="214">
                  <c:v>372</c:v>
                </c:pt>
                <c:pt idx="215">
                  <c:v>370</c:v>
                </c:pt>
                <c:pt idx="216">
                  <c:v>368</c:v>
                </c:pt>
                <c:pt idx="217">
                  <c:v>366</c:v>
                </c:pt>
                <c:pt idx="218">
                  <c:v>364</c:v>
                </c:pt>
                <c:pt idx="219">
                  <c:v>362</c:v>
                </c:pt>
                <c:pt idx="220">
                  <c:v>360</c:v>
                </c:pt>
                <c:pt idx="221">
                  <c:v>358</c:v>
                </c:pt>
                <c:pt idx="222">
                  <c:v>356</c:v>
                </c:pt>
                <c:pt idx="223">
                  <c:v>354</c:v>
                </c:pt>
                <c:pt idx="224">
                  <c:v>352</c:v>
                </c:pt>
                <c:pt idx="225">
                  <c:v>350</c:v>
                </c:pt>
                <c:pt idx="226">
                  <c:v>348</c:v>
                </c:pt>
                <c:pt idx="227">
                  <c:v>346</c:v>
                </c:pt>
                <c:pt idx="228">
                  <c:v>344</c:v>
                </c:pt>
                <c:pt idx="229">
                  <c:v>342</c:v>
                </c:pt>
                <c:pt idx="230">
                  <c:v>340</c:v>
                </c:pt>
                <c:pt idx="231">
                  <c:v>338</c:v>
                </c:pt>
                <c:pt idx="232">
                  <c:v>336</c:v>
                </c:pt>
                <c:pt idx="233">
                  <c:v>334</c:v>
                </c:pt>
                <c:pt idx="234">
                  <c:v>332</c:v>
                </c:pt>
                <c:pt idx="235">
                  <c:v>330</c:v>
                </c:pt>
                <c:pt idx="236">
                  <c:v>328</c:v>
                </c:pt>
                <c:pt idx="237">
                  <c:v>326</c:v>
                </c:pt>
                <c:pt idx="238">
                  <c:v>324</c:v>
                </c:pt>
                <c:pt idx="239">
                  <c:v>322</c:v>
                </c:pt>
                <c:pt idx="240">
                  <c:v>320</c:v>
                </c:pt>
                <c:pt idx="241">
                  <c:v>318</c:v>
                </c:pt>
                <c:pt idx="242">
                  <c:v>316</c:v>
                </c:pt>
                <c:pt idx="243">
                  <c:v>314</c:v>
                </c:pt>
                <c:pt idx="244">
                  <c:v>312</c:v>
                </c:pt>
                <c:pt idx="245">
                  <c:v>310</c:v>
                </c:pt>
                <c:pt idx="246">
                  <c:v>308</c:v>
                </c:pt>
                <c:pt idx="247">
                  <c:v>306</c:v>
                </c:pt>
                <c:pt idx="248">
                  <c:v>304</c:v>
                </c:pt>
                <c:pt idx="249">
                  <c:v>302</c:v>
                </c:pt>
                <c:pt idx="250">
                  <c:v>300</c:v>
                </c:pt>
                <c:pt idx="251">
                  <c:v>298</c:v>
                </c:pt>
                <c:pt idx="252">
                  <c:v>296</c:v>
                </c:pt>
                <c:pt idx="253">
                  <c:v>294</c:v>
                </c:pt>
                <c:pt idx="254">
                  <c:v>292</c:v>
                </c:pt>
                <c:pt idx="255">
                  <c:v>290</c:v>
                </c:pt>
                <c:pt idx="256">
                  <c:v>288</c:v>
                </c:pt>
                <c:pt idx="257">
                  <c:v>286</c:v>
                </c:pt>
                <c:pt idx="258">
                  <c:v>284</c:v>
                </c:pt>
                <c:pt idx="259">
                  <c:v>282</c:v>
                </c:pt>
                <c:pt idx="260">
                  <c:v>280</c:v>
                </c:pt>
                <c:pt idx="261">
                  <c:v>278</c:v>
                </c:pt>
                <c:pt idx="262">
                  <c:v>276</c:v>
                </c:pt>
                <c:pt idx="263">
                  <c:v>274</c:v>
                </c:pt>
                <c:pt idx="264">
                  <c:v>272</c:v>
                </c:pt>
                <c:pt idx="265">
                  <c:v>270</c:v>
                </c:pt>
                <c:pt idx="266">
                  <c:v>268</c:v>
                </c:pt>
                <c:pt idx="267">
                  <c:v>266</c:v>
                </c:pt>
                <c:pt idx="268">
                  <c:v>264</c:v>
                </c:pt>
                <c:pt idx="269">
                  <c:v>262</c:v>
                </c:pt>
                <c:pt idx="270">
                  <c:v>260</c:v>
                </c:pt>
                <c:pt idx="271">
                  <c:v>258</c:v>
                </c:pt>
                <c:pt idx="272">
                  <c:v>256</c:v>
                </c:pt>
                <c:pt idx="273">
                  <c:v>254</c:v>
                </c:pt>
                <c:pt idx="274">
                  <c:v>252</c:v>
                </c:pt>
                <c:pt idx="275">
                  <c:v>250</c:v>
                </c:pt>
                <c:pt idx="276">
                  <c:v>248</c:v>
                </c:pt>
                <c:pt idx="277">
                  <c:v>246</c:v>
                </c:pt>
                <c:pt idx="278">
                  <c:v>244</c:v>
                </c:pt>
                <c:pt idx="279">
                  <c:v>242</c:v>
                </c:pt>
                <c:pt idx="280">
                  <c:v>240</c:v>
                </c:pt>
                <c:pt idx="281">
                  <c:v>238</c:v>
                </c:pt>
                <c:pt idx="282">
                  <c:v>236</c:v>
                </c:pt>
                <c:pt idx="283">
                  <c:v>234</c:v>
                </c:pt>
                <c:pt idx="284">
                  <c:v>232</c:v>
                </c:pt>
                <c:pt idx="285">
                  <c:v>230</c:v>
                </c:pt>
                <c:pt idx="286">
                  <c:v>228</c:v>
                </c:pt>
                <c:pt idx="287">
                  <c:v>226</c:v>
                </c:pt>
                <c:pt idx="288">
                  <c:v>224</c:v>
                </c:pt>
                <c:pt idx="289">
                  <c:v>222</c:v>
                </c:pt>
                <c:pt idx="290">
                  <c:v>220</c:v>
                </c:pt>
                <c:pt idx="291">
                  <c:v>218</c:v>
                </c:pt>
                <c:pt idx="292">
                  <c:v>216</c:v>
                </c:pt>
                <c:pt idx="293">
                  <c:v>214</c:v>
                </c:pt>
                <c:pt idx="294">
                  <c:v>212</c:v>
                </c:pt>
                <c:pt idx="295">
                  <c:v>210</c:v>
                </c:pt>
                <c:pt idx="296">
                  <c:v>208</c:v>
                </c:pt>
                <c:pt idx="297">
                  <c:v>206</c:v>
                </c:pt>
                <c:pt idx="298">
                  <c:v>204</c:v>
                </c:pt>
                <c:pt idx="299">
                  <c:v>202</c:v>
                </c:pt>
                <c:pt idx="300">
                  <c:v>200</c:v>
                </c:pt>
              </c:numCache>
            </c:numRef>
          </c:xVal>
          <c:yVal>
            <c:numRef>
              <c:f>Feuil1!$C$2:$C$302</c:f>
              <c:numCache>
                <c:formatCode>General</c:formatCode>
                <c:ptCount val="301"/>
                <c:pt idx="0">
                  <c:v>3.8400000000000092E-3</c:v>
                </c:pt>
                <c:pt idx="1">
                  <c:v>2.120000000000009E-3</c:v>
                </c:pt>
                <c:pt idx="2">
                  <c:v>7.3000000000000139E-3</c:v>
                </c:pt>
                <c:pt idx="3">
                  <c:v>7.3300000000000188E-3</c:v>
                </c:pt>
                <c:pt idx="4">
                  <c:v>-2.2400000000000085E-3</c:v>
                </c:pt>
                <c:pt idx="5">
                  <c:v>-1.9000000000000085E-4</c:v>
                </c:pt>
                <c:pt idx="6">
                  <c:v>1.9700000000000069E-3</c:v>
                </c:pt>
                <c:pt idx="7">
                  <c:v>1.4300000000000035E-3</c:v>
                </c:pt>
                <c:pt idx="8">
                  <c:v>3.5900000000000072E-3</c:v>
                </c:pt>
                <c:pt idx="9">
                  <c:v>2.9800000000000078E-3</c:v>
                </c:pt>
                <c:pt idx="10">
                  <c:v>2.5500000000000045E-3</c:v>
                </c:pt>
                <c:pt idx="11">
                  <c:v>3.210000000000008E-3</c:v>
                </c:pt>
                <c:pt idx="12">
                  <c:v>1.6900000000000077E-3</c:v>
                </c:pt>
                <c:pt idx="13">
                  <c:v>2.5400000000000067E-3</c:v>
                </c:pt>
                <c:pt idx="14">
                  <c:v>-4.2000000000000136E-3</c:v>
                </c:pt>
                <c:pt idx="15">
                  <c:v>2.9500000000000012E-3</c:v>
                </c:pt>
                <c:pt idx="16">
                  <c:v>5.6000000000000034E-3</c:v>
                </c:pt>
                <c:pt idx="17">
                  <c:v>5.8500000000000114E-3</c:v>
                </c:pt>
                <c:pt idx="18">
                  <c:v>-9.9000000000000477E-4</c:v>
                </c:pt>
                <c:pt idx="19">
                  <c:v>8.9900000000000257E-3</c:v>
                </c:pt>
                <c:pt idx="20">
                  <c:v>7.8000000000000259E-4</c:v>
                </c:pt>
                <c:pt idx="21">
                  <c:v>2.1400000000000086E-3</c:v>
                </c:pt>
                <c:pt idx="22">
                  <c:v>-9.7000000000000276E-4</c:v>
                </c:pt>
                <c:pt idx="23">
                  <c:v>4.7200000000000089E-3</c:v>
                </c:pt>
                <c:pt idx="24">
                  <c:v>5.960000000000013E-3</c:v>
                </c:pt>
                <c:pt idx="25">
                  <c:v>-2.0800000000000076E-3</c:v>
                </c:pt>
                <c:pt idx="26">
                  <c:v>7.4000000000000272E-3</c:v>
                </c:pt>
                <c:pt idx="27">
                  <c:v>-1.1000000000000056E-4</c:v>
                </c:pt>
                <c:pt idx="28">
                  <c:v>3.350000000000004E-3</c:v>
                </c:pt>
                <c:pt idx="29">
                  <c:v>1.9500000000000058E-3</c:v>
                </c:pt>
                <c:pt idx="30">
                  <c:v>8.400000000000029E-3</c:v>
                </c:pt>
                <c:pt idx="31">
                  <c:v>7.5900000000000177E-3</c:v>
                </c:pt>
                <c:pt idx="32">
                  <c:v>3.8700000000000045E-3</c:v>
                </c:pt>
                <c:pt idx="33">
                  <c:v>3.5800000000000111E-3</c:v>
                </c:pt>
                <c:pt idx="34">
                  <c:v>4.5000000000000109E-3</c:v>
                </c:pt>
                <c:pt idx="35">
                  <c:v>4.5700000000000133E-3</c:v>
                </c:pt>
                <c:pt idx="36">
                  <c:v>4.8800000000000111E-3</c:v>
                </c:pt>
                <c:pt idx="37">
                  <c:v>3.0500000000000054E-3</c:v>
                </c:pt>
                <c:pt idx="38">
                  <c:v>5.6300000000000126E-3</c:v>
                </c:pt>
                <c:pt idx="39">
                  <c:v>7.6100000000000091E-3</c:v>
                </c:pt>
                <c:pt idx="40">
                  <c:v>3.9700000000000056E-3</c:v>
                </c:pt>
                <c:pt idx="41">
                  <c:v>7.9100000000000229E-3</c:v>
                </c:pt>
                <c:pt idx="42">
                  <c:v>5.0800000000000133E-3</c:v>
                </c:pt>
                <c:pt idx="43">
                  <c:v>3.9100000000000011E-3</c:v>
                </c:pt>
                <c:pt idx="44">
                  <c:v>4.6700000000000101E-3</c:v>
                </c:pt>
                <c:pt idx="45">
                  <c:v>1.1710000000000031E-2</c:v>
                </c:pt>
                <c:pt idx="46">
                  <c:v>8.7200000000000003E-3</c:v>
                </c:pt>
                <c:pt idx="47">
                  <c:v>8.7700000000000208E-3</c:v>
                </c:pt>
                <c:pt idx="48">
                  <c:v>1.376000000000005E-2</c:v>
                </c:pt>
                <c:pt idx="49">
                  <c:v>1.5509999999999999E-2</c:v>
                </c:pt>
                <c:pt idx="50">
                  <c:v>1.5810000000000001E-2</c:v>
                </c:pt>
                <c:pt idx="51">
                  <c:v>1.9080000000000052E-2</c:v>
                </c:pt>
                <c:pt idx="52">
                  <c:v>1.7620000000000063E-2</c:v>
                </c:pt>
                <c:pt idx="53">
                  <c:v>2.0850000000000011E-2</c:v>
                </c:pt>
                <c:pt idx="54">
                  <c:v>2.5240000000000012E-2</c:v>
                </c:pt>
                <c:pt idx="55">
                  <c:v>2.2300000000000052E-2</c:v>
                </c:pt>
                <c:pt idx="56">
                  <c:v>3.2050000000000085E-2</c:v>
                </c:pt>
                <c:pt idx="57">
                  <c:v>3.1300000000000015E-2</c:v>
                </c:pt>
                <c:pt idx="58">
                  <c:v>4.1269999999999987E-2</c:v>
                </c:pt>
                <c:pt idx="59">
                  <c:v>4.5669999999999995E-2</c:v>
                </c:pt>
                <c:pt idx="60">
                  <c:v>5.2090000000000171E-2</c:v>
                </c:pt>
                <c:pt idx="61">
                  <c:v>5.777000000000012E-2</c:v>
                </c:pt>
                <c:pt idx="62">
                  <c:v>6.2850000000000114E-2</c:v>
                </c:pt>
                <c:pt idx="63">
                  <c:v>7.4010000000000284E-2</c:v>
                </c:pt>
                <c:pt idx="64">
                  <c:v>8.2580000000000001E-2</c:v>
                </c:pt>
                <c:pt idx="65">
                  <c:v>9.5950000000000271E-2</c:v>
                </c:pt>
                <c:pt idx="66">
                  <c:v>0.1071000000000002</c:v>
                </c:pt>
                <c:pt idx="67">
                  <c:v>0.12057000000000002</c:v>
                </c:pt>
                <c:pt idx="68">
                  <c:v>0.13428999999999999</c:v>
                </c:pt>
                <c:pt idx="69">
                  <c:v>0.14954000000000048</c:v>
                </c:pt>
                <c:pt idx="70">
                  <c:v>0.16431000000000029</c:v>
                </c:pt>
                <c:pt idx="71">
                  <c:v>0.18202000000000004</c:v>
                </c:pt>
                <c:pt idx="72">
                  <c:v>0.20003000000000001</c:v>
                </c:pt>
                <c:pt idx="73">
                  <c:v>0.22601000000000041</c:v>
                </c:pt>
                <c:pt idx="74">
                  <c:v>0.24765000000000001</c:v>
                </c:pt>
                <c:pt idx="75">
                  <c:v>0.26944000000000001</c:v>
                </c:pt>
                <c:pt idx="76">
                  <c:v>0.29041000000000078</c:v>
                </c:pt>
                <c:pt idx="77">
                  <c:v>0.3213900000000009</c:v>
                </c:pt>
                <c:pt idx="78">
                  <c:v>0.34432000000000146</c:v>
                </c:pt>
                <c:pt idx="79">
                  <c:v>0.3716800000000009</c:v>
                </c:pt>
                <c:pt idx="80">
                  <c:v>0.39713000000000032</c:v>
                </c:pt>
                <c:pt idx="81">
                  <c:v>0.42294000000000032</c:v>
                </c:pt>
                <c:pt idx="82">
                  <c:v>0.45282000000000078</c:v>
                </c:pt>
                <c:pt idx="83">
                  <c:v>0.47561000000000031</c:v>
                </c:pt>
                <c:pt idx="84">
                  <c:v>0.50352999999999959</c:v>
                </c:pt>
                <c:pt idx="85">
                  <c:v>0.52759999999999996</c:v>
                </c:pt>
                <c:pt idx="86">
                  <c:v>0.55225000000000002</c:v>
                </c:pt>
                <c:pt idx="87">
                  <c:v>0.57421</c:v>
                </c:pt>
                <c:pt idx="88">
                  <c:v>0.59319000000000077</c:v>
                </c:pt>
                <c:pt idx="89">
                  <c:v>0.61012000000000155</c:v>
                </c:pt>
                <c:pt idx="90">
                  <c:v>0.62283999999999995</c:v>
                </c:pt>
                <c:pt idx="91">
                  <c:v>0.63630000000000064</c:v>
                </c:pt>
                <c:pt idx="92">
                  <c:v>0.64883000000000179</c:v>
                </c:pt>
                <c:pt idx="93">
                  <c:v>0.6600400000000024</c:v>
                </c:pt>
                <c:pt idx="94">
                  <c:v>0.66440000000000154</c:v>
                </c:pt>
                <c:pt idx="95">
                  <c:v>0.67218999999999995</c:v>
                </c:pt>
                <c:pt idx="96">
                  <c:v>0.67916000000000065</c:v>
                </c:pt>
                <c:pt idx="97">
                  <c:v>0.68106000000000078</c:v>
                </c:pt>
                <c:pt idx="98">
                  <c:v>0.68206999999999951</c:v>
                </c:pt>
                <c:pt idx="99">
                  <c:v>0.68833000000000077</c:v>
                </c:pt>
                <c:pt idx="100">
                  <c:v>0.68491000000000102</c:v>
                </c:pt>
                <c:pt idx="101">
                  <c:v>0.6876500000000022</c:v>
                </c:pt>
                <c:pt idx="102">
                  <c:v>0.68625000000000103</c:v>
                </c:pt>
                <c:pt idx="103">
                  <c:v>0.68131000000000053</c:v>
                </c:pt>
                <c:pt idx="104">
                  <c:v>0.67784000000000311</c:v>
                </c:pt>
                <c:pt idx="105">
                  <c:v>0.6749700000000024</c:v>
                </c:pt>
                <c:pt idx="106">
                  <c:v>0.67457000000000178</c:v>
                </c:pt>
                <c:pt idx="107">
                  <c:v>0.66546000000000005</c:v>
                </c:pt>
                <c:pt idx="108">
                  <c:v>0.65775000000000228</c:v>
                </c:pt>
                <c:pt idx="109">
                  <c:v>0.65154000000000178</c:v>
                </c:pt>
                <c:pt idx="110">
                  <c:v>0.64226000000000005</c:v>
                </c:pt>
                <c:pt idx="111">
                  <c:v>0.63441000000000003</c:v>
                </c:pt>
                <c:pt idx="112">
                  <c:v>0.62597000000000202</c:v>
                </c:pt>
                <c:pt idx="113">
                  <c:v>0.61431000000000002</c:v>
                </c:pt>
                <c:pt idx="114">
                  <c:v>0.60455999999999999</c:v>
                </c:pt>
                <c:pt idx="115">
                  <c:v>0.59139999999999959</c:v>
                </c:pt>
                <c:pt idx="116">
                  <c:v>0.57852000000000003</c:v>
                </c:pt>
                <c:pt idx="117">
                  <c:v>0.56318999999999997</c:v>
                </c:pt>
                <c:pt idx="118">
                  <c:v>0.55069000000000179</c:v>
                </c:pt>
                <c:pt idx="119">
                  <c:v>0.53786</c:v>
                </c:pt>
                <c:pt idx="120">
                  <c:v>0.5245299999999995</c:v>
                </c:pt>
                <c:pt idx="121">
                  <c:v>0.50924000000000003</c:v>
                </c:pt>
                <c:pt idx="122">
                  <c:v>0.49774000000000002</c:v>
                </c:pt>
                <c:pt idx="123">
                  <c:v>0.48389000000000032</c:v>
                </c:pt>
                <c:pt idx="124">
                  <c:v>0.46965000000000001</c:v>
                </c:pt>
                <c:pt idx="125">
                  <c:v>0.45885000000000031</c:v>
                </c:pt>
                <c:pt idx="126">
                  <c:v>0.44575000000000026</c:v>
                </c:pt>
                <c:pt idx="127">
                  <c:v>0.43356000000000078</c:v>
                </c:pt>
                <c:pt idx="128">
                  <c:v>0.42050000000000032</c:v>
                </c:pt>
                <c:pt idx="129">
                  <c:v>0.40890000000000032</c:v>
                </c:pt>
                <c:pt idx="130">
                  <c:v>0.39659000000000078</c:v>
                </c:pt>
                <c:pt idx="131">
                  <c:v>0.38420000000000032</c:v>
                </c:pt>
                <c:pt idx="132">
                  <c:v>0.37336000000000108</c:v>
                </c:pt>
                <c:pt idx="133">
                  <c:v>0.36225000000000002</c:v>
                </c:pt>
                <c:pt idx="134">
                  <c:v>0.35099000000000002</c:v>
                </c:pt>
                <c:pt idx="135">
                  <c:v>0.33941000000000143</c:v>
                </c:pt>
                <c:pt idx="136">
                  <c:v>0.33013000000000031</c:v>
                </c:pt>
                <c:pt idx="137">
                  <c:v>0.32010000000000038</c:v>
                </c:pt>
                <c:pt idx="138">
                  <c:v>0.30985000000000096</c:v>
                </c:pt>
                <c:pt idx="139">
                  <c:v>0.30079</c:v>
                </c:pt>
                <c:pt idx="140">
                  <c:v>0.2912300000000001</c:v>
                </c:pt>
                <c:pt idx="141">
                  <c:v>0.28193000000000001</c:v>
                </c:pt>
                <c:pt idx="142">
                  <c:v>0.27240000000000031</c:v>
                </c:pt>
                <c:pt idx="143">
                  <c:v>0.26513000000000003</c:v>
                </c:pt>
                <c:pt idx="144">
                  <c:v>0.25569999999999998</c:v>
                </c:pt>
                <c:pt idx="145">
                  <c:v>0.24945000000000048</c:v>
                </c:pt>
                <c:pt idx="146">
                  <c:v>0.24427000000000001</c:v>
                </c:pt>
                <c:pt idx="147">
                  <c:v>0.23877999999999999</c:v>
                </c:pt>
                <c:pt idx="148">
                  <c:v>0.23442000000000021</c:v>
                </c:pt>
                <c:pt idx="149">
                  <c:v>0.23050000000000001</c:v>
                </c:pt>
                <c:pt idx="150">
                  <c:v>0.22794000000000061</c:v>
                </c:pt>
                <c:pt idx="151">
                  <c:v>0.22528000000000026</c:v>
                </c:pt>
                <c:pt idx="152">
                  <c:v>0.22488000000000019</c:v>
                </c:pt>
                <c:pt idx="153">
                  <c:v>0.22453000000000026</c:v>
                </c:pt>
                <c:pt idx="154">
                  <c:v>0.22552000000000019</c:v>
                </c:pt>
                <c:pt idx="155">
                  <c:v>0.22600000000000026</c:v>
                </c:pt>
                <c:pt idx="156">
                  <c:v>0.22634000000000035</c:v>
                </c:pt>
                <c:pt idx="157">
                  <c:v>0.22641000000000058</c:v>
                </c:pt>
                <c:pt idx="158">
                  <c:v>0.22585000000000019</c:v>
                </c:pt>
                <c:pt idx="159">
                  <c:v>0.22460000000000019</c:v>
                </c:pt>
                <c:pt idx="160">
                  <c:v>0.22286999999999998</c:v>
                </c:pt>
                <c:pt idx="161">
                  <c:v>0.21987999999999999</c:v>
                </c:pt>
                <c:pt idx="162">
                  <c:v>0.21661000000000039</c:v>
                </c:pt>
                <c:pt idx="163">
                  <c:v>0.21350000000000038</c:v>
                </c:pt>
                <c:pt idx="164">
                  <c:v>0.21002999999999999</c:v>
                </c:pt>
                <c:pt idx="165">
                  <c:v>0.20677999999999999</c:v>
                </c:pt>
                <c:pt idx="166">
                  <c:v>0.20402000000000001</c:v>
                </c:pt>
                <c:pt idx="167">
                  <c:v>0.20119000000000001</c:v>
                </c:pt>
                <c:pt idx="168">
                  <c:v>0.19926000000000044</c:v>
                </c:pt>
                <c:pt idx="169">
                  <c:v>0.19788000000000022</c:v>
                </c:pt>
                <c:pt idx="170">
                  <c:v>0.19653000000000029</c:v>
                </c:pt>
                <c:pt idx="171">
                  <c:v>0.19576000000000041</c:v>
                </c:pt>
                <c:pt idx="172">
                  <c:v>0.19489000000000026</c:v>
                </c:pt>
                <c:pt idx="173">
                  <c:v>0.19403000000000026</c:v>
                </c:pt>
                <c:pt idx="174">
                  <c:v>0.19325000000000025</c:v>
                </c:pt>
                <c:pt idx="175">
                  <c:v>0.19182000000000018</c:v>
                </c:pt>
                <c:pt idx="176">
                  <c:v>0.1904300000000004</c:v>
                </c:pt>
                <c:pt idx="177">
                  <c:v>0.18942000000000048</c:v>
                </c:pt>
                <c:pt idx="178">
                  <c:v>0.18797000000000039</c:v>
                </c:pt>
                <c:pt idx="179">
                  <c:v>0.18715999999999999</c:v>
                </c:pt>
                <c:pt idx="180">
                  <c:v>0.18597000000000038</c:v>
                </c:pt>
                <c:pt idx="181">
                  <c:v>0.18473000000000048</c:v>
                </c:pt>
                <c:pt idx="182">
                  <c:v>0.18379000000000048</c:v>
                </c:pt>
                <c:pt idx="183">
                  <c:v>0.18299000000000054</c:v>
                </c:pt>
                <c:pt idx="184">
                  <c:v>0.18210999999999999</c:v>
                </c:pt>
                <c:pt idx="185">
                  <c:v>0.18180000000000004</c:v>
                </c:pt>
                <c:pt idx="186">
                  <c:v>0.18137</c:v>
                </c:pt>
                <c:pt idx="187">
                  <c:v>0.18099000000000054</c:v>
                </c:pt>
                <c:pt idx="188">
                  <c:v>0.18089000000000038</c:v>
                </c:pt>
                <c:pt idx="189">
                  <c:v>0.18100000000000024</c:v>
                </c:pt>
                <c:pt idx="190">
                  <c:v>0.18148000000000042</c:v>
                </c:pt>
                <c:pt idx="191">
                  <c:v>0.18150000000000024</c:v>
                </c:pt>
                <c:pt idx="192">
                  <c:v>0.18171000000000054</c:v>
                </c:pt>
                <c:pt idx="193">
                  <c:v>0.18260000000000001</c:v>
                </c:pt>
                <c:pt idx="194">
                  <c:v>0.18268000000000001</c:v>
                </c:pt>
                <c:pt idx="195">
                  <c:v>0.18405000000000021</c:v>
                </c:pt>
                <c:pt idx="196">
                  <c:v>0.18643000000000054</c:v>
                </c:pt>
                <c:pt idx="197">
                  <c:v>0.18932000000000004</c:v>
                </c:pt>
                <c:pt idx="198">
                  <c:v>0.1942400000000005</c:v>
                </c:pt>
                <c:pt idx="199">
                  <c:v>0.2001</c:v>
                </c:pt>
                <c:pt idx="200">
                  <c:v>0.20673000000000039</c:v>
                </c:pt>
                <c:pt idx="201">
                  <c:v>0.21382000000000001</c:v>
                </c:pt>
                <c:pt idx="202">
                  <c:v>0.22048000000000026</c:v>
                </c:pt>
                <c:pt idx="203">
                  <c:v>0.22461000000000025</c:v>
                </c:pt>
                <c:pt idx="204">
                  <c:v>0.22669000000000022</c:v>
                </c:pt>
                <c:pt idx="205">
                  <c:v>0.22616000000000022</c:v>
                </c:pt>
                <c:pt idx="206">
                  <c:v>0.22361999999999999</c:v>
                </c:pt>
                <c:pt idx="207">
                  <c:v>0.21946000000000063</c:v>
                </c:pt>
                <c:pt idx="208">
                  <c:v>0.21462999999999999</c:v>
                </c:pt>
                <c:pt idx="209">
                  <c:v>0.20882999999999999</c:v>
                </c:pt>
                <c:pt idx="210">
                  <c:v>0.20343000000000042</c:v>
                </c:pt>
                <c:pt idx="211">
                  <c:v>0.19781000000000035</c:v>
                </c:pt>
                <c:pt idx="212">
                  <c:v>0.19248000000000035</c:v>
                </c:pt>
                <c:pt idx="213">
                  <c:v>0.18677000000000021</c:v>
                </c:pt>
                <c:pt idx="214">
                  <c:v>0.18076000000000045</c:v>
                </c:pt>
                <c:pt idx="215">
                  <c:v>0.17485999999999999</c:v>
                </c:pt>
                <c:pt idx="216">
                  <c:v>0.16864000000000035</c:v>
                </c:pt>
                <c:pt idx="217">
                  <c:v>0.16377000000000022</c:v>
                </c:pt>
                <c:pt idx="218">
                  <c:v>0.15956000000000048</c:v>
                </c:pt>
                <c:pt idx="219">
                  <c:v>0.15722000000000041</c:v>
                </c:pt>
                <c:pt idx="220">
                  <c:v>0.15729000000000054</c:v>
                </c:pt>
                <c:pt idx="221">
                  <c:v>0.16048000000000029</c:v>
                </c:pt>
                <c:pt idx="222">
                  <c:v>0.16719000000000026</c:v>
                </c:pt>
                <c:pt idx="223">
                  <c:v>0.17740000000000042</c:v>
                </c:pt>
                <c:pt idx="224">
                  <c:v>0.19404000000000043</c:v>
                </c:pt>
                <c:pt idx="225">
                  <c:v>0.21378000000000039</c:v>
                </c:pt>
                <c:pt idx="226">
                  <c:v>0.24150000000000021</c:v>
                </c:pt>
                <c:pt idx="227">
                  <c:v>0.28056000000000031</c:v>
                </c:pt>
                <c:pt idx="228">
                  <c:v>0.32680000000000115</c:v>
                </c:pt>
                <c:pt idx="229">
                  <c:v>0.39859000000000078</c:v>
                </c:pt>
                <c:pt idx="230">
                  <c:v>0.50978000000000001</c:v>
                </c:pt>
                <c:pt idx="231">
                  <c:v>0.65776000000000179</c:v>
                </c:pt>
                <c:pt idx="232">
                  <c:v>0.88654999999999951</c:v>
                </c:pt>
                <c:pt idx="233">
                  <c:v>1.2541199999999999</c:v>
                </c:pt>
                <c:pt idx="234">
                  <c:v>1.7304700000000015</c:v>
                </c:pt>
                <c:pt idx="235">
                  <c:v>2.36835</c:v>
                </c:pt>
                <c:pt idx="236">
                  <c:v>2.8769499999999879</c:v>
                </c:pt>
                <c:pt idx="237">
                  <c:v>3.0678000000000001</c:v>
                </c:pt>
                <c:pt idx="238">
                  <c:v>3.1481800000000062</c:v>
                </c:pt>
                <c:pt idx="239">
                  <c:v>3.07437</c:v>
                </c:pt>
                <c:pt idx="240">
                  <c:v>3.2753999999999999</c:v>
                </c:pt>
                <c:pt idx="241">
                  <c:v>3.2809400000000002</c:v>
                </c:pt>
                <c:pt idx="242">
                  <c:v>3.3454699999999939</c:v>
                </c:pt>
                <c:pt idx="243">
                  <c:v>3.4378099999999967</c:v>
                </c:pt>
                <c:pt idx="244">
                  <c:v>3.5045799999999998</c:v>
                </c:pt>
                <c:pt idx="245">
                  <c:v>3.5668099999999967</c:v>
                </c:pt>
                <c:pt idx="246">
                  <c:v>3.552899999999994</c:v>
                </c:pt>
                <c:pt idx="247">
                  <c:v>3.5778099999999977</c:v>
                </c:pt>
                <c:pt idx="248">
                  <c:v>3.5829399999999998</c:v>
                </c:pt>
                <c:pt idx="249">
                  <c:v>3.93377</c:v>
                </c:pt>
                <c:pt idx="250">
                  <c:v>3.8399299999999967</c:v>
                </c:pt>
                <c:pt idx="251">
                  <c:v>3.87791</c:v>
                </c:pt>
                <c:pt idx="252">
                  <c:v>3.841049999999993</c:v>
                </c:pt>
                <c:pt idx="253">
                  <c:v>3.8085900000000001</c:v>
                </c:pt>
                <c:pt idx="254">
                  <c:v>3.5423499999999977</c:v>
                </c:pt>
                <c:pt idx="255">
                  <c:v>3.45322</c:v>
                </c:pt>
                <c:pt idx="256">
                  <c:v>3.34423</c:v>
                </c:pt>
                <c:pt idx="257">
                  <c:v>3.1591100000000001</c:v>
                </c:pt>
                <c:pt idx="258">
                  <c:v>3.0660599999999967</c:v>
                </c:pt>
                <c:pt idx="259">
                  <c:v>2.82369</c:v>
                </c:pt>
                <c:pt idx="260">
                  <c:v>2.6457999999999999</c:v>
                </c:pt>
                <c:pt idx="261">
                  <c:v>2.4200300000000001</c:v>
                </c:pt>
                <c:pt idx="262">
                  <c:v>2.152449999999992</c:v>
                </c:pt>
                <c:pt idx="263">
                  <c:v>1.8742500000000031</c:v>
                </c:pt>
                <c:pt idx="264">
                  <c:v>1.57698</c:v>
                </c:pt>
                <c:pt idx="265">
                  <c:v>1.1806300000000001</c:v>
                </c:pt>
                <c:pt idx="266">
                  <c:v>0.78981999999999997</c:v>
                </c:pt>
                <c:pt idx="267">
                  <c:v>0.53576999999999997</c:v>
                </c:pt>
                <c:pt idx="268">
                  <c:v>0.4002</c:v>
                </c:pt>
                <c:pt idx="269">
                  <c:v>0.35427000000000008</c:v>
                </c:pt>
                <c:pt idx="270">
                  <c:v>0.32690000000000102</c:v>
                </c:pt>
                <c:pt idx="271">
                  <c:v>0.32843000000000078</c:v>
                </c:pt>
                <c:pt idx="272">
                  <c:v>0.35168000000000038</c:v>
                </c:pt>
                <c:pt idx="273">
                  <c:v>0.33548000000000155</c:v>
                </c:pt>
                <c:pt idx="274">
                  <c:v>0.31755000000000078</c:v>
                </c:pt>
                <c:pt idx="275">
                  <c:v>0.32073000000000002</c:v>
                </c:pt>
                <c:pt idx="276">
                  <c:v>0.29756000000000032</c:v>
                </c:pt>
                <c:pt idx="277">
                  <c:v>0.29410000000000008</c:v>
                </c:pt>
                <c:pt idx="278">
                  <c:v>0.30079</c:v>
                </c:pt>
                <c:pt idx="279">
                  <c:v>0.28796000000000038</c:v>
                </c:pt>
                <c:pt idx="280">
                  <c:v>0.30514000000000002</c:v>
                </c:pt>
                <c:pt idx="281">
                  <c:v>0.29519000000000001</c:v>
                </c:pt>
                <c:pt idx="282">
                  <c:v>0.29389000000000032</c:v>
                </c:pt>
                <c:pt idx="283">
                  <c:v>0.29943000000000008</c:v>
                </c:pt>
                <c:pt idx="284">
                  <c:v>0.3028000000000009</c:v>
                </c:pt>
                <c:pt idx="285">
                  <c:v>0.28664000000000001</c:v>
                </c:pt>
                <c:pt idx="286">
                  <c:v>0.28926000000000002</c:v>
                </c:pt>
                <c:pt idx="287">
                  <c:v>0.29404000000000002</c:v>
                </c:pt>
                <c:pt idx="288">
                  <c:v>0.31594000000000078</c:v>
                </c:pt>
                <c:pt idx="289">
                  <c:v>0.30273</c:v>
                </c:pt>
                <c:pt idx="290">
                  <c:v>0.31136000000000114</c:v>
                </c:pt>
                <c:pt idx="291">
                  <c:v>0.30877000000000032</c:v>
                </c:pt>
                <c:pt idx="292">
                  <c:v>0.34441000000000116</c:v>
                </c:pt>
                <c:pt idx="293">
                  <c:v>0.34086000000000116</c:v>
                </c:pt>
                <c:pt idx="294">
                  <c:v>0.34302000000000088</c:v>
                </c:pt>
                <c:pt idx="295">
                  <c:v>0.33559000000000078</c:v>
                </c:pt>
                <c:pt idx="296">
                  <c:v>0.3270500000000009</c:v>
                </c:pt>
                <c:pt idx="297">
                  <c:v>0.34548000000000134</c:v>
                </c:pt>
                <c:pt idx="298">
                  <c:v>0.37277000000000032</c:v>
                </c:pt>
                <c:pt idx="299">
                  <c:v>0.34819000000000039</c:v>
                </c:pt>
                <c:pt idx="300">
                  <c:v>0.3387300000000003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01B-4127-A621-24501A84C0B5}"/>
            </c:ext>
          </c:extLst>
        </c:ser>
        <c:ser>
          <c:idx val="2"/>
          <c:order val="2"/>
          <c:tx>
            <c:strRef>
              <c:f>Feuil1!$D$1</c:f>
              <c:strCache>
                <c:ptCount val="1"/>
                <c:pt idx="0">
                  <c:v>RB5 (25mg/L)+ Laccase</c:v>
                </c:pt>
              </c:strCache>
            </c:strRef>
          </c:tx>
          <c:spPr>
            <a:ln w="12700">
              <a:solidFill>
                <a:srgbClr val="969696"/>
              </a:solidFill>
              <a:prstDash val="solid"/>
            </a:ln>
          </c:spPr>
          <c:marker>
            <c:symbol val="none"/>
          </c:marker>
          <c:xVal>
            <c:numRef>
              <c:f>Feuil1!$A$2:$A$302</c:f>
              <c:numCache>
                <c:formatCode>General</c:formatCode>
                <c:ptCount val="301"/>
                <c:pt idx="0">
                  <c:v>800</c:v>
                </c:pt>
                <c:pt idx="1">
                  <c:v>798</c:v>
                </c:pt>
                <c:pt idx="2">
                  <c:v>796</c:v>
                </c:pt>
                <c:pt idx="3">
                  <c:v>794</c:v>
                </c:pt>
                <c:pt idx="4">
                  <c:v>792</c:v>
                </c:pt>
                <c:pt idx="5">
                  <c:v>790</c:v>
                </c:pt>
                <c:pt idx="6">
                  <c:v>788</c:v>
                </c:pt>
                <c:pt idx="7">
                  <c:v>786</c:v>
                </c:pt>
                <c:pt idx="8">
                  <c:v>784</c:v>
                </c:pt>
                <c:pt idx="9">
                  <c:v>782</c:v>
                </c:pt>
                <c:pt idx="10">
                  <c:v>780</c:v>
                </c:pt>
                <c:pt idx="11">
                  <c:v>778</c:v>
                </c:pt>
                <c:pt idx="12">
                  <c:v>776</c:v>
                </c:pt>
                <c:pt idx="13">
                  <c:v>774</c:v>
                </c:pt>
                <c:pt idx="14">
                  <c:v>772</c:v>
                </c:pt>
                <c:pt idx="15">
                  <c:v>770</c:v>
                </c:pt>
                <c:pt idx="16">
                  <c:v>768</c:v>
                </c:pt>
                <c:pt idx="17">
                  <c:v>766</c:v>
                </c:pt>
                <c:pt idx="18">
                  <c:v>764</c:v>
                </c:pt>
                <c:pt idx="19">
                  <c:v>762</c:v>
                </c:pt>
                <c:pt idx="20">
                  <c:v>760</c:v>
                </c:pt>
                <c:pt idx="21">
                  <c:v>758</c:v>
                </c:pt>
                <c:pt idx="22">
                  <c:v>756</c:v>
                </c:pt>
                <c:pt idx="23">
                  <c:v>754</c:v>
                </c:pt>
                <c:pt idx="24">
                  <c:v>752</c:v>
                </c:pt>
                <c:pt idx="25">
                  <c:v>750</c:v>
                </c:pt>
                <c:pt idx="26">
                  <c:v>748</c:v>
                </c:pt>
                <c:pt idx="27">
                  <c:v>746</c:v>
                </c:pt>
                <c:pt idx="28">
                  <c:v>744</c:v>
                </c:pt>
                <c:pt idx="29">
                  <c:v>742</c:v>
                </c:pt>
                <c:pt idx="30">
                  <c:v>740</c:v>
                </c:pt>
                <c:pt idx="31">
                  <c:v>738</c:v>
                </c:pt>
                <c:pt idx="32">
                  <c:v>736</c:v>
                </c:pt>
                <c:pt idx="33">
                  <c:v>734</c:v>
                </c:pt>
                <c:pt idx="34">
                  <c:v>732</c:v>
                </c:pt>
                <c:pt idx="35">
                  <c:v>730</c:v>
                </c:pt>
                <c:pt idx="36">
                  <c:v>728</c:v>
                </c:pt>
                <c:pt idx="37">
                  <c:v>726</c:v>
                </c:pt>
                <c:pt idx="38">
                  <c:v>724</c:v>
                </c:pt>
                <c:pt idx="39">
                  <c:v>722</c:v>
                </c:pt>
                <c:pt idx="40">
                  <c:v>720</c:v>
                </c:pt>
                <c:pt idx="41">
                  <c:v>718</c:v>
                </c:pt>
                <c:pt idx="42">
                  <c:v>716</c:v>
                </c:pt>
                <c:pt idx="43">
                  <c:v>714</c:v>
                </c:pt>
                <c:pt idx="44">
                  <c:v>712</c:v>
                </c:pt>
                <c:pt idx="45">
                  <c:v>710</c:v>
                </c:pt>
                <c:pt idx="46">
                  <c:v>708</c:v>
                </c:pt>
                <c:pt idx="47">
                  <c:v>706</c:v>
                </c:pt>
                <c:pt idx="48">
                  <c:v>704</c:v>
                </c:pt>
                <c:pt idx="49">
                  <c:v>702</c:v>
                </c:pt>
                <c:pt idx="50">
                  <c:v>700</c:v>
                </c:pt>
                <c:pt idx="51">
                  <c:v>698</c:v>
                </c:pt>
                <c:pt idx="52">
                  <c:v>696</c:v>
                </c:pt>
                <c:pt idx="53">
                  <c:v>694</c:v>
                </c:pt>
                <c:pt idx="54">
                  <c:v>692</c:v>
                </c:pt>
                <c:pt idx="55">
                  <c:v>690</c:v>
                </c:pt>
                <c:pt idx="56">
                  <c:v>688</c:v>
                </c:pt>
                <c:pt idx="57">
                  <c:v>686</c:v>
                </c:pt>
                <c:pt idx="58">
                  <c:v>684</c:v>
                </c:pt>
                <c:pt idx="59">
                  <c:v>682</c:v>
                </c:pt>
                <c:pt idx="60">
                  <c:v>680</c:v>
                </c:pt>
                <c:pt idx="61">
                  <c:v>678</c:v>
                </c:pt>
                <c:pt idx="62">
                  <c:v>676</c:v>
                </c:pt>
                <c:pt idx="63">
                  <c:v>674</c:v>
                </c:pt>
                <c:pt idx="64">
                  <c:v>672</c:v>
                </c:pt>
                <c:pt idx="65">
                  <c:v>670</c:v>
                </c:pt>
                <c:pt idx="66">
                  <c:v>668</c:v>
                </c:pt>
                <c:pt idx="67">
                  <c:v>666</c:v>
                </c:pt>
                <c:pt idx="68">
                  <c:v>664</c:v>
                </c:pt>
                <c:pt idx="69">
                  <c:v>662</c:v>
                </c:pt>
                <c:pt idx="70">
                  <c:v>660</c:v>
                </c:pt>
                <c:pt idx="71">
                  <c:v>658</c:v>
                </c:pt>
                <c:pt idx="72">
                  <c:v>656</c:v>
                </c:pt>
                <c:pt idx="73">
                  <c:v>654</c:v>
                </c:pt>
                <c:pt idx="74">
                  <c:v>652</c:v>
                </c:pt>
                <c:pt idx="75">
                  <c:v>650</c:v>
                </c:pt>
                <c:pt idx="76">
                  <c:v>648</c:v>
                </c:pt>
                <c:pt idx="77">
                  <c:v>646</c:v>
                </c:pt>
                <c:pt idx="78">
                  <c:v>644</c:v>
                </c:pt>
                <c:pt idx="79">
                  <c:v>642</c:v>
                </c:pt>
                <c:pt idx="80">
                  <c:v>640</c:v>
                </c:pt>
                <c:pt idx="81">
                  <c:v>638</c:v>
                </c:pt>
                <c:pt idx="82">
                  <c:v>636</c:v>
                </c:pt>
                <c:pt idx="83">
                  <c:v>634</c:v>
                </c:pt>
                <c:pt idx="84">
                  <c:v>632</c:v>
                </c:pt>
                <c:pt idx="85">
                  <c:v>630</c:v>
                </c:pt>
                <c:pt idx="86">
                  <c:v>628</c:v>
                </c:pt>
                <c:pt idx="87">
                  <c:v>626</c:v>
                </c:pt>
                <c:pt idx="88">
                  <c:v>624</c:v>
                </c:pt>
                <c:pt idx="89">
                  <c:v>622</c:v>
                </c:pt>
                <c:pt idx="90">
                  <c:v>620</c:v>
                </c:pt>
                <c:pt idx="91">
                  <c:v>618</c:v>
                </c:pt>
                <c:pt idx="92">
                  <c:v>616</c:v>
                </c:pt>
                <c:pt idx="93">
                  <c:v>614</c:v>
                </c:pt>
                <c:pt idx="94">
                  <c:v>612</c:v>
                </c:pt>
                <c:pt idx="95">
                  <c:v>610</c:v>
                </c:pt>
                <c:pt idx="96">
                  <c:v>608</c:v>
                </c:pt>
                <c:pt idx="97">
                  <c:v>606</c:v>
                </c:pt>
                <c:pt idx="98">
                  <c:v>604</c:v>
                </c:pt>
                <c:pt idx="99">
                  <c:v>602</c:v>
                </c:pt>
                <c:pt idx="100">
                  <c:v>600</c:v>
                </c:pt>
                <c:pt idx="101">
                  <c:v>598</c:v>
                </c:pt>
                <c:pt idx="102">
                  <c:v>596</c:v>
                </c:pt>
                <c:pt idx="103">
                  <c:v>594</c:v>
                </c:pt>
                <c:pt idx="104">
                  <c:v>592</c:v>
                </c:pt>
                <c:pt idx="105">
                  <c:v>590</c:v>
                </c:pt>
                <c:pt idx="106">
                  <c:v>588</c:v>
                </c:pt>
                <c:pt idx="107">
                  <c:v>586</c:v>
                </c:pt>
                <c:pt idx="108">
                  <c:v>584</c:v>
                </c:pt>
                <c:pt idx="109">
                  <c:v>582</c:v>
                </c:pt>
                <c:pt idx="110">
                  <c:v>580</c:v>
                </c:pt>
                <c:pt idx="111">
                  <c:v>578</c:v>
                </c:pt>
                <c:pt idx="112">
                  <c:v>576</c:v>
                </c:pt>
                <c:pt idx="113">
                  <c:v>574</c:v>
                </c:pt>
                <c:pt idx="114">
                  <c:v>572</c:v>
                </c:pt>
                <c:pt idx="115">
                  <c:v>570</c:v>
                </c:pt>
                <c:pt idx="116">
                  <c:v>568</c:v>
                </c:pt>
                <c:pt idx="117">
                  <c:v>566</c:v>
                </c:pt>
                <c:pt idx="118">
                  <c:v>564</c:v>
                </c:pt>
                <c:pt idx="119">
                  <c:v>562</c:v>
                </c:pt>
                <c:pt idx="120">
                  <c:v>560</c:v>
                </c:pt>
                <c:pt idx="121">
                  <c:v>558</c:v>
                </c:pt>
                <c:pt idx="122">
                  <c:v>556</c:v>
                </c:pt>
                <c:pt idx="123">
                  <c:v>554</c:v>
                </c:pt>
                <c:pt idx="124">
                  <c:v>552</c:v>
                </c:pt>
                <c:pt idx="125">
                  <c:v>550</c:v>
                </c:pt>
                <c:pt idx="126">
                  <c:v>548</c:v>
                </c:pt>
                <c:pt idx="127">
                  <c:v>546</c:v>
                </c:pt>
                <c:pt idx="128">
                  <c:v>544</c:v>
                </c:pt>
                <c:pt idx="129">
                  <c:v>542</c:v>
                </c:pt>
                <c:pt idx="130">
                  <c:v>540</c:v>
                </c:pt>
                <c:pt idx="131">
                  <c:v>538</c:v>
                </c:pt>
                <c:pt idx="132">
                  <c:v>536</c:v>
                </c:pt>
                <c:pt idx="133">
                  <c:v>534</c:v>
                </c:pt>
                <c:pt idx="134">
                  <c:v>532</c:v>
                </c:pt>
                <c:pt idx="135">
                  <c:v>530</c:v>
                </c:pt>
                <c:pt idx="136">
                  <c:v>528</c:v>
                </c:pt>
                <c:pt idx="137">
                  <c:v>526</c:v>
                </c:pt>
                <c:pt idx="138">
                  <c:v>524</c:v>
                </c:pt>
                <c:pt idx="139">
                  <c:v>522</c:v>
                </c:pt>
                <c:pt idx="140">
                  <c:v>520</c:v>
                </c:pt>
                <c:pt idx="141">
                  <c:v>518</c:v>
                </c:pt>
                <c:pt idx="142">
                  <c:v>516</c:v>
                </c:pt>
                <c:pt idx="143">
                  <c:v>514</c:v>
                </c:pt>
                <c:pt idx="144">
                  <c:v>512</c:v>
                </c:pt>
                <c:pt idx="145">
                  <c:v>510</c:v>
                </c:pt>
                <c:pt idx="146">
                  <c:v>508</c:v>
                </c:pt>
                <c:pt idx="147">
                  <c:v>506</c:v>
                </c:pt>
                <c:pt idx="148">
                  <c:v>504</c:v>
                </c:pt>
                <c:pt idx="149">
                  <c:v>502</c:v>
                </c:pt>
                <c:pt idx="150">
                  <c:v>500</c:v>
                </c:pt>
                <c:pt idx="151">
                  <c:v>498</c:v>
                </c:pt>
                <c:pt idx="152">
                  <c:v>496</c:v>
                </c:pt>
                <c:pt idx="153">
                  <c:v>494</c:v>
                </c:pt>
                <c:pt idx="154">
                  <c:v>492</c:v>
                </c:pt>
                <c:pt idx="155">
                  <c:v>490</c:v>
                </c:pt>
                <c:pt idx="156">
                  <c:v>488</c:v>
                </c:pt>
                <c:pt idx="157">
                  <c:v>486</c:v>
                </c:pt>
                <c:pt idx="158">
                  <c:v>484</c:v>
                </c:pt>
                <c:pt idx="159">
                  <c:v>482</c:v>
                </c:pt>
                <c:pt idx="160">
                  <c:v>480</c:v>
                </c:pt>
                <c:pt idx="161">
                  <c:v>478</c:v>
                </c:pt>
                <c:pt idx="162">
                  <c:v>476</c:v>
                </c:pt>
                <c:pt idx="163">
                  <c:v>474</c:v>
                </c:pt>
                <c:pt idx="164">
                  <c:v>472</c:v>
                </c:pt>
                <c:pt idx="165">
                  <c:v>470</c:v>
                </c:pt>
                <c:pt idx="166">
                  <c:v>468</c:v>
                </c:pt>
                <c:pt idx="167">
                  <c:v>466</c:v>
                </c:pt>
                <c:pt idx="168">
                  <c:v>464</c:v>
                </c:pt>
                <c:pt idx="169">
                  <c:v>462</c:v>
                </c:pt>
                <c:pt idx="170">
                  <c:v>460</c:v>
                </c:pt>
                <c:pt idx="171">
                  <c:v>458</c:v>
                </c:pt>
                <c:pt idx="172">
                  <c:v>456</c:v>
                </c:pt>
                <c:pt idx="173">
                  <c:v>454</c:v>
                </c:pt>
                <c:pt idx="174">
                  <c:v>452</c:v>
                </c:pt>
                <c:pt idx="175">
                  <c:v>450</c:v>
                </c:pt>
                <c:pt idx="176">
                  <c:v>448</c:v>
                </c:pt>
                <c:pt idx="177">
                  <c:v>446</c:v>
                </c:pt>
                <c:pt idx="178">
                  <c:v>444</c:v>
                </c:pt>
                <c:pt idx="179">
                  <c:v>442</c:v>
                </c:pt>
                <c:pt idx="180">
                  <c:v>440</c:v>
                </c:pt>
                <c:pt idx="181">
                  <c:v>438</c:v>
                </c:pt>
                <c:pt idx="182">
                  <c:v>436</c:v>
                </c:pt>
                <c:pt idx="183">
                  <c:v>434</c:v>
                </c:pt>
                <c:pt idx="184">
                  <c:v>432</c:v>
                </c:pt>
                <c:pt idx="185">
                  <c:v>430</c:v>
                </c:pt>
                <c:pt idx="186">
                  <c:v>428</c:v>
                </c:pt>
                <c:pt idx="187">
                  <c:v>426</c:v>
                </c:pt>
                <c:pt idx="188">
                  <c:v>424</c:v>
                </c:pt>
                <c:pt idx="189">
                  <c:v>422</c:v>
                </c:pt>
                <c:pt idx="190">
                  <c:v>420</c:v>
                </c:pt>
                <c:pt idx="191">
                  <c:v>418</c:v>
                </c:pt>
                <c:pt idx="192">
                  <c:v>416</c:v>
                </c:pt>
                <c:pt idx="193">
                  <c:v>414</c:v>
                </c:pt>
                <c:pt idx="194">
                  <c:v>412</c:v>
                </c:pt>
                <c:pt idx="195">
                  <c:v>410</c:v>
                </c:pt>
                <c:pt idx="196">
                  <c:v>408</c:v>
                </c:pt>
                <c:pt idx="197">
                  <c:v>406</c:v>
                </c:pt>
                <c:pt idx="198">
                  <c:v>404</c:v>
                </c:pt>
                <c:pt idx="199">
                  <c:v>402</c:v>
                </c:pt>
                <c:pt idx="200">
                  <c:v>400</c:v>
                </c:pt>
                <c:pt idx="201">
                  <c:v>398</c:v>
                </c:pt>
                <c:pt idx="202">
                  <c:v>396</c:v>
                </c:pt>
                <c:pt idx="203">
                  <c:v>394</c:v>
                </c:pt>
                <c:pt idx="204">
                  <c:v>392</c:v>
                </c:pt>
                <c:pt idx="205">
                  <c:v>390</c:v>
                </c:pt>
                <c:pt idx="206">
                  <c:v>388</c:v>
                </c:pt>
                <c:pt idx="207">
                  <c:v>386</c:v>
                </c:pt>
                <c:pt idx="208">
                  <c:v>384</c:v>
                </c:pt>
                <c:pt idx="209">
                  <c:v>382</c:v>
                </c:pt>
                <c:pt idx="210">
                  <c:v>380</c:v>
                </c:pt>
                <c:pt idx="211">
                  <c:v>378</c:v>
                </c:pt>
                <c:pt idx="212">
                  <c:v>376</c:v>
                </c:pt>
                <c:pt idx="213">
                  <c:v>374</c:v>
                </c:pt>
                <c:pt idx="214">
                  <c:v>372</c:v>
                </c:pt>
                <c:pt idx="215">
                  <c:v>370</c:v>
                </c:pt>
                <c:pt idx="216">
                  <c:v>368</c:v>
                </c:pt>
                <c:pt idx="217">
                  <c:v>366</c:v>
                </c:pt>
                <c:pt idx="218">
                  <c:v>364</c:v>
                </c:pt>
                <c:pt idx="219">
                  <c:v>362</c:v>
                </c:pt>
                <c:pt idx="220">
                  <c:v>360</c:v>
                </c:pt>
                <c:pt idx="221">
                  <c:v>358</c:v>
                </c:pt>
                <c:pt idx="222">
                  <c:v>356</c:v>
                </c:pt>
                <c:pt idx="223">
                  <c:v>354</c:v>
                </c:pt>
                <c:pt idx="224">
                  <c:v>352</c:v>
                </c:pt>
                <c:pt idx="225">
                  <c:v>350</c:v>
                </c:pt>
                <c:pt idx="226">
                  <c:v>348</c:v>
                </c:pt>
                <c:pt idx="227">
                  <c:v>346</c:v>
                </c:pt>
                <c:pt idx="228">
                  <c:v>344</c:v>
                </c:pt>
                <c:pt idx="229">
                  <c:v>342</c:v>
                </c:pt>
                <c:pt idx="230">
                  <c:v>340</c:v>
                </c:pt>
                <c:pt idx="231">
                  <c:v>338</c:v>
                </c:pt>
                <c:pt idx="232">
                  <c:v>336</c:v>
                </c:pt>
                <c:pt idx="233">
                  <c:v>334</c:v>
                </c:pt>
                <c:pt idx="234">
                  <c:v>332</c:v>
                </c:pt>
                <c:pt idx="235">
                  <c:v>330</c:v>
                </c:pt>
                <c:pt idx="236">
                  <c:v>328</c:v>
                </c:pt>
                <c:pt idx="237">
                  <c:v>326</c:v>
                </c:pt>
                <c:pt idx="238">
                  <c:v>324</c:v>
                </c:pt>
                <c:pt idx="239">
                  <c:v>322</c:v>
                </c:pt>
                <c:pt idx="240">
                  <c:v>320</c:v>
                </c:pt>
                <c:pt idx="241">
                  <c:v>318</c:v>
                </c:pt>
                <c:pt idx="242">
                  <c:v>316</c:v>
                </c:pt>
                <c:pt idx="243">
                  <c:v>314</c:v>
                </c:pt>
                <c:pt idx="244">
                  <c:v>312</c:v>
                </c:pt>
                <c:pt idx="245">
                  <c:v>310</c:v>
                </c:pt>
                <c:pt idx="246">
                  <c:v>308</c:v>
                </c:pt>
                <c:pt idx="247">
                  <c:v>306</c:v>
                </c:pt>
                <c:pt idx="248">
                  <c:v>304</c:v>
                </c:pt>
                <c:pt idx="249">
                  <c:v>302</c:v>
                </c:pt>
                <c:pt idx="250">
                  <c:v>300</c:v>
                </c:pt>
                <c:pt idx="251">
                  <c:v>298</c:v>
                </c:pt>
                <c:pt idx="252">
                  <c:v>296</c:v>
                </c:pt>
                <c:pt idx="253">
                  <c:v>294</c:v>
                </c:pt>
                <c:pt idx="254">
                  <c:v>292</c:v>
                </c:pt>
                <c:pt idx="255">
                  <c:v>290</c:v>
                </c:pt>
                <c:pt idx="256">
                  <c:v>288</c:v>
                </c:pt>
                <c:pt idx="257">
                  <c:v>286</c:v>
                </c:pt>
                <c:pt idx="258">
                  <c:v>284</c:v>
                </c:pt>
                <c:pt idx="259">
                  <c:v>282</c:v>
                </c:pt>
                <c:pt idx="260">
                  <c:v>280</c:v>
                </c:pt>
                <c:pt idx="261">
                  <c:v>278</c:v>
                </c:pt>
                <c:pt idx="262">
                  <c:v>276</c:v>
                </c:pt>
                <c:pt idx="263">
                  <c:v>274</c:v>
                </c:pt>
                <c:pt idx="264">
                  <c:v>272</c:v>
                </c:pt>
                <c:pt idx="265">
                  <c:v>270</c:v>
                </c:pt>
                <c:pt idx="266">
                  <c:v>268</c:v>
                </c:pt>
                <c:pt idx="267">
                  <c:v>266</c:v>
                </c:pt>
                <c:pt idx="268">
                  <c:v>264</c:v>
                </c:pt>
                <c:pt idx="269">
                  <c:v>262</c:v>
                </c:pt>
                <c:pt idx="270">
                  <c:v>260</c:v>
                </c:pt>
                <c:pt idx="271">
                  <c:v>258</c:v>
                </c:pt>
                <c:pt idx="272">
                  <c:v>256</c:v>
                </c:pt>
                <c:pt idx="273">
                  <c:v>254</c:v>
                </c:pt>
                <c:pt idx="274">
                  <c:v>252</c:v>
                </c:pt>
                <c:pt idx="275">
                  <c:v>250</c:v>
                </c:pt>
                <c:pt idx="276">
                  <c:v>248</c:v>
                </c:pt>
                <c:pt idx="277">
                  <c:v>246</c:v>
                </c:pt>
                <c:pt idx="278">
                  <c:v>244</c:v>
                </c:pt>
                <c:pt idx="279">
                  <c:v>242</c:v>
                </c:pt>
                <c:pt idx="280">
                  <c:v>240</c:v>
                </c:pt>
                <c:pt idx="281">
                  <c:v>238</c:v>
                </c:pt>
                <c:pt idx="282">
                  <c:v>236</c:v>
                </c:pt>
                <c:pt idx="283">
                  <c:v>234</c:v>
                </c:pt>
                <c:pt idx="284">
                  <c:v>232</c:v>
                </c:pt>
                <c:pt idx="285">
                  <c:v>230</c:v>
                </c:pt>
                <c:pt idx="286">
                  <c:v>228</c:v>
                </c:pt>
                <c:pt idx="287">
                  <c:v>226</c:v>
                </c:pt>
                <c:pt idx="288">
                  <c:v>224</c:v>
                </c:pt>
                <c:pt idx="289">
                  <c:v>222</c:v>
                </c:pt>
                <c:pt idx="290">
                  <c:v>220</c:v>
                </c:pt>
                <c:pt idx="291">
                  <c:v>218</c:v>
                </c:pt>
                <c:pt idx="292">
                  <c:v>216</c:v>
                </c:pt>
                <c:pt idx="293">
                  <c:v>214</c:v>
                </c:pt>
                <c:pt idx="294">
                  <c:v>212</c:v>
                </c:pt>
                <c:pt idx="295">
                  <c:v>210</c:v>
                </c:pt>
                <c:pt idx="296">
                  <c:v>208</c:v>
                </c:pt>
                <c:pt idx="297">
                  <c:v>206</c:v>
                </c:pt>
                <c:pt idx="298">
                  <c:v>204</c:v>
                </c:pt>
                <c:pt idx="299">
                  <c:v>202</c:v>
                </c:pt>
                <c:pt idx="300">
                  <c:v>200</c:v>
                </c:pt>
              </c:numCache>
            </c:numRef>
          </c:xVal>
          <c:yVal>
            <c:numRef>
              <c:f>Feuil1!$D$2:$D$302</c:f>
              <c:numCache>
                <c:formatCode>General</c:formatCode>
                <c:ptCount val="301"/>
                <c:pt idx="0">
                  <c:v>6.1900000000000097E-3</c:v>
                </c:pt>
                <c:pt idx="1">
                  <c:v>3.9000000000000098E-3</c:v>
                </c:pt>
                <c:pt idx="2">
                  <c:v>6.9600000000000183E-3</c:v>
                </c:pt>
                <c:pt idx="3">
                  <c:v>4.5700000000000133E-3</c:v>
                </c:pt>
                <c:pt idx="4">
                  <c:v>1.5000000000000061E-4</c:v>
                </c:pt>
                <c:pt idx="5">
                  <c:v>1.2999999999999999E-4</c:v>
                </c:pt>
                <c:pt idx="6">
                  <c:v>9.9000000000000477E-4</c:v>
                </c:pt>
                <c:pt idx="7">
                  <c:v>4.7000000000000132E-3</c:v>
                </c:pt>
                <c:pt idx="8">
                  <c:v>4.7800000000000134E-3</c:v>
                </c:pt>
                <c:pt idx="9">
                  <c:v>9.6200000000000192E-3</c:v>
                </c:pt>
                <c:pt idx="10">
                  <c:v>3.8900000000000059E-3</c:v>
                </c:pt>
                <c:pt idx="11">
                  <c:v>9.3600000000000471E-3</c:v>
                </c:pt>
                <c:pt idx="12">
                  <c:v>4.5000000000000109E-3</c:v>
                </c:pt>
                <c:pt idx="13">
                  <c:v>-2.0600000000000071E-3</c:v>
                </c:pt>
                <c:pt idx="14">
                  <c:v>-4.4000000000000218E-4</c:v>
                </c:pt>
                <c:pt idx="15">
                  <c:v>5.2700000000000221E-3</c:v>
                </c:pt>
                <c:pt idx="16">
                  <c:v>5.0200000000000071E-3</c:v>
                </c:pt>
                <c:pt idx="17">
                  <c:v>5.0300000000000162E-3</c:v>
                </c:pt>
                <c:pt idx="18">
                  <c:v>1.2500000000000037E-3</c:v>
                </c:pt>
                <c:pt idx="19">
                  <c:v>6.380000000000015E-3</c:v>
                </c:pt>
                <c:pt idx="20">
                  <c:v>1.6500000000000069E-3</c:v>
                </c:pt>
                <c:pt idx="21">
                  <c:v>5.7100000000000137E-3</c:v>
                </c:pt>
                <c:pt idx="22">
                  <c:v>3.5800000000000111E-3</c:v>
                </c:pt>
                <c:pt idx="23">
                  <c:v>4.6900000000000023E-3</c:v>
                </c:pt>
                <c:pt idx="24">
                  <c:v>7.8400000000000171E-3</c:v>
                </c:pt>
                <c:pt idx="25">
                  <c:v>7.4300000000000295E-3</c:v>
                </c:pt>
                <c:pt idx="26">
                  <c:v>1.1320000000000054E-2</c:v>
                </c:pt>
                <c:pt idx="27">
                  <c:v>8.7800000000000048E-3</c:v>
                </c:pt>
                <c:pt idx="28">
                  <c:v>2.6100000000000012E-3</c:v>
                </c:pt>
                <c:pt idx="29">
                  <c:v>3.1800000000000118E-3</c:v>
                </c:pt>
                <c:pt idx="30">
                  <c:v>5.6200000000000061E-3</c:v>
                </c:pt>
                <c:pt idx="31">
                  <c:v>8.150000000000027E-3</c:v>
                </c:pt>
                <c:pt idx="32">
                  <c:v>3.1900000000000084E-3</c:v>
                </c:pt>
                <c:pt idx="33">
                  <c:v>4.230000000000015E-3</c:v>
                </c:pt>
                <c:pt idx="34">
                  <c:v>8.740000000000003E-3</c:v>
                </c:pt>
                <c:pt idx="35">
                  <c:v>8.46000000000003E-3</c:v>
                </c:pt>
                <c:pt idx="36">
                  <c:v>8.4500000000000373E-3</c:v>
                </c:pt>
                <c:pt idx="37">
                  <c:v>6.3300000000000162E-3</c:v>
                </c:pt>
                <c:pt idx="38">
                  <c:v>3.7200000000000141E-3</c:v>
                </c:pt>
                <c:pt idx="39">
                  <c:v>7.1500000000000122E-3</c:v>
                </c:pt>
                <c:pt idx="40">
                  <c:v>8.1400000000000049E-3</c:v>
                </c:pt>
                <c:pt idx="41">
                  <c:v>1.0650000000000001E-2</c:v>
                </c:pt>
                <c:pt idx="42">
                  <c:v>5.790000000000013E-3</c:v>
                </c:pt>
                <c:pt idx="43">
                  <c:v>8.6000000000000208E-3</c:v>
                </c:pt>
                <c:pt idx="44">
                  <c:v>3.680000000000014E-3</c:v>
                </c:pt>
                <c:pt idx="45">
                  <c:v>1.0090000000000002E-2</c:v>
                </c:pt>
                <c:pt idx="46">
                  <c:v>8.7700000000000208E-3</c:v>
                </c:pt>
                <c:pt idx="47">
                  <c:v>8.1900000000000028E-3</c:v>
                </c:pt>
                <c:pt idx="48">
                  <c:v>1.5500000000000045E-2</c:v>
                </c:pt>
                <c:pt idx="49">
                  <c:v>1.1190000000000026E-2</c:v>
                </c:pt>
                <c:pt idx="50">
                  <c:v>1.172000000000005E-2</c:v>
                </c:pt>
                <c:pt idx="51">
                  <c:v>1.4310000000000002E-2</c:v>
                </c:pt>
                <c:pt idx="52">
                  <c:v>1.699000000000005E-2</c:v>
                </c:pt>
                <c:pt idx="53">
                  <c:v>1.0120000000000021E-2</c:v>
                </c:pt>
                <c:pt idx="54">
                  <c:v>1.8530000000000043E-2</c:v>
                </c:pt>
                <c:pt idx="55">
                  <c:v>1.7640000000000058E-2</c:v>
                </c:pt>
                <c:pt idx="56">
                  <c:v>2.035E-2</c:v>
                </c:pt>
                <c:pt idx="57">
                  <c:v>2.2190000000000001E-2</c:v>
                </c:pt>
                <c:pt idx="58">
                  <c:v>2.7820000000000067E-2</c:v>
                </c:pt>
                <c:pt idx="59">
                  <c:v>2.6190000000000001E-2</c:v>
                </c:pt>
                <c:pt idx="60">
                  <c:v>3.0840000000000083E-2</c:v>
                </c:pt>
                <c:pt idx="61">
                  <c:v>3.1890000000000092E-2</c:v>
                </c:pt>
                <c:pt idx="62">
                  <c:v>3.4950000000000002E-2</c:v>
                </c:pt>
                <c:pt idx="63">
                  <c:v>4.317E-2</c:v>
                </c:pt>
                <c:pt idx="64">
                  <c:v>4.5560000000000024E-2</c:v>
                </c:pt>
                <c:pt idx="65">
                  <c:v>5.4330000000000211E-2</c:v>
                </c:pt>
                <c:pt idx="66">
                  <c:v>6.2680000000000013E-2</c:v>
                </c:pt>
                <c:pt idx="67">
                  <c:v>6.7730000000000179E-2</c:v>
                </c:pt>
                <c:pt idx="68">
                  <c:v>7.6579999999999995E-2</c:v>
                </c:pt>
                <c:pt idx="69">
                  <c:v>8.0690000000000289E-2</c:v>
                </c:pt>
                <c:pt idx="70">
                  <c:v>8.6630000000000068E-2</c:v>
                </c:pt>
                <c:pt idx="71">
                  <c:v>9.7940000000000013E-2</c:v>
                </c:pt>
                <c:pt idx="72">
                  <c:v>0.10847999999999998</c:v>
                </c:pt>
                <c:pt idx="73">
                  <c:v>0.1173400000000001</c:v>
                </c:pt>
                <c:pt idx="74">
                  <c:v>0.13255</c:v>
                </c:pt>
                <c:pt idx="75">
                  <c:v>0.14185</c:v>
                </c:pt>
                <c:pt idx="76">
                  <c:v>0.15250000000000039</c:v>
                </c:pt>
                <c:pt idx="77">
                  <c:v>0.16889000000000035</c:v>
                </c:pt>
                <c:pt idx="78">
                  <c:v>0.18134000000000042</c:v>
                </c:pt>
                <c:pt idx="79">
                  <c:v>0.19792000000000035</c:v>
                </c:pt>
                <c:pt idx="80">
                  <c:v>0.20816999999999999</c:v>
                </c:pt>
                <c:pt idx="81">
                  <c:v>0.22129000000000029</c:v>
                </c:pt>
                <c:pt idx="82">
                  <c:v>0.23643000000000042</c:v>
                </c:pt>
                <c:pt idx="83">
                  <c:v>0.24852000000000021</c:v>
                </c:pt>
                <c:pt idx="84">
                  <c:v>0.26379000000000002</c:v>
                </c:pt>
                <c:pt idx="85">
                  <c:v>0.27565000000000001</c:v>
                </c:pt>
                <c:pt idx="86">
                  <c:v>0.29012000000000032</c:v>
                </c:pt>
                <c:pt idx="87">
                  <c:v>0.30205000000000032</c:v>
                </c:pt>
                <c:pt idx="88">
                  <c:v>0.31358000000000108</c:v>
                </c:pt>
                <c:pt idx="89">
                  <c:v>0.32086000000000114</c:v>
                </c:pt>
                <c:pt idx="90">
                  <c:v>0.32621000000000078</c:v>
                </c:pt>
                <c:pt idx="91">
                  <c:v>0.33635000000000137</c:v>
                </c:pt>
                <c:pt idx="92">
                  <c:v>0.34183000000000052</c:v>
                </c:pt>
                <c:pt idx="93">
                  <c:v>0.34903000000000045</c:v>
                </c:pt>
                <c:pt idx="94">
                  <c:v>0.35065000000000002</c:v>
                </c:pt>
                <c:pt idx="95">
                  <c:v>0.35578000000000032</c:v>
                </c:pt>
                <c:pt idx="96">
                  <c:v>0.3604700000000009</c:v>
                </c:pt>
                <c:pt idx="97">
                  <c:v>0.36322000000000032</c:v>
                </c:pt>
                <c:pt idx="98">
                  <c:v>0.36125000000000002</c:v>
                </c:pt>
                <c:pt idx="99">
                  <c:v>0.36644000000000032</c:v>
                </c:pt>
                <c:pt idx="100">
                  <c:v>0.3673500000000009</c:v>
                </c:pt>
                <c:pt idx="101">
                  <c:v>0.37070000000000008</c:v>
                </c:pt>
                <c:pt idx="102">
                  <c:v>0.37171000000000032</c:v>
                </c:pt>
                <c:pt idx="103">
                  <c:v>0.37031000000000114</c:v>
                </c:pt>
                <c:pt idx="104">
                  <c:v>0.37249000000000032</c:v>
                </c:pt>
                <c:pt idx="105">
                  <c:v>0.37586000000000125</c:v>
                </c:pt>
                <c:pt idx="106">
                  <c:v>0.37867000000000089</c:v>
                </c:pt>
                <c:pt idx="107">
                  <c:v>0.38140000000000102</c:v>
                </c:pt>
                <c:pt idx="108">
                  <c:v>0.38373000000000002</c:v>
                </c:pt>
                <c:pt idx="109">
                  <c:v>0.38915000000000038</c:v>
                </c:pt>
                <c:pt idx="110">
                  <c:v>0.39223000000000002</c:v>
                </c:pt>
                <c:pt idx="111">
                  <c:v>0.39902000000000143</c:v>
                </c:pt>
                <c:pt idx="112">
                  <c:v>0.40608000000000077</c:v>
                </c:pt>
                <c:pt idx="113">
                  <c:v>0.41055000000000008</c:v>
                </c:pt>
                <c:pt idx="114">
                  <c:v>0.41576000000000002</c:v>
                </c:pt>
                <c:pt idx="115">
                  <c:v>0.4198600000000009</c:v>
                </c:pt>
                <c:pt idx="116">
                  <c:v>0.42445000000000038</c:v>
                </c:pt>
                <c:pt idx="117">
                  <c:v>0.42516000000000032</c:v>
                </c:pt>
                <c:pt idx="118">
                  <c:v>0.42471000000000031</c:v>
                </c:pt>
                <c:pt idx="119">
                  <c:v>0.4238000000000009</c:v>
                </c:pt>
                <c:pt idx="120">
                  <c:v>0.4189700000000009</c:v>
                </c:pt>
                <c:pt idx="121">
                  <c:v>0.41624</c:v>
                </c:pt>
                <c:pt idx="122">
                  <c:v>0.41241000000000078</c:v>
                </c:pt>
                <c:pt idx="123">
                  <c:v>0.40508000000000038</c:v>
                </c:pt>
                <c:pt idx="124">
                  <c:v>0.40010000000000001</c:v>
                </c:pt>
                <c:pt idx="125">
                  <c:v>0.39613000000000032</c:v>
                </c:pt>
                <c:pt idx="126">
                  <c:v>0.3881100000000009</c:v>
                </c:pt>
                <c:pt idx="127">
                  <c:v>0.38083000000000078</c:v>
                </c:pt>
                <c:pt idx="128">
                  <c:v>0.3740700000000009</c:v>
                </c:pt>
                <c:pt idx="129">
                  <c:v>0.36926000000000031</c:v>
                </c:pt>
                <c:pt idx="130">
                  <c:v>0.36400000000000032</c:v>
                </c:pt>
                <c:pt idx="131">
                  <c:v>0.36035000000000089</c:v>
                </c:pt>
                <c:pt idx="132">
                  <c:v>0.3569700000000009</c:v>
                </c:pt>
                <c:pt idx="133">
                  <c:v>0.35414000000000001</c:v>
                </c:pt>
                <c:pt idx="134">
                  <c:v>0.35084000000000032</c:v>
                </c:pt>
                <c:pt idx="135">
                  <c:v>0.34828000000000076</c:v>
                </c:pt>
                <c:pt idx="136">
                  <c:v>0.34558000000000116</c:v>
                </c:pt>
                <c:pt idx="137">
                  <c:v>0.3421700000000007</c:v>
                </c:pt>
                <c:pt idx="138">
                  <c:v>0.33744000000000102</c:v>
                </c:pt>
                <c:pt idx="139">
                  <c:v>0.33280000000000137</c:v>
                </c:pt>
                <c:pt idx="140">
                  <c:v>0.3263900000000009</c:v>
                </c:pt>
                <c:pt idx="141">
                  <c:v>0.31930000000000114</c:v>
                </c:pt>
                <c:pt idx="142">
                  <c:v>0.31145000000000089</c:v>
                </c:pt>
                <c:pt idx="143">
                  <c:v>0.30525000000000002</c:v>
                </c:pt>
                <c:pt idx="144">
                  <c:v>0.29661000000000032</c:v>
                </c:pt>
                <c:pt idx="145">
                  <c:v>0.28861000000000031</c:v>
                </c:pt>
                <c:pt idx="146">
                  <c:v>0.28284000000000031</c:v>
                </c:pt>
                <c:pt idx="147">
                  <c:v>0.27630000000000032</c:v>
                </c:pt>
                <c:pt idx="148">
                  <c:v>0.27145000000000002</c:v>
                </c:pt>
                <c:pt idx="149">
                  <c:v>0.26598000000000038</c:v>
                </c:pt>
                <c:pt idx="150">
                  <c:v>0.26193</c:v>
                </c:pt>
                <c:pt idx="151">
                  <c:v>0.25883</c:v>
                </c:pt>
                <c:pt idx="152">
                  <c:v>0.25631000000000032</c:v>
                </c:pt>
                <c:pt idx="153">
                  <c:v>0.25408000000000008</c:v>
                </c:pt>
                <c:pt idx="154">
                  <c:v>0.25164999999999998</c:v>
                </c:pt>
                <c:pt idx="155">
                  <c:v>0.24960000000000004</c:v>
                </c:pt>
                <c:pt idx="156">
                  <c:v>0.24745000000000042</c:v>
                </c:pt>
                <c:pt idx="157">
                  <c:v>0.24498000000000042</c:v>
                </c:pt>
                <c:pt idx="158">
                  <c:v>0.24185999999999999</c:v>
                </c:pt>
                <c:pt idx="159">
                  <c:v>0.23845000000000038</c:v>
                </c:pt>
                <c:pt idx="160">
                  <c:v>0.23505999999999999</c:v>
                </c:pt>
                <c:pt idx="161">
                  <c:v>0.23042000000000001</c:v>
                </c:pt>
                <c:pt idx="162">
                  <c:v>0.22593000000000044</c:v>
                </c:pt>
                <c:pt idx="163">
                  <c:v>0.22212999999999997</c:v>
                </c:pt>
                <c:pt idx="164">
                  <c:v>0.21843000000000054</c:v>
                </c:pt>
                <c:pt idx="165">
                  <c:v>0.21486000000000038</c:v>
                </c:pt>
                <c:pt idx="166">
                  <c:v>0.21210000000000001</c:v>
                </c:pt>
                <c:pt idx="167">
                  <c:v>0.20910999999999999</c:v>
                </c:pt>
                <c:pt idx="168">
                  <c:v>0.20729000000000042</c:v>
                </c:pt>
                <c:pt idx="169">
                  <c:v>0.2056</c:v>
                </c:pt>
                <c:pt idx="170">
                  <c:v>0.20416000000000001</c:v>
                </c:pt>
                <c:pt idx="171">
                  <c:v>0.20327000000000001</c:v>
                </c:pt>
                <c:pt idx="172">
                  <c:v>0.20224000000000042</c:v>
                </c:pt>
                <c:pt idx="173">
                  <c:v>0.20132</c:v>
                </c:pt>
                <c:pt idx="174">
                  <c:v>0.20064000000000001</c:v>
                </c:pt>
                <c:pt idx="175">
                  <c:v>0.19952000000000022</c:v>
                </c:pt>
                <c:pt idx="176">
                  <c:v>0.19866999999999999</c:v>
                </c:pt>
                <c:pt idx="177">
                  <c:v>0.19838000000000022</c:v>
                </c:pt>
                <c:pt idx="178">
                  <c:v>0.19843000000000049</c:v>
                </c:pt>
                <c:pt idx="179">
                  <c:v>0.1989300000000005</c:v>
                </c:pt>
                <c:pt idx="180">
                  <c:v>0.20039999999999999</c:v>
                </c:pt>
                <c:pt idx="181">
                  <c:v>0.20211000000000001</c:v>
                </c:pt>
                <c:pt idx="182">
                  <c:v>0.20452000000000001</c:v>
                </c:pt>
                <c:pt idx="183">
                  <c:v>0.20760000000000001</c:v>
                </c:pt>
                <c:pt idx="184">
                  <c:v>0.21115</c:v>
                </c:pt>
                <c:pt idx="185">
                  <c:v>0.21492000000000042</c:v>
                </c:pt>
                <c:pt idx="186">
                  <c:v>0.21873000000000048</c:v>
                </c:pt>
                <c:pt idx="187">
                  <c:v>0.2222900000000004</c:v>
                </c:pt>
                <c:pt idx="188">
                  <c:v>0.22558000000000022</c:v>
                </c:pt>
                <c:pt idx="189">
                  <c:v>0.2288400000000004</c:v>
                </c:pt>
                <c:pt idx="190">
                  <c:v>0.23169000000000001</c:v>
                </c:pt>
                <c:pt idx="191">
                  <c:v>0.23375000000000001</c:v>
                </c:pt>
                <c:pt idx="192">
                  <c:v>0.23602000000000001</c:v>
                </c:pt>
                <c:pt idx="193">
                  <c:v>0.23809000000000038</c:v>
                </c:pt>
                <c:pt idx="194">
                  <c:v>0.23956000000000024</c:v>
                </c:pt>
                <c:pt idx="195">
                  <c:v>0.24185000000000001</c:v>
                </c:pt>
                <c:pt idx="196">
                  <c:v>0.24446000000000054</c:v>
                </c:pt>
                <c:pt idx="197">
                  <c:v>0.24757000000000001</c:v>
                </c:pt>
                <c:pt idx="198">
                  <c:v>0.25128</c:v>
                </c:pt>
                <c:pt idx="199">
                  <c:v>0.25584000000000001</c:v>
                </c:pt>
                <c:pt idx="200">
                  <c:v>0.26089000000000001</c:v>
                </c:pt>
                <c:pt idx="201">
                  <c:v>0.26564000000000004</c:v>
                </c:pt>
                <c:pt idx="202">
                  <c:v>0.27066000000000001</c:v>
                </c:pt>
                <c:pt idx="203">
                  <c:v>0.27410000000000001</c:v>
                </c:pt>
                <c:pt idx="204">
                  <c:v>0.2768200000000009</c:v>
                </c:pt>
                <c:pt idx="205">
                  <c:v>0.27843000000000001</c:v>
                </c:pt>
                <c:pt idx="206">
                  <c:v>0.27842000000000078</c:v>
                </c:pt>
                <c:pt idx="207">
                  <c:v>0.27814</c:v>
                </c:pt>
                <c:pt idx="208">
                  <c:v>0.27746000000000032</c:v>
                </c:pt>
                <c:pt idx="209">
                  <c:v>0.27687000000000089</c:v>
                </c:pt>
                <c:pt idx="210">
                  <c:v>0.27622000000000002</c:v>
                </c:pt>
                <c:pt idx="211">
                  <c:v>0.27504000000000001</c:v>
                </c:pt>
                <c:pt idx="212">
                  <c:v>0.27440000000000031</c:v>
                </c:pt>
                <c:pt idx="213">
                  <c:v>0.27403</c:v>
                </c:pt>
                <c:pt idx="214">
                  <c:v>0.27310000000000001</c:v>
                </c:pt>
                <c:pt idx="215">
                  <c:v>0.27408000000000032</c:v>
                </c:pt>
                <c:pt idx="216">
                  <c:v>0.27485000000000032</c:v>
                </c:pt>
                <c:pt idx="217">
                  <c:v>0.27688000000000101</c:v>
                </c:pt>
                <c:pt idx="218">
                  <c:v>0.28179000000000004</c:v>
                </c:pt>
                <c:pt idx="219">
                  <c:v>0.28739000000000031</c:v>
                </c:pt>
                <c:pt idx="220">
                  <c:v>0.29481000000000102</c:v>
                </c:pt>
                <c:pt idx="221">
                  <c:v>0.3050700000000009</c:v>
                </c:pt>
                <c:pt idx="222">
                  <c:v>0.31449000000000032</c:v>
                </c:pt>
                <c:pt idx="223">
                  <c:v>0.32362000000000102</c:v>
                </c:pt>
                <c:pt idx="224">
                  <c:v>0.33239000000000102</c:v>
                </c:pt>
                <c:pt idx="225">
                  <c:v>0.33907000000000137</c:v>
                </c:pt>
                <c:pt idx="226">
                  <c:v>0.34542000000000117</c:v>
                </c:pt>
                <c:pt idx="227">
                  <c:v>0.35093000000000002</c:v>
                </c:pt>
                <c:pt idx="228">
                  <c:v>0.35672000000000031</c:v>
                </c:pt>
                <c:pt idx="229">
                  <c:v>0.36340000000000078</c:v>
                </c:pt>
                <c:pt idx="230">
                  <c:v>0.37269000000000002</c:v>
                </c:pt>
                <c:pt idx="231">
                  <c:v>0.38203000000000031</c:v>
                </c:pt>
                <c:pt idx="232">
                  <c:v>0.39382000000000167</c:v>
                </c:pt>
                <c:pt idx="233">
                  <c:v>0.40667000000000031</c:v>
                </c:pt>
                <c:pt idx="234">
                  <c:v>0.4192300000000001</c:v>
                </c:pt>
                <c:pt idx="235">
                  <c:v>0.43309000000000031</c:v>
                </c:pt>
                <c:pt idx="236">
                  <c:v>0.44693000000000033</c:v>
                </c:pt>
                <c:pt idx="237">
                  <c:v>0.45871000000000001</c:v>
                </c:pt>
                <c:pt idx="238">
                  <c:v>0.47006000000000031</c:v>
                </c:pt>
                <c:pt idx="239">
                  <c:v>0.48114000000000001</c:v>
                </c:pt>
                <c:pt idx="240">
                  <c:v>0.49050000000000032</c:v>
                </c:pt>
                <c:pt idx="241">
                  <c:v>0.49830000000000102</c:v>
                </c:pt>
                <c:pt idx="242">
                  <c:v>0.5055499999999995</c:v>
                </c:pt>
                <c:pt idx="243">
                  <c:v>0.51234999999999997</c:v>
                </c:pt>
                <c:pt idx="244">
                  <c:v>0.51970000000000005</c:v>
                </c:pt>
                <c:pt idx="245">
                  <c:v>0.52710999999999997</c:v>
                </c:pt>
                <c:pt idx="246">
                  <c:v>0.53552999999999951</c:v>
                </c:pt>
                <c:pt idx="247">
                  <c:v>0.54593000000000003</c:v>
                </c:pt>
                <c:pt idx="248">
                  <c:v>0.55510000000000004</c:v>
                </c:pt>
                <c:pt idx="249">
                  <c:v>0.56411999999999951</c:v>
                </c:pt>
                <c:pt idx="250">
                  <c:v>0.57245999999999997</c:v>
                </c:pt>
                <c:pt idx="251">
                  <c:v>0.58060000000000089</c:v>
                </c:pt>
                <c:pt idx="252">
                  <c:v>0.58815999999999957</c:v>
                </c:pt>
                <c:pt idx="253">
                  <c:v>0.59710000000000052</c:v>
                </c:pt>
                <c:pt idx="254">
                  <c:v>0.60600000000000065</c:v>
                </c:pt>
                <c:pt idx="255">
                  <c:v>0.61377000000000204</c:v>
                </c:pt>
                <c:pt idx="256">
                  <c:v>0.62246000000000001</c:v>
                </c:pt>
                <c:pt idx="257">
                  <c:v>0.63134000000000179</c:v>
                </c:pt>
                <c:pt idx="258">
                  <c:v>0.63920000000000154</c:v>
                </c:pt>
                <c:pt idx="259">
                  <c:v>0.65003999999999995</c:v>
                </c:pt>
                <c:pt idx="260">
                  <c:v>0.65934000000000204</c:v>
                </c:pt>
                <c:pt idx="261">
                  <c:v>0.6687000000000024</c:v>
                </c:pt>
                <c:pt idx="262">
                  <c:v>0.67711000000000154</c:v>
                </c:pt>
                <c:pt idx="263">
                  <c:v>0.68669000000000269</c:v>
                </c:pt>
                <c:pt idx="264">
                  <c:v>0.67721000000000064</c:v>
                </c:pt>
                <c:pt idx="265">
                  <c:v>0.64008000000000065</c:v>
                </c:pt>
                <c:pt idx="266">
                  <c:v>0.52876999999999996</c:v>
                </c:pt>
                <c:pt idx="267">
                  <c:v>0.42087000000000102</c:v>
                </c:pt>
                <c:pt idx="268">
                  <c:v>0.34223000000000026</c:v>
                </c:pt>
                <c:pt idx="269">
                  <c:v>0.31319000000000002</c:v>
                </c:pt>
                <c:pt idx="270">
                  <c:v>0.30577000000000032</c:v>
                </c:pt>
                <c:pt idx="271">
                  <c:v>0.30321000000000031</c:v>
                </c:pt>
                <c:pt idx="272">
                  <c:v>0.31081000000000114</c:v>
                </c:pt>
                <c:pt idx="273">
                  <c:v>0.30483000000000032</c:v>
                </c:pt>
                <c:pt idx="274">
                  <c:v>0.29827000000000031</c:v>
                </c:pt>
                <c:pt idx="275">
                  <c:v>0.30347000000000102</c:v>
                </c:pt>
                <c:pt idx="276">
                  <c:v>0.29099000000000008</c:v>
                </c:pt>
                <c:pt idx="277">
                  <c:v>0.28665000000000002</c:v>
                </c:pt>
                <c:pt idx="278">
                  <c:v>0.28460000000000002</c:v>
                </c:pt>
                <c:pt idx="279">
                  <c:v>0.28108000000000077</c:v>
                </c:pt>
                <c:pt idx="280">
                  <c:v>0.28868000000000038</c:v>
                </c:pt>
                <c:pt idx="281">
                  <c:v>0.2874800000000009</c:v>
                </c:pt>
                <c:pt idx="282">
                  <c:v>0.29117000000000032</c:v>
                </c:pt>
                <c:pt idx="283">
                  <c:v>0.29538000000000114</c:v>
                </c:pt>
                <c:pt idx="284">
                  <c:v>0.28151000000000032</c:v>
                </c:pt>
                <c:pt idx="285">
                  <c:v>0.28497000000000078</c:v>
                </c:pt>
                <c:pt idx="286">
                  <c:v>0.27576000000000001</c:v>
                </c:pt>
                <c:pt idx="287">
                  <c:v>0.27723000000000003</c:v>
                </c:pt>
                <c:pt idx="288">
                  <c:v>0.28569</c:v>
                </c:pt>
                <c:pt idx="289">
                  <c:v>0.27434000000000008</c:v>
                </c:pt>
                <c:pt idx="290">
                  <c:v>0.29518000000000078</c:v>
                </c:pt>
                <c:pt idx="291">
                  <c:v>0.27195000000000008</c:v>
                </c:pt>
                <c:pt idx="292">
                  <c:v>0.28250000000000008</c:v>
                </c:pt>
                <c:pt idx="293">
                  <c:v>0.30439000000000038</c:v>
                </c:pt>
                <c:pt idx="294">
                  <c:v>0.30599000000000032</c:v>
                </c:pt>
                <c:pt idx="295">
                  <c:v>0.32490000000000102</c:v>
                </c:pt>
                <c:pt idx="296">
                  <c:v>0.27800000000000002</c:v>
                </c:pt>
                <c:pt idx="297">
                  <c:v>0.28372000000000008</c:v>
                </c:pt>
                <c:pt idx="298">
                  <c:v>0.29684000000000038</c:v>
                </c:pt>
                <c:pt idx="299">
                  <c:v>0.33035000000000114</c:v>
                </c:pt>
                <c:pt idx="300">
                  <c:v>0.2839000000000003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E01B-4127-A621-24501A84C0B5}"/>
            </c:ext>
          </c:extLst>
        </c:ser>
        <c:ser>
          <c:idx val="3"/>
          <c:order val="3"/>
          <c:tx>
            <c:strRef>
              <c:f>Feuil1!$E$1</c:f>
              <c:strCache>
                <c:ptCount val="1"/>
                <c:pt idx="0">
                  <c:v>RB5 (25mg/L)+HBT+ Laccase</c:v>
                </c:pt>
              </c:strCache>
            </c:strRef>
          </c:tx>
          <c:spPr>
            <a:ln w="12700">
              <a:solidFill>
                <a:srgbClr val="FFCC00"/>
              </a:solidFill>
              <a:prstDash val="solid"/>
            </a:ln>
          </c:spPr>
          <c:marker>
            <c:symbol val="none"/>
          </c:marker>
          <c:xVal>
            <c:numRef>
              <c:f>Feuil1!$A$2:$A$302</c:f>
              <c:numCache>
                <c:formatCode>General</c:formatCode>
                <c:ptCount val="301"/>
                <c:pt idx="0">
                  <c:v>800</c:v>
                </c:pt>
                <c:pt idx="1">
                  <c:v>798</c:v>
                </c:pt>
                <c:pt idx="2">
                  <c:v>796</c:v>
                </c:pt>
                <c:pt idx="3">
                  <c:v>794</c:v>
                </c:pt>
                <c:pt idx="4">
                  <c:v>792</c:v>
                </c:pt>
                <c:pt idx="5">
                  <c:v>790</c:v>
                </c:pt>
                <c:pt idx="6">
                  <c:v>788</c:v>
                </c:pt>
                <c:pt idx="7">
                  <c:v>786</c:v>
                </c:pt>
                <c:pt idx="8">
                  <c:v>784</c:v>
                </c:pt>
                <c:pt idx="9">
                  <c:v>782</c:v>
                </c:pt>
                <c:pt idx="10">
                  <c:v>780</c:v>
                </c:pt>
                <c:pt idx="11">
                  <c:v>778</c:v>
                </c:pt>
                <c:pt idx="12">
                  <c:v>776</c:v>
                </c:pt>
                <c:pt idx="13">
                  <c:v>774</c:v>
                </c:pt>
                <c:pt idx="14">
                  <c:v>772</c:v>
                </c:pt>
                <c:pt idx="15">
                  <c:v>770</c:v>
                </c:pt>
                <c:pt idx="16">
                  <c:v>768</c:v>
                </c:pt>
                <c:pt idx="17">
                  <c:v>766</c:v>
                </c:pt>
                <c:pt idx="18">
                  <c:v>764</c:v>
                </c:pt>
                <c:pt idx="19">
                  <c:v>762</c:v>
                </c:pt>
                <c:pt idx="20">
                  <c:v>760</c:v>
                </c:pt>
                <c:pt idx="21">
                  <c:v>758</c:v>
                </c:pt>
                <c:pt idx="22">
                  <c:v>756</c:v>
                </c:pt>
                <c:pt idx="23">
                  <c:v>754</c:v>
                </c:pt>
                <c:pt idx="24">
                  <c:v>752</c:v>
                </c:pt>
                <c:pt idx="25">
                  <c:v>750</c:v>
                </c:pt>
                <c:pt idx="26">
                  <c:v>748</c:v>
                </c:pt>
                <c:pt idx="27">
                  <c:v>746</c:v>
                </c:pt>
                <c:pt idx="28">
                  <c:v>744</c:v>
                </c:pt>
                <c:pt idx="29">
                  <c:v>742</c:v>
                </c:pt>
                <c:pt idx="30">
                  <c:v>740</c:v>
                </c:pt>
                <c:pt idx="31">
                  <c:v>738</c:v>
                </c:pt>
                <c:pt idx="32">
                  <c:v>736</c:v>
                </c:pt>
                <c:pt idx="33">
                  <c:v>734</c:v>
                </c:pt>
                <c:pt idx="34">
                  <c:v>732</c:v>
                </c:pt>
                <c:pt idx="35">
                  <c:v>730</c:v>
                </c:pt>
                <c:pt idx="36">
                  <c:v>728</c:v>
                </c:pt>
                <c:pt idx="37">
                  <c:v>726</c:v>
                </c:pt>
                <c:pt idx="38">
                  <c:v>724</c:v>
                </c:pt>
                <c:pt idx="39">
                  <c:v>722</c:v>
                </c:pt>
                <c:pt idx="40">
                  <c:v>720</c:v>
                </c:pt>
                <c:pt idx="41">
                  <c:v>718</c:v>
                </c:pt>
                <c:pt idx="42">
                  <c:v>716</c:v>
                </c:pt>
                <c:pt idx="43">
                  <c:v>714</c:v>
                </c:pt>
                <c:pt idx="44">
                  <c:v>712</c:v>
                </c:pt>
                <c:pt idx="45">
                  <c:v>710</c:v>
                </c:pt>
                <c:pt idx="46">
                  <c:v>708</c:v>
                </c:pt>
                <c:pt idx="47">
                  <c:v>706</c:v>
                </c:pt>
                <c:pt idx="48">
                  <c:v>704</c:v>
                </c:pt>
                <c:pt idx="49">
                  <c:v>702</c:v>
                </c:pt>
                <c:pt idx="50">
                  <c:v>700</c:v>
                </c:pt>
                <c:pt idx="51">
                  <c:v>698</c:v>
                </c:pt>
                <c:pt idx="52">
                  <c:v>696</c:v>
                </c:pt>
                <c:pt idx="53">
                  <c:v>694</c:v>
                </c:pt>
                <c:pt idx="54">
                  <c:v>692</c:v>
                </c:pt>
                <c:pt idx="55">
                  <c:v>690</c:v>
                </c:pt>
                <c:pt idx="56">
                  <c:v>688</c:v>
                </c:pt>
                <c:pt idx="57">
                  <c:v>686</c:v>
                </c:pt>
                <c:pt idx="58">
                  <c:v>684</c:v>
                </c:pt>
                <c:pt idx="59">
                  <c:v>682</c:v>
                </c:pt>
                <c:pt idx="60">
                  <c:v>680</c:v>
                </c:pt>
                <c:pt idx="61">
                  <c:v>678</c:v>
                </c:pt>
                <c:pt idx="62">
                  <c:v>676</c:v>
                </c:pt>
                <c:pt idx="63">
                  <c:v>674</c:v>
                </c:pt>
                <c:pt idx="64">
                  <c:v>672</c:v>
                </c:pt>
                <c:pt idx="65">
                  <c:v>670</c:v>
                </c:pt>
                <c:pt idx="66">
                  <c:v>668</c:v>
                </c:pt>
                <c:pt idx="67">
                  <c:v>666</c:v>
                </c:pt>
                <c:pt idx="68">
                  <c:v>664</c:v>
                </c:pt>
                <c:pt idx="69">
                  <c:v>662</c:v>
                </c:pt>
                <c:pt idx="70">
                  <c:v>660</c:v>
                </c:pt>
                <c:pt idx="71">
                  <c:v>658</c:v>
                </c:pt>
                <c:pt idx="72">
                  <c:v>656</c:v>
                </c:pt>
                <c:pt idx="73">
                  <c:v>654</c:v>
                </c:pt>
                <c:pt idx="74">
                  <c:v>652</c:v>
                </c:pt>
                <c:pt idx="75">
                  <c:v>650</c:v>
                </c:pt>
                <c:pt idx="76">
                  <c:v>648</c:v>
                </c:pt>
                <c:pt idx="77">
                  <c:v>646</c:v>
                </c:pt>
                <c:pt idx="78">
                  <c:v>644</c:v>
                </c:pt>
                <c:pt idx="79">
                  <c:v>642</c:v>
                </c:pt>
                <c:pt idx="80">
                  <c:v>640</c:v>
                </c:pt>
                <c:pt idx="81">
                  <c:v>638</c:v>
                </c:pt>
                <c:pt idx="82">
                  <c:v>636</c:v>
                </c:pt>
                <c:pt idx="83">
                  <c:v>634</c:v>
                </c:pt>
                <c:pt idx="84">
                  <c:v>632</c:v>
                </c:pt>
                <c:pt idx="85">
                  <c:v>630</c:v>
                </c:pt>
                <c:pt idx="86">
                  <c:v>628</c:v>
                </c:pt>
                <c:pt idx="87">
                  <c:v>626</c:v>
                </c:pt>
                <c:pt idx="88">
                  <c:v>624</c:v>
                </c:pt>
                <c:pt idx="89">
                  <c:v>622</c:v>
                </c:pt>
                <c:pt idx="90">
                  <c:v>620</c:v>
                </c:pt>
                <c:pt idx="91">
                  <c:v>618</c:v>
                </c:pt>
                <c:pt idx="92">
                  <c:v>616</c:v>
                </c:pt>
                <c:pt idx="93">
                  <c:v>614</c:v>
                </c:pt>
                <c:pt idx="94">
                  <c:v>612</c:v>
                </c:pt>
                <c:pt idx="95">
                  <c:v>610</c:v>
                </c:pt>
                <c:pt idx="96">
                  <c:v>608</c:v>
                </c:pt>
                <c:pt idx="97">
                  <c:v>606</c:v>
                </c:pt>
                <c:pt idx="98">
                  <c:v>604</c:v>
                </c:pt>
                <c:pt idx="99">
                  <c:v>602</c:v>
                </c:pt>
                <c:pt idx="100">
                  <c:v>600</c:v>
                </c:pt>
                <c:pt idx="101">
                  <c:v>598</c:v>
                </c:pt>
                <c:pt idx="102">
                  <c:v>596</c:v>
                </c:pt>
                <c:pt idx="103">
                  <c:v>594</c:v>
                </c:pt>
                <c:pt idx="104">
                  <c:v>592</c:v>
                </c:pt>
                <c:pt idx="105">
                  <c:v>590</c:v>
                </c:pt>
                <c:pt idx="106">
                  <c:v>588</c:v>
                </c:pt>
                <c:pt idx="107">
                  <c:v>586</c:v>
                </c:pt>
                <c:pt idx="108">
                  <c:v>584</c:v>
                </c:pt>
                <c:pt idx="109">
                  <c:v>582</c:v>
                </c:pt>
                <c:pt idx="110">
                  <c:v>580</c:v>
                </c:pt>
                <c:pt idx="111">
                  <c:v>578</c:v>
                </c:pt>
                <c:pt idx="112">
                  <c:v>576</c:v>
                </c:pt>
                <c:pt idx="113">
                  <c:v>574</c:v>
                </c:pt>
                <c:pt idx="114">
                  <c:v>572</c:v>
                </c:pt>
                <c:pt idx="115">
                  <c:v>570</c:v>
                </c:pt>
                <c:pt idx="116">
                  <c:v>568</c:v>
                </c:pt>
                <c:pt idx="117">
                  <c:v>566</c:v>
                </c:pt>
                <c:pt idx="118">
                  <c:v>564</c:v>
                </c:pt>
                <c:pt idx="119">
                  <c:v>562</c:v>
                </c:pt>
                <c:pt idx="120">
                  <c:v>560</c:v>
                </c:pt>
                <c:pt idx="121">
                  <c:v>558</c:v>
                </c:pt>
                <c:pt idx="122">
                  <c:v>556</c:v>
                </c:pt>
                <c:pt idx="123">
                  <c:v>554</c:v>
                </c:pt>
                <c:pt idx="124">
                  <c:v>552</c:v>
                </c:pt>
                <c:pt idx="125">
                  <c:v>550</c:v>
                </c:pt>
                <c:pt idx="126">
                  <c:v>548</c:v>
                </c:pt>
                <c:pt idx="127">
                  <c:v>546</c:v>
                </c:pt>
                <c:pt idx="128">
                  <c:v>544</c:v>
                </c:pt>
                <c:pt idx="129">
                  <c:v>542</c:v>
                </c:pt>
                <c:pt idx="130">
                  <c:v>540</c:v>
                </c:pt>
                <c:pt idx="131">
                  <c:v>538</c:v>
                </c:pt>
                <c:pt idx="132">
                  <c:v>536</c:v>
                </c:pt>
                <c:pt idx="133">
                  <c:v>534</c:v>
                </c:pt>
                <c:pt idx="134">
                  <c:v>532</c:v>
                </c:pt>
                <c:pt idx="135">
                  <c:v>530</c:v>
                </c:pt>
                <c:pt idx="136">
                  <c:v>528</c:v>
                </c:pt>
                <c:pt idx="137">
                  <c:v>526</c:v>
                </c:pt>
                <c:pt idx="138">
                  <c:v>524</c:v>
                </c:pt>
                <c:pt idx="139">
                  <c:v>522</c:v>
                </c:pt>
                <c:pt idx="140">
                  <c:v>520</c:v>
                </c:pt>
                <c:pt idx="141">
                  <c:v>518</c:v>
                </c:pt>
                <c:pt idx="142">
                  <c:v>516</c:v>
                </c:pt>
                <c:pt idx="143">
                  <c:v>514</c:v>
                </c:pt>
                <c:pt idx="144">
                  <c:v>512</c:v>
                </c:pt>
                <c:pt idx="145">
                  <c:v>510</c:v>
                </c:pt>
                <c:pt idx="146">
                  <c:v>508</c:v>
                </c:pt>
                <c:pt idx="147">
                  <c:v>506</c:v>
                </c:pt>
                <c:pt idx="148">
                  <c:v>504</c:v>
                </c:pt>
                <c:pt idx="149">
                  <c:v>502</c:v>
                </c:pt>
                <c:pt idx="150">
                  <c:v>500</c:v>
                </c:pt>
                <c:pt idx="151">
                  <c:v>498</c:v>
                </c:pt>
                <c:pt idx="152">
                  <c:v>496</c:v>
                </c:pt>
                <c:pt idx="153">
                  <c:v>494</c:v>
                </c:pt>
                <c:pt idx="154">
                  <c:v>492</c:v>
                </c:pt>
                <c:pt idx="155">
                  <c:v>490</c:v>
                </c:pt>
                <c:pt idx="156">
                  <c:v>488</c:v>
                </c:pt>
                <c:pt idx="157">
                  <c:v>486</c:v>
                </c:pt>
                <c:pt idx="158">
                  <c:v>484</c:v>
                </c:pt>
                <c:pt idx="159">
                  <c:v>482</c:v>
                </c:pt>
                <c:pt idx="160">
                  <c:v>480</c:v>
                </c:pt>
                <c:pt idx="161">
                  <c:v>478</c:v>
                </c:pt>
                <c:pt idx="162">
                  <c:v>476</c:v>
                </c:pt>
                <c:pt idx="163">
                  <c:v>474</c:v>
                </c:pt>
                <c:pt idx="164">
                  <c:v>472</c:v>
                </c:pt>
                <c:pt idx="165">
                  <c:v>470</c:v>
                </c:pt>
                <c:pt idx="166">
                  <c:v>468</c:v>
                </c:pt>
                <c:pt idx="167">
                  <c:v>466</c:v>
                </c:pt>
                <c:pt idx="168">
                  <c:v>464</c:v>
                </c:pt>
                <c:pt idx="169">
                  <c:v>462</c:v>
                </c:pt>
                <c:pt idx="170">
                  <c:v>460</c:v>
                </c:pt>
                <c:pt idx="171">
                  <c:v>458</c:v>
                </c:pt>
                <c:pt idx="172">
                  <c:v>456</c:v>
                </c:pt>
                <c:pt idx="173">
                  <c:v>454</c:v>
                </c:pt>
                <c:pt idx="174">
                  <c:v>452</c:v>
                </c:pt>
                <c:pt idx="175">
                  <c:v>450</c:v>
                </c:pt>
                <c:pt idx="176">
                  <c:v>448</c:v>
                </c:pt>
                <c:pt idx="177">
                  <c:v>446</c:v>
                </c:pt>
                <c:pt idx="178">
                  <c:v>444</c:v>
                </c:pt>
                <c:pt idx="179">
                  <c:v>442</c:v>
                </c:pt>
                <c:pt idx="180">
                  <c:v>440</c:v>
                </c:pt>
                <c:pt idx="181">
                  <c:v>438</c:v>
                </c:pt>
                <c:pt idx="182">
                  <c:v>436</c:v>
                </c:pt>
                <c:pt idx="183">
                  <c:v>434</c:v>
                </c:pt>
                <c:pt idx="184">
                  <c:v>432</c:v>
                </c:pt>
                <c:pt idx="185">
                  <c:v>430</c:v>
                </c:pt>
                <c:pt idx="186">
                  <c:v>428</c:v>
                </c:pt>
                <c:pt idx="187">
                  <c:v>426</c:v>
                </c:pt>
                <c:pt idx="188">
                  <c:v>424</c:v>
                </c:pt>
                <c:pt idx="189">
                  <c:v>422</c:v>
                </c:pt>
                <c:pt idx="190">
                  <c:v>420</c:v>
                </c:pt>
                <c:pt idx="191">
                  <c:v>418</c:v>
                </c:pt>
                <c:pt idx="192">
                  <c:v>416</c:v>
                </c:pt>
                <c:pt idx="193">
                  <c:v>414</c:v>
                </c:pt>
                <c:pt idx="194">
                  <c:v>412</c:v>
                </c:pt>
                <c:pt idx="195">
                  <c:v>410</c:v>
                </c:pt>
                <c:pt idx="196">
                  <c:v>408</c:v>
                </c:pt>
                <c:pt idx="197">
                  <c:v>406</c:v>
                </c:pt>
                <c:pt idx="198">
                  <c:v>404</c:v>
                </c:pt>
                <c:pt idx="199">
                  <c:v>402</c:v>
                </c:pt>
                <c:pt idx="200">
                  <c:v>400</c:v>
                </c:pt>
                <c:pt idx="201">
                  <c:v>398</c:v>
                </c:pt>
                <c:pt idx="202">
                  <c:v>396</c:v>
                </c:pt>
                <c:pt idx="203">
                  <c:v>394</c:v>
                </c:pt>
                <c:pt idx="204">
                  <c:v>392</c:v>
                </c:pt>
                <c:pt idx="205">
                  <c:v>390</c:v>
                </c:pt>
                <c:pt idx="206">
                  <c:v>388</c:v>
                </c:pt>
                <c:pt idx="207">
                  <c:v>386</c:v>
                </c:pt>
                <c:pt idx="208">
                  <c:v>384</c:v>
                </c:pt>
                <c:pt idx="209">
                  <c:v>382</c:v>
                </c:pt>
                <c:pt idx="210">
                  <c:v>380</c:v>
                </c:pt>
                <c:pt idx="211">
                  <c:v>378</c:v>
                </c:pt>
                <c:pt idx="212">
                  <c:v>376</c:v>
                </c:pt>
                <c:pt idx="213">
                  <c:v>374</c:v>
                </c:pt>
                <c:pt idx="214">
                  <c:v>372</c:v>
                </c:pt>
                <c:pt idx="215">
                  <c:v>370</c:v>
                </c:pt>
                <c:pt idx="216">
                  <c:v>368</c:v>
                </c:pt>
                <c:pt idx="217">
                  <c:v>366</c:v>
                </c:pt>
                <c:pt idx="218">
                  <c:v>364</c:v>
                </c:pt>
                <c:pt idx="219">
                  <c:v>362</c:v>
                </c:pt>
                <c:pt idx="220">
                  <c:v>360</c:v>
                </c:pt>
                <c:pt idx="221">
                  <c:v>358</c:v>
                </c:pt>
                <c:pt idx="222">
                  <c:v>356</c:v>
                </c:pt>
                <c:pt idx="223">
                  <c:v>354</c:v>
                </c:pt>
                <c:pt idx="224">
                  <c:v>352</c:v>
                </c:pt>
                <c:pt idx="225">
                  <c:v>350</c:v>
                </c:pt>
                <c:pt idx="226">
                  <c:v>348</c:v>
                </c:pt>
                <c:pt idx="227">
                  <c:v>346</c:v>
                </c:pt>
                <c:pt idx="228">
                  <c:v>344</c:v>
                </c:pt>
                <c:pt idx="229">
                  <c:v>342</c:v>
                </c:pt>
                <c:pt idx="230">
                  <c:v>340</c:v>
                </c:pt>
                <c:pt idx="231">
                  <c:v>338</c:v>
                </c:pt>
                <c:pt idx="232">
                  <c:v>336</c:v>
                </c:pt>
                <c:pt idx="233">
                  <c:v>334</c:v>
                </c:pt>
                <c:pt idx="234">
                  <c:v>332</c:v>
                </c:pt>
                <c:pt idx="235">
                  <c:v>330</c:v>
                </c:pt>
                <c:pt idx="236">
                  <c:v>328</c:v>
                </c:pt>
                <c:pt idx="237">
                  <c:v>326</c:v>
                </c:pt>
                <c:pt idx="238">
                  <c:v>324</c:v>
                </c:pt>
                <c:pt idx="239">
                  <c:v>322</c:v>
                </c:pt>
                <c:pt idx="240">
                  <c:v>320</c:v>
                </c:pt>
                <c:pt idx="241">
                  <c:v>318</c:v>
                </c:pt>
                <c:pt idx="242">
                  <c:v>316</c:v>
                </c:pt>
                <c:pt idx="243">
                  <c:v>314</c:v>
                </c:pt>
                <c:pt idx="244">
                  <c:v>312</c:v>
                </c:pt>
                <c:pt idx="245">
                  <c:v>310</c:v>
                </c:pt>
                <c:pt idx="246">
                  <c:v>308</c:v>
                </c:pt>
                <c:pt idx="247">
                  <c:v>306</c:v>
                </c:pt>
                <c:pt idx="248">
                  <c:v>304</c:v>
                </c:pt>
                <c:pt idx="249">
                  <c:v>302</c:v>
                </c:pt>
                <c:pt idx="250">
                  <c:v>300</c:v>
                </c:pt>
                <c:pt idx="251">
                  <c:v>298</c:v>
                </c:pt>
                <c:pt idx="252">
                  <c:v>296</c:v>
                </c:pt>
                <c:pt idx="253">
                  <c:v>294</c:v>
                </c:pt>
                <c:pt idx="254">
                  <c:v>292</c:v>
                </c:pt>
                <c:pt idx="255">
                  <c:v>290</c:v>
                </c:pt>
                <c:pt idx="256">
                  <c:v>288</c:v>
                </c:pt>
                <c:pt idx="257">
                  <c:v>286</c:v>
                </c:pt>
                <c:pt idx="258">
                  <c:v>284</c:v>
                </c:pt>
                <c:pt idx="259">
                  <c:v>282</c:v>
                </c:pt>
                <c:pt idx="260">
                  <c:v>280</c:v>
                </c:pt>
                <c:pt idx="261">
                  <c:v>278</c:v>
                </c:pt>
                <c:pt idx="262">
                  <c:v>276</c:v>
                </c:pt>
                <c:pt idx="263">
                  <c:v>274</c:v>
                </c:pt>
                <c:pt idx="264">
                  <c:v>272</c:v>
                </c:pt>
                <c:pt idx="265">
                  <c:v>270</c:v>
                </c:pt>
                <c:pt idx="266">
                  <c:v>268</c:v>
                </c:pt>
                <c:pt idx="267">
                  <c:v>266</c:v>
                </c:pt>
                <c:pt idx="268">
                  <c:v>264</c:v>
                </c:pt>
                <c:pt idx="269">
                  <c:v>262</c:v>
                </c:pt>
                <c:pt idx="270">
                  <c:v>260</c:v>
                </c:pt>
                <c:pt idx="271">
                  <c:v>258</c:v>
                </c:pt>
                <c:pt idx="272">
                  <c:v>256</c:v>
                </c:pt>
                <c:pt idx="273">
                  <c:v>254</c:v>
                </c:pt>
                <c:pt idx="274">
                  <c:v>252</c:v>
                </c:pt>
                <c:pt idx="275">
                  <c:v>250</c:v>
                </c:pt>
                <c:pt idx="276">
                  <c:v>248</c:v>
                </c:pt>
                <c:pt idx="277">
                  <c:v>246</c:v>
                </c:pt>
                <c:pt idx="278">
                  <c:v>244</c:v>
                </c:pt>
                <c:pt idx="279">
                  <c:v>242</c:v>
                </c:pt>
                <c:pt idx="280">
                  <c:v>240</c:v>
                </c:pt>
                <c:pt idx="281">
                  <c:v>238</c:v>
                </c:pt>
                <c:pt idx="282">
                  <c:v>236</c:v>
                </c:pt>
                <c:pt idx="283">
                  <c:v>234</c:v>
                </c:pt>
                <c:pt idx="284">
                  <c:v>232</c:v>
                </c:pt>
                <c:pt idx="285">
                  <c:v>230</c:v>
                </c:pt>
                <c:pt idx="286">
                  <c:v>228</c:v>
                </c:pt>
                <c:pt idx="287">
                  <c:v>226</c:v>
                </c:pt>
                <c:pt idx="288">
                  <c:v>224</c:v>
                </c:pt>
                <c:pt idx="289">
                  <c:v>222</c:v>
                </c:pt>
                <c:pt idx="290">
                  <c:v>220</c:v>
                </c:pt>
                <c:pt idx="291">
                  <c:v>218</c:v>
                </c:pt>
                <c:pt idx="292">
                  <c:v>216</c:v>
                </c:pt>
                <c:pt idx="293">
                  <c:v>214</c:v>
                </c:pt>
                <c:pt idx="294">
                  <c:v>212</c:v>
                </c:pt>
                <c:pt idx="295">
                  <c:v>210</c:v>
                </c:pt>
                <c:pt idx="296">
                  <c:v>208</c:v>
                </c:pt>
                <c:pt idx="297">
                  <c:v>206</c:v>
                </c:pt>
                <c:pt idx="298">
                  <c:v>204</c:v>
                </c:pt>
                <c:pt idx="299">
                  <c:v>202</c:v>
                </c:pt>
                <c:pt idx="300">
                  <c:v>200</c:v>
                </c:pt>
              </c:numCache>
            </c:numRef>
          </c:xVal>
          <c:yVal>
            <c:numRef>
              <c:f>Feuil1!$E$2:$E$302</c:f>
              <c:numCache>
                <c:formatCode>General</c:formatCode>
                <c:ptCount val="301"/>
                <c:pt idx="0">
                  <c:v>1.0570000000000001E-2</c:v>
                </c:pt>
                <c:pt idx="1">
                  <c:v>7.0200000000000132E-3</c:v>
                </c:pt>
                <c:pt idx="2">
                  <c:v>7.2200000000000163E-3</c:v>
                </c:pt>
                <c:pt idx="3">
                  <c:v>4.8400000000000101E-3</c:v>
                </c:pt>
                <c:pt idx="4">
                  <c:v>9.7000000000000142E-3</c:v>
                </c:pt>
                <c:pt idx="5">
                  <c:v>8.6200000000000027E-3</c:v>
                </c:pt>
                <c:pt idx="6">
                  <c:v>6.7600000000000151E-3</c:v>
                </c:pt>
                <c:pt idx="7">
                  <c:v>6.4100000000000172E-3</c:v>
                </c:pt>
                <c:pt idx="8">
                  <c:v>8.3500000000000379E-3</c:v>
                </c:pt>
                <c:pt idx="9">
                  <c:v>1.3120000000000041E-2</c:v>
                </c:pt>
                <c:pt idx="10">
                  <c:v>6.7300000000000233E-3</c:v>
                </c:pt>
                <c:pt idx="11">
                  <c:v>4.0300000000000136E-3</c:v>
                </c:pt>
                <c:pt idx="12">
                  <c:v>2.7800000000000112E-3</c:v>
                </c:pt>
                <c:pt idx="13">
                  <c:v>3.4000000000000081E-3</c:v>
                </c:pt>
                <c:pt idx="14">
                  <c:v>6.8900000000000124E-3</c:v>
                </c:pt>
                <c:pt idx="15">
                  <c:v>5.6400000000000113E-3</c:v>
                </c:pt>
                <c:pt idx="16">
                  <c:v>1.1410000000000028E-2</c:v>
                </c:pt>
                <c:pt idx="17">
                  <c:v>1.282000000000004E-2</c:v>
                </c:pt>
                <c:pt idx="18">
                  <c:v>4.3600000000000002E-3</c:v>
                </c:pt>
                <c:pt idx="19">
                  <c:v>1.2690000000000003E-2</c:v>
                </c:pt>
                <c:pt idx="20">
                  <c:v>6.040000000000015E-3</c:v>
                </c:pt>
                <c:pt idx="21">
                  <c:v>1.0040000000000021E-2</c:v>
                </c:pt>
                <c:pt idx="22">
                  <c:v>6.6500000000000101E-3</c:v>
                </c:pt>
                <c:pt idx="23">
                  <c:v>7.0400000000000185E-3</c:v>
                </c:pt>
                <c:pt idx="24">
                  <c:v>1.5230000000000021E-2</c:v>
                </c:pt>
                <c:pt idx="25">
                  <c:v>9.2000000000000068E-3</c:v>
                </c:pt>
                <c:pt idx="26">
                  <c:v>1.4780000000000031E-2</c:v>
                </c:pt>
                <c:pt idx="27">
                  <c:v>1.1390000000000029E-2</c:v>
                </c:pt>
                <c:pt idx="28">
                  <c:v>9.5300000000000194E-3</c:v>
                </c:pt>
                <c:pt idx="29">
                  <c:v>1.0359999999999998E-2</c:v>
                </c:pt>
                <c:pt idx="30">
                  <c:v>1.3700000000000054E-2</c:v>
                </c:pt>
                <c:pt idx="31">
                  <c:v>7.7700000000000269E-3</c:v>
                </c:pt>
                <c:pt idx="32">
                  <c:v>9.4600000000000396E-3</c:v>
                </c:pt>
                <c:pt idx="33">
                  <c:v>1.3820000000000056E-2</c:v>
                </c:pt>
                <c:pt idx="34">
                  <c:v>1.3210000000000001E-2</c:v>
                </c:pt>
                <c:pt idx="35">
                  <c:v>1.3890000000000034E-2</c:v>
                </c:pt>
                <c:pt idx="36">
                  <c:v>1.5570000000000025E-2</c:v>
                </c:pt>
                <c:pt idx="37">
                  <c:v>1.3169999999999999E-2</c:v>
                </c:pt>
                <c:pt idx="38">
                  <c:v>1.3050000000000023E-2</c:v>
                </c:pt>
                <c:pt idx="39">
                  <c:v>1.2000000000000021E-2</c:v>
                </c:pt>
                <c:pt idx="40">
                  <c:v>1.3020000000000047E-2</c:v>
                </c:pt>
                <c:pt idx="41">
                  <c:v>1.4440000000000001E-2</c:v>
                </c:pt>
                <c:pt idx="42">
                  <c:v>1.1299999999999998E-2</c:v>
                </c:pt>
                <c:pt idx="43">
                  <c:v>9.9900000000000266E-3</c:v>
                </c:pt>
                <c:pt idx="44">
                  <c:v>1.1330000000000031E-2</c:v>
                </c:pt>
                <c:pt idx="45">
                  <c:v>1.5920000000000049E-2</c:v>
                </c:pt>
                <c:pt idx="46">
                  <c:v>1.8860000000000054E-2</c:v>
                </c:pt>
                <c:pt idx="47">
                  <c:v>1.3050000000000023E-2</c:v>
                </c:pt>
                <c:pt idx="48">
                  <c:v>1.5480000000000042E-2</c:v>
                </c:pt>
                <c:pt idx="49">
                  <c:v>1.8960000000000067E-2</c:v>
                </c:pt>
                <c:pt idx="50">
                  <c:v>1.9019999999999999E-2</c:v>
                </c:pt>
                <c:pt idx="51">
                  <c:v>1.7140000000000041E-2</c:v>
                </c:pt>
                <c:pt idx="52">
                  <c:v>1.8610000000000043E-2</c:v>
                </c:pt>
                <c:pt idx="53">
                  <c:v>1.9830000000000052E-2</c:v>
                </c:pt>
                <c:pt idx="54">
                  <c:v>2.204000000000008E-2</c:v>
                </c:pt>
                <c:pt idx="55">
                  <c:v>1.8489999999999999E-2</c:v>
                </c:pt>
                <c:pt idx="56">
                  <c:v>2.1759999999999998E-2</c:v>
                </c:pt>
                <c:pt idx="57">
                  <c:v>1.9810000000000046E-2</c:v>
                </c:pt>
                <c:pt idx="58">
                  <c:v>2.0650000000000012E-2</c:v>
                </c:pt>
                <c:pt idx="59">
                  <c:v>2.0000000000000052E-2</c:v>
                </c:pt>
                <c:pt idx="60">
                  <c:v>2.4290000000000006E-2</c:v>
                </c:pt>
                <c:pt idx="61">
                  <c:v>2.4840000000000053E-2</c:v>
                </c:pt>
                <c:pt idx="62">
                  <c:v>2.1850000000000053E-2</c:v>
                </c:pt>
                <c:pt idx="63">
                  <c:v>2.7100000000000055E-2</c:v>
                </c:pt>
                <c:pt idx="64">
                  <c:v>2.6260000000000009E-2</c:v>
                </c:pt>
                <c:pt idx="65">
                  <c:v>2.9690000000000043E-2</c:v>
                </c:pt>
                <c:pt idx="66">
                  <c:v>3.176000000000001E-2</c:v>
                </c:pt>
                <c:pt idx="67">
                  <c:v>3.2180000000000084E-2</c:v>
                </c:pt>
                <c:pt idx="68">
                  <c:v>3.4630000000000091E-2</c:v>
                </c:pt>
                <c:pt idx="69">
                  <c:v>2.9509999999999998E-2</c:v>
                </c:pt>
                <c:pt idx="70">
                  <c:v>3.2310000000000012E-2</c:v>
                </c:pt>
                <c:pt idx="71">
                  <c:v>3.2740000000000012E-2</c:v>
                </c:pt>
                <c:pt idx="72">
                  <c:v>3.6020000000000052E-2</c:v>
                </c:pt>
                <c:pt idx="73">
                  <c:v>3.8390000000000001E-2</c:v>
                </c:pt>
                <c:pt idx="74">
                  <c:v>4.0960000000000024E-2</c:v>
                </c:pt>
                <c:pt idx="75">
                  <c:v>4.0349999999999997E-2</c:v>
                </c:pt>
                <c:pt idx="76">
                  <c:v>4.2110000000000126E-2</c:v>
                </c:pt>
                <c:pt idx="77">
                  <c:v>4.6269999999999985E-2</c:v>
                </c:pt>
                <c:pt idx="78">
                  <c:v>4.7610000000000034E-2</c:v>
                </c:pt>
                <c:pt idx="79">
                  <c:v>4.9700000000000182E-2</c:v>
                </c:pt>
                <c:pt idx="80">
                  <c:v>5.1729999999999998E-2</c:v>
                </c:pt>
                <c:pt idx="81">
                  <c:v>5.3890000000000132E-2</c:v>
                </c:pt>
                <c:pt idx="82">
                  <c:v>5.5720000000000124E-2</c:v>
                </c:pt>
                <c:pt idx="83">
                  <c:v>5.7720000000000139E-2</c:v>
                </c:pt>
                <c:pt idx="84">
                  <c:v>6.3740000000000033E-2</c:v>
                </c:pt>
                <c:pt idx="85">
                  <c:v>6.1190000000000105E-2</c:v>
                </c:pt>
                <c:pt idx="86">
                  <c:v>6.6890000000000144E-2</c:v>
                </c:pt>
                <c:pt idx="87">
                  <c:v>7.2370000000000184E-2</c:v>
                </c:pt>
                <c:pt idx="88">
                  <c:v>7.4450000000000183E-2</c:v>
                </c:pt>
                <c:pt idx="89">
                  <c:v>7.6490000000000155E-2</c:v>
                </c:pt>
                <c:pt idx="90">
                  <c:v>7.6860000000000137E-2</c:v>
                </c:pt>
                <c:pt idx="91">
                  <c:v>8.1140000000000004E-2</c:v>
                </c:pt>
                <c:pt idx="92">
                  <c:v>8.3610000000000267E-2</c:v>
                </c:pt>
                <c:pt idx="93">
                  <c:v>9.0260000000000062E-2</c:v>
                </c:pt>
                <c:pt idx="94">
                  <c:v>9.2610000000000026E-2</c:v>
                </c:pt>
                <c:pt idx="95">
                  <c:v>9.540000000000004E-2</c:v>
                </c:pt>
                <c:pt idx="96">
                  <c:v>9.8230000000000248E-2</c:v>
                </c:pt>
                <c:pt idx="97">
                  <c:v>0.10353999999999998</c:v>
                </c:pt>
                <c:pt idx="98">
                  <c:v>0.10476000000000024</c:v>
                </c:pt>
                <c:pt idx="99">
                  <c:v>0.11249000000000016</c:v>
                </c:pt>
                <c:pt idx="100">
                  <c:v>0.11362000000000023</c:v>
                </c:pt>
                <c:pt idx="101">
                  <c:v>0.12112000000000023</c:v>
                </c:pt>
                <c:pt idx="102">
                  <c:v>0.12411000000000012</c:v>
                </c:pt>
                <c:pt idx="103">
                  <c:v>0.12825</c:v>
                </c:pt>
                <c:pt idx="104">
                  <c:v>0.13097</c:v>
                </c:pt>
                <c:pt idx="105">
                  <c:v>0.13574000000000042</c:v>
                </c:pt>
                <c:pt idx="106">
                  <c:v>0.14607999999999999</c:v>
                </c:pt>
                <c:pt idx="107">
                  <c:v>0.15001000000000048</c:v>
                </c:pt>
                <c:pt idx="108">
                  <c:v>0.15325000000000039</c:v>
                </c:pt>
                <c:pt idx="109">
                  <c:v>0.15725000000000042</c:v>
                </c:pt>
                <c:pt idx="110">
                  <c:v>0.16309000000000035</c:v>
                </c:pt>
                <c:pt idx="111">
                  <c:v>0.17079000000000039</c:v>
                </c:pt>
                <c:pt idx="112">
                  <c:v>0.17423000000000038</c:v>
                </c:pt>
                <c:pt idx="113">
                  <c:v>0.18044000000000063</c:v>
                </c:pt>
                <c:pt idx="114">
                  <c:v>0.18571000000000051</c:v>
                </c:pt>
                <c:pt idx="115">
                  <c:v>0.18923000000000048</c:v>
                </c:pt>
                <c:pt idx="116">
                  <c:v>0.19660000000000019</c:v>
                </c:pt>
                <c:pt idx="117">
                  <c:v>0.20000999999999999</c:v>
                </c:pt>
                <c:pt idx="118">
                  <c:v>0.20435</c:v>
                </c:pt>
                <c:pt idx="119">
                  <c:v>0.21190000000000048</c:v>
                </c:pt>
                <c:pt idx="120">
                  <c:v>0.21528000000000042</c:v>
                </c:pt>
                <c:pt idx="121">
                  <c:v>0.22119000000000019</c:v>
                </c:pt>
                <c:pt idx="122">
                  <c:v>0.22663000000000019</c:v>
                </c:pt>
                <c:pt idx="123">
                  <c:v>0.23149000000000042</c:v>
                </c:pt>
                <c:pt idx="124">
                  <c:v>0.23704000000000042</c:v>
                </c:pt>
                <c:pt idx="125">
                  <c:v>0.24522000000000024</c:v>
                </c:pt>
                <c:pt idx="126">
                  <c:v>0.24915000000000001</c:v>
                </c:pt>
                <c:pt idx="127">
                  <c:v>0.25365000000000004</c:v>
                </c:pt>
                <c:pt idx="128">
                  <c:v>0.25945000000000001</c:v>
                </c:pt>
                <c:pt idx="129">
                  <c:v>0.26529000000000003</c:v>
                </c:pt>
                <c:pt idx="130">
                  <c:v>0.27093</c:v>
                </c:pt>
                <c:pt idx="131">
                  <c:v>0.27762000000000031</c:v>
                </c:pt>
                <c:pt idx="132">
                  <c:v>0.28331000000000089</c:v>
                </c:pt>
                <c:pt idx="133">
                  <c:v>0.29009000000000001</c:v>
                </c:pt>
                <c:pt idx="134">
                  <c:v>0.29604000000000008</c:v>
                </c:pt>
                <c:pt idx="135">
                  <c:v>0.30368000000000089</c:v>
                </c:pt>
                <c:pt idx="136">
                  <c:v>0.3088500000000009</c:v>
                </c:pt>
                <c:pt idx="137">
                  <c:v>0.31559000000000031</c:v>
                </c:pt>
                <c:pt idx="138">
                  <c:v>0.32353000000000032</c:v>
                </c:pt>
                <c:pt idx="139">
                  <c:v>0.33014000000000032</c:v>
                </c:pt>
                <c:pt idx="140">
                  <c:v>0.3386000000000009</c:v>
                </c:pt>
                <c:pt idx="141">
                  <c:v>0.34553000000000045</c:v>
                </c:pt>
                <c:pt idx="142">
                  <c:v>0.35258000000000089</c:v>
                </c:pt>
                <c:pt idx="143">
                  <c:v>0.36060000000000031</c:v>
                </c:pt>
                <c:pt idx="144">
                  <c:v>0.36877000000000032</c:v>
                </c:pt>
                <c:pt idx="145">
                  <c:v>0.37583000000000077</c:v>
                </c:pt>
                <c:pt idx="146">
                  <c:v>0.38392000000000137</c:v>
                </c:pt>
                <c:pt idx="147">
                  <c:v>0.39267000000000102</c:v>
                </c:pt>
                <c:pt idx="148">
                  <c:v>0.40152000000000032</c:v>
                </c:pt>
                <c:pt idx="149">
                  <c:v>0.40951000000000032</c:v>
                </c:pt>
                <c:pt idx="150">
                  <c:v>0.41657000000000038</c:v>
                </c:pt>
                <c:pt idx="151">
                  <c:v>0.42589000000000032</c:v>
                </c:pt>
                <c:pt idx="152">
                  <c:v>0.43439000000000078</c:v>
                </c:pt>
                <c:pt idx="153">
                  <c:v>0.44300000000000045</c:v>
                </c:pt>
                <c:pt idx="154">
                  <c:v>0.45161000000000001</c:v>
                </c:pt>
                <c:pt idx="155">
                  <c:v>0.46030000000000032</c:v>
                </c:pt>
                <c:pt idx="156">
                  <c:v>0.46816000000000002</c:v>
                </c:pt>
                <c:pt idx="157">
                  <c:v>0.47656000000000032</c:v>
                </c:pt>
                <c:pt idx="158">
                  <c:v>0.4850800000000009</c:v>
                </c:pt>
                <c:pt idx="159">
                  <c:v>0.49260000000000032</c:v>
                </c:pt>
                <c:pt idx="160">
                  <c:v>0.50117999999999996</c:v>
                </c:pt>
                <c:pt idx="161">
                  <c:v>0.5095199999999982</c:v>
                </c:pt>
                <c:pt idx="162">
                  <c:v>0.51675000000000004</c:v>
                </c:pt>
                <c:pt idx="163">
                  <c:v>0.52517000000000003</c:v>
                </c:pt>
                <c:pt idx="164">
                  <c:v>0.53271999999999997</c:v>
                </c:pt>
                <c:pt idx="165">
                  <c:v>0.54005999999999998</c:v>
                </c:pt>
                <c:pt idx="166">
                  <c:v>0.54764000000000179</c:v>
                </c:pt>
                <c:pt idx="167">
                  <c:v>0.55452000000000001</c:v>
                </c:pt>
                <c:pt idx="168">
                  <c:v>0.56150999999999951</c:v>
                </c:pt>
                <c:pt idx="169">
                  <c:v>0.56916999999999951</c:v>
                </c:pt>
                <c:pt idx="170">
                  <c:v>0.57590000000000063</c:v>
                </c:pt>
                <c:pt idx="171">
                  <c:v>0.58237999999999956</c:v>
                </c:pt>
                <c:pt idx="172">
                  <c:v>0.58988000000000052</c:v>
                </c:pt>
                <c:pt idx="173">
                  <c:v>0.59705999999999959</c:v>
                </c:pt>
                <c:pt idx="174">
                  <c:v>0.60306999999999999</c:v>
                </c:pt>
                <c:pt idx="175">
                  <c:v>0.60993000000000064</c:v>
                </c:pt>
                <c:pt idx="176">
                  <c:v>0.61594000000000204</c:v>
                </c:pt>
                <c:pt idx="177">
                  <c:v>0.62199000000000204</c:v>
                </c:pt>
                <c:pt idx="178">
                  <c:v>0.62883999999999995</c:v>
                </c:pt>
                <c:pt idx="179">
                  <c:v>0.63558000000000003</c:v>
                </c:pt>
                <c:pt idx="180">
                  <c:v>0.64211000000000062</c:v>
                </c:pt>
                <c:pt idx="181">
                  <c:v>0.64858000000000005</c:v>
                </c:pt>
                <c:pt idx="182">
                  <c:v>0.65576000000000179</c:v>
                </c:pt>
                <c:pt idx="183">
                  <c:v>0.66289000000000275</c:v>
                </c:pt>
                <c:pt idx="184">
                  <c:v>0.67040999999999995</c:v>
                </c:pt>
                <c:pt idx="185">
                  <c:v>0.67794000000000276</c:v>
                </c:pt>
                <c:pt idx="186">
                  <c:v>0.6860100000000009</c:v>
                </c:pt>
                <c:pt idx="187">
                  <c:v>0.69416000000000078</c:v>
                </c:pt>
                <c:pt idx="188">
                  <c:v>0.70225000000000004</c:v>
                </c:pt>
                <c:pt idx="189">
                  <c:v>0.71162000000000203</c:v>
                </c:pt>
                <c:pt idx="190">
                  <c:v>0.72048999999999996</c:v>
                </c:pt>
                <c:pt idx="191">
                  <c:v>0.72973000000000154</c:v>
                </c:pt>
                <c:pt idx="192">
                  <c:v>0.74034999999999995</c:v>
                </c:pt>
                <c:pt idx="193">
                  <c:v>0.75098000000000065</c:v>
                </c:pt>
                <c:pt idx="194">
                  <c:v>0.76115000000000155</c:v>
                </c:pt>
                <c:pt idx="195">
                  <c:v>0.77286000000000077</c:v>
                </c:pt>
                <c:pt idx="196">
                  <c:v>0.78393999999999997</c:v>
                </c:pt>
                <c:pt idx="197">
                  <c:v>0.79605999999999999</c:v>
                </c:pt>
                <c:pt idx="198">
                  <c:v>0.80896000000000001</c:v>
                </c:pt>
                <c:pt idx="199">
                  <c:v>0.82235000000000003</c:v>
                </c:pt>
                <c:pt idx="200">
                  <c:v>0.83553999999999951</c:v>
                </c:pt>
                <c:pt idx="201">
                  <c:v>0.85048999999999997</c:v>
                </c:pt>
                <c:pt idx="202">
                  <c:v>0.86578999999999995</c:v>
                </c:pt>
                <c:pt idx="203">
                  <c:v>0.88018000000000052</c:v>
                </c:pt>
                <c:pt idx="204">
                  <c:v>0.89686000000000077</c:v>
                </c:pt>
                <c:pt idx="205">
                  <c:v>0.91313</c:v>
                </c:pt>
                <c:pt idx="206">
                  <c:v>0.93074000000000179</c:v>
                </c:pt>
                <c:pt idx="207">
                  <c:v>0.94769000000000203</c:v>
                </c:pt>
                <c:pt idx="208">
                  <c:v>0.96555000000000002</c:v>
                </c:pt>
                <c:pt idx="209">
                  <c:v>0.9842699999999982</c:v>
                </c:pt>
                <c:pt idx="210">
                  <c:v>1.0053099999999966</c:v>
                </c:pt>
                <c:pt idx="211">
                  <c:v>1.0254099999999968</c:v>
                </c:pt>
                <c:pt idx="212">
                  <c:v>1.0457199999999998</c:v>
                </c:pt>
                <c:pt idx="213">
                  <c:v>1.06921</c:v>
                </c:pt>
                <c:pt idx="214">
                  <c:v>1.09324</c:v>
                </c:pt>
                <c:pt idx="215">
                  <c:v>1.1200699999999999</c:v>
                </c:pt>
                <c:pt idx="216">
                  <c:v>1.1457999999999968</c:v>
                </c:pt>
                <c:pt idx="217">
                  <c:v>1.1704500000000033</c:v>
                </c:pt>
                <c:pt idx="218">
                  <c:v>1.2026199999999998</c:v>
                </c:pt>
                <c:pt idx="219">
                  <c:v>1.2296899999999968</c:v>
                </c:pt>
                <c:pt idx="220">
                  <c:v>1.2588599999999999</c:v>
                </c:pt>
                <c:pt idx="221">
                  <c:v>1.2955899999999998</c:v>
                </c:pt>
                <c:pt idx="222">
                  <c:v>1.3281700000000001</c:v>
                </c:pt>
                <c:pt idx="223">
                  <c:v>1.3637899999999998</c:v>
                </c:pt>
                <c:pt idx="224">
                  <c:v>1.4072499999999966</c:v>
                </c:pt>
                <c:pt idx="225">
                  <c:v>1.4467299999999963</c:v>
                </c:pt>
                <c:pt idx="226">
                  <c:v>1.49701</c:v>
                </c:pt>
                <c:pt idx="227">
                  <c:v>1.5593399999999968</c:v>
                </c:pt>
                <c:pt idx="228">
                  <c:v>1.6217699999999968</c:v>
                </c:pt>
                <c:pt idx="229">
                  <c:v>1.7053899999999984</c:v>
                </c:pt>
                <c:pt idx="230">
                  <c:v>1.8198799999999968</c:v>
                </c:pt>
                <c:pt idx="231">
                  <c:v>1.9557499999999983</c:v>
                </c:pt>
                <c:pt idx="232">
                  <c:v>2.1403900000000067</c:v>
                </c:pt>
                <c:pt idx="233">
                  <c:v>2.4079600000000001</c:v>
                </c:pt>
                <c:pt idx="234">
                  <c:v>2.7360699999999967</c:v>
                </c:pt>
                <c:pt idx="235">
                  <c:v>3.032889999999993</c:v>
                </c:pt>
                <c:pt idx="236">
                  <c:v>3.21156</c:v>
                </c:pt>
                <c:pt idx="237">
                  <c:v>3.4445600000000001</c:v>
                </c:pt>
                <c:pt idx="238">
                  <c:v>3.3589899999999977</c:v>
                </c:pt>
                <c:pt idx="239">
                  <c:v>3.4120199999999929</c:v>
                </c:pt>
                <c:pt idx="240">
                  <c:v>3.5744699999999967</c:v>
                </c:pt>
                <c:pt idx="241">
                  <c:v>3.5790099999999967</c:v>
                </c:pt>
                <c:pt idx="242">
                  <c:v>3.8595099999999967</c:v>
                </c:pt>
                <c:pt idx="243">
                  <c:v>3.906859999999992</c:v>
                </c:pt>
                <c:pt idx="244">
                  <c:v>3.85412</c:v>
                </c:pt>
                <c:pt idx="245">
                  <c:v>4.0931499999999996</c:v>
                </c:pt>
                <c:pt idx="246">
                  <c:v>4.1584099999999955</c:v>
                </c:pt>
                <c:pt idx="247">
                  <c:v>4.0704000000000002</c:v>
                </c:pt>
                <c:pt idx="248">
                  <c:v>4.40388</c:v>
                </c:pt>
                <c:pt idx="249">
                  <c:v>4.1863000000000001</c:v>
                </c:pt>
                <c:pt idx="250">
                  <c:v>4.0395200000000004</c:v>
                </c:pt>
                <c:pt idx="251">
                  <c:v>5.0000099999999996</c:v>
                </c:pt>
                <c:pt idx="252">
                  <c:v>5.0000099999999996</c:v>
                </c:pt>
                <c:pt idx="253">
                  <c:v>4.1009599999999873</c:v>
                </c:pt>
                <c:pt idx="254">
                  <c:v>3.9151399999999987</c:v>
                </c:pt>
                <c:pt idx="255">
                  <c:v>3.98861</c:v>
                </c:pt>
                <c:pt idx="256">
                  <c:v>3.8973399999999998</c:v>
                </c:pt>
                <c:pt idx="257">
                  <c:v>3.6821299999999999</c:v>
                </c:pt>
                <c:pt idx="258">
                  <c:v>3.5544799999999968</c:v>
                </c:pt>
                <c:pt idx="259">
                  <c:v>3.3955399999999987</c:v>
                </c:pt>
                <c:pt idx="260">
                  <c:v>3.1676000000000002</c:v>
                </c:pt>
                <c:pt idx="261">
                  <c:v>2.9556199999999935</c:v>
                </c:pt>
                <c:pt idx="262">
                  <c:v>2.6335799999999998</c:v>
                </c:pt>
                <c:pt idx="263">
                  <c:v>2.4147799999999977</c:v>
                </c:pt>
                <c:pt idx="264">
                  <c:v>2.095949999999994</c:v>
                </c:pt>
                <c:pt idx="265">
                  <c:v>1.67252</c:v>
                </c:pt>
                <c:pt idx="266">
                  <c:v>1.2751899999999998</c:v>
                </c:pt>
                <c:pt idx="267">
                  <c:v>1.0173399999999966</c:v>
                </c:pt>
                <c:pt idx="268">
                  <c:v>0.86290000000000167</c:v>
                </c:pt>
                <c:pt idx="269">
                  <c:v>0.81852999999999998</c:v>
                </c:pt>
                <c:pt idx="270">
                  <c:v>0.7795699999999991</c:v>
                </c:pt>
                <c:pt idx="271">
                  <c:v>0.78966999999999998</c:v>
                </c:pt>
                <c:pt idx="272">
                  <c:v>0.77266000000000101</c:v>
                </c:pt>
                <c:pt idx="273">
                  <c:v>0.75927000000000167</c:v>
                </c:pt>
                <c:pt idx="274">
                  <c:v>0.73109000000000179</c:v>
                </c:pt>
                <c:pt idx="275">
                  <c:v>0.70808000000000004</c:v>
                </c:pt>
                <c:pt idx="276">
                  <c:v>0.69804000000000221</c:v>
                </c:pt>
                <c:pt idx="277">
                  <c:v>0.68855000000000077</c:v>
                </c:pt>
                <c:pt idx="278">
                  <c:v>0.68177000000000221</c:v>
                </c:pt>
                <c:pt idx="279">
                  <c:v>0.68669000000000269</c:v>
                </c:pt>
                <c:pt idx="280">
                  <c:v>0.66062000000000276</c:v>
                </c:pt>
                <c:pt idx="281">
                  <c:v>0.67380000000000229</c:v>
                </c:pt>
                <c:pt idx="282">
                  <c:v>0.67905000000000204</c:v>
                </c:pt>
                <c:pt idx="283">
                  <c:v>0.64824000000000204</c:v>
                </c:pt>
                <c:pt idx="284">
                  <c:v>0.63504000000000205</c:v>
                </c:pt>
                <c:pt idx="285">
                  <c:v>0.63290000000000179</c:v>
                </c:pt>
                <c:pt idx="286">
                  <c:v>0.63280000000000203</c:v>
                </c:pt>
                <c:pt idx="287">
                  <c:v>0.64445000000000063</c:v>
                </c:pt>
                <c:pt idx="288">
                  <c:v>0.64583000000000179</c:v>
                </c:pt>
                <c:pt idx="289">
                  <c:v>0.63058000000000003</c:v>
                </c:pt>
                <c:pt idx="290">
                  <c:v>0.62574000000000241</c:v>
                </c:pt>
                <c:pt idx="291">
                  <c:v>0.66948000000000063</c:v>
                </c:pt>
                <c:pt idx="292">
                  <c:v>0.67696000000000178</c:v>
                </c:pt>
                <c:pt idx="293">
                  <c:v>0.65780000000000205</c:v>
                </c:pt>
                <c:pt idx="294">
                  <c:v>0.75704000000000204</c:v>
                </c:pt>
                <c:pt idx="295">
                  <c:v>0.67611000000000065</c:v>
                </c:pt>
                <c:pt idx="296">
                  <c:v>0.64245000000000063</c:v>
                </c:pt>
                <c:pt idx="297">
                  <c:v>0.63645000000000063</c:v>
                </c:pt>
                <c:pt idx="298">
                  <c:v>0.64684000000000275</c:v>
                </c:pt>
                <c:pt idx="299">
                  <c:v>0.69029000000000162</c:v>
                </c:pt>
                <c:pt idx="300">
                  <c:v>0.599940000000001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E01B-4127-A621-24501A84C0B5}"/>
            </c:ext>
          </c:extLst>
        </c:ser>
        <c:ser>
          <c:idx val="4"/>
          <c:order val="4"/>
          <c:tx>
            <c:strRef>
              <c:f>Feuil1!$F$1</c:f>
              <c:strCache>
                <c:ptCount val="1"/>
                <c:pt idx="0">
                  <c:v>HBT+ Laccase</c:v>
                </c:pt>
              </c:strCache>
            </c:strRef>
          </c:tx>
          <c:spPr>
            <a:ln w="12700">
              <a:solidFill>
                <a:srgbClr val="33CCCC"/>
              </a:solidFill>
              <a:prstDash val="solid"/>
            </a:ln>
          </c:spPr>
          <c:marker>
            <c:symbol val="none"/>
          </c:marker>
          <c:xVal>
            <c:numRef>
              <c:f>Feuil1!$A$2:$A$302</c:f>
              <c:numCache>
                <c:formatCode>General</c:formatCode>
                <c:ptCount val="301"/>
                <c:pt idx="0">
                  <c:v>800</c:v>
                </c:pt>
                <c:pt idx="1">
                  <c:v>798</c:v>
                </c:pt>
                <c:pt idx="2">
                  <c:v>796</c:v>
                </c:pt>
                <c:pt idx="3">
                  <c:v>794</c:v>
                </c:pt>
                <c:pt idx="4">
                  <c:v>792</c:v>
                </c:pt>
                <c:pt idx="5">
                  <c:v>790</c:v>
                </c:pt>
                <c:pt idx="6">
                  <c:v>788</c:v>
                </c:pt>
                <c:pt idx="7">
                  <c:v>786</c:v>
                </c:pt>
                <c:pt idx="8">
                  <c:v>784</c:v>
                </c:pt>
                <c:pt idx="9">
                  <c:v>782</c:v>
                </c:pt>
                <c:pt idx="10">
                  <c:v>780</c:v>
                </c:pt>
                <c:pt idx="11">
                  <c:v>778</c:v>
                </c:pt>
                <c:pt idx="12">
                  <c:v>776</c:v>
                </c:pt>
                <c:pt idx="13">
                  <c:v>774</c:v>
                </c:pt>
                <c:pt idx="14">
                  <c:v>772</c:v>
                </c:pt>
                <c:pt idx="15">
                  <c:v>770</c:v>
                </c:pt>
                <c:pt idx="16">
                  <c:v>768</c:v>
                </c:pt>
                <c:pt idx="17">
                  <c:v>766</c:v>
                </c:pt>
                <c:pt idx="18">
                  <c:v>764</c:v>
                </c:pt>
                <c:pt idx="19">
                  <c:v>762</c:v>
                </c:pt>
                <c:pt idx="20">
                  <c:v>760</c:v>
                </c:pt>
                <c:pt idx="21">
                  <c:v>758</c:v>
                </c:pt>
                <c:pt idx="22">
                  <c:v>756</c:v>
                </c:pt>
                <c:pt idx="23">
                  <c:v>754</c:v>
                </c:pt>
                <c:pt idx="24">
                  <c:v>752</c:v>
                </c:pt>
                <c:pt idx="25">
                  <c:v>750</c:v>
                </c:pt>
                <c:pt idx="26">
                  <c:v>748</c:v>
                </c:pt>
                <c:pt idx="27">
                  <c:v>746</c:v>
                </c:pt>
                <c:pt idx="28">
                  <c:v>744</c:v>
                </c:pt>
                <c:pt idx="29">
                  <c:v>742</c:v>
                </c:pt>
                <c:pt idx="30">
                  <c:v>740</c:v>
                </c:pt>
                <c:pt idx="31">
                  <c:v>738</c:v>
                </c:pt>
                <c:pt idx="32">
                  <c:v>736</c:v>
                </c:pt>
                <c:pt idx="33">
                  <c:v>734</c:v>
                </c:pt>
                <c:pt idx="34">
                  <c:v>732</c:v>
                </c:pt>
                <c:pt idx="35">
                  <c:v>730</c:v>
                </c:pt>
                <c:pt idx="36">
                  <c:v>728</c:v>
                </c:pt>
                <c:pt idx="37">
                  <c:v>726</c:v>
                </c:pt>
                <c:pt idx="38">
                  <c:v>724</c:v>
                </c:pt>
                <c:pt idx="39">
                  <c:v>722</c:v>
                </c:pt>
                <c:pt idx="40">
                  <c:v>720</c:v>
                </c:pt>
                <c:pt idx="41">
                  <c:v>718</c:v>
                </c:pt>
                <c:pt idx="42">
                  <c:v>716</c:v>
                </c:pt>
                <c:pt idx="43">
                  <c:v>714</c:v>
                </c:pt>
                <c:pt idx="44">
                  <c:v>712</c:v>
                </c:pt>
                <c:pt idx="45">
                  <c:v>710</c:v>
                </c:pt>
                <c:pt idx="46">
                  <c:v>708</c:v>
                </c:pt>
                <c:pt idx="47">
                  <c:v>706</c:v>
                </c:pt>
                <c:pt idx="48">
                  <c:v>704</c:v>
                </c:pt>
                <c:pt idx="49">
                  <c:v>702</c:v>
                </c:pt>
                <c:pt idx="50">
                  <c:v>700</c:v>
                </c:pt>
                <c:pt idx="51">
                  <c:v>698</c:v>
                </c:pt>
                <c:pt idx="52">
                  <c:v>696</c:v>
                </c:pt>
                <c:pt idx="53">
                  <c:v>694</c:v>
                </c:pt>
                <c:pt idx="54">
                  <c:v>692</c:v>
                </c:pt>
                <c:pt idx="55">
                  <c:v>690</c:v>
                </c:pt>
                <c:pt idx="56">
                  <c:v>688</c:v>
                </c:pt>
                <c:pt idx="57">
                  <c:v>686</c:v>
                </c:pt>
                <c:pt idx="58">
                  <c:v>684</c:v>
                </c:pt>
                <c:pt idx="59">
                  <c:v>682</c:v>
                </c:pt>
                <c:pt idx="60">
                  <c:v>680</c:v>
                </c:pt>
                <c:pt idx="61">
                  <c:v>678</c:v>
                </c:pt>
                <c:pt idx="62">
                  <c:v>676</c:v>
                </c:pt>
                <c:pt idx="63">
                  <c:v>674</c:v>
                </c:pt>
                <c:pt idx="64">
                  <c:v>672</c:v>
                </c:pt>
                <c:pt idx="65">
                  <c:v>670</c:v>
                </c:pt>
                <c:pt idx="66">
                  <c:v>668</c:v>
                </c:pt>
                <c:pt idx="67">
                  <c:v>666</c:v>
                </c:pt>
                <c:pt idx="68">
                  <c:v>664</c:v>
                </c:pt>
                <c:pt idx="69">
                  <c:v>662</c:v>
                </c:pt>
                <c:pt idx="70">
                  <c:v>660</c:v>
                </c:pt>
                <c:pt idx="71">
                  <c:v>658</c:v>
                </c:pt>
                <c:pt idx="72">
                  <c:v>656</c:v>
                </c:pt>
                <c:pt idx="73">
                  <c:v>654</c:v>
                </c:pt>
                <c:pt idx="74">
                  <c:v>652</c:v>
                </c:pt>
                <c:pt idx="75">
                  <c:v>650</c:v>
                </c:pt>
                <c:pt idx="76">
                  <c:v>648</c:v>
                </c:pt>
                <c:pt idx="77">
                  <c:v>646</c:v>
                </c:pt>
                <c:pt idx="78">
                  <c:v>644</c:v>
                </c:pt>
                <c:pt idx="79">
                  <c:v>642</c:v>
                </c:pt>
                <c:pt idx="80">
                  <c:v>640</c:v>
                </c:pt>
                <c:pt idx="81">
                  <c:v>638</c:v>
                </c:pt>
                <c:pt idx="82">
                  <c:v>636</c:v>
                </c:pt>
                <c:pt idx="83">
                  <c:v>634</c:v>
                </c:pt>
                <c:pt idx="84">
                  <c:v>632</c:v>
                </c:pt>
                <c:pt idx="85">
                  <c:v>630</c:v>
                </c:pt>
                <c:pt idx="86">
                  <c:v>628</c:v>
                </c:pt>
                <c:pt idx="87">
                  <c:v>626</c:v>
                </c:pt>
                <c:pt idx="88">
                  <c:v>624</c:v>
                </c:pt>
                <c:pt idx="89">
                  <c:v>622</c:v>
                </c:pt>
                <c:pt idx="90">
                  <c:v>620</c:v>
                </c:pt>
                <c:pt idx="91">
                  <c:v>618</c:v>
                </c:pt>
                <c:pt idx="92">
                  <c:v>616</c:v>
                </c:pt>
                <c:pt idx="93">
                  <c:v>614</c:v>
                </c:pt>
                <c:pt idx="94">
                  <c:v>612</c:v>
                </c:pt>
                <c:pt idx="95">
                  <c:v>610</c:v>
                </c:pt>
                <c:pt idx="96">
                  <c:v>608</c:v>
                </c:pt>
                <c:pt idx="97">
                  <c:v>606</c:v>
                </c:pt>
                <c:pt idx="98">
                  <c:v>604</c:v>
                </c:pt>
                <c:pt idx="99">
                  <c:v>602</c:v>
                </c:pt>
                <c:pt idx="100">
                  <c:v>600</c:v>
                </c:pt>
                <c:pt idx="101">
                  <c:v>598</c:v>
                </c:pt>
                <c:pt idx="102">
                  <c:v>596</c:v>
                </c:pt>
                <c:pt idx="103">
                  <c:v>594</c:v>
                </c:pt>
                <c:pt idx="104">
                  <c:v>592</c:v>
                </c:pt>
                <c:pt idx="105">
                  <c:v>590</c:v>
                </c:pt>
                <c:pt idx="106">
                  <c:v>588</c:v>
                </c:pt>
                <c:pt idx="107">
                  <c:v>586</c:v>
                </c:pt>
                <c:pt idx="108">
                  <c:v>584</c:v>
                </c:pt>
                <c:pt idx="109">
                  <c:v>582</c:v>
                </c:pt>
                <c:pt idx="110">
                  <c:v>580</c:v>
                </c:pt>
                <c:pt idx="111">
                  <c:v>578</c:v>
                </c:pt>
                <c:pt idx="112">
                  <c:v>576</c:v>
                </c:pt>
                <c:pt idx="113">
                  <c:v>574</c:v>
                </c:pt>
                <c:pt idx="114">
                  <c:v>572</c:v>
                </c:pt>
                <c:pt idx="115">
                  <c:v>570</c:v>
                </c:pt>
                <c:pt idx="116">
                  <c:v>568</c:v>
                </c:pt>
                <c:pt idx="117">
                  <c:v>566</c:v>
                </c:pt>
                <c:pt idx="118">
                  <c:v>564</c:v>
                </c:pt>
                <c:pt idx="119">
                  <c:v>562</c:v>
                </c:pt>
                <c:pt idx="120">
                  <c:v>560</c:v>
                </c:pt>
                <c:pt idx="121">
                  <c:v>558</c:v>
                </c:pt>
                <c:pt idx="122">
                  <c:v>556</c:v>
                </c:pt>
                <c:pt idx="123">
                  <c:v>554</c:v>
                </c:pt>
                <c:pt idx="124">
                  <c:v>552</c:v>
                </c:pt>
                <c:pt idx="125">
                  <c:v>550</c:v>
                </c:pt>
                <c:pt idx="126">
                  <c:v>548</c:v>
                </c:pt>
                <c:pt idx="127">
                  <c:v>546</c:v>
                </c:pt>
                <c:pt idx="128">
                  <c:v>544</c:v>
                </c:pt>
                <c:pt idx="129">
                  <c:v>542</c:v>
                </c:pt>
                <c:pt idx="130">
                  <c:v>540</c:v>
                </c:pt>
                <c:pt idx="131">
                  <c:v>538</c:v>
                </c:pt>
                <c:pt idx="132">
                  <c:v>536</c:v>
                </c:pt>
                <c:pt idx="133">
                  <c:v>534</c:v>
                </c:pt>
                <c:pt idx="134">
                  <c:v>532</c:v>
                </c:pt>
                <c:pt idx="135">
                  <c:v>530</c:v>
                </c:pt>
                <c:pt idx="136">
                  <c:v>528</c:v>
                </c:pt>
                <c:pt idx="137">
                  <c:v>526</c:v>
                </c:pt>
                <c:pt idx="138">
                  <c:v>524</c:v>
                </c:pt>
                <c:pt idx="139">
                  <c:v>522</c:v>
                </c:pt>
                <c:pt idx="140">
                  <c:v>520</c:v>
                </c:pt>
                <c:pt idx="141">
                  <c:v>518</c:v>
                </c:pt>
                <c:pt idx="142">
                  <c:v>516</c:v>
                </c:pt>
                <c:pt idx="143">
                  <c:v>514</c:v>
                </c:pt>
                <c:pt idx="144">
                  <c:v>512</c:v>
                </c:pt>
                <c:pt idx="145">
                  <c:v>510</c:v>
                </c:pt>
                <c:pt idx="146">
                  <c:v>508</c:v>
                </c:pt>
                <c:pt idx="147">
                  <c:v>506</c:v>
                </c:pt>
                <c:pt idx="148">
                  <c:v>504</c:v>
                </c:pt>
                <c:pt idx="149">
                  <c:v>502</c:v>
                </c:pt>
                <c:pt idx="150">
                  <c:v>500</c:v>
                </c:pt>
                <c:pt idx="151">
                  <c:v>498</c:v>
                </c:pt>
                <c:pt idx="152">
                  <c:v>496</c:v>
                </c:pt>
                <c:pt idx="153">
                  <c:v>494</c:v>
                </c:pt>
                <c:pt idx="154">
                  <c:v>492</c:v>
                </c:pt>
                <c:pt idx="155">
                  <c:v>490</c:v>
                </c:pt>
                <c:pt idx="156">
                  <c:v>488</c:v>
                </c:pt>
                <c:pt idx="157">
                  <c:v>486</c:v>
                </c:pt>
                <c:pt idx="158">
                  <c:v>484</c:v>
                </c:pt>
                <c:pt idx="159">
                  <c:v>482</c:v>
                </c:pt>
                <c:pt idx="160">
                  <c:v>480</c:v>
                </c:pt>
                <c:pt idx="161">
                  <c:v>478</c:v>
                </c:pt>
                <c:pt idx="162">
                  <c:v>476</c:v>
                </c:pt>
                <c:pt idx="163">
                  <c:v>474</c:v>
                </c:pt>
                <c:pt idx="164">
                  <c:v>472</c:v>
                </c:pt>
                <c:pt idx="165">
                  <c:v>470</c:v>
                </c:pt>
                <c:pt idx="166">
                  <c:v>468</c:v>
                </c:pt>
                <c:pt idx="167">
                  <c:v>466</c:v>
                </c:pt>
                <c:pt idx="168">
                  <c:v>464</c:v>
                </c:pt>
                <c:pt idx="169">
                  <c:v>462</c:v>
                </c:pt>
                <c:pt idx="170">
                  <c:v>460</c:v>
                </c:pt>
                <c:pt idx="171">
                  <c:v>458</c:v>
                </c:pt>
                <c:pt idx="172">
                  <c:v>456</c:v>
                </c:pt>
                <c:pt idx="173">
                  <c:v>454</c:v>
                </c:pt>
                <c:pt idx="174">
                  <c:v>452</c:v>
                </c:pt>
                <c:pt idx="175">
                  <c:v>450</c:v>
                </c:pt>
                <c:pt idx="176">
                  <c:v>448</c:v>
                </c:pt>
                <c:pt idx="177">
                  <c:v>446</c:v>
                </c:pt>
                <c:pt idx="178">
                  <c:v>444</c:v>
                </c:pt>
                <c:pt idx="179">
                  <c:v>442</c:v>
                </c:pt>
                <c:pt idx="180">
                  <c:v>440</c:v>
                </c:pt>
                <c:pt idx="181">
                  <c:v>438</c:v>
                </c:pt>
                <c:pt idx="182">
                  <c:v>436</c:v>
                </c:pt>
                <c:pt idx="183">
                  <c:v>434</c:v>
                </c:pt>
                <c:pt idx="184">
                  <c:v>432</c:v>
                </c:pt>
                <c:pt idx="185">
                  <c:v>430</c:v>
                </c:pt>
                <c:pt idx="186">
                  <c:v>428</c:v>
                </c:pt>
                <c:pt idx="187">
                  <c:v>426</c:v>
                </c:pt>
                <c:pt idx="188">
                  <c:v>424</c:v>
                </c:pt>
                <c:pt idx="189">
                  <c:v>422</c:v>
                </c:pt>
                <c:pt idx="190">
                  <c:v>420</c:v>
                </c:pt>
                <c:pt idx="191">
                  <c:v>418</c:v>
                </c:pt>
                <c:pt idx="192">
                  <c:v>416</c:v>
                </c:pt>
                <c:pt idx="193">
                  <c:v>414</c:v>
                </c:pt>
                <c:pt idx="194">
                  <c:v>412</c:v>
                </c:pt>
                <c:pt idx="195">
                  <c:v>410</c:v>
                </c:pt>
                <c:pt idx="196">
                  <c:v>408</c:v>
                </c:pt>
                <c:pt idx="197">
                  <c:v>406</c:v>
                </c:pt>
                <c:pt idx="198">
                  <c:v>404</c:v>
                </c:pt>
                <c:pt idx="199">
                  <c:v>402</c:v>
                </c:pt>
                <c:pt idx="200">
                  <c:v>400</c:v>
                </c:pt>
                <c:pt idx="201">
                  <c:v>398</c:v>
                </c:pt>
                <c:pt idx="202">
                  <c:v>396</c:v>
                </c:pt>
                <c:pt idx="203">
                  <c:v>394</c:v>
                </c:pt>
                <c:pt idx="204">
                  <c:v>392</c:v>
                </c:pt>
                <c:pt idx="205">
                  <c:v>390</c:v>
                </c:pt>
                <c:pt idx="206">
                  <c:v>388</c:v>
                </c:pt>
                <c:pt idx="207">
                  <c:v>386</c:v>
                </c:pt>
                <c:pt idx="208">
                  <c:v>384</c:v>
                </c:pt>
                <c:pt idx="209">
                  <c:v>382</c:v>
                </c:pt>
                <c:pt idx="210">
                  <c:v>380</c:v>
                </c:pt>
                <c:pt idx="211">
                  <c:v>378</c:v>
                </c:pt>
                <c:pt idx="212">
                  <c:v>376</c:v>
                </c:pt>
                <c:pt idx="213">
                  <c:v>374</c:v>
                </c:pt>
                <c:pt idx="214">
                  <c:v>372</c:v>
                </c:pt>
                <c:pt idx="215">
                  <c:v>370</c:v>
                </c:pt>
                <c:pt idx="216">
                  <c:v>368</c:v>
                </c:pt>
                <c:pt idx="217">
                  <c:v>366</c:v>
                </c:pt>
                <c:pt idx="218">
                  <c:v>364</c:v>
                </c:pt>
                <c:pt idx="219">
                  <c:v>362</c:v>
                </c:pt>
                <c:pt idx="220">
                  <c:v>360</c:v>
                </c:pt>
                <c:pt idx="221">
                  <c:v>358</c:v>
                </c:pt>
                <c:pt idx="222">
                  <c:v>356</c:v>
                </c:pt>
                <c:pt idx="223">
                  <c:v>354</c:v>
                </c:pt>
                <c:pt idx="224">
                  <c:v>352</c:v>
                </c:pt>
                <c:pt idx="225">
                  <c:v>350</c:v>
                </c:pt>
                <c:pt idx="226">
                  <c:v>348</c:v>
                </c:pt>
                <c:pt idx="227">
                  <c:v>346</c:v>
                </c:pt>
                <c:pt idx="228">
                  <c:v>344</c:v>
                </c:pt>
                <c:pt idx="229">
                  <c:v>342</c:v>
                </c:pt>
                <c:pt idx="230">
                  <c:v>340</c:v>
                </c:pt>
                <c:pt idx="231">
                  <c:v>338</c:v>
                </c:pt>
                <c:pt idx="232">
                  <c:v>336</c:v>
                </c:pt>
                <c:pt idx="233">
                  <c:v>334</c:v>
                </c:pt>
                <c:pt idx="234">
                  <c:v>332</c:v>
                </c:pt>
                <c:pt idx="235">
                  <c:v>330</c:v>
                </c:pt>
                <c:pt idx="236">
                  <c:v>328</c:v>
                </c:pt>
                <c:pt idx="237">
                  <c:v>326</c:v>
                </c:pt>
                <c:pt idx="238">
                  <c:v>324</c:v>
                </c:pt>
                <c:pt idx="239">
                  <c:v>322</c:v>
                </c:pt>
                <c:pt idx="240">
                  <c:v>320</c:v>
                </c:pt>
                <c:pt idx="241">
                  <c:v>318</c:v>
                </c:pt>
                <c:pt idx="242">
                  <c:v>316</c:v>
                </c:pt>
                <c:pt idx="243">
                  <c:v>314</c:v>
                </c:pt>
                <c:pt idx="244">
                  <c:v>312</c:v>
                </c:pt>
                <c:pt idx="245">
                  <c:v>310</c:v>
                </c:pt>
                <c:pt idx="246">
                  <c:v>308</c:v>
                </c:pt>
                <c:pt idx="247">
                  <c:v>306</c:v>
                </c:pt>
                <c:pt idx="248">
                  <c:v>304</c:v>
                </c:pt>
                <c:pt idx="249">
                  <c:v>302</c:v>
                </c:pt>
                <c:pt idx="250">
                  <c:v>300</c:v>
                </c:pt>
                <c:pt idx="251">
                  <c:v>298</c:v>
                </c:pt>
                <c:pt idx="252">
                  <c:v>296</c:v>
                </c:pt>
                <c:pt idx="253">
                  <c:v>294</c:v>
                </c:pt>
                <c:pt idx="254">
                  <c:v>292</c:v>
                </c:pt>
                <c:pt idx="255">
                  <c:v>290</c:v>
                </c:pt>
                <c:pt idx="256">
                  <c:v>288</c:v>
                </c:pt>
                <c:pt idx="257">
                  <c:v>286</c:v>
                </c:pt>
                <c:pt idx="258">
                  <c:v>284</c:v>
                </c:pt>
                <c:pt idx="259">
                  <c:v>282</c:v>
                </c:pt>
                <c:pt idx="260">
                  <c:v>280</c:v>
                </c:pt>
                <c:pt idx="261">
                  <c:v>278</c:v>
                </c:pt>
                <c:pt idx="262">
                  <c:v>276</c:v>
                </c:pt>
                <c:pt idx="263">
                  <c:v>274</c:v>
                </c:pt>
                <c:pt idx="264">
                  <c:v>272</c:v>
                </c:pt>
                <c:pt idx="265">
                  <c:v>270</c:v>
                </c:pt>
                <c:pt idx="266">
                  <c:v>268</c:v>
                </c:pt>
                <c:pt idx="267">
                  <c:v>266</c:v>
                </c:pt>
                <c:pt idx="268">
                  <c:v>264</c:v>
                </c:pt>
                <c:pt idx="269">
                  <c:v>262</c:v>
                </c:pt>
                <c:pt idx="270">
                  <c:v>260</c:v>
                </c:pt>
                <c:pt idx="271">
                  <c:v>258</c:v>
                </c:pt>
                <c:pt idx="272">
                  <c:v>256</c:v>
                </c:pt>
                <c:pt idx="273">
                  <c:v>254</c:v>
                </c:pt>
                <c:pt idx="274">
                  <c:v>252</c:v>
                </c:pt>
                <c:pt idx="275">
                  <c:v>250</c:v>
                </c:pt>
                <c:pt idx="276">
                  <c:v>248</c:v>
                </c:pt>
                <c:pt idx="277">
                  <c:v>246</c:v>
                </c:pt>
                <c:pt idx="278">
                  <c:v>244</c:v>
                </c:pt>
                <c:pt idx="279">
                  <c:v>242</c:v>
                </c:pt>
                <c:pt idx="280">
                  <c:v>240</c:v>
                </c:pt>
                <c:pt idx="281">
                  <c:v>238</c:v>
                </c:pt>
                <c:pt idx="282">
                  <c:v>236</c:v>
                </c:pt>
                <c:pt idx="283">
                  <c:v>234</c:v>
                </c:pt>
                <c:pt idx="284">
                  <c:v>232</c:v>
                </c:pt>
                <c:pt idx="285">
                  <c:v>230</c:v>
                </c:pt>
                <c:pt idx="286">
                  <c:v>228</c:v>
                </c:pt>
                <c:pt idx="287">
                  <c:v>226</c:v>
                </c:pt>
                <c:pt idx="288">
                  <c:v>224</c:v>
                </c:pt>
                <c:pt idx="289">
                  <c:v>222</c:v>
                </c:pt>
                <c:pt idx="290">
                  <c:v>220</c:v>
                </c:pt>
                <c:pt idx="291">
                  <c:v>218</c:v>
                </c:pt>
                <c:pt idx="292">
                  <c:v>216</c:v>
                </c:pt>
                <c:pt idx="293">
                  <c:v>214</c:v>
                </c:pt>
                <c:pt idx="294">
                  <c:v>212</c:v>
                </c:pt>
                <c:pt idx="295">
                  <c:v>210</c:v>
                </c:pt>
                <c:pt idx="296">
                  <c:v>208</c:v>
                </c:pt>
                <c:pt idx="297">
                  <c:v>206</c:v>
                </c:pt>
                <c:pt idx="298">
                  <c:v>204</c:v>
                </c:pt>
                <c:pt idx="299">
                  <c:v>202</c:v>
                </c:pt>
                <c:pt idx="300">
                  <c:v>200</c:v>
                </c:pt>
              </c:numCache>
            </c:numRef>
          </c:xVal>
          <c:yVal>
            <c:numRef>
              <c:f>Feuil1!$F$2:$F$302</c:f>
              <c:numCache>
                <c:formatCode>General</c:formatCode>
                <c:ptCount val="301"/>
                <c:pt idx="0">
                  <c:v>1.5049999999999999E-2</c:v>
                </c:pt>
                <c:pt idx="1">
                  <c:v>1.7070000000000026E-2</c:v>
                </c:pt>
                <c:pt idx="2">
                  <c:v>1.734000000000006E-2</c:v>
                </c:pt>
                <c:pt idx="3">
                  <c:v>1.6370000000000041E-2</c:v>
                </c:pt>
                <c:pt idx="4">
                  <c:v>1.6150000000000043E-2</c:v>
                </c:pt>
                <c:pt idx="5">
                  <c:v>1.7250000000000033E-2</c:v>
                </c:pt>
                <c:pt idx="6">
                  <c:v>1.6630000000000041E-2</c:v>
                </c:pt>
                <c:pt idx="7">
                  <c:v>1.5190000000000021E-2</c:v>
                </c:pt>
                <c:pt idx="8">
                  <c:v>1.870000000000006E-2</c:v>
                </c:pt>
                <c:pt idx="9">
                  <c:v>2.2940000000000012E-2</c:v>
                </c:pt>
                <c:pt idx="10">
                  <c:v>2.108000000000006E-2</c:v>
                </c:pt>
                <c:pt idx="11">
                  <c:v>1.4600000000000026E-2</c:v>
                </c:pt>
                <c:pt idx="12">
                  <c:v>1.4360000000000027E-2</c:v>
                </c:pt>
                <c:pt idx="13">
                  <c:v>1.042000000000003E-2</c:v>
                </c:pt>
                <c:pt idx="14">
                  <c:v>1.2500000000000035E-2</c:v>
                </c:pt>
                <c:pt idx="15">
                  <c:v>1.5089999999999999E-2</c:v>
                </c:pt>
                <c:pt idx="16">
                  <c:v>1.4919999999999998E-2</c:v>
                </c:pt>
                <c:pt idx="17">
                  <c:v>2.1010000000000011E-2</c:v>
                </c:pt>
                <c:pt idx="18">
                  <c:v>1.6760000000000067E-2</c:v>
                </c:pt>
                <c:pt idx="19">
                  <c:v>2.1450000000000052E-2</c:v>
                </c:pt>
                <c:pt idx="20">
                  <c:v>1.4760000000000027E-2</c:v>
                </c:pt>
                <c:pt idx="21">
                  <c:v>1.8560000000000056E-2</c:v>
                </c:pt>
                <c:pt idx="22">
                  <c:v>1.5080000000000041E-2</c:v>
                </c:pt>
                <c:pt idx="23">
                  <c:v>2.204000000000008E-2</c:v>
                </c:pt>
                <c:pt idx="24">
                  <c:v>1.9290000000000043E-2</c:v>
                </c:pt>
                <c:pt idx="25">
                  <c:v>1.7520000000000056E-2</c:v>
                </c:pt>
                <c:pt idx="26">
                  <c:v>2.4969999999999989E-2</c:v>
                </c:pt>
                <c:pt idx="27">
                  <c:v>1.6930000000000056E-2</c:v>
                </c:pt>
                <c:pt idx="28">
                  <c:v>2.1400000000000058E-2</c:v>
                </c:pt>
                <c:pt idx="29">
                  <c:v>2.1440000000000056E-2</c:v>
                </c:pt>
                <c:pt idx="30">
                  <c:v>2.2000000000000075E-2</c:v>
                </c:pt>
                <c:pt idx="31">
                  <c:v>2.0060000000000001E-2</c:v>
                </c:pt>
                <c:pt idx="32">
                  <c:v>1.457999999999997E-2</c:v>
                </c:pt>
                <c:pt idx="33">
                  <c:v>1.8040000000000049E-2</c:v>
                </c:pt>
                <c:pt idx="34">
                  <c:v>2.3830000000000053E-2</c:v>
                </c:pt>
                <c:pt idx="35">
                  <c:v>2.5140000000000006E-2</c:v>
                </c:pt>
                <c:pt idx="36">
                  <c:v>2.300000000000001E-2</c:v>
                </c:pt>
                <c:pt idx="37">
                  <c:v>2.0799999999999999E-2</c:v>
                </c:pt>
                <c:pt idx="38">
                  <c:v>1.9290000000000043E-2</c:v>
                </c:pt>
                <c:pt idx="39">
                  <c:v>1.7800000000000066E-2</c:v>
                </c:pt>
                <c:pt idx="40">
                  <c:v>2.0140000000000002E-2</c:v>
                </c:pt>
                <c:pt idx="41">
                  <c:v>2.435E-2</c:v>
                </c:pt>
                <c:pt idx="42">
                  <c:v>2.1759999999999998E-2</c:v>
                </c:pt>
                <c:pt idx="43">
                  <c:v>2.0240000000000011E-2</c:v>
                </c:pt>
                <c:pt idx="44">
                  <c:v>2.163000000000009E-2</c:v>
                </c:pt>
                <c:pt idx="45">
                  <c:v>2.7530000000000075E-2</c:v>
                </c:pt>
                <c:pt idx="46">
                  <c:v>2.7340000000000062E-2</c:v>
                </c:pt>
                <c:pt idx="47">
                  <c:v>2.0119999999999999E-2</c:v>
                </c:pt>
                <c:pt idx="48">
                  <c:v>2.1980000000000048E-2</c:v>
                </c:pt>
                <c:pt idx="49">
                  <c:v>2.6910000000000052E-2</c:v>
                </c:pt>
                <c:pt idx="50">
                  <c:v>2.4890000000000002E-2</c:v>
                </c:pt>
                <c:pt idx="51">
                  <c:v>2.7230000000000108E-2</c:v>
                </c:pt>
                <c:pt idx="52">
                  <c:v>2.6040000000000067E-2</c:v>
                </c:pt>
                <c:pt idx="53">
                  <c:v>2.334E-2</c:v>
                </c:pt>
                <c:pt idx="54">
                  <c:v>2.8000000000000011E-2</c:v>
                </c:pt>
                <c:pt idx="55">
                  <c:v>2.2990000000000052E-2</c:v>
                </c:pt>
                <c:pt idx="56">
                  <c:v>2.946000000000001E-2</c:v>
                </c:pt>
                <c:pt idx="57">
                  <c:v>2.7740000000000067E-2</c:v>
                </c:pt>
                <c:pt idx="58">
                  <c:v>2.930000000000001E-2</c:v>
                </c:pt>
                <c:pt idx="59">
                  <c:v>3.015000000000001E-2</c:v>
                </c:pt>
                <c:pt idx="60">
                  <c:v>3.0850000000000068E-2</c:v>
                </c:pt>
                <c:pt idx="61">
                  <c:v>2.8830000000000064E-2</c:v>
                </c:pt>
                <c:pt idx="62">
                  <c:v>2.8959999999999993E-2</c:v>
                </c:pt>
                <c:pt idx="63">
                  <c:v>3.1880000000000096E-2</c:v>
                </c:pt>
                <c:pt idx="64">
                  <c:v>3.0690000000000058E-2</c:v>
                </c:pt>
                <c:pt idx="65">
                  <c:v>3.4759999999999999E-2</c:v>
                </c:pt>
                <c:pt idx="66">
                  <c:v>3.7520000000000012E-2</c:v>
                </c:pt>
                <c:pt idx="67">
                  <c:v>3.5140000000000012E-2</c:v>
                </c:pt>
                <c:pt idx="68">
                  <c:v>3.678000000000009E-2</c:v>
                </c:pt>
                <c:pt idx="69">
                  <c:v>3.5110000000000002E-2</c:v>
                </c:pt>
                <c:pt idx="70">
                  <c:v>3.7600000000000112E-2</c:v>
                </c:pt>
                <c:pt idx="71">
                  <c:v>3.7170000000000092E-2</c:v>
                </c:pt>
                <c:pt idx="72">
                  <c:v>3.7210000000000097E-2</c:v>
                </c:pt>
                <c:pt idx="73">
                  <c:v>4.2300000000000122E-2</c:v>
                </c:pt>
                <c:pt idx="74">
                  <c:v>3.8920000000000003E-2</c:v>
                </c:pt>
                <c:pt idx="75">
                  <c:v>4.0900000000000013E-2</c:v>
                </c:pt>
                <c:pt idx="76">
                  <c:v>4.1199999999999987E-2</c:v>
                </c:pt>
                <c:pt idx="77">
                  <c:v>4.4300000000000159E-2</c:v>
                </c:pt>
                <c:pt idx="78">
                  <c:v>4.4970000000000024E-2</c:v>
                </c:pt>
                <c:pt idx="79">
                  <c:v>4.8070000000000002E-2</c:v>
                </c:pt>
                <c:pt idx="80">
                  <c:v>4.8219999999999999E-2</c:v>
                </c:pt>
                <c:pt idx="81">
                  <c:v>4.7250000000000007E-2</c:v>
                </c:pt>
                <c:pt idx="82">
                  <c:v>5.1299999999999998E-2</c:v>
                </c:pt>
                <c:pt idx="83">
                  <c:v>4.8610000000000014E-2</c:v>
                </c:pt>
                <c:pt idx="84">
                  <c:v>5.1990000000000099E-2</c:v>
                </c:pt>
                <c:pt idx="85">
                  <c:v>5.2229999999999999E-2</c:v>
                </c:pt>
                <c:pt idx="86">
                  <c:v>5.5100000000000024E-2</c:v>
                </c:pt>
                <c:pt idx="87">
                  <c:v>5.8049999999999997E-2</c:v>
                </c:pt>
                <c:pt idx="88">
                  <c:v>5.8870000000000013E-2</c:v>
                </c:pt>
                <c:pt idx="89">
                  <c:v>5.8040000000000015E-2</c:v>
                </c:pt>
                <c:pt idx="90">
                  <c:v>5.7140000000000003E-2</c:v>
                </c:pt>
                <c:pt idx="91">
                  <c:v>6.0860000000000136E-2</c:v>
                </c:pt>
                <c:pt idx="92">
                  <c:v>6.1199999999999997E-2</c:v>
                </c:pt>
                <c:pt idx="93">
                  <c:v>6.4960000000000184E-2</c:v>
                </c:pt>
                <c:pt idx="94">
                  <c:v>6.6059999999999994E-2</c:v>
                </c:pt>
                <c:pt idx="95">
                  <c:v>6.6000000000000003E-2</c:v>
                </c:pt>
                <c:pt idx="96">
                  <c:v>6.7900000000000155E-2</c:v>
                </c:pt>
                <c:pt idx="97">
                  <c:v>7.2120000000000031E-2</c:v>
                </c:pt>
                <c:pt idx="98">
                  <c:v>7.0670000000000011E-2</c:v>
                </c:pt>
                <c:pt idx="99">
                  <c:v>7.4190000000000186E-2</c:v>
                </c:pt>
                <c:pt idx="100">
                  <c:v>7.3050000000000032E-2</c:v>
                </c:pt>
                <c:pt idx="101">
                  <c:v>7.7940000000000023E-2</c:v>
                </c:pt>
                <c:pt idx="102">
                  <c:v>7.9250000000000154E-2</c:v>
                </c:pt>
                <c:pt idx="103">
                  <c:v>7.898000000000012E-2</c:v>
                </c:pt>
                <c:pt idx="104">
                  <c:v>8.2680000000000003E-2</c:v>
                </c:pt>
                <c:pt idx="105">
                  <c:v>8.278000000000002E-2</c:v>
                </c:pt>
                <c:pt idx="106">
                  <c:v>8.6500000000000229E-2</c:v>
                </c:pt>
                <c:pt idx="107">
                  <c:v>8.8430000000000064E-2</c:v>
                </c:pt>
                <c:pt idx="108">
                  <c:v>9.1570000000000068E-2</c:v>
                </c:pt>
                <c:pt idx="109">
                  <c:v>9.0470000000000023E-2</c:v>
                </c:pt>
                <c:pt idx="110">
                  <c:v>9.4130000000000227E-2</c:v>
                </c:pt>
                <c:pt idx="111">
                  <c:v>9.8760000000000361E-2</c:v>
                </c:pt>
                <c:pt idx="112">
                  <c:v>0.10011</c:v>
                </c:pt>
                <c:pt idx="113">
                  <c:v>0.10208</c:v>
                </c:pt>
                <c:pt idx="114">
                  <c:v>0.10456000000000019</c:v>
                </c:pt>
                <c:pt idx="115">
                  <c:v>0.10727000000000021</c:v>
                </c:pt>
                <c:pt idx="116">
                  <c:v>0.10956000000000021</c:v>
                </c:pt>
                <c:pt idx="117">
                  <c:v>0.11101000000000008</c:v>
                </c:pt>
                <c:pt idx="118">
                  <c:v>0.11484000000000008</c:v>
                </c:pt>
                <c:pt idx="119">
                  <c:v>0.11922000000000037</c:v>
                </c:pt>
                <c:pt idx="120">
                  <c:v>0.11974000000000025</c:v>
                </c:pt>
                <c:pt idx="121">
                  <c:v>0.12245</c:v>
                </c:pt>
                <c:pt idx="122">
                  <c:v>0.12723999999999999</c:v>
                </c:pt>
                <c:pt idx="123">
                  <c:v>0.13006999999999999</c:v>
                </c:pt>
                <c:pt idx="124">
                  <c:v>0.13324000000000039</c:v>
                </c:pt>
                <c:pt idx="125">
                  <c:v>0.13832</c:v>
                </c:pt>
                <c:pt idx="126">
                  <c:v>0.14224000000000048</c:v>
                </c:pt>
                <c:pt idx="127">
                  <c:v>0.14447000000000004</c:v>
                </c:pt>
                <c:pt idx="128">
                  <c:v>0.14888000000000001</c:v>
                </c:pt>
                <c:pt idx="129">
                  <c:v>0.15315999999999999</c:v>
                </c:pt>
                <c:pt idx="130">
                  <c:v>0.15778000000000042</c:v>
                </c:pt>
                <c:pt idx="131">
                  <c:v>0.16152000000000019</c:v>
                </c:pt>
                <c:pt idx="132">
                  <c:v>0.16635000000000019</c:v>
                </c:pt>
                <c:pt idx="133">
                  <c:v>0.17129000000000039</c:v>
                </c:pt>
                <c:pt idx="134">
                  <c:v>0.17577999999999999</c:v>
                </c:pt>
                <c:pt idx="135">
                  <c:v>0.18179000000000048</c:v>
                </c:pt>
                <c:pt idx="136">
                  <c:v>0.18589000000000042</c:v>
                </c:pt>
                <c:pt idx="137">
                  <c:v>0.19137999999999997</c:v>
                </c:pt>
                <c:pt idx="138">
                  <c:v>0.19782000000000019</c:v>
                </c:pt>
                <c:pt idx="139">
                  <c:v>0.20258000000000001</c:v>
                </c:pt>
                <c:pt idx="140">
                  <c:v>0.21015</c:v>
                </c:pt>
                <c:pt idx="141">
                  <c:v>0.21544000000000063</c:v>
                </c:pt>
                <c:pt idx="142">
                  <c:v>0.22153000000000025</c:v>
                </c:pt>
                <c:pt idx="143">
                  <c:v>0.22755000000000022</c:v>
                </c:pt>
                <c:pt idx="144">
                  <c:v>0.23380999999999999</c:v>
                </c:pt>
                <c:pt idx="145">
                  <c:v>0.23971000000000048</c:v>
                </c:pt>
                <c:pt idx="146">
                  <c:v>0.24567</c:v>
                </c:pt>
                <c:pt idx="147">
                  <c:v>0.25394</c:v>
                </c:pt>
                <c:pt idx="148">
                  <c:v>0.26229999999999998</c:v>
                </c:pt>
                <c:pt idx="149">
                  <c:v>0.26867000000000002</c:v>
                </c:pt>
                <c:pt idx="150">
                  <c:v>0.27605000000000002</c:v>
                </c:pt>
                <c:pt idx="151">
                  <c:v>0.28403</c:v>
                </c:pt>
                <c:pt idx="152">
                  <c:v>0.2917900000000001</c:v>
                </c:pt>
                <c:pt idx="153">
                  <c:v>0.30011000000000032</c:v>
                </c:pt>
                <c:pt idx="154">
                  <c:v>0.30703000000000008</c:v>
                </c:pt>
                <c:pt idx="155">
                  <c:v>0.31485000000000102</c:v>
                </c:pt>
                <c:pt idx="156">
                  <c:v>0.32237000000000143</c:v>
                </c:pt>
                <c:pt idx="157">
                  <c:v>0.33010000000000089</c:v>
                </c:pt>
                <c:pt idx="158">
                  <c:v>0.3380400000000009</c:v>
                </c:pt>
                <c:pt idx="159">
                  <c:v>0.34516000000000052</c:v>
                </c:pt>
                <c:pt idx="160">
                  <c:v>0.3538100000000009</c:v>
                </c:pt>
                <c:pt idx="161">
                  <c:v>0.36190000000000078</c:v>
                </c:pt>
                <c:pt idx="162">
                  <c:v>0.36954000000000031</c:v>
                </c:pt>
                <c:pt idx="163">
                  <c:v>0.37802000000000102</c:v>
                </c:pt>
                <c:pt idx="164">
                  <c:v>0.38621000000000077</c:v>
                </c:pt>
                <c:pt idx="165">
                  <c:v>0.39389000000000102</c:v>
                </c:pt>
                <c:pt idx="166">
                  <c:v>0.40180000000000032</c:v>
                </c:pt>
                <c:pt idx="167">
                  <c:v>0.40945000000000031</c:v>
                </c:pt>
                <c:pt idx="168">
                  <c:v>0.41738000000000114</c:v>
                </c:pt>
                <c:pt idx="169">
                  <c:v>0.42628000000000038</c:v>
                </c:pt>
                <c:pt idx="170">
                  <c:v>0.4339000000000009</c:v>
                </c:pt>
                <c:pt idx="171">
                  <c:v>0.44151000000000051</c:v>
                </c:pt>
                <c:pt idx="172">
                  <c:v>0.45052000000000031</c:v>
                </c:pt>
                <c:pt idx="173">
                  <c:v>0.45893</c:v>
                </c:pt>
                <c:pt idx="174">
                  <c:v>0.46650000000000008</c:v>
                </c:pt>
                <c:pt idx="175">
                  <c:v>0.47554000000000002</c:v>
                </c:pt>
                <c:pt idx="176">
                  <c:v>0.48325000000000001</c:v>
                </c:pt>
                <c:pt idx="177">
                  <c:v>0.49123</c:v>
                </c:pt>
                <c:pt idx="178">
                  <c:v>0.50012999999999996</c:v>
                </c:pt>
                <c:pt idx="179">
                  <c:v>0.50882000000000005</c:v>
                </c:pt>
                <c:pt idx="180">
                  <c:v>0.51707000000000003</c:v>
                </c:pt>
                <c:pt idx="181">
                  <c:v>0.52639000000000002</c:v>
                </c:pt>
                <c:pt idx="182">
                  <c:v>0.53527999999999998</c:v>
                </c:pt>
                <c:pt idx="183">
                  <c:v>0.54476999999999998</c:v>
                </c:pt>
                <c:pt idx="184">
                  <c:v>0.55422000000000005</c:v>
                </c:pt>
                <c:pt idx="185">
                  <c:v>0.56403000000000003</c:v>
                </c:pt>
                <c:pt idx="186">
                  <c:v>0.57435999999999998</c:v>
                </c:pt>
                <c:pt idx="187">
                  <c:v>0.58458999999999872</c:v>
                </c:pt>
                <c:pt idx="188">
                  <c:v>0.59455999999999909</c:v>
                </c:pt>
                <c:pt idx="189">
                  <c:v>0.60601000000000005</c:v>
                </c:pt>
                <c:pt idx="190">
                  <c:v>0.61668000000000178</c:v>
                </c:pt>
                <c:pt idx="191">
                  <c:v>0.62781000000000065</c:v>
                </c:pt>
                <c:pt idx="192">
                  <c:v>0.64035000000000064</c:v>
                </c:pt>
                <c:pt idx="193">
                  <c:v>0.65276000000000178</c:v>
                </c:pt>
                <c:pt idx="194">
                  <c:v>0.66405000000000203</c:v>
                </c:pt>
                <c:pt idx="195">
                  <c:v>0.67740000000000178</c:v>
                </c:pt>
                <c:pt idx="196">
                  <c:v>0.68997000000000175</c:v>
                </c:pt>
                <c:pt idx="197">
                  <c:v>0.70323999999999998</c:v>
                </c:pt>
                <c:pt idx="198">
                  <c:v>0.71679000000000204</c:v>
                </c:pt>
                <c:pt idx="199">
                  <c:v>0.73071000000000064</c:v>
                </c:pt>
                <c:pt idx="200">
                  <c:v>0.74491000000000063</c:v>
                </c:pt>
                <c:pt idx="201">
                  <c:v>0.76014000000000204</c:v>
                </c:pt>
                <c:pt idx="202">
                  <c:v>0.77594000000000163</c:v>
                </c:pt>
                <c:pt idx="203">
                  <c:v>0.79117000000000004</c:v>
                </c:pt>
                <c:pt idx="204">
                  <c:v>0.80864000000000202</c:v>
                </c:pt>
                <c:pt idx="205">
                  <c:v>0.82550000000000001</c:v>
                </c:pt>
                <c:pt idx="206">
                  <c:v>0.84419999999999995</c:v>
                </c:pt>
                <c:pt idx="207">
                  <c:v>0.86284000000000205</c:v>
                </c:pt>
                <c:pt idx="208">
                  <c:v>0.88290000000000102</c:v>
                </c:pt>
                <c:pt idx="209">
                  <c:v>0.90310000000000001</c:v>
                </c:pt>
                <c:pt idx="210">
                  <c:v>0.92762000000000167</c:v>
                </c:pt>
                <c:pt idx="211">
                  <c:v>0.95081000000000004</c:v>
                </c:pt>
                <c:pt idx="212">
                  <c:v>0.97390000000000065</c:v>
                </c:pt>
                <c:pt idx="213">
                  <c:v>1.0012799999999968</c:v>
                </c:pt>
                <c:pt idx="214">
                  <c:v>1.02878</c:v>
                </c:pt>
                <c:pt idx="215">
                  <c:v>1.05884</c:v>
                </c:pt>
                <c:pt idx="216">
                  <c:v>1.08874</c:v>
                </c:pt>
                <c:pt idx="217">
                  <c:v>1.11711</c:v>
                </c:pt>
                <c:pt idx="218">
                  <c:v>1.1520999999999999</c:v>
                </c:pt>
                <c:pt idx="219">
                  <c:v>1.18161</c:v>
                </c:pt>
                <c:pt idx="220">
                  <c:v>1.2115099999999965</c:v>
                </c:pt>
                <c:pt idx="221">
                  <c:v>1.2491399999999966</c:v>
                </c:pt>
                <c:pt idx="222">
                  <c:v>1.28138</c:v>
                </c:pt>
                <c:pt idx="223">
                  <c:v>1.3153299999999968</c:v>
                </c:pt>
                <c:pt idx="224">
                  <c:v>1.3554299999999966</c:v>
                </c:pt>
                <c:pt idx="225">
                  <c:v>1.3941100000000031</c:v>
                </c:pt>
                <c:pt idx="226">
                  <c:v>1.4381899999999999</c:v>
                </c:pt>
                <c:pt idx="227">
                  <c:v>1.49491</c:v>
                </c:pt>
                <c:pt idx="228">
                  <c:v>1.54941</c:v>
                </c:pt>
                <c:pt idx="229">
                  <c:v>1.6231</c:v>
                </c:pt>
                <c:pt idx="230">
                  <c:v>1.7248399999999984</c:v>
                </c:pt>
                <c:pt idx="231">
                  <c:v>1.84711</c:v>
                </c:pt>
                <c:pt idx="232">
                  <c:v>2.0216699999999967</c:v>
                </c:pt>
                <c:pt idx="233">
                  <c:v>2.2789700000000002</c:v>
                </c:pt>
                <c:pt idx="234">
                  <c:v>2.5878299999999999</c:v>
                </c:pt>
                <c:pt idx="235">
                  <c:v>2.916719999999994</c:v>
                </c:pt>
                <c:pt idx="236">
                  <c:v>3.19597</c:v>
                </c:pt>
                <c:pt idx="237">
                  <c:v>3.51532</c:v>
                </c:pt>
                <c:pt idx="238">
                  <c:v>3.3766399999999925</c:v>
                </c:pt>
                <c:pt idx="239">
                  <c:v>3.3872200000000001</c:v>
                </c:pt>
                <c:pt idx="240">
                  <c:v>3.4695</c:v>
                </c:pt>
                <c:pt idx="241">
                  <c:v>3.5060199999999977</c:v>
                </c:pt>
                <c:pt idx="242">
                  <c:v>3.6666399999999997</c:v>
                </c:pt>
                <c:pt idx="243">
                  <c:v>3.854659999999992</c:v>
                </c:pt>
                <c:pt idx="244">
                  <c:v>3.7082799999999998</c:v>
                </c:pt>
                <c:pt idx="245">
                  <c:v>3.8114499999999869</c:v>
                </c:pt>
                <c:pt idx="246">
                  <c:v>4.0556599999999996</c:v>
                </c:pt>
                <c:pt idx="247">
                  <c:v>4.0584899999999955</c:v>
                </c:pt>
                <c:pt idx="248">
                  <c:v>4.0690999999999997</c:v>
                </c:pt>
                <c:pt idx="249">
                  <c:v>4.4164099999999999</c:v>
                </c:pt>
                <c:pt idx="250">
                  <c:v>4.1652799999999965</c:v>
                </c:pt>
                <c:pt idx="251">
                  <c:v>3.9983300000000002</c:v>
                </c:pt>
                <c:pt idx="252">
                  <c:v>4.6145599999999813</c:v>
                </c:pt>
                <c:pt idx="253">
                  <c:v>5.0000099999999996</c:v>
                </c:pt>
                <c:pt idx="254">
                  <c:v>3.949659999999994</c:v>
                </c:pt>
                <c:pt idx="255">
                  <c:v>3.8420799999999939</c:v>
                </c:pt>
                <c:pt idx="256">
                  <c:v>3.7841200000000081</c:v>
                </c:pt>
                <c:pt idx="257">
                  <c:v>3.5737100000000002</c:v>
                </c:pt>
                <c:pt idx="258">
                  <c:v>3.5047999999999999</c:v>
                </c:pt>
                <c:pt idx="259">
                  <c:v>3.2550300000000001</c:v>
                </c:pt>
                <c:pt idx="260">
                  <c:v>3.05159</c:v>
                </c:pt>
                <c:pt idx="261">
                  <c:v>2.84822</c:v>
                </c:pt>
                <c:pt idx="262">
                  <c:v>2.5725399999999987</c:v>
                </c:pt>
                <c:pt idx="263">
                  <c:v>2.27217</c:v>
                </c:pt>
                <c:pt idx="264">
                  <c:v>1.97729</c:v>
                </c:pt>
                <c:pt idx="265">
                  <c:v>1.5693699999999968</c:v>
                </c:pt>
                <c:pt idx="266">
                  <c:v>1.1600400000000031</c:v>
                </c:pt>
                <c:pt idx="267">
                  <c:v>0.92174000000000178</c:v>
                </c:pt>
                <c:pt idx="268">
                  <c:v>0.76173000000000179</c:v>
                </c:pt>
                <c:pt idx="269">
                  <c:v>0.69500000000000151</c:v>
                </c:pt>
                <c:pt idx="270">
                  <c:v>0.6947000000000022</c:v>
                </c:pt>
                <c:pt idx="271">
                  <c:v>0.69027000000000127</c:v>
                </c:pt>
                <c:pt idx="272">
                  <c:v>0.65112000000000203</c:v>
                </c:pt>
                <c:pt idx="273">
                  <c:v>0.63528000000000062</c:v>
                </c:pt>
                <c:pt idx="274">
                  <c:v>0.62278999999999995</c:v>
                </c:pt>
                <c:pt idx="275">
                  <c:v>0.60241999999999996</c:v>
                </c:pt>
                <c:pt idx="276">
                  <c:v>0.58975999999999951</c:v>
                </c:pt>
                <c:pt idx="277">
                  <c:v>0.58252999999999922</c:v>
                </c:pt>
                <c:pt idx="278">
                  <c:v>0.55730000000000002</c:v>
                </c:pt>
                <c:pt idx="279">
                  <c:v>0.56391999999999998</c:v>
                </c:pt>
                <c:pt idx="280">
                  <c:v>0.55042000000000002</c:v>
                </c:pt>
                <c:pt idx="281">
                  <c:v>0.55139000000000005</c:v>
                </c:pt>
                <c:pt idx="282">
                  <c:v>0.55386000000000002</c:v>
                </c:pt>
                <c:pt idx="283">
                  <c:v>0.54459000000000002</c:v>
                </c:pt>
                <c:pt idx="284">
                  <c:v>0.53385000000000005</c:v>
                </c:pt>
                <c:pt idx="285">
                  <c:v>0.52100999999999997</c:v>
                </c:pt>
                <c:pt idx="286">
                  <c:v>0.51339000000000001</c:v>
                </c:pt>
                <c:pt idx="287">
                  <c:v>0.53073999999999999</c:v>
                </c:pt>
                <c:pt idx="288">
                  <c:v>0.54490000000000005</c:v>
                </c:pt>
                <c:pt idx="289">
                  <c:v>0.51887000000000005</c:v>
                </c:pt>
                <c:pt idx="290">
                  <c:v>0.49774000000000002</c:v>
                </c:pt>
                <c:pt idx="291">
                  <c:v>0.54627999999999999</c:v>
                </c:pt>
                <c:pt idx="292">
                  <c:v>0.55147000000000002</c:v>
                </c:pt>
                <c:pt idx="293">
                  <c:v>0.60684000000000204</c:v>
                </c:pt>
                <c:pt idx="294">
                  <c:v>0.59379000000000104</c:v>
                </c:pt>
                <c:pt idx="295">
                  <c:v>0.64661000000000179</c:v>
                </c:pt>
                <c:pt idx="296">
                  <c:v>0.56932000000000005</c:v>
                </c:pt>
                <c:pt idx="297">
                  <c:v>0.54986999999999997</c:v>
                </c:pt>
                <c:pt idx="298">
                  <c:v>0.56833</c:v>
                </c:pt>
                <c:pt idx="299">
                  <c:v>0.60198000000000063</c:v>
                </c:pt>
                <c:pt idx="300">
                  <c:v>0.52720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E01B-4127-A621-24501A84C0B5}"/>
            </c:ext>
          </c:extLst>
        </c:ser>
        <c:ser>
          <c:idx val="5"/>
          <c:order val="5"/>
          <c:tx>
            <c:strRef>
              <c:f>Feuil1!$G$1</c:f>
              <c:strCache>
                <c:ptCount val="1"/>
                <c:pt idx="0">
                  <c:v>4.5 mM HBT</c:v>
                </c:pt>
              </c:strCache>
            </c:strRef>
          </c:tx>
          <c:spPr>
            <a:ln w="12700">
              <a:solidFill>
                <a:srgbClr val="339966"/>
              </a:solidFill>
              <a:prstDash val="solid"/>
            </a:ln>
          </c:spPr>
          <c:marker>
            <c:symbol val="none"/>
          </c:marker>
          <c:xVal>
            <c:numRef>
              <c:f>Feuil1!$A$2:$A$302</c:f>
              <c:numCache>
                <c:formatCode>General</c:formatCode>
                <c:ptCount val="301"/>
                <c:pt idx="0">
                  <c:v>800</c:v>
                </c:pt>
                <c:pt idx="1">
                  <c:v>798</c:v>
                </c:pt>
                <c:pt idx="2">
                  <c:v>796</c:v>
                </c:pt>
                <c:pt idx="3">
                  <c:v>794</c:v>
                </c:pt>
                <c:pt idx="4">
                  <c:v>792</c:v>
                </c:pt>
                <c:pt idx="5">
                  <c:v>790</c:v>
                </c:pt>
                <c:pt idx="6">
                  <c:v>788</c:v>
                </c:pt>
                <c:pt idx="7">
                  <c:v>786</c:v>
                </c:pt>
                <c:pt idx="8">
                  <c:v>784</c:v>
                </c:pt>
                <c:pt idx="9">
                  <c:v>782</c:v>
                </c:pt>
                <c:pt idx="10">
                  <c:v>780</c:v>
                </c:pt>
                <c:pt idx="11">
                  <c:v>778</c:v>
                </c:pt>
                <c:pt idx="12">
                  <c:v>776</c:v>
                </c:pt>
                <c:pt idx="13">
                  <c:v>774</c:v>
                </c:pt>
                <c:pt idx="14">
                  <c:v>772</c:v>
                </c:pt>
                <c:pt idx="15">
                  <c:v>770</c:v>
                </c:pt>
                <c:pt idx="16">
                  <c:v>768</c:v>
                </c:pt>
                <c:pt idx="17">
                  <c:v>766</c:v>
                </c:pt>
                <c:pt idx="18">
                  <c:v>764</c:v>
                </c:pt>
                <c:pt idx="19">
                  <c:v>762</c:v>
                </c:pt>
                <c:pt idx="20">
                  <c:v>760</c:v>
                </c:pt>
                <c:pt idx="21">
                  <c:v>758</c:v>
                </c:pt>
                <c:pt idx="22">
                  <c:v>756</c:v>
                </c:pt>
                <c:pt idx="23">
                  <c:v>754</c:v>
                </c:pt>
                <c:pt idx="24">
                  <c:v>752</c:v>
                </c:pt>
                <c:pt idx="25">
                  <c:v>750</c:v>
                </c:pt>
                <c:pt idx="26">
                  <c:v>748</c:v>
                </c:pt>
                <c:pt idx="27">
                  <c:v>746</c:v>
                </c:pt>
                <c:pt idx="28">
                  <c:v>744</c:v>
                </c:pt>
                <c:pt idx="29">
                  <c:v>742</c:v>
                </c:pt>
                <c:pt idx="30">
                  <c:v>740</c:v>
                </c:pt>
                <c:pt idx="31">
                  <c:v>738</c:v>
                </c:pt>
                <c:pt idx="32">
                  <c:v>736</c:v>
                </c:pt>
                <c:pt idx="33">
                  <c:v>734</c:v>
                </c:pt>
                <c:pt idx="34">
                  <c:v>732</c:v>
                </c:pt>
                <c:pt idx="35">
                  <c:v>730</c:v>
                </c:pt>
                <c:pt idx="36">
                  <c:v>728</c:v>
                </c:pt>
                <c:pt idx="37">
                  <c:v>726</c:v>
                </c:pt>
                <c:pt idx="38">
                  <c:v>724</c:v>
                </c:pt>
                <c:pt idx="39">
                  <c:v>722</c:v>
                </c:pt>
                <c:pt idx="40">
                  <c:v>720</c:v>
                </c:pt>
                <c:pt idx="41">
                  <c:v>718</c:v>
                </c:pt>
                <c:pt idx="42">
                  <c:v>716</c:v>
                </c:pt>
                <c:pt idx="43">
                  <c:v>714</c:v>
                </c:pt>
                <c:pt idx="44">
                  <c:v>712</c:v>
                </c:pt>
                <c:pt idx="45">
                  <c:v>710</c:v>
                </c:pt>
                <c:pt idx="46">
                  <c:v>708</c:v>
                </c:pt>
                <c:pt idx="47">
                  <c:v>706</c:v>
                </c:pt>
                <c:pt idx="48">
                  <c:v>704</c:v>
                </c:pt>
                <c:pt idx="49">
                  <c:v>702</c:v>
                </c:pt>
                <c:pt idx="50">
                  <c:v>700</c:v>
                </c:pt>
                <c:pt idx="51">
                  <c:v>698</c:v>
                </c:pt>
                <c:pt idx="52">
                  <c:v>696</c:v>
                </c:pt>
                <c:pt idx="53">
                  <c:v>694</c:v>
                </c:pt>
                <c:pt idx="54">
                  <c:v>692</c:v>
                </c:pt>
                <c:pt idx="55">
                  <c:v>690</c:v>
                </c:pt>
                <c:pt idx="56">
                  <c:v>688</c:v>
                </c:pt>
                <c:pt idx="57">
                  <c:v>686</c:v>
                </c:pt>
                <c:pt idx="58">
                  <c:v>684</c:v>
                </c:pt>
                <c:pt idx="59">
                  <c:v>682</c:v>
                </c:pt>
                <c:pt idx="60">
                  <c:v>680</c:v>
                </c:pt>
                <c:pt idx="61">
                  <c:v>678</c:v>
                </c:pt>
                <c:pt idx="62">
                  <c:v>676</c:v>
                </c:pt>
                <c:pt idx="63">
                  <c:v>674</c:v>
                </c:pt>
                <c:pt idx="64">
                  <c:v>672</c:v>
                </c:pt>
                <c:pt idx="65">
                  <c:v>670</c:v>
                </c:pt>
                <c:pt idx="66">
                  <c:v>668</c:v>
                </c:pt>
                <c:pt idx="67">
                  <c:v>666</c:v>
                </c:pt>
                <c:pt idx="68">
                  <c:v>664</c:v>
                </c:pt>
                <c:pt idx="69">
                  <c:v>662</c:v>
                </c:pt>
                <c:pt idx="70">
                  <c:v>660</c:v>
                </c:pt>
                <c:pt idx="71">
                  <c:v>658</c:v>
                </c:pt>
                <c:pt idx="72">
                  <c:v>656</c:v>
                </c:pt>
                <c:pt idx="73">
                  <c:v>654</c:v>
                </c:pt>
                <c:pt idx="74">
                  <c:v>652</c:v>
                </c:pt>
                <c:pt idx="75">
                  <c:v>650</c:v>
                </c:pt>
                <c:pt idx="76">
                  <c:v>648</c:v>
                </c:pt>
                <c:pt idx="77">
                  <c:v>646</c:v>
                </c:pt>
                <c:pt idx="78">
                  <c:v>644</c:v>
                </c:pt>
                <c:pt idx="79">
                  <c:v>642</c:v>
                </c:pt>
                <c:pt idx="80">
                  <c:v>640</c:v>
                </c:pt>
                <c:pt idx="81">
                  <c:v>638</c:v>
                </c:pt>
                <c:pt idx="82">
                  <c:v>636</c:v>
                </c:pt>
                <c:pt idx="83">
                  <c:v>634</c:v>
                </c:pt>
                <c:pt idx="84">
                  <c:v>632</c:v>
                </c:pt>
                <c:pt idx="85">
                  <c:v>630</c:v>
                </c:pt>
                <c:pt idx="86">
                  <c:v>628</c:v>
                </c:pt>
                <c:pt idx="87">
                  <c:v>626</c:v>
                </c:pt>
                <c:pt idx="88">
                  <c:v>624</c:v>
                </c:pt>
                <c:pt idx="89">
                  <c:v>622</c:v>
                </c:pt>
                <c:pt idx="90">
                  <c:v>620</c:v>
                </c:pt>
                <c:pt idx="91">
                  <c:v>618</c:v>
                </c:pt>
                <c:pt idx="92">
                  <c:v>616</c:v>
                </c:pt>
                <c:pt idx="93">
                  <c:v>614</c:v>
                </c:pt>
                <c:pt idx="94">
                  <c:v>612</c:v>
                </c:pt>
                <c:pt idx="95">
                  <c:v>610</c:v>
                </c:pt>
                <c:pt idx="96">
                  <c:v>608</c:v>
                </c:pt>
                <c:pt idx="97">
                  <c:v>606</c:v>
                </c:pt>
                <c:pt idx="98">
                  <c:v>604</c:v>
                </c:pt>
                <c:pt idx="99">
                  <c:v>602</c:v>
                </c:pt>
                <c:pt idx="100">
                  <c:v>600</c:v>
                </c:pt>
                <c:pt idx="101">
                  <c:v>598</c:v>
                </c:pt>
                <c:pt idx="102">
                  <c:v>596</c:v>
                </c:pt>
                <c:pt idx="103">
                  <c:v>594</c:v>
                </c:pt>
                <c:pt idx="104">
                  <c:v>592</c:v>
                </c:pt>
                <c:pt idx="105">
                  <c:v>590</c:v>
                </c:pt>
                <c:pt idx="106">
                  <c:v>588</c:v>
                </c:pt>
                <c:pt idx="107">
                  <c:v>586</c:v>
                </c:pt>
                <c:pt idx="108">
                  <c:v>584</c:v>
                </c:pt>
                <c:pt idx="109">
                  <c:v>582</c:v>
                </c:pt>
                <c:pt idx="110">
                  <c:v>580</c:v>
                </c:pt>
                <c:pt idx="111">
                  <c:v>578</c:v>
                </c:pt>
                <c:pt idx="112">
                  <c:v>576</c:v>
                </c:pt>
                <c:pt idx="113">
                  <c:v>574</c:v>
                </c:pt>
                <c:pt idx="114">
                  <c:v>572</c:v>
                </c:pt>
                <c:pt idx="115">
                  <c:v>570</c:v>
                </c:pt>
                <c:pt idx="116">
                  <c:v>568</c:v>
                </c:pt>
                <c:pt idx="117">
                  <c:v>566</c:v>
                </c:pt>
                <c:pt idx="118">
                  <c:v>564</c:v>
                </c:pt>
                <c:pt idx="119">
                  <c:v>562</c:v>
                </c:pt>
                <c:pt idx="120">
                  <c:v>560</c:v>
                </c:pt>
                <c:pt idx="121">
                  <c:v>558</c:v>
                </c:pt>
                <c:pt idx="122">
                  <c:v>556</c:v>
                </c:pt>
                <c:pt idx="123">
                  <c:v>554</c:v>
                </c:pt>
                <c:pt idx="124">
                  <c:v>552</c:v>
                </c:pt>
                <c:pt idx="125">
                  <c:v>550</c:v>
                </c:pt>
                <c:pt idx="126">
                  <c:v>548</c:v>
                </c:pt>
                <c:pt idx="127">
                  <c:v>546</c:v>
                </c:pt>
                <c:pt idx="128">
                  <c:v>544</c:v>
                </c:pt>
                <c:pt idx="129">
                  <c:v>542</c:v>
                </c:pt>
                <c:pt idx="130">
                  <c:v>540</c:v>
                </c:pt>
                <c:pt idx="131">
                  <c:v>538</c:v>
                </c:pt>
                <c:pt idx="132">
                  <c:v>536</c:v>
                </c:pt>
                <c:pt idx="133">
                  <c:v>534</c:v>
                </c:pt>
                <c:pt idx="134">
                  <c:v>532</c:v>
                </c:pt>
                <c:pt idx="135">
                  <c:v>530</c:v>
                </c:pt>
                <c:pt idx="136">
                  <c:v>528</c:v>
                </c:pt>
                <c:pt idx="137">
                  <c:v>526</c:v>
                </c:pt>
                <c:pt idx="138">
                  <c:v>524</c:v>
                </c:pt>
                <c:pt idx="139">
                  <c:v>522</c:v>
                </c:pt>
                <c:pt idx="140">
                  <c:v>520</c:v>
                </c:pt>
                <c:pt idx="141">
                  <c:v>518</c:v>
                </c:pt>
                <c:pt idx="142">
                  <c:v>516</c:v>
                </c:pt>
                <c:pt idx="143">
                  <c:v>514</c:v>
                </c:pt>
                <c:pt idx="144">
                  <c:v>512</c:v>
                </c:pt>
                <c:pt idx="145">
                  <c:v>510</c:v>
                </c:pt>
                <c:pt idx="146">
                  <c:v>508</c:v>
                </c:pt>
                <c:pt idx="147">
                  <c:v>506</c:v>
                </c:pt>
                <c:pt idx="148">
                  <c:v>504</c:v>
                </c:pt>
                <c:pt idx="149">
                  <c:v>502</c:v>
                </c:pt>
                <c:pt idx="150">
                  <c:v>500</c:v>
                </c:pt>
                <c:pt idx="151">
                  <c:v>498</c:v>
                </c:pt>
                <c:pt idx="152">
                  <c:v>496</c:v>
                </c:pt>
                <c:pt idx="153">
                  <c:v>494</c:v>
                </c:pt>
                <c:pt idx="154">
                  <c:v>492</c:v>
                </c:pt>
                <c:pt idx="155">
                  <c:v>490</c:v>
                </c:pt>
                <c:pt idx="156">
                  <c:v>488</c:v>
                </c:pt>
                <c:pt idx="157">
                  <c:v>486</c:v>
                </c:pt>
                <c:pt idx="158">
                  <c:v>484</c:v>
                </c:pt>
                <c:pt idx="159">
                  <c:v>482</c:v>
                </c:pt>
                <c:pt idx="160">
                  <c:v>480</c:v>
                </c:pt>
                <c:pt idx="161">
                  <c:v>478</c:v>
                </c:pt>
                <c:pt idx="162">
                  <c:v>476</c:v>
                </c:pt>
                <c:pt idx="163">
                  <c:v>474</c:v>
                </c:pt>
                <c:pt idx="164">
                  <c:v>472</c:v>
                </c:pt>
                <c:pt idx="165">
                  <c:v>470</c:v>
                </c:pt>
                <c:pt idx="166">
                  <c:v>468</c:v>
                </c:pt>
                <c:pt idx="167">
                  <c:v>466</c:v>
                </c:pt>
                <c:pt idx="168">
                  <c:v>464</c:v>
                </c:pt>
                <c:pt idx="169">
                  <c:v>462</c:v>
                </c:pt>
                <c:pt idx="170">
                  <c:v>460</c:v>
                </c:pt>
                <c:pt idx="171">
                  <c:v>458</c:v>
                </c:pt>
                <c:pt idx="172">
                  <c:v>456</c:v>
                </c:pt>
                <c:pt idx="173">
                  <c:v>454</c:v>
                </c:pt>
                <c:pt idx="174">
                  <c:v>452</c:v>
                </c:pt>
                <c:pt idx="175">
                  <c:v>450</c:v>
                </c:pt>
                <c:pt idx="176">
                  <c:v>448</c:v>
                </c:pt>
                <c:pt idx="177">
                  <c:v>446</c:v>
                </c:pt>
                <c:pt idx="178">
                  <c:v>444</c:v>
                </c:pt>
                <c:pt idx="179">
                  <c:v>442</c:v>
                </c:pt>
                <c:pt idx="180">
                  <c:v>440</c:v>
                </c:pt>
                <c:pt idx="181">
                  <c:v>438</c:v>
                </c:pt>
                <c:pt idx="182">
                  <c:v>436</c:v>
                </c:pt>
                <c:pt idx="183">
                  <c:v>434</c:v>
                </c:pt>
                <c:pt idx="184">
                  <c:v>432</c:v>
                </c:pt>
                <c:pt idx="185">
                  <c:v>430</c:v>
                </c:pt>
                <c:pt idx="186">
                  <c:v>428</c:v>
                </c:pt>
                <c:pt idx="187">
                  <c:v>426</c:v>
                </c:pt>
                <c:pt idx="188">
                  <c:v>424</c:v>
                </c:pt>
                <c:pt idx="189">
                  <c:v>422</c:v>
                </c:pt>
                <c:pt idx="190">
                  <c:v>420</c:v>
                </c:pt>
                <c:pt idx="191">
                  <c:v>418</c:v>
                </c:pt>
                <c:pt idx="192">
                  <c:v>416</c:v>
                </c:pt>
                <c:pt idx="193">
                  <c:v>414</c:v>
                </c:pt>
                <c:pt idx="194">
                  <c:v>412</c:v>
                </c:pt>
                <c:pt idx="195">
                  <c:v>410</c:v>
                </c:pt>
                <c:pt idx="196">
                  <c:v>408</c:v>
                </c:pt>
                <c:pt idx="197">
                  <c:v>406</c:v>
                </c:pt>
                <c:pt idx="198">
                  <c:v>404</c:v>
                </c:pt>
                <c:pt idx="199">
                  <c:v>402</c:v>
                </c:pt>
                <c:pt idx="200">
                  <c:v>400</c:v>
                </c:pt>
                <c:pt idx="201">
                  <c:v>398</c:v>
                </c:pt>
                <c:pt idx="202">
                  <c:v>396</c:v>
                </c:pt>
                <c:pt idx="203">
                  <c:v>394</c:v>
                </c:pt>
                <c:pt idx="204">
                  <c:v>392</c:v>
                </c:pt>
                <c:pt idx="205">
                  <c:v>390</c:v>
                </c:pt>
                <c:pt idx="206">
                  <c:v>388</c:v>
                </c:pt>
                <c:pt idx="207">
                  <c:v>386</c:v>
                </c:pt>
                <c:pt idx="208">
                  <c:v>384</c:v>
                </c:pt>
                <c:pt idx="209">
                  <c:v>382</c:v>
                </c:pt>
                <c:pt idx="210">
                  <c:v>380</c:v>
                </c:pt>
                <c:pt idx="211">
                  <c:v>378</c:v>
                </c:pt>
                <c:pt idx="212">
                  <c:v>376</c:v>
                </c:pt>
                <c:pt idx="213">
                  <c:v>374</c:v>
                </c:pt>
                <c:pt idx="214">
                  <c:v>372</c:v>
                </c:pt>
                <c:pt idx="215">
                  <c:v>370</c:v>
                </c:pt>
                <c:pt idx="216">
                  <c:v>368</c:v>
                </c:pt>
                <c:pt idx="217">
                  <c:v>366</c:v>
                </c:pt>
                <c:pt idx="218">
                  <c:v>364</c:v>
                </c:pt>
                <c:pt idx="219">
                  <c:v>362</c:v>
                </c:pt>
                <c:pt idx="220">
                  <c:v>360</c:v>
                </c:pt>
                <c:pt idx="221">
                  <c:v>358</c:v>
                </c:pt>
                <c:pt idx="222">
                  <c:v>356</c:v>
                </c:pt>
                <c:pt idx="223">
                  <c:v>354</c:v>
                </c:pt>
                <c:pt idx="224">
                  <c:v>352</c:v>
                </c:pt>
                <c:pt idx="225">
                  <c:v>350</c:v>
                </c:pt>
                <c:pt idx="226">
                  <c:v>348</c:v>
                </c:pt>
                <c:pt idx="227">
                  <c:v>346</c:v>
                </c:pt>
                <c:pt idx="228">
                  <c:v>344</c:v>
                </c:pt>
                <c:pt idx="229">
                  <c:v>342</c:v>
                </c:pt>
                <c:pt idx="230">
                  <c:v>340</c:v>
                </c:pt>
                <c:pt idx="231">
                  <c:v>338</c:v>
                </c:pt>
                <c:pt idx="232">
                  <c:v>336</c:v>
                </c:pt>
                <c:pt idx="233">
                  <c:v>334</c:v>
                </c:pt>
                <c:pt idx="234">
                  <c:v>332</c:v>
                </c:pt>
                <c:pt idx="235">
                  <c:v>330</c:v>
                </c:pt>
                <c:pt idx="236">
                  <c:v>328</c:v>
                </c:pt>
                <c:pt idx="237">
                  <c:v>326</c:v>
                </c:pt>
                <c:pt idx="238">
                  <c:v>324</c:v>
                </c:pt>
                <c:pt idx="239">
                  <c:v>322</c:v>
                </c:pt>
                <c:pt idx="240">
                  <c:v>320</c:v>
                </c:pt>
                <c:pt idx="241">
                  <c:v>318</c:v>
                </c:pt>
                <c:pt idx="242">
                  <c:v>316</c:v>
                </c:pt>
                <c:pt idx="243">
                  <c:v>314</c:v>
                </c:pt>
                <c:pt idx="244">
                  <c:v>312</c:v>
                </c:pt>
                <c:pt idx="245">
                  <c:v>310</c:v>
                </c:pt>
                <c:pt idx="246">
                  <c:v>308</c:v>
                </c:pt>
                <c:pt idx="247">
                  <c:v>306</c:v>
                </c:pt>
                <c:pt idx="248">
                  <c:v>304</c:v>
                </c:pt>
                <c:pt idx="249">
                  <c:v>302</c:v>
                </c:pt>
                <c:pt idx="250">
                  <c:v>300</c:v>
                </c:pt>
                <c:pt idx="251">
                  <c:v>298</c:v>
                </c:pt>
                <c:pt idx="252">
                  <c:v>296</c:v>
                </c:pt>
                <c:pt idx="253">
                  <c:v>294</c:v>
                </c:pt>
                <c:pt idx="254">
                  <c:v>292</c:v>
                </c:pt>
                <c:pt idx="255">
                  <c:v>290</c:v>
                </c:pt>
                <c:pt idx="256">
                  <c:v>288</c:v>
                </c:pt>
                <c:pt idx="257">
                  <c:v>286</c:v>
                </c:pt>
                <c:pt idx="258">
                  <c:v>284</c:v>
                </c:pt>
                <c:pt idx="259">
                  <c:v>282</c:v>
                </c:pt>
                <c:pt idx="260">
                  <c:v>280</c:v>
                </c:pt>
                <c:pt idx="261">
                  <c:v>278</c:v>
                </c:pt>
                <c:pt idx="262">
                  <c:v>276</c:v>
                </c:pt>
                <c:pt idx="263">
                  <c:v>274</c:v>
                </c:pt>
                <c:pt idx="264">
                  <c:v>272</c:v>
                </c:pt>
                <c:pt idx="265">
                  <c:v>270</c:v>
                </c:pt>
                <c:pt idx="266">
                  <c:v>268</c:v>
                </c:pt>
                <c:pt idx="267">
                  <c:v>266</c:v>
                </c:pt>
                <c:pt idx="268">
                  <c:v>264</c:v>
                </c:pt>
                <c:pt idx="269">
                  <c:v>262</c:v>
                </c:pt>
                <c:pt idx="270">
                  <c:v>260</c:v>
                </c:pt>
                <c:pt idx="271">
                  <c:v>258</c:v>
                </c:pt>
                <c:pt idx="272">
                  <c:v>256</c:v>
                </c:pt>
                <c:pt idx="273">
                  <c:v>254</c:v>
                </c:pt>
                <c:pt idx="274">
                  <c:v>252</c:v>
                </c:pt>
                <c:pt idx="275">
                  <c:v>250</c:v>
                </c:pt>
                <c:pt idx="276">
                  <c:v>248</c:v>
                </c:pt>
                <c:pt idx="277">
                  <c:v>246</c:v>
                </c:pt>
                <c:pt idx="278">
                  <c:v>244</c:v>
                </c:pt>
                <c:pt idx="279">
                  <c:v>242</c:v>
                </c:pt>
                <c:pt idx="280">
                  <c:v>240</c:v>
                </c:pt>
                <c:pt idx="281">
                  <c:v>238</c:v>
                </c:pt>
                <c:pt idx="282">
                  <c:v>236</c:v>
                </c:pt>
                <c:pt idx="283">
                  <c:v>234</c:v>
                </c:pt>
                <c:pt idx="284">
                  <c:v>232</c:v>
                </c:pt>
                <c:pt idx="285">
                  <c:v>230</c:v>
                </c:pt>
                <c:pt idx="286">
                  <c:v>228</c:v>
                </c:pt>
                <c:pt idx="287">
                  <c:v>226</c:v>
                </c:pt>
                <c:pt idx="288">
                  <c:v>224</c:v>
                </c:pt>
                <c:pt idx="289">
                  <c:v>222</c:v>
                </c:pt>
                <c:pt idx="290">
                  <c:v>220</c:v>
                </c:pt>
                <c:pt idx="291">
                  <c:v>218</c:v>
                </c:pt>
                <c:pt idx="292">
                  <c:v>216</c:v>
                </c:pt>
                <c:pt idx="293">
                  <c:v>214</c:v>
                </c:pt>
                <c:pt idx="294">
                  <c:v>212</c:v>
                </c:pt>
                <c:pt idx="295">
                  <c:v>210</c:v>
                </c:pt>
                <c:pt idx="296">
                  <c:v>208</c:v>
                </c:pt>
                <c:pt idx="297">
                  <c:v>206</c:v>
                </c:pt>
                <c:pt idx="298">
                  <c:v>204</c:v>
                </c:pt>
                <c:pt idx="299">
                  <c:v>202</c:v>
                </c:pt>
                <c:pt idx="300">
                  <c:v>200</c:v>
                </c:pt>
              </c:numCache>
            </c:numRef>
          </c:xVal>
          <c:yVal>
            <c:numRef>
              <c:f>Feuil1!$G$2:$G$302</c:f>
              <c:numCache>
                <c:formatCode>General</c:formatCode>
                <c:ptCount val="301"/>
                <c:pt idx="0">
                  <c:v>3.2900000000000099E-3</c:v>
                </c:pt>
                <c:pt idx="1">
                  <c:v>4.4000000000000133E-3</c:v>
                </c:pt>
                <c:pt idx="2">
                  <c:v>2.7500000000000076E-3</c:v>
                </c:pt>
                <c:pt idx="3">
                  <c:v>5.0700000000000163E-3</c:v>
                </c:pt>
                <c:pt idx="4">
                  <c:v>2.1900000000000062E-3</c:v>
                </c:pt>
                <c:pt idx="5">
                  <c:v>2.3800000000000041E-3</c:v>
                </c:pt>
                <c:pt idx="6">
                  <c:v>8.400000000000034E-4</c:v>
                </c:pt>
                <c:pt idx="7">
                  <c:v>6.3000000000000176E-4</c:v>
                </c:pt>
                <c:pt idx="8">
                  <c:v>1.1600000000000059E-3</c:v>
                </c:pt>
                <c:pt idx="9">
                  <c:v>7.7100000000000198E-3</c:v>
                </c:pt>
                <c:pt idx="10">
                  <c:v>8.1300000000000001E-3</c:v>
                </c:pt>
                <c:pt idx="11">
                  <c:v>6.0200000000000123E-3</c:v>
                </c:pt>
                <c:pt idx="12">
                  <c:v>3.8500000000000049E-3</c:v>
                </c:pt>
                <c:pt idx="13">
                  <c:v>-9.9000000000000477E-4</c:v>
                </c:pt>
                <c:pt idx="14">
                  <c:v>7.4800000000000248E-3</c:v>
                </c:pt>
                <c:pt idx="15">
                  <c:v>2.0600000000000071E-3</c:v>
                </c:pt>
                <c:pt idx="16">
                  <c:v>3.350000000000004E-3</c:v>
                </c:pt>
                <c:pt idx="17">
                  <c:v>7.7100000000000198E-3</c:v>
                </c:pt>
                <c:pt idx="18">
                  <c:v>-1.1500000000000052E-3</c:v>
                </c:pt>
                <c:pt idx="19">
                  <c:v>4.6100000000000004E-3</c:v>
                </c:pt>
                <c:pt idx="20">
                  <c:v>1.6700000000000074E-3</c:v>
                </c:pt>
                <c:pt idx="21">
                  <c:v>8.9900000000000257E-3</c:v>
                </c:pt>
                <c:pt idx="22">
                  <c:v>1.7800000000000071E-3</c:v>
                </c:pt>
                <c:pt idx="23">
                  <c:v>3.3000000000000065E-3</c:v>
                </c:pt>
                <c:pt idx="24">
                  <c:v>9.1600000000000258E-3</c:v>
                </c:pt>
                <c:pt idx="25">
                  <c:v>3.0500000000000054E-3</c:v>
                </c:pt>
                <c:pt idx="26">
                  <c:v>5.1500000000000061E-3</c:v>
                </c:pt>
                <c:pt idx="27">
                  <c:v>-2.850000000000004E-3</c:v>
                </c:pt>
                <c:pt idx="28">
                  <c:v>5.970000000000023E-3</c:v>
                </c:pt>
                <c:pt idx="29">
                  <c:v>1.8300000000000068E-3</c:v>
                </c:pt>
                <c:pt idx="30">
                  <c:v>7.1300000000000165E-3</c:v>
                </c:pt>
                <c:pt idx="31">
                  <c:v>7.2700000000000273E-3</c:v>
                </c:pt>
                <c:pt idx="32">
                  <c:v>-8.8000000000000448E-4</c:v>
                </c:pt>
                <c:pt idx="33">
                  <c:v>3.1400000000000113E-3</c:v>
                </c:pt>
                <c:pt idx="34">
                  <c:v>4.0700000000000137E-3</c:v>
                </c:pt>
                <c:pt idx="35">
                  <c:v>3.8600000000000097E-3</c:v>
                </c:pt>
                <c:pt idx="36">
                  <c:v>4.8200000000000014E-3</c:v>
                </c:pt>
                <c:pt idx="37">
                  <c:v>-1.4400000000000033E-3</c:v>
                </c:pt>
                <c:pt idx="38">
                  <c:v>4.0000000000000186E-5</c:v>
                </c:pt>
                <c:pt idx="39">
                  <c:v>6.4700000000000269E-3</c:v>
                </c:pt>
                <c:pt idx="40">
                  <c:v>4.8500000000000088E-3</c:v>
                </c:pt>
                <c:pt idx="41">
                  <c:v>1.0030000000000001E-2</c:v>
                </c:pt>
                <c:pt idx="42">
                  <c:v>4.9000000000000215E-4</c:v>
                </c:pt>
                <c:pt idx="43">
                  <c:v>3.680000000000014E-3</c:v>
                </c:pt>
                <c:pt idx="44">
                  <c:v>6.200000000000026E-4</c:v>
                </c:pt>
                <c:pt idx="45">
                  <c:v>7.8000000000000179E-3</c:v>
                </c:pt>
                <c:pt idx="46">
                  <c:v>4.3000000000000104E-3</c:v>
                </c:pt>
                <c:pt idx="47">
                  <c:v>2.5500000000000045E-3</c:v>
                </c:pt>
                <c:pt idx="48">
                  <c:v>3.0700000000000063E-3</c:v>
                </c:pt>
                <c:pt idx="49">
                  <c:v>8.6800000000000228E-3</c:v>
                </c:pt>
                <c:pt idx="50">
                  <c:v>4.2600000000000034E-3</c:v>
                </c:pt>
                <c:pt idx="51">
                  <c:v>4.62E-3</c:v>
                </c:pt>
                <c:pt idx="52">
                  <c:v>6.4100000000000172E-3</c:v>
                </c:pt>
                <c:pt idx="53">
                  <c:v>7.5000000000000262E-4</c:v>
                </c:pt>
                <c:pt idx="54">
                  <c:v>4.3100000000000013E-3</c:v>
                </c:pt>
                <c:pt idx="55">
                  <c:v>8.8000000000000448E-4</c:v>
                </c:pt>
                <c:pt idx="56">
                  <c:v>1.8100000000000065E-3</c:v>
                </c:pt>
                <c:pt idx="57">
                  <c:v>4.46000000000001E-3</c:v>
                </c:pt>
                <c:pt idx="58">
                  <c:v>6.230000000000022E-3</c:v>
                </c:pt>
                <c:pt idx="59">
                  <c:v>3.1000000000000099E-3</c:v>
                </c:pt>
                <c:pt idx="60">
                  <c:v>4.8000000000000083E-3</c:v>
                </c:pt>
                <c:pt idx="61">
                  <c:v>5.5000000000000127E-3</c:v>
                </c:pt>
                <c:pt idx="62">
                  <c:v>2.530000000000004E-3</c:v>
                </c:pt>
                <c:pt idx="63">
                  <c:v>5.4000000000000194E-3</c:v>
                </c:pt>
                <c:pt idx="64">
                  <c:v>4.4200000000000099E-3</c:v>
                </c:pt>
                <c:pt idx="65">
                  <c:v>8.050000000000038E-3</c:v>
                </c:pt>
                <c:pt idx="66">
                  <c:v>7.2300000000000272E-3</c:v>
                </c:pt>
                <c:pt idx="67">
                  <c:v>6.3200000000000096E-3</c:v>
                </c:pt>
                <c:pt idx="68">
                  <c:v>7.0500000000000146E-3</c:v>
                </c:pt>
                <c:pt idx="69">
                  <c:v>6.5100000000000132E-3</c:v>
                </c:pt>
                <c:pt idx="70">
                  <c:v>3.9300000000000012E-3</c:v>
                </c:pt>
                <c:pt idx="71">
                  <c:v>3.1500000000000087E-3</c:v>
                </c:pt>
                <c:pt idx="72">
                  <c:v>4.6900000000000023E-3</c:v>
                </c:pt>
                <c:pt idx="73">
                  <c:v>7.2100000000000176E-3</c:v>
                </c:pt>
                <c:pt idx="74">
                  <c:v>4.3900000000000024E-3</c:v>
                </c:pt>
                <c:pt idx="75">
                  <c:v>5.5300000000000193E-3</c:v>
                </c:pt>
                <c:pt idx="76">
                  <c:v>1.8700000000000069E-3</c:v>
                </c:pt>
                <c:pt idx="77">
                  <c:v>5.0300000000000162E-3</c:v>
                </c:pt>
                <c:pt idx="78">
                  <c:v>4.1100000000000025E-3</c:v>
                </c:pt>
                <c:pt idx="79">
                  <c:v>8.2200000000000051E-3</c:v>
                </c:pt>
                <c:pt idx="80">
                  <c:v>4.9200000000000034E-3</c:v>
                </c:pt>
                <c:pt idx="81">
                  <c:v>3.9600000000000113E-3</c:v>
                </c:pt>
                <c:pt idx="82">
                  <c:v>7.2300000000000272E-3</c:v>
                </c:pt>
                <c:pt idx="83">
                  <c:v>4.6500000000000014E-3</c:v>
                </c:pt>
                <c:pt idx="84">
                  <c:v>7.1700000000000149E-3</c:v>
                </c:pt>
                <c:pt idx="85">
                  <c:v>6.180000000000011E-3</c:v>
                </c:pt>
                <c:pt idx="86">
                  <c:v>4.8200000000000014E-3</c:v>
                </c:pt>
                <c:pt idx="87">
                  <c:v>7.2600000000000147E-3</c:v>
                </c:pt>
                <c:pt idx="88">
                  <c:v>9.4200000000000238E-3</c:v>
                </c:pt>
                <c:pt idx="89">
                  <c:v>9.6400000000000027E-3</c:v>
                </c:pt>
                <c:pt idx="90">
                  <c:v>4.8600000000000023E-3</c:v>
                </c:pt>
                <c:pt idx="91">
                  <c:v>8.570000000000029E-3</c:v>
                </c:pt>
                <c:pt idx="92">
                  <c:v>6.1600000000000014E-3</c:v>
                </c:pt>
                <c:pt idx="93">
                  <c:v>7.1200000000000083E-3</c:v>
                </c:pt>
                <c:pt idx="94">
                  <c:v>6.6000000000000121E-3</c:v>
                </c:pt>
                <c:pt idx="95">
                  <c:v>6.7100000000000172E-3</c:v>
                </c:pt>
                <c:pt idx="96">
                  <c:v>7.0200000000000132E-3</c:v>
                </c:pt>
                <c:pt idx="97">
                  <c:v>7.2200000000000163E-3</c:v>
                </c:pt>
                <c:pt idx="98">
                  <c:v>4.7200000000000089E-3</c:v>
                </c:pt>
                <c:pt idx="99">
                  <c:v>6.6000000000000121E-3</c:v>
                </c:pt>
                <c:pt idx="100">
                  <c:v>5.4000000000000194E-3</c:v>
                </c:pt>
                <c:pt idx="101">
                  <c:v>7.1900000000000124E-3</c:v>
                </c:pt>
                <c:pt idx="102">
                  <c:v>7.3500000000000136E-3</c:v>
                </c:pt>
                <c:pt idx="103">
                  <c:v>3.5600000000000111E-3</c:v>
                </c:pt>
                <c:pt idx="104">
                  <c:v>5.3200000000000061E-3</c:v>
                </c:pt>
                <c:pt idx="105">
                  <c:v>6.0100000000000119E-3</c:v>
                </c:pt>
                <c:pt idx="106">
                  <c:v>8.6700000000000249E-3</c:v>
                </c:pt>
                <c:pt idx="107">
                  <c:v>4.930000000000022E-3</c:v>
                </c:pt>
                <c:pt idx="108">
                  <c:v>6.5400000000000172E-3</c:v>
                </c:pt>
                <c:pt idx="109">
                  <c:v>6.9000000000000224E-3</c:v>
                </c:pt>
                <c:pt idx="110">
                  <c:v>4.5500000000000106E-3</c:v>
                </c:pt>
                <c:pt idx="111">
                  <c:v>7.3700000000000189E-3</c:v>
                </c:pt>
                <c:pt idx="112">
                  <c:v>7.9600000000000191E-3</c:v>
                </c:pt>
                <c:pt idx="113">
                  <c:v>6.9100000000000186E-3</c:v>
                </c:pt>
                <c:pt idx="114">
                  <c:v>7.6600000000000114E-3</c:v>
                </c:pt>
                <c:pt idx="115">
                  <c:v>8.0000000000000227E-3</c:v>
                </c:pt>
                <c:pt idx="116">
                  <c:v>7.1900000000000124E-3</c:v>
                </c:pt>
                <c:pt idx="117">
                  <c:v>6.5500000000000133E-3</c:v>
                </c:pt>
                <c:pt idx="118">
                  <c:v>6.8500000000000132E-3</c:v>
                </c:pt>
                <c:pt idx="119">
                  <c:v>7.0600000000000124E-3</c:v>
                </c:pt>
                <c:pt idx="120">
                  <c:v>7.0300000000000223E-3</c:v>
                </c:pt>
                <c:pt idx="121">
                  <c:v>7.8100000000000148E-3</c:v>
                </c:pt>
                <c:pt idx="122">
                  <c:v>9.1000000000000247E-3</c:v>
                </c:pt>
                <c:pt idx="123">
                  <c:v>7.4600000000000187E-3</c:v>
                </c:pt>
                <c:pt idx="124">
                  <c:v>5.2200000000000024E-3</c:v>
                </c:pt>
                <c:pt idx="125">
                  <c:v>7.3700000000000189E-3</c:v>
                </c:pt>
                <c:pt idx="126">
                  <c:v>7.7600000000000178E-3</c:v>
                </c:pt>
                <c:pt idx="127">
                  <c:v>7.9900000000000266E-3</c:v>
                </c:pt>
                <c:pt idx="128">
                  <c:v>6.7100000000000172E-3</c:v>
                </c:pt>
                <c:pt idx="129">
                  <c:v>7.560000000000012E-3</c:v>
                </c:pt>
                <c:pt idx="130">
                  <c:v>6.8500000000000132E-3</c:v>
                </c:pt>
                <c:pt idx="131">
                  <c:v>7.4500000000000217E-3</c:v>
                </c:pt>
                <c:pt idx="132">
                  <c:v>6.8600000000000111E-3</c:v>
                </c:pt>
                <c:pt idx="133">
                  <c:v>7.980000000000027E-3</c:v>
                </c:pt>
                <c:pt idx="134">
                  <c:v>7.8600000000000024E-3</c:v>
                </c:pt>
                <c:pt idx="135">
                  <c:v>7.8500000000000132E-3</c:v>
                </c:pt>
                <c:pt idx="136">
                  <c:v>7.8700000000000228E-3</c:v>
                </c:pt>
                <c:pt idx="137">
                  <c:v>8.3400000000000227E-3</c:v>
                </c:pt>
                <c:pt idx="138">
                  <c:v>8.3800000000000263E-3</c:v>
                </c:pt>
                <c:pt idx="139">
                  <c:v>8.7000000000000046E-3</c:v>
                </c:pt>
                <c:pt idx="140">
                  <c:v>9.3600000000000471E-3</c:v>
                </c:pt>
                <c:pt idx="141">
                  <c:v>7.9500000000000248E-3</c:v>
                </c:pt>
                <c:pt idx="142">
                  <c:v>8.5200000000000067E-3</c:v>
                </c:pt>
                <c:pt idx="143">
                  <c:v>8.1000000000000048E-3</c:v>
                </c:pt>
                <c:pt idx="144">
                  <c:v>9.1700000000000254E-3</c:v>
                </c:pt>
                <c:pt idx="145">
                  <c:v>8.9400000000000208E-3</c:v>
                </c:pt>
                <c:pt idx="146">
                  <c:v>7.6600000000000114E-3</c:v>
                </c:pt>
                <c:pt idx="147">
                  <c:v>8.2500000000000247E-3</c:v>
                </c:pt>
                <c:pt idx="148">
                  <c:v>8.0200000000000028E-3</c:v>
                </c:pt>
                <c:pt idx="149">
                  <c:v>7.720000000000015E-3</c:v>
                </c:pt>
                <c:pt idx="150">
                  <c:v>7.7600000000000178E-3</c:v>
                </c:pt>
                <c:pt idx="151">
                  <c:v>8.8800000000000354E-3</c:v>
                </c:pt>
                <c:pt idx="152">
                  <c:v>8.570000000000029E-3</c:v>
                </c:pt>
                <c:pt idx="153">
                  <c:v>8.7200000000000003E-3</c:v>
                </c:pt>
                <c:pt idx="154">
                  <c:v>9.3200000000000262E-3</c:v>
                </c:pt>
                <c:pt idx="155">
                  <c:v>9.2300000000000004E-3</c:v>
                </c:pt>
                <c:pt idx="156">
                  <c:v>9.3200000000000262E-3</c:v>
                </c:pt>
                <c:pt idx="157">
                  <c:v>9.5200000000000163E-3</c:v>
                </c:pt>
                <c:pt idx="158">
                  <c:v>9.4200000000000238E-3</c:v>
                </c:pt>
                <c:pt idx="159">
                  <c:v>9.4400000000000213E-3</c:v>
                </c:pt>
                <c:pt idx="160">
                  <c:v>1.001999999999997E-2</c:v>
                </c:pt>
                <c:pt idx="161">
                  <c:v>9.8500000000000497E-3</c:v>
                </c:pt>
                <c:pt idx="162">
                  <c:v>9.60000000000002E-3</c:v>
                </c:pt>
                <c:pt idx="163">
                  <c:v>9.8900000000000342E-3</c:v>
                </c:pt>
                <c:pt idx="164">
                  <c:v>1.0149999999999998E-2</c:v>
                </c:pt>
                <c:pt idx="165">
                  <c:v>1.0279999999999973E-2</c:v>
                </c:pt>
                <c:pt idx="166">
                  <c:v>1.0540000000000037E-2</c:v>
                </c:pt>
                <c:pt idx="167">
                  <c:v>1.0189999999999998E-2</c:v>
                </c:pt>
                <c:pt idx="168">
                  <c:v>1.0590000000000007E-2</c:v>
                </c:pt>
                <c:pt idx="169">
                  <c:v>1.0570000000000001E-2</c:v>
                </c:pt>
                <c:pt idx="170">
                  <c:v>1.0489999999999998E-2</c:v>
                </c:pt>
                <c:pt idx="171">
                  <c:v>1.0440000000000031E-2</c:v>
                </c:pt>
                <c:pt idx="172">
                  <c:v>1.0680000000000033E-2</c:v>
                </c:pt>
                <c:pt idx="173">
                  <c:v>1.1209999999999999E-2</c:v>
                </c:pt>
                <c:pt idx="174">
                  <c:v>1.1450000000000033E-2</c:v>
                </c:pt>
                <c:pt idx="175">
                  <c:v>1.146000000000005E-2</c:v>
                </c:pt>
                <c:pt idx="176">
                  <c:v>1.1450000000000033E-2</c:v>
                </c:pt>
                <c:pt idx="177">
                  <c:v>1.1500000000000047E-2</c:v>
                </c:pt>
                <c:pt idx="178">
                  <c:v>1.1550000000000032E-2</c:v>
                </c:pt>
                <c:pt idx="179">
                  <c:v>1.2050000000000002E-2</c:v>
                </c:pt>
                <c:pt idx="180">
                  <c:v>1.2080000000000021E-2</c:v>
                </c:pt>
                <c:pt idx="181">
                  <c:v>1.2300000000000033E-2</c:v>
                </c:pt>
                <c:pt idx="182">
                  <c:v>1.2520000000000031E-2</c:v>
                </c:pt>
                <c:pt idx="183">
                  <c:v>1.2619999999999998E-2</c:v>
                </c:pt>
                <c:pt idx="184">
                  <c:v>1.2999999999999998E-2</c:v>
                </c:pt>
                <c:pt idx="185">
                  <c:v>1.3430000000000025E-2</c:v>
                </c:pt>
                <c:pt idx="186">
                  <c:v>1.3670000000000031E-2</c:v>
                </c:pt>
                <c:pt idx="187">
                  <c:v>1.3870000000000035E-2</c:v>
                </c:pt>
                <c:pt idx="188">
                  <c:v>1.4060000000000001E-2</c:v>
                </c:pt>
                <c:pt idx="189">
                  <c:v>1.4420000000000025E-2</c:v>
                </c:pt>
                <c:pt idx="190">
                  <c:v>1.4730000000000005E-2</c:v>
                </c:pt>
                <c:pt idx="191">
                  <c:v>1.4880000000000036E-2</c:v>
                </c:pt>
                <c:pt idx="192">
                  <c:v>1.4900000000000036E-2</c:v>
                </c:pt>
                <c:pt idx="193">
                  <c:v>1.5689999999999999E-2</c:v>
                </c:pt>
                <c:pt idx="194">
                  <c:v>1.5469999999999999E-2</c:v>
                </c:pt>
                <c:pt idx="195">
                  <c:v>1.5820000000000049E-2</c:v>
                </c:pt>
                <c:pt idx="196">
                  <c:v>1.6379999999999999E-2</c:v>
                </c:pt>
                <c:pt idx="197">
                  <c:v>1.6870000000000048E-2</c:v>
                </c:pt>
                <c:pt idx="198">
                  <c:v>1.6879999999999999E-2</c:v>
                </c:pt>
                <c:pt idx="199">
                  <c:v>1.7870000000000049E-2</c:v>
                </c:pt>
                <c:pt idx="200">
                  <c:v>1.817000000000004E-2</c:v>
                </c:pt>
                <c:pt idx="201">
                  <c:v>1.8470000000000045E-2</c:v>
                </c:pt>
                <c:pt idx="202">
                  <c:v>1.8860000000000054E-2</c:v>
                </c:pt>
                <c:pt idx="203">
                  <c:v>1.9150000000000021E-2</c:v>
                </c:pt>
                <c:pt idx="204">
                  <c:v>1.9660000000000063E-2</c:v>
                </c:pt>
                <c:pt idx="205">
                  <c:v>2.0040000000000002E-2</c:v>
                </c:pt>
                <c:pt idx="206">
                  <c:v>2.0119999999999999E-2</c:v>
                </c:pt>
                <c:pt idx="207">
                  <c:v>2.0959999999999999E-2</c:v>
                </c:pt>
                <c:pt idx="208">
                  <c:v>2.1230000000000086E-2</c:v>
                </c:pt>
                <c:pt idx="209">
                  <c:v>2.1840000000000085E-2</c:v>
                </c:pt>
                <c:pt idx="210">
                  <c:v>2.2500000000000055E-2</c:v>
                </c:pt>
                <c:pt idx="211">
                  <c:v>2.2700000000000012E-2</c:v>
                </c:pt>
                <c:pt idx="212">
                  <c:v>2.3109999999999999E-2</c:v>
                </c:pt>
                <c:pt idx="213">
                  <c:v>2.4219999999999998E-2</c:v>
                </c:pt>
                <c:pt idx="214">
                  <c:v>2.4270000000000062E-2</c:v>
                </c:pt>
                <c:pt idx="215">
                  <c:v>2.5670000000000068E-2</c:v>
                </c:pt>
                <c:pt idx="216">
                  <c:v>2.6030000000000095E-2</c:v>
                </c:pt>
                <c:pt idx="217">
                  <c:v>2.7230000000000108E-2</c:v>
                </c:pt>
                <c:pt idx="218">
                  <c:v>2.8349999999999997E-2</c:v>
                </c:pt>
                <c:pt idx="219">
                  <c:v>2.9170000000000012E-2</c:v>
                </c:pt>
                <c:pt idx="220">
                  <c:v>3.0980000000000053E-2</c:v>
                </c:pt>
                <c:pt idx="221">
                  <c:v>3.4010000000000012E-2</c:v>
                </c:pt>
                <c:pt idx="222">
                  <c:v>3.7870000000000147E-2</c:v>
                </c:pt>
                <c:pt idx="223">
                  <c:v>4.3090000000000114E-2</c:v>
                </c:pt>
                <c:pt idx="224">
                  <c:v>5.1690000000000014E-2</c:v>
                </c:pt>
                <c:pt idx="225">
                  <c:v>6.2979999999999994E-2</c:v>
                </c:pt>
                <c:pt idx="226">
                  <c:v>7.9960000000000198E-2</c:v>
                </c:pt>
                <c:pt idx="227">
                  <c:v>0.10687000000000002</c:v>
                </c:pt>
                <c:pt idx="228">
                  <c:v>0.14038</c:v>
                </c:pt>
                <c:pt idx="229">
                  <c:v>0.19504000000000044</c:v>
                </c:pt>
                <c:pt idx="230">
                  <c:v>0.28310000000000002</c:v>
                </c:pt>
                <c:pt idx="231">
                  <c:v>0.40135000000000032</c:v>
                </c:pt>
                <c:pt idx="232">
                  <c:v>0.59270000000000089</c:v>
                </c:pt>
                <c:pt idx="233">
                  <c:v>0.90824000000000005</c:v>
                </c:pt>
                <c:pt idx="234">
                  <c:v>1.3364400000000001</c:v>
                </c:pt>
                <c:pt idx="235">
                  <c:v>1.9765900000000001</c:v>
                </c:pt>
                <c:pt idx="236">
                  <c:v>2.6201599999999998</c:v>
                </c:pt>
                <c:pt idx="237">
                  <c:v>2.8941699999999977</c:v>
                </c:pt>
                <c:pt idx="238">
                  <c:v>2.992749999999992</c:v>
                </c:pt>
                <c:pt idx="239">
                  <c:v>2.93493</c:v>
                </c:pt>
                <c:pt idx="240">
                  <c:v>3.0587200000000001</c:v>
                </c:pt>
                <c:pt idx="241">
                  <c:v>3.0628399999999987</c:v>
                </c:pt>
                <c:pt idx="242">
                  <c:v>3.1576599999999977</c:v>
                </c:pt>
                <c:pt idx="243">
                  <c:v>3.1947899999999998</c:v>
                </c:pt>
                <c:pt idx="244">
                  <c:v>3.2364899999999968</c:v>
                </c:pt>
                <c:pt idx="245">
                  <c:v>3.3009900000000001</c:v>
                </c:pt>
                <c:pt idx="246">
                  <c:v>3.34768</c:v>
                </c:pt>
                <c:pt idx="247">
                  <c:v>3.4077199999999999</c:v>
                </c:pt>
                <c:pt idx="248">
                  <c:v>3.3931399999999998</c:v>
                </c:pt>
                <c:pt idx="249">
                  <c:v>3.490469999999994</c:v>
                </c:pt>
                <c:pt idx="250">
                  <c:v>3.5632700000000002</c:v>
                </c:pt>
                <c:pt idx="251">
                  <c:v>3.6419800000000002</c:v>
                </c:pt>
                <c:pt idx="252">
                  <c:v>3.5105900000000001</c:v>
                </c:pt>
                <c:pt idx="253">
                  <c:v>3.4695</c:v>
                </c:pt>
                <c:pt idx="254">
                  <c:v>3.3531200000000001</c:v>
                </c:pt>
                <c:pt idx="255">
                  <c:v>3.22</c:v>
                </c:pt>
                <c:pt idx="256">
                  <c:v>3.06976</c:v>
                </c:pt>
                <c:pt idx="257">
                  <c:v>2.9674499999999977</c:v>
                </c:pt>
                <c:pt idx="258">
                  <c:v>2.8225699999999967</c:v>
                </c:pt>
                <c:pt idx="259">
                  <c:v>2.6480700000000001</c:v>
                </c:pt>
                <c:pt idx="260">
                  <c:v>2.4494099999999968</c:v>
                </c:pt>
                <c:pt idx="261">
                  <c:v>2.2415600000000002</c:v>
                </c:pt>
                <c:pt idx="262">
                  <c:v>1.9758699999999974</c:v>
                </c:pt>
                <c:pt idx="263">
                  <c:v>1.6981800000000038</c:v>
                </c:pt>
                <c:pt idx="264">
                  <c:v>1.3917299999999966</c:v>
                </c:pt>
                <c:pt idx="265">
                  <c:v>1.0007299999999966</c:v>
                </c:pt>
                <c:pt idx="266">
                  <c:v>0.60597000000000178</c:v>
                </c:pt>
                <c:pt idx="267">
                  <c:v>0.34599000000000052</c:v>
                </c:pt>
                <c:pt idx="268">
                  <c:v>0.20810999999999999</c:v>
                </c:pt>
                <c:pt idx="269">
                  <c:v>0.15936000000000042</c:v>
                </c:pt>
                <c:pt idx="270">
                  <c:v>0.13599000000000042</c:v>
                </c:pt>
                <c:pt idx="271">
                  <c:v>0.14105999999999999</c:v>
                </c:pt>
                <c:pt idx="272">
                  <c:v>0.14863000000000001</c:v>
                </c:pt>
                <c:pt idx="273">
                  <c:v>0.13824000000000042</c:v>
                </c:pt>
                <c:pt idx="274">
                  <c:v>0.12520000000000001</c:v>
                </c:pt>
                <c:pt idx="275">
                  <c:v>0.12003000000000009</c:v>
                </c:pt>
                <c:pt idx="276">
                  <c:v>9.7390000000000004E-2</c:v>
                </c:pt>
                <c:pt idx="277">
                  <c:v>9.3400000000000066E-2</c:v>
                </c:pt>
                <c:pt idx="278">
                  <c:v>9.9810000000000065E-2</c:v>
                </c:pt>
                <c:pt idx="279">
                  <c:v>8.8820000000000343E-2</c:v>
                </c:pt>
                <c:pt idx="280">
                  <c:v>9.4520000000000451E-2</c:v>
                </c:pt>
                <c:pt idx="281">
                  <c:v>9.9460000000000048E-2</c:v>
                </c:pt>
                <c:pt idx="282">
                  <c:v>0.10501000000000002</c:v>
                </c:pt>
                <c:pt idx="283">
                  <c:v>0.1026200000000002</c:v>
                </c:pt>
                <c:pt idx="284">
                  <c:v>8.9560000000000348E-2</c:v>
                </c:pt>
                <c:pt idx="285">
                  <c:v>8.3070000000000227E-2</c:v>
                </c:pt>
                <c:pt idx="286">
                  <c:v>8.4600000000000272E-2</c:v>
                </c:pt>
                <c:pt idx="287">
                  <c:v>9.3940000000000246E-2</c:v>
                </c:pt>
                <c:pt idx="288">
                  <c:v>0.10498</c:v>
                </c:pt>
                <c:pt idx="289">
                  <c:v>0.1021900000000002</c:v>
                </c:pt>
                <c:pt idx="290">
                  <c:v>0.1224900000000002</c:v>
                </c:pt>
                <c:pt idx="291">
                  <c:v>0.13514000000000001</c:v>
                </c:pt>
                <c:pt idx="292">
                  <c:v>0.14834000000000042</c:v>
                </c:pt>
                <c:pt idx="293">
                  <c:v>0.13217999999999988</c:v>
                </c:pt>
                <c:pt idx="294">
                  <c:v>0.13755000000000001</c:v>
                </c:pt>
                <c:pt idx="295">
                  <c:v>0.15973000000000054</c:v>
                </c:pt>
                <c:pt idx="296">
                  <c:v>0.11906000000000025</c:v>
                </c:pt>
                <c:pt idx="297">
                  <c:v>0.13403000000000001</c:v>
                </c:pt>
                <c:pt idx="298">
                  <c:v>0.14647000000000004</c:v>
                </c:pt>
                <c:pt idx="299">
                  <c:v>0.16410000000000019</c:v>
                </c:pt>
                <c:pt idx="300">
                  <c:v>0.1427600000000003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E01B-4127-A621-24501A84C0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7748992"/>
        <c:axId val="68054400"/>
      </c:scatterChart>
      <c:valAx>
        <c:axId val="67748992"/>
        <c:scaling>
          <c:orientation val="minMax"/>
          <c:max val="800"/>
          <c:min val="400"/>
        </c:scaling>
        <c:delete val="0"/>
        <c:axPos val="b"/>
        <c:title>
          <c:tx>
            <c:rich>
              <a:bodyPr/>
              <a:lstStyle/>
              <a:p>
                <a:pPr>
                  <a:defRPr b="1"/>
                </a:pPr>
                <a:r>
                  <a:rPr lang="en-US" b="1"/>
                  <a:t>Wavelength (nm)</a:t>
                </a:r>
              </a:p>
            </c:rich>
          </c:tx>
          <c:layout>
            <c:manualLayout>
              <c:xMode val="edge"/>
              <c:yMode val="edge"/>
              <c:x val="0.32972172056474591"/>
              <c:y val="0.87347517730496449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in"/>
        <c:minorTickMark val="none"/>
        <c:tickLblPos val="nextTo"/>
        <c:spPr>
          <a:ln w="3175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fr-FR"/>
          </a:p>
        </c:txPr>
        <c:crossAx val="68054400"/>
        <c:crosses val="autoZero"/>
        <c:crossBetween val="midCat"/>
        <c:majorUnit val="50"/>
      </c:valAx>
      <c:valAx>
        <c:axId val="68054400"/>
        <c:scaling>
          <c:orientation val="minMax"/>
          <c:max val="1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b="1"/>
                </a:pPr>
                <a:r>
                  <a:rPr lang="en-US" b="1"/>
                  <a:t>Absorbance</a:t>
                </a:r>
              </a:p>
            </c:rich>
          </c:tx>
          <c:layout>
            <c:manualLayout>
              <c:xMode val="edge"/>
              <c:yMode val="edge"/>
              <c:x val="4.0167914790467715E-3"/>
              <c:y val="0.16472105880381974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in"/>
        <c:minorTickMark val="none"/>
        <c:tickLblPos val="nextTo"/>
        <c:spPr>
          <a:ln w="3175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fr-FR"/>
          </a:p>
        </c:txPr>
        <c:crossAx val="67748992"/>
        <c:crosses val="autoZero"/>
        <c:crossBetween val="midCat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12700">
      <a:noFill/>
      <a:prstDash val="solid"/>
    </a:ln>
  </c:spPr>
  <c:txPr>
    <a:bodyPr/>
    <a:lstStyle/>
    <a:p>
      <a:pPr>
        <a:defRPr sz="1100" b="0" i="0" u="none" strike="noStrike" baseline="0">
          <a:solidFill>
            <a:srgbClr val="000000"/>
          </a:solidFill>
          <a:latin typeface="Palatino Linotype" panose="02040502050505030304" pitchFamily="18" charset="0"/>
          <a:ea typeface="Times New Roman"/>
          <a:cs typeface="Times New Roman"/>
        </a:defRPr>
      </a:pPr>
      <a:endParaRPr lang="fr-F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F7F598-4ED5-4CAF-B6B7-393E567640C6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FB49A8-8C75-4ACB-A4F7-EA7CAA164A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90630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CADAE4F-CB87-4286-BB70-A1ED3EB27E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479B5238-338C-4DC6-A6E4-2FF30F5F81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19A2946-8F07-4DE1-B08B-F49FA9E04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D1A25-E2DE-4810-A63C-60ED6AED679C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3F06E89-6928-4F49-B186-A14B20E5B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2FB1945-C0C0-4229-B5F0-7BA6ADBFA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7A119-3A84-4E1B-83FB-779BA3E4EA1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8298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5F6B6F6-C2EE-4D11-B0D7-87C673DF54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C3B8419-649D-4046-9379-91F72A30E6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6A21686-DB58-4846-9EE2-3430812C9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D1A25-E2DE-4810-A63C-60ED6AED679C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78ED47E-2711-4ED0-B64D-B9E7804798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DE7A6FE-27DD-42E9-8331-AA2E409E7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7A119-3A84-4E1B-83FB-779BA3E4EA1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9685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9045976E-816D-444C-AC58-0E16CE8B1C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34540F9-84FA-47A4-852F-5242AAD673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51458CC-7FFC-4F58-AF95-E5523177E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D1A25-E2DE-4810-A63C-60ED6AED679C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4114682-87BA-4F08-B255-7224866B7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53BB0AE-1150-4731-BF08-27998A7B82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7A119-3A84-4E1B-83FB-779BA3E4EA1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4131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FBD629C-C560-438A-B92C-EDB2F4C52E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C4AF10C-596D-4B16-9016-5CBEEBA673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FC84C65-25F4-400B-BF89-420AF8B24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D1A25-E2DE-4810-A63C-60ED6AED679C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A20C304-0252-4413-876D-515ECE8A0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E434C17-DE31-46C7-8A3B-BB6DE3846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7A119-3A84-4E1B-83FB-779BA3E4EA1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8555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93EA2E0-1B06-4B1D-87B2-294E4B0C76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C4CD4EA-08B3-4755-A788-D1F1DE05FB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C0F77B0-03FB-4217-A9A8-2C74F4249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D1A25-E2DE-4810-A63C-60ED6AED679C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B221984-ACAB-4968-B537-63C7D3F39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DA14658-D81D-464B-B52D-C6F5E9D4A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7A119-3A84-4E1B-83FB-779BA3E4EA1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7428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9EE49A2-69CE-41C0-9112-31FB111CFC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A702E54-4ADB-47D2-A267-13585FAE78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66E6339-36C6-44F4-85DC-3730418B33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A2331EF-D49C-4BF3-82CD-E41874ACF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D1A25-E2DE-4810-A63C-60ED6AED679C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42AB025-FB47-4189-A30D-615B6B0F8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1537D97-19F7-4517-BE3D-BD63EEEFF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7A119-3A84-4E1B-83FB-779BA3E4EA1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9729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338BCBF-D0BA-497F-821E-35873038F5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215EF19-CD21-46F6-91D5-2EF1F6F163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DAC4B71-92F7-48A2-9541-C29E279C8A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2066E00C-6BD7-40FE-9D70-B66502AEAD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85965E2-9A7C-4889-8239-94E5CB249D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5C82F782-17DD-4277-9AB1-5E46A96A1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D1A25-E2DE-4810-A63C-60ED6AED679C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8C04C815-8085-4B33-B0E1-3BA9D28E5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57DB0A09-F2D3-4803-91D3-D07DFF7E97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7A119-3A84-4E1B-83FB-779BA3E4EA1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4556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2300123-C0A3-4A78-AEC8-1966D1E017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0082CDB-1F23-467F-B081-720F4D4D87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D1A25-E2DE-4810-A63C-60ED6AED679C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A9581CCE-512B-47FE-AD57-EE16133F27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DDA9D0E-1DA4-4216-A857-99003985D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7A119-3A84-4E1B-83FB-779BA3E4EA1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6845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2E7A2968-1D32-42BE-9DBA-0721FF826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D1A25-E2DE-4810-A63C-60ED6AED679C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2CCB8ADC-44EE-4541-9E85-AF6DB5825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7235D56B-6B2C-4FE5-B6D9-47D5A1609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7A119-3A84-4E1B-83FB-779BA3E4EA1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7773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97AFD2C-DD99-4931-A122-574DE337C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8FC5A97-E325-43FE-9C9A-2041F6B191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FDEEE38-11C6-4545-8258-DF4083A8A6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9672828-29F7-4391-A34D-F6E99933E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D1A25-E2DE-4810-A63C-60ED6AED679C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E76A5C4-EB42-44B7-A1A7-193A5749F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3D5D467-82AF-4748-87E6-DE91A9387C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7A119-3A84-4E1B-83FB-779BA3E4EA1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9714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11FACB4-4BC7-4697-9E3D-5D632CB556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15AFF2D4-F2CF-47DC-89DB-07693A54A7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CFE7239-57BF-4E55-84BC-4319682AE9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4492F09-47CE-4A75-9CAF-26698E97E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D1A25-E2DE-4810-A63C-60ED6AED679C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B42D4E7-BED8-4F5D-80A0-F004C6510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2B54759-982A-4F14-B15F-EE8C12E280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7A119-3A84-4E1B-83FB-779BA3E4EA1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5334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F07BC9C-6BD6-4114-819D-01FEC04A6F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A88E394-214D-4752-8EFD-816801968E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31112A-A5DE-4F58-B7C5-2C1E997F43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9D1A25-E2DE-4810-A63C-60ED6AED679C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D50B894-413A-4965-BAF6-A03CFE68A5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CEDF310-5402-4222-B823-3393D568DA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A7A119-3A84-4E1B-83FB-779BA3E4EA1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5920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016A68F7-3D1E-E979-27FC-A12E2FB2B3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0160" y="60959"/>
            <a:ext cx="9144000" cy="5306161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218E3F0C-BA1F-40AD-CA7D-EA5CDD5C9D8B}"/>
              </a:ext>
            </a:extLst>
          </p:cNvPr>
          <p:cNvSpPr txBox="1"/>
          <p:nvPr/>
        </p:nvSpPr>
        <p:spPr>
          <a:xfrm>
            <a:off x="2164080" y="5461200"/>
            <a:ext cx="7376160" cy="881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reto Chart of the standardized effects for RB5 decolorization (after 120 min of reaction) as function of coded value of factors.</a:t>
            </a:r>
            <a:endParaRPr lang="fr-FR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30202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e 9">
            <a:extLst>
              <a:ext uri="{FF2B5EF4-FFF2-40B4-BE49-F238E27FC236}">
                <a16:creationId xmlns:a16="http://schemas.microsoft.com/office/drawing/2014/main" id="{37942DBF-BD26-F8E9-B1B2-7FBCF679DAE4}"/>
              </a:ext>
            </a:extLst>
          </p:cNvPr>
          <p:cNvGrpSpPr/>
          <p:nvPr/>
        </p:nvGrpSpPr>
        <p:grpSpPr>
          <a:xfrm>
            <a:off x="3871304" y="924891"/>
            <a:ext cx="4449392" cy="3412159"/>
            <a:chOff x="3298773" y="940131"/>
            <a:chExt cx="4449392" cy="3412159"/>
          </a:xfrm>
        </p:grpSpPr>
        <p:pic>
          <p:nvPicPr>
            <p:cNvPr id="4" name="image8.png">
              <a:extLst>
                <a:ext uri="{FF2B5EF4-FFF2-40B4-BE49-F238E27FC236}">
                  <a16:creationId xmlns:a16="http://schemas.microsoft.com/office/drawing/2014/main" id="{9ACEB31E-880E-F46C-4172-A56D3FC167F0}"/>
                </a:ext>
              </a:extLst>
            </p:cNvPr>
            <p:cNvPicPr/>
            <p:nvPr/>
          </p:nvPicPr>
          <p:blipFill rotWithShape="1">
            <a:blip r:embed="rId2"/>
            <a:srcRect l="29431" r="41063"/>
            <a:stretch/>
          </p:blipFill>
          <p:spPr>
            <a:xfrm>
              <a:off x="3298773" y="940131"/>
              <a:ext cx="2507668" cy="3076482"/>
            </a:xfrm>
            <a:prstGeom prst="rect">
              <a:avLst/>
            </a:prstGeom>
            <a:ln/>
          </p:spPr>
        </p:pic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C8A7BDC3-2387-26AD-7A10-2D1DC42671C2}"/>
                </a:ext>
              </a:extLst>
            </p:cNvPr>
            <p:cNvSpPr txBox="1"/>
            <p:nvPr/>
          </p:nvSpPr>
          <p:spPr>
            <a:xfrm>
              <a:off x="3691547" y="3982958"/>
              <a:ext cx="1722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latin typeface="Palatino Linotype" panose="02040502050505030304" pitchFamily="18" charset="0"/>
                </a:rPr>
                <a:t>Untreated dye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9FF3748D-B0EF-0A7A-AC73-91F5A5502AAF}"/>
                </a:ext>
              </a:extLst>
            </p:cNvPr>
            <p:cNvSpPr txBox="1"/>
            <p:nvPr/>
          </p:nvSpPr>
          <p:spPr>
            <a:xfrm>
              <a:off x="6026045" y="3976608"/>
              <a:ext cx="1722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Palatino Linotype" panose="02040502050505030304" pitchFamily="18" charset="0"/>
                </a:rPr>
                <a:t>Treated</a:t>
              </a:r>
              <a:r>
                <a:rPr lang="en-US" dirty="0"/>
                <a:t> dye</a:t>
              </a:r>
            </a:p>
          </p:txBody>
        </p:sp>
        <p:pic>
          <p:nvPicPr>
            <p:cNvPr id="8" name="image8.png">
              <a:extLst>
                <a:ext uri="{FF2B5EF4-FFF2-40B4-BE49-F238E27FC236}">
                  <a16:creationId xmlns:a16="http://schemas.microsoft.com/office/drawing/2014/main" id="{C335154A-753A-C89A-2D28-F840EF918A95}"/>
                </a:ext>
              </a:extLst>
            </p:cNvPr>
            <p:cNvPicPr/>
            <p:nvPr/>
          </p:nvPicPr>
          <p:blipFill rotWithShape="1">
            <a:blip r:embed="rId2"/>
            <a:srcRect l="76225"/>
            <a:stretch/>
          </p:blipFill>
          <p:spPr>
            <a:xfrm>
              <a:off x="5806441" y="940131"/>
              <a:ext cx="1761595" cy="3042827"/>
            </a:xfrm>
            <a:prstGeom prst="rect">
              <a:avLst/>
            </a:prstGeom>
            <a:ln/>
          </p:spPr>
        </p:pic>
      </p:grpSp>
      <p:sp>
        <p:nvSpPr>
          <p:cNvPr id="9" name="ZoneTexte 8">
            <a:extLst>
              <a:ext uri="{FF2B5EF4-FFF2-40B4-BE49-F238E27FC236}">
                <a16:creationId xmlns:a16="http://schemas.microsoft.com/office/drawing/2014/main" id="{58F26B23-1472-5F50-4D8B-AC29845F2B26}"/>
              </a:ext>
            </a:extLst>
          </p:cNvPr>
          <p:cNvSpPr txBox="1"/>
          <p:nvPr/>
        </p:nvSpPr>
        <p:spPr>
          <a:xfrm>
            <a:off x="1826051" y="4504293"/>
            <a:ext cx="925342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Palatino Linotype" panose="02040502050505030304" pitchFamily="18" charset="0"/>
              </a:rPr>
              <a:t>Figure S2.</a:t>
            </a:r>
            <a:r>
              <a:rPr lang="fr-FR" dirty="0">
                <a:latin typeface="Palatino Linotype" panose="0204050205050503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Shift of RB5 color from dark blue to intense yellow after 2 hours of incubation. Untreated dye: 25 mg L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-1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 RB5 dye, 4.5 mM HBT, </a:t>
            </a:r>
            <a:r>
              <a:rPr lang="en-U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 4.2, and temperature 55°C. </a:t>
            </a:r>
          </a:p>
          <a:p>
            <a:r>
              <a:rPr lang="en-U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eated dye: 0.5 U mL</a:t>
            </a:r>
            <a:r>
              <a:rPr lang="en-US" sz="1800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accase-like activity,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25 mg L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-1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 RB5 dye, 4.5 mM HBT, </a:t>
            </a:r>
            <a:r>
              <a:rPr lang="en-U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 4.2, and temperature 55°C. </a:t>
            </a:r>
            <a:endParaRPr lang="fr-FR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76322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>
            <a:extLst>
              <a:ext uri="{FF2B5EF4-FFF2-40B4-BE49-F238E27FC236}">
                <a16:creationId xmlns:a16="http://schemas.microsoft.com/office/drawing/2014/main" id="{3F9C344C-3027-4FFF-BB95-98574096B821}"/>
              </a:ext>
            </a:extLst>
          </p:cNvPr>
          <p:cNvGrpSpPr/>
          <p:nvPr/>
        </p:nvGrpSpPr>
        <p:grpSpPr>
          <a:xfrm>
            <a:off x="2499360" y="358141"/>
            <a:ext cx="7193281" cy="4191000"/>
            <a:chOff x="1569720" y="518160"/>
            <a:chExt cx="7193281" cy="4191000"/>
          </a:xfrm>
        </p:grpSpPr>
        <p:graphicFrame>
          <p:nvGraphicFramePr>
            <p:cNvPr id="4" name="Graphique 3">
              <a:extLst>
                <a:ext uri="{FF2B5EF4-FFF2-40B4-BE49-F238E27FC236}">
                  <a16:creationId xmlns:a16="http://schemas.microsoft.com/office/drawing/2014/main" id="{CA22D6D9-4193-4899-A10E-324D1A12A50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67730738"/>
                </p:ext>
              </p:extLst>
            </p:nvPr>
          </p:nvGraphicFramePr>
          <p:xfrm>
            <a:off x="1569720" y="518160"/>
            <a:ext cx="7193280" cy="4191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Graphique 4">
              <a:extLst>
                <a:ext uri="{FF2B5EF4-FFF2-40B4-BE49-F238E27FC236}">
                  <a16:creationId xmlns:a16="http://schemas.microsoft.com/office/drawing/2014/main" id="{DF8BA72C-C127-49AC-890B-94581DD125C1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796332031"/>
                </p:ext>
              </p:extLst>
            </p:nvPr>
          </p:nvGraphicFramePr>
          <p:xfrm>
            <a:off x="5806441" y="518160"/>
            <a:ext cx="2956560" cy="17907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sp>
        <p:nvSpPr>
          <p:cNvPr id="7" name="ZoneTexte 6">
            <a:extLst>
              <a:ext uri="{FF2B5EF4-FFF2-40B4-BE49-F238E27FC236}">
                <a16:creationId xmlns:a16="http://schemas.microsoft.com/office/drawing/2014/main" id="{3F0A4527-B3BB-47D1-A4EC-18CB9201982C}"/>
              </a:ext>
            </a:extLst>
          </p:cNvPr>
          <p:cNvSpPr txBox="1"/>
          <p:nvPr/>
        </p:nvSpPr>
        <p:spPr>
          <a:xfrm>
            <a:off x="1060055" y="4549141"/>
            <a:ext cx="969264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>
                <a:latin typeface="Palatino Linotype" panose="02040502050505030304" pitchFamily="18" charset="0"/>
              </a:rPr>
              <a:t>Figure S3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V–VIS spectrum of RB5 showing original dye (25 mg L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−1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(dark blue), RB5 added with 4.5 mM HBT (red), RB5 added with the laccase-like cell free supernatant from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 gallic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green), RB5 added with both 4.5 mM HBT and the laccase-like cell free supernatant from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 gallic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purple), HBT with the laccase-like cell free supernatant from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 gallic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light blue), and 4.5 mM HBT (orange) after a 24 h incubation period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05779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au 7">
            <a:extLst>
              <a:ext uri="{FF2B5EF4-FFF2-40B4-BE49-F238E27FC236}">
                <a16:creationId xmlns:a16="http://schemas.microsoft.com/office/drawing/2014/main" id="{FE6A772A-BA24-49F1-81A1-C3CC6A3F7F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7014051"/>
              </p:ext>
            </p:extLst>
          </p:nvPr>
        </p:nvGraphicFramePr>
        <p:xfrm>
          <a:off x="1386840" y="1051560"/>
          <a:ext cx="9128759" cy="334359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4736161">
                  <a:extLst>
                    <a:ext uri="{9D8B030D-6E8A-4147-A177-3AD203B41FA5}">
                      <a16:colId xmlns:a16="http://schemas.microsoft.com/office/drawing/2014/main" val="2823923205"/>
                    </a:ext>
                  </a:extLst>
                </a:gridCol>
                <a:gridCol w="592542">
                  <a:extLst>
                    <a:ext uri="{9D8B030D-6E8A-4147-A177-3AD203B41FA5}">
                      <a16:colId xmlns:a16="http://schemas.microsoft.com/office/drawing/2014/main" val="2867535576"/>
                    </a:ext>
                  </a:extLst>
                </a:gridCol>
                <a:gridCol w="923586">
                  <a:extLst>
                    <a:ext uri="{9D8B030D-6E8A-4147-A177-3AD203B41FA5}">
                      <a16:colId xmlns:a16="http://schemas.microsoft.com/office/drawing/2014/main" val="1368224857"/>
                    </a:ext>
                  </a:extLst>
                </a:gridCol>
                <a:gridCol w="873511">
                  <a:extLst>
                    <a:ext uri="{9D8B030D-6E8A-4147-A177-3AD203B41FA5}">
                      <a16:colId xmlns:a16="http://schemas.microsoft.com/office/drawing/2014/main" val="932981322"/>
                    </a:ext>
                  </a:extLst>
                </a:gridCol>
                <a:gridCol w="667653">
                  <a:extLst>
                    <a:ext uri="{9D8B030D-6E8A-4147-A177-3AD203B41FA5}">
                      <a16:colId xmlns:a16="http://schemas.microsoft.com/office/drawing/2014/main" val="4143123923"/>
                    </a:ext>
                  </a:extLst>
                </a:gridCol>
                <a:gridCol w="667653">
                  <a:extLst>
                    <a:ext uri="{9D8B030D-6E8A-4147-A177-3AD203B41FA5}">
                      <a16:colId xmlns:a16="http://schemas.microsoft.com/office/drawing/2014/main" val="2524648"/>
                    </a:ext>
                  </a:extLst>
                </a:gridCol>
                <a:gridCol w="667653">
                  <a:extLst>
                    <a:ext uri="{9D8B030D-6E8A-4147-A177-3AD203B41FA5}">
                      <a16:colId xmlns:a16="http://schemas.microsoft.com/office/drawing/2014/main" val="2354569517"/>
                    </a:ext>
                  </a:extLst>
                </a:gridCol>
              </a:tblGrid>
              <a:tr h="668718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 dirty="0">
                          <a:effectLst/>
                          <a:latin typeface="Palatino Linotype" panose="02040502050505030304" pitchFamily="18" charset="0"/>
                        </a:rPr>
                        <a:t>Condition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 dirty="0"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 dirty="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 dirty="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 dirty="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 dirty="0">
                          <a:effectLst/>
                          <a:latin typeface="Palatino Linotype" panose="02040502050505030304" pitchFamily="18" charset="0"/>
                        </a:rPr>
                        <a:t>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 dirty="0">
                          <a:effectLst/>
                          <a:latin typeface="Palatino Linotype" panose="02040502050505030304" pitchFamily="18" charset="0"/>
                        </a:rPr>
                        <a:t>6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4235402"/>
                  </a:ext>
                </a:extLst>
              </a:tr>
              <a:tr h="668718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Citrate buffer pH 4.2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9414173"/>
                  </a:ext>
                </a:extLst>
              </a:tr>
              <a:tr h="668718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Dye 25 mg L</a:t>
                      </a:r>
                      <a:r>
                        <a:rPr lang="en-US" sz="1200" baseline="30000">
                          <a:effectLst/>
                          <a:latin typeface="Palatino Linotype" panose="02040502050505030304" pitchFamily="18" charset="0"/>
                        </a:rPr>
                        <a:t>-1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956794"/>
                  </a:ext>
                </a:extLst>
              </a:tr>
              <a:tr h="668718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HBT 4.5 mM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2746573"/>
                  </a:ext>
                </a:extLst>
              </a:tr>
              <a:tr h="668718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 dirty="0">
                          <a:effectLst/>
                          <a:latin typeface="Palatino Linotype" panose="02040502050505030304" pitchFamily="18" charset="0"/>
                        </a:rPr>
                        <a:t>Laccase-like activity 0.5 U m L</a:t>
                      </a:r>
                      <a:r>
                        <a:rPr lang="en-US" sz="1200" baseline="30000" dirty="0">
                          <a:effectLst/>
                          <a:latin typeface="Palatino Linotype" panose="02040502050505030304" pitchFamily="18" charset="0"/>
                        </a:rPr>
                        <a:t>-1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200" dirty="0"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3955793"/>
                  </a:ext>
                </a:extLst>
              </a:tr>
            </a:tbl>
          </a:graphicData>
        </a:graphic>
      </p:graphicFrame>
      <p:sp>
        <p:nvSpPr>
          <p:cNvPr id="14" name="ZoneTexte 13">
            <a:extLst>
              <a:ext uri="{FF2B5EF4-FFF2-40B4-BE49-F238E27FC236}">
                <a16:creationId xmlns:a16="http://schemas.microsoft.com/office/drawing/2014/main" id="{4618782E-A0C3-920F-382B-BDE1BAED5C0C}"/>
              </a:ext>
            </a:extLst>
          </p:cNvPr>
          <p:cNvSpPr txBox="1"/>
          <p:nvPr/>
        </p:nvSpPr>
        <p:spPr>
          <a:xfrm>
            <a:off x="1386840" y="553779"/>
            <a:ext cx="6096000" cy="3554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Table S1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Decolorization conditions.</a:t>
            </a:r>
            <a:endParaRPr lang="fr-FR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17284130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7</TotalTime>
  <Words>260</Words>
  <Application>Microsoft Office PowerPoint</Application>
  <PresentationFormat>Grand écran</PresentationFormat>
  <Paragraphs>46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mal.benayed@enis.tn</dc:creator>
  <cp:lastModifiedBy>amal.benayed@enis.tn</cp:lastModifiedBy>
  <cp:revision>9</cp:revision>
  <dcterms:created xsi:type="dcterms:W3CDTF">2022-04-11T20:53:42Z</dcterms:created>
  <dcterms:modified xsi:type="dcterms:W3CDTF">2022-05-25T14:04:17Z</dcterms:modified>
</cp:coreProperties>
</file>